
<file path=[Content_Types].xml><?xml version="1.0" encoding="utf-8"?>
<Types xmlns="http://schemas.openxmlformats.org/package/2006/content-types">
  <Default Extension="bin" ContentType="application/vnd.openxmlformats-officedocument.oleObject"/>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94" r:id="rId2"/>
    <p:sldId id="290" r:id="rId3"/>
    <p:sldId id="293" r:id="rId4"/>
    <p:sldId id="275" r:id="rId5"/>
    <p:sldId id="295" r:id="rId6"/>
    <p:sldId id="296"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FA1546C-AAE4-4B89-86A7-C130A0B04C58}" v="358" dt="2022-06-22T20:10:48.95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2665" autoAdjust="0"/>
    <p:restoredTop sz="93758" autoAdjust="0"/>
  </p:normalViewPr>
  <p:slideViewPr>
    <p:cSldViewPr snapToGrid="0">
      <p:cViewPr varScale="1">
        <p:scale>
          <a:sx n="67" d="100"/>
          <a:sy n="67" d="100"/>
        </p:scale>
        <p:origin x="3396"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ang, Shengming - ARS" userId="37bd5b25-7571-49cb-bfc8-588a18706c35" providerId="ADAL" clId="{64974484-A414-4DA9-9FFB-7D0FAE92FD4F}"/>
    <pc:docChg chg="modSld">
      <pc:chgData name="Yang, Shengming - ARS" userId="37bd5b25-7571-49cb-bfc8-588a18706c35" providerId="ADAL" clId="{64974484-A414-4DA9-9FFB-7D0FAE92FD4F}" dt="2022-01-04T15:08:28.685" v="12" actId="1038"/>
      <pc:docMkLst>
        <pc:docMk/>
      </pc:docMkLst>
      <pc:sldChg chg="modSp mod">
        <pc:chgData name="Yang, Shengming - ARS" userId="37bd5b25-7571-49cb-bfc8-588a18706c35" providerId="ADAL" clId="{64974484-A414-4DA9-9FFB-7D0FAE92FD4F}" dt="2022-01-04T15:08:28.685" v="12" actId="1038"/>
        <pc:sldMkLst>
          <pc:docMk/>
          <pc:sldMk cId="1327558011" sldId="276"/>
        </pc:sldMkLst>
        <pc:picChg chg="mod">
          <ac:chgData name="Yang, Shengming - ARS" userId="37bd5b25-7571-49cb-bfc8-588a18706c35" providerId="ADAL" clId="{64974484-A414-4DA9-9FFB-7D0FAE92FD4F}" dt="2022-01-04T15:08:11.027" v="8" actId="14100"/>
          <ac:picMkLst>
            <pc:docMk/>
            <pc:sldMk cId="1327558011" sldId="276"/>
            <ac:picMk id="10" creationId="{05A166F1-4B35-440B-8A66-9471844B2815}"/>
          </ac:picMkLst>
        </pc:picChg>
        <pc:picChg chg="mod">
          <ac:chgData name="Yang, Shengming - ARS" userId="37bd5b25-7571-49cb-bfc8-588a18706c35" providerId="ADAL" clId="{64974484-A414-4DA9-9FFB-7D0FAE92FD4F}" dt="2022-01-04T15:08:28.685" v="12" actId="1038"/>
          <ac:picMkLst>
            <pc:docMk/>
            <pc:sldMk cId="1327558011" sldId="276"/>
            <ac:picMk id="13" creationId="{7337B5DD-D9CC-4FD6-9539-A6256FEF0D65}"/>
          </ac:picMkLst>
        </pc:picChg>
      </pc:sldChg>
    </pc:docChg>
  </pc:docChgLst>
  <pc:docChgLst>
    <pc:chgData name="Yang, Shengming - ARS" userId="37bd5b25-7571-49cb-bfc8-588a18706c35" providerId="ADAL" clId="{AE56A9E5-EE4C-4DAB-B208-155664F2B8E0}"/>
    <pc:docChg chg="modSld">
      <pc:chgData name="Yang, Shengming - ARS" userId="37bd5b25-7571-49cb-bfc8-588a18706c35" providerId="ADAL" clId="{AE56A9E5-EE4C-4DAB-B208-155664F2B8E0}" dt="2021-11-11T21:59:36.790" v="6" actId="1076"/>
      <pc:docMkLst>
        <pc:docMk/>
      </pc:docMkLst>
      <pc:sldChg chg="modSp mod">
        <pc:chgData name="Yang, Shengming - ARS" userId="37bd5b25-7571-49cb-bfc8-588a18706c35" providerId="ADAL" clId="{AE56A9E5-EE4C-4DAB-B208-155664F2B8E0}" dt="2021-11-11T21:59:36.790" v="6" actId="1076"/>
        <pc:sldMkLst>
          <pc:docMk/>
          <pc:sldMk cId="187198215" sldId="256"/>
        </pc:sldMkLst>
        <pc:grpChg chg="mod">
          <ac:chgData name="Yang, Shengming - ARS" userId="37bd5b25-7571-49cb-bfc8-588a18706c35" providerId="ADAL" clId="{AE56A9E5-EE4C-4DAB-B208-155664F2B8E0}" dt="2021-11-11T21:59:36.790" v="6" actId="1076"/>
          <ac:grpSpMkLst>
            <pc:docMk/>
            <pc:sldMk cId="187198215" sldId="256"/>
            <ac:grpSpMk id="4" creationId="{4713D267-1D1C-445B-9270-5911825C9C0B}"/>
          </ac:grpSpMkLst>
        </pc:grpChg>
      </pc:sldChg>
    </pc:docChg>
  </pc:docChgLst>
  <pc:docChgLst>
    <pc:chgData name="Yang, Shengming - ARS" userId="37bd5b25-7571-49cb-bfc8-588a18706c35" providerId="ADAL" clId="{4FA1546C-AAE4-4B89-86A7-C130A0B04C58}"/>
    <pc:docChg chg="undo custSel addSld delSld modSld sldOrd">
      <pc:chgData name="Yang, Shengming - ARS" userId="37bd5b25-7571-49cb-bfc8-588a18706c35" providerId="ADAL" clId="{4FA1546C-AAE4-4B89-86A7-C130A0B04C58}" dt="2022-06-23T00:29:36.750" v="3297" actId="47"/>
      <pc:docMkLst>
        <pc:docMk/>
      </pc:docMkLst>
      <pc:sldChg chg="modSp mod">
        <pc:chgData name="Yang, Shengming - ARS" userId="37bd5b25-7571-49cb-bfc8-588a18706c35" providerId="ADAL" clId="{4FA1546C-AAE4-4B89-86A7-C130A0B04C58}" dt="2022-06-15T21:13:21.362" v="2972" actId="20577"/>
        <pc:sldMkLst>
          <pc:docMk/>
          <pc:sldMk cId="1525299809" sldId="275"/>
        </pc:sldMkLst>
        <pc:spChg chg="mod">
          <ac:chgData name="Yang, Shengming - ARS" userId="37bd5b25-7571-49cb-bfc8-588a18706c35" providerId="ADAL" clId="{4FA1546C-AAE4-4B89-86A7-C130A0B04C58}" dt="2022-06-15T21:13:21.362" v="2972" actId="20577"/>
          <ac:spMkLst>
            <pc:docMk/>
            <pc:sldMk cId="1525299809" sldId="275"/>
            <ac:spMk id="25" creationId="{A876130B-ED92-4416-90CA-563FA5FCBC5F}"/>
          </ac:spMkLst>
        </pc:spChg>
      </pc:sldChg>
      <pc:sldChg chg="del ord">
        <pc:chgData name="Yang, Shengming - ARS" userId="37bd5b25-7571-49cb-bfc8-588a18706c35" providerId="ADAL" clId="{4FA1546C-AAE4-4B89-86A7-C130A0B04C58}" dt="2022-06-23T00:29:36.750" v="3297" actId="47"/>
        <pc:sldMkLst>
          <pc:docMk/>
          <pc:sldMk cId="887383785" sldId="278"/>
        </pc:sldMkLst>
      </pc:sldChg>
      <pc:sldChg chg="modSp mod">
        <pc:chgData name="Yang, Shengming - ARS" userId="37bd5b25-7571-49cb-bfc8-588a18706c35" providerId="ADAL" clId="{4FA1546C-AAE4-4B89-86A7-C130A0B04C58}" dt="2022-06-15T21:26:28.024" v="3001" actId="20577"/>
        <pc:sldMkLst>
          <pc:docMk/>
          <pc:sldMk cId="2200906561" sldId="290"/>
        </pc:sldMkLst>
        <pc:spChg chg="mod">
          <ac:chgData name="Yang, Shengming - ARS" userId="37bd5b25-7571-49cb-bfc8-588a18706c35" providerId="ADAL" clId="{4FA1546C-AAE4-4B89-86A7-C130A0B04C58}" dt="2022-06-15T21:26:28.024" v="3001" actId="20577"/>
          <ac:spMkLst>
            <pc:docMk/>
            <pc:sldMk cId="2200906561" sldId="290"/>
            <ac:spMk id="58" creationId="{127FACC4-AEA3-45C6-A512-B76CA41EF55B}"/>
          </ac:spMkLst>
        </pc:spChg>
      </pc:sldChg>
      <pc:sldChg chg="del ord">
        <pc:chgData name="Yang, Shengming - ARS" userId="37bd5b25-7571-49cb-bfc8-588a18706c35" providerId="ADAL" clId="{4FA1546C-AAE4-4B89-86A7-C130A0B04C58}" dt="2022-06-23T00:29:36.750" v="3297" actId="47"/>
        <pc:sldMkLst>
          <pc:docMk/>
          <pc:sldMk cId="530921904" sldId="291"/>
        </pc:sldMkLst>
      </pc:sldChg>
      <pc:sldChg chg="modSp del mod ord">
        <pc:chgData name="Yang, Shengming - ARS" userId="37bd5b25-7571-49cb-bfc8-588a18706c35" providerId="ADAL" clId="{4FA1546C-AAE4-4B89-86A7-C130A0B04C58}" dt="2022-06-23T00:29:36.750" v="3297" actId="47"/>
        <pc:sldMkLst>
          <pc:docMk/>
          <pc:sldMk cId="2282065266" sldId="292"/>
        </pc:sldMkLst>
        <pc:spChg chg="mod">
          <ac:chgData name="Yang, Shengming - ARS" userId="37bd5b25-7571-49cb-bfc8-588a18706c35" providerId="ADAL" clId="{4FA1546C-AAE4-4B89-86A7-C130A0B04C58}" dt="2022-06-16T14:21:35.623" v="3159" actId="20577"/>
          <ac:spMkLst>
            <pc:docMk/>
            <pc:sldMk cId="2282065266" sldId="292"/>
            <ac:spMk id="5" creationId="{22CABD5C-E7F8-4D30-AF77-D1DF38BD1326}"/>
          </ac:spMkLst>
        </pc:spChg>
        <pc:graphicFrameChg chg="mod modGraphic">
          <ac:chgData name="Yang, Shengming - ARS" userId="37bd5b25-7571-49cb-bfc8-588a18706c35" providerId="ADAL" clId="{4FA1546C-AAE4-4B89-86A7-C130A0B04C58}" dt="2022-06-16T15:26:26.877" v="3217" actId="114"/>
          <ac:graphicFrameMkLst>
            <pc:docMk/>
            <pc:sldMk cId="2282065266" sldId="292"/>
            <ac:graphicFrameMk id="3" creationId="{A0F8C46D-3CFE-4677-A518-154587BE828B}"/>
          </ac:graphicFrameMkLst>
        </pc:graphicFrameChg>
      </pc:sldChg>
      <pc:sldChg chg="addSp delSp modSp new mod">
        <pc:chgData name="Yang, Shengming - ARS" userId="37bd5b25-7571-49cb-bfc8-588a18706c35" providerId="ADAL" clId="{4FA1546C-AAE4-4B89-86A7-C130A0B04C58}" dt="2022-06-16T15:36:01.484" v="3219" actId="14100"/>
        <pc:sldMkLst>
          <pc:docMk/>
          <pc:sldMk cId="2589227480" sldId="293"/>
        </pc:sldMkLst>
        <pc:spChg chg="del">
          <ac:chgData name="Yang, Shengming - ARS" userId="37bd5b25-7571-49cb-bfc8-588a18706c35" providerId="ADAL" clId="{4FA1546C-AAE4-4B89-86A7-C130A0B04C58}" dt="2022-06-15T16:01:41.714" v="1" actId="478"/>
          <ac:spMkLst>
            <pc:docMk/>
            <pc:sldMk cId="2589227480" sldId="293"/>
            <ac:spMk id="2" creationId="{FFE1FA07-83BC-4F18-87BF-849389D4A786}"/>
          </ac:spMkLst>
        </pc:spChg>
        <pc:spChg chg="del">
          <ac:chgData name="Yang, Shengming - ARS" userId="37bd5b25-7571-49cb-bfc8-588a18706c35" providerId="ADAL" clId="{4FA1546C-AAE4-4B89-86A7-C130A0B04C58}" dt="2022-06-15T16:01:41.714" v="1" actId="478"/>
          <ac:spMkLst>
            <pc:docMk/>
            <pc:sldMk cId="2589227480" sldId="293"/>
            <ac:spMk id="3" creationId="{E22CE041-B8AE-4AA8-BE44-12ADA9B39DA9}"/>
          </ac:spMkLst>
        </pc:spChg>
        <pc:spChg chg="add mod">
          <ac:chgData name="Yang, Shengming - ARS" userId="37bd5b25-7571-49cb-bfc8-588a18706c35" providerId="ADAL" clId="{4FA1546C-AAE4-4B89-86A7-C130A0B04C58}" dt="2022-06-15T18:46:04.811" v="1832" actId="1036"/>
          <ac:spMkLst>
            <pc:docMk/>
            <pc:sldMk cId="2589227480" sldId="293"/>
            <ac:spMk id="6" creationId="{EBABDFAB-9059-4DE4-9E1E-ACE8458AAE51}"/>
          </ac:spMkLst>
        </pc:spChg>
        <pc:spChg chg="add mod">
          <ac:chgData name="Yang, Shengming - ARS" userId="37bd5b25-7571-49cb-bfc8-588a18706c35" providerId="ADAL" clId="{4FA1546C-AAE4-4B89-86A7-C130A0B04C58}" dt="2022-06-15T18:46:04.811" v="1832" actId="1036"/>
          <ac:spMkLst>
            <pc:docMk/>
            <pc:sldMk cId="2589227480" sldId="293"/>
            <ac:spMk id="7" creationId="{E8ACE48E-D164-4B9D-B329-565028B27A2C}"/>
          </ac:spMkLst>
        </pc:spChg>
        <pc:spChg chg="add mod">
          <ac:chgData name="Yang, Shengming - ARS" userId="37bd5b25-7571-49cb-bfc8-588a18706c35" providerId="ADAL" clId="{4FA1546C-AAE4-4B89-86A7-C130A0B04C58}" dt="2022-06-15T18:46:04.811" v="1832" actId="1036"/>
          <ac:spMkLst>
            <pc:docMk/>
            <pc:sldMk cId="2589227480" sldId="293"/>
            <ac:spMk id="8" creationId="{C5C55104-D522-41DB-93F6-DF80B525D13B}"/>
          </ac:spMkLst>
        </pc:spChg>
        <pc:spChg chg="add mod">
          <ac:chgData name="Yang, Shengming - ARS" userId="37bd5b25-7571-49cb-bfc8-588a18706c35" providerId="ADAL" clId="{4FA1546C-AAE4-4B89-86A7-C130A0B04C58}" dt="2022-06-15T18:46:04.811" v="1832" actId="1036"/>
          <ac:spMkLst>
            <pc:docMk/>
            <pc:sldMk cId="2589227480" sldId="293"/>
            <ac:spMk id="9" creationId="{4B135AEC-B398-4ACF-BBE7-8743B5D02C41}"/>
          </ac:spMkLst>
        </pc:spChg>
        <pc:spChg chg="add mod">
          <ac:chgData name="Yang, Shengming - ARS" userId="37bd5b25-7571-49cb-bfc8-588a18706c35" providerId="ADAL" clId="{4FA1546C-AAE4-4B89-86A7-C130A0B04C58}" dt="2022-06-15T18:46:04.811" v="1832" actId="1036"/>
          <ac:spMkLst>
            <pc:docMk/>
            <pc:sldMk cId="2589227480" sldId="293"/>
            <ac:spMk id="10" creationId="{173A45CE-7FAA-4927-AF0B-23A32A8CA548}"/>
          </ac:spMkLst>
        </pc:spChg>
        <pc:spChg chg="add mod">
          <ac:chgData name="Yang, Shengming - ARS" userId="37bd5b25-7571-49cb-bfc8-588a18706c35" providerId="ADAL" clId="{4FA1546C-AAE4-4B89-86A7-C130A0B04C58}" dt="2022-06-15T18:46:04.811" v="1832" actId="1036"/>
          <ac:spMkLst>
            <pc:docMk/>
            <pc:sldMk cId="2589227480" sldId="293"/>
            <ac:spMk id="11" creationId="{18F8A3AF-FAE9-4577-817B-6D511413DA65}"/>
          </ac:spMkLst>
        </pc:spChg>
        <pc:spChg chg="add mod">
          <ac:chgData name="Yang, Shengming - ARS" userId="37bd5b25-7571-49cb-bfc8-588a18706c35" providerId="ADAL" clId="{4FA1546C-AAE4-4B89-86A7-C130A0B04C58}" dt="2022-06-15T18:46:04.811" v="1832" actId="1036"/>
          <ac:spMkLst>
            <pc:docMk/>
            <pc:sldMk cId="2589227480" sldId="293"/>
            <ac:spMk id="12" creationId="{3F0DCC11-D4CB-4F1C-B9FB-E1394721C0E0}"/>
          </ac:spMkLst>
        </pc:spChg>
        <pc:spChg chg="add mod">
          <ac:chgData name="Yang, Shengming - ARS" userId="37bd5b25-7571-49cb-bfc8-588a18706c35" providerId="ADAL" clId="{4FA1546C-AAE4-4B89-86A7-C130A0B04C58}" dt="2022-06-15T18:46:04.811" v="1832" actId="1036"/>
          <ac:spMkLst>
            <pc:docMk/>
            <pc:sldMk cId="2589227480" sldId="293"/>
            <ac:spMk id="13" creationId="{DB5A4933-CF11-4AB5-932B-84BDCBFFB809}"/>
          </ac:spMkLst>
        </pc:spChg>
        <pc:spChg chg="add mod">
          <ac:chgData name="Yang, Shengming - ARS" userId="37bd5b25-7571-49cb-bfc8-588a18706c35" providerId="ADAL" clId="{4FA1546C-AAE4-4B89-86A7-C130A0B04C58}" dt="2022-06-15T18:46:04.811" v="1832" actId="1036"/>
          <ac:spMkLst>
            <pc:docMk/>
            <pc:sldMk cId="2589227480" sldId="293"/>
            <ac:spMk id="14" creationId="{C77BFB50-48AD-469A-94BB-E0CA2135C184}"/>
          </ac:spMkLst>
        </pc:spChg>
        <pc:spChg chg="add mod">
          <ac:chgData name="Yang, Shengming - ARS" userId="37bd5b25-7571-49cb-bfc8-588a18706c35" providerId="ADAL" clId="{4FA1546C-AAE4-4B89-86A7-C130A0B04C58}" dt="2022-06-15T18:46:04.811" v="1832" actId="1036"/>
          <ac:spMkLst>
            <pc:docMk/>
            <pc:sldMk cId="2589227480" sldId="293"/>
            <ac:spMk id="15" creationId="{A018B8A4-9BE6-43F5-8604-A76D00BD4949}"/>
          </ac:spMkLst>
        </pc:spChg>
        <pc:spChg chg="add mod">
          <ac:chgData name="Yang, Shengming - ARS" userId="37bd5b25-7571-49cb-bfc8-588a18706c35" providerId="ADAL" clId="{4FA1546C-AAE4-4B89-86A7-C130A0B04C58}" dt="2022-06-15T18:46:04.811" v="1832" actId="1036"/>
          <ac:spMkLst>
            <pc:docMk/>
            <pc:sldMk cId="2589227480" sldId="293"/>
            <ac:spMk id="16" creationId="{6A338B3F-3120-4AD4-AB0F-C8525465A3A2}"/>
          </ac:spMkLst>
        </pc:spChg>
        <pc:spChg chg="add mod">
          <ac:chgData name="Yang, Shengming - ARS" userId="37bd5b25-7571-49cb-bfc8-588a18706c35" providerId="ADAL" clId="{4FA1546C-AAE4-4B89-86A7-C130A0B04C58}" dt="2022-06-15T18:46:04.811" v="1832" actId="1036"/>
          <ac:spMkLst>
            <pc:docMk/>
            <pc:sldMk cId="2589227480" sldId="293"/>
            <ac:spMk id="17" creationId="{7BCB8FE6-3364-4258-ABBC-830200CB5BB0}"/>
          </ac:spMkLst>
        </pc:spChg>
        <pc:spChg chg="add mod">
          <ac:chgData name="Yang, Shengming - ARS" userId="37bd5b25-7571-49cb-bfc8-588a18706c35" providerId="ADAL" clId="{4FA1546C-AAE4-4B89-86A7-C130A0B04C58}" dt="2022-06-15T18:46:04.811" v="1832" actId="1036"/>
          <ac:spMkLst>
            <pc:docMk/>
            <pc:sldMk cId="2589227480" sldId="293"/>
            <ac:spMk id="18" creationId="{1A2AD85E-926D-46FD-9F1A-397E8FF2CC67}"/>
          </ac:spMkLst>
        </pc:spChg>
        <pc:spChg chg="add mod">
          <ac:chgData name="Yang, Shengming - ARS" userId="37bd5b25-7571-49cb-bfc8-588a18706c35" providerId="ADAL" clId="{4FA1546C-AAE4-4B89-86A7-C130A0B04C58}" dt="2022-06-15T18:46:04.811" v="1832" actId="1036"/>
          <ac:spMkLst>
            <pc:docMk/>
            <pc:sldMk cId="2589227480" sldId="293"/>
            <ac:spMk id="19" creationId="{9D59066D-222A-4B6F-A461-683A2AEB6E10}"/>
          </ac:spMkLst>
        </pc:spChg>
        <pc:spChg chg="add mod">
          <ac:chgData name="Yang, Shengming - ARS" userId="37bd5b25-7571-49cb-bfc8-588a18706c35" providerId="ADAL" clId="{4FA1546C-AAE4-4B89-86A7-C130A0B04C58}" dt="2022-06-15T18:46:04.811" v="1832" actId="1036"/>
          <ac:spMkLst>
            <pc:docMk/>
            <pc:sldMk cId="2589227480" sldId="293"/>
            <ac:spMk id="20" creationId="{B1D598EA-1B00-444B-AA63-AC9937D782A8}"/>
          </ac:spMkLst>
        </pc:spChg>
        <pc:spChg chg="add mod">
          <ac:chgData name="Yang, Shengming - ARS" userId="37bd5b25-7571-49cb-bfc8-588a18706c35" providerId="ADAL" clId="{4FA1546C-AAE4-4B89-86A7-C130A0B04C58}" dt="2022-06-15T18:46:04.811" v="1832" actId="1036"/>
          <ac:spMkLst>
            <pc:docMk/>
            <pc:sldMk cId="2589227480" sldId="293"/>
            <ac:spMk id="21" creationId="{410C12DF-EA62-45B1-9E8A-24F8D153CF43}"/>
          </ac:spMkLst>
        </pc:spChg>
        <pc:spChg chg="add mod">
          <ac:chgData name="Yang, Shengming - ARS" userId="37bd5b25-7571-49cb-bfc8-588a18706c35" providerId="ADAL" clId="{4FA1546C-AAE4-4B89-86A7-C130A0B04C58}" dt="2022-06-16T15:36:01.484" v="3219" actId="14100"/>
          <ac:spMkLst>
            <pc:docMk/>
            <pc:sldMk cId="2589227480" sldId="293"/>
            <ac:spMk id="23" creationId="{9678172C-DAD8-4225-9157-C796BB2BC932}"/>
          </ac:spMkLst>
        </pc:spChg>
        <pc:spChg chg="add mod">
          <ac:chgData name="Yang, Shengming - ARS" userId="37bd5b25-7571-49cb-bfc8-588a18706c35" providerId="ADAL" clId="{4FA1546C-AAE4-4B89-86A7-C130A0B04C58}" dt="2022-06-15T18:46:04.811" v="1832" actId="1036"/>
          <ac:spMkLst>
            <pc:docMk/>
            <pc:sldMk cId="2589227480" sldId="293"/>
            <ac:spMk id="24" creationId="{30A92E5A-3B0A-45E8-A9B1-0684CA5E8505}"/>
          </ac:spMkLst>
        </pc:spChg>
        <pc:spChg chg="add mod">
          <ac:chgData name="Yang, Shengming - ARS" userId="37bd5b25-7571-49cb-bfc8-588a18706c35" providerId="ADAL" clId="{4FA1546C-AAE4-4B89-86A7-C130A0B04C58}" dt="2022-06-15T18:46:04.811" v="1832" actId="1036"/>
          <ac:spMkLst>
            <pc:docMk/>
            <pc:sldMk cId="2589227480" sldId="293"/>
            <ac:spMk id="25" creationId="{33189B57-48A5-495B-811D-D7C2493F6F2B}"/>
          </ac:spMkLst>
        </pc:spChg>
        <pc:spChg chg="add mod">
          <ac:chgData name="Yang, Shengming - ARS" userId="37bd5b25-7571-49cb-bfc8-588a18706c35" providerId="ADAL" clId="{4FA1546C-AAE4-4B89-86A7-C130A0B04C58}" dt="2022-06-15T18:46:04.811" v="1832" actId="1036"/>
          <ac:spMkLst>
            <pc:docMk/>
            <pc:sldMk cId="2589227480" sldId="293"/>
            <ac:spMk id="26" creationId="{1A43C643-0F66-4159-A9FF-576F7C92EB0F}"/>
          </ac:spMkLst>
        </pc:spChg>
        <pc:spChg chg="add mod">
          <ac:chgData name="Yang, Shengming - ARS" userId="37bd5b25-7571-49cb-bfc8-588a18706c35" providerId="ADAL" clId="{4FA1546C-AAE4-4B89-86A7-C130A0B04C58}" dt="2022-06-15T18:46:04.811" v="1832" actId="1036"/>
          <ac:spMkLst>
            <pc:docMk/>
            <pc:sldMk cId="2589227480" sldId="293"/>
            <ac:spMk id="27" creationId="{C82DD6B3-F159-4D6E-81A5-56DACAF95DBB}"/>
          </ac:spMkLst>
        </pc:spChg>
        <pc:spChg chg="add mod">
          <ac:chgData name="Yang, Shengming - ARS" userId="37bd5b25-7571-49cb-bfc8-588a18706c35" providerId="ADAL" clId="{4FA1546C-AAE4-4B89-86A7-C130A0B04C58}" dt="2022-06-15T18:46:04.811" v="1832" actId="1036"/>
          <ac:spMkLst>
            <pc:docMk/>
            <pc:sldMk cId="2589227480" sldId="293"/>
            <ac:spMk id="28" creationId="{B8F9A9AD-D20B-4ECE-A76A-B06BE19A842B}"/>
          </ac:spMkLst>
        </pc:spChg>
        <pc:spChg chg="add mod">
          <ac:chgData name="Yang, Shengming - ARS" userId="37bd5b25-7571-49cb-bfc8-588a18706c35" providerId="ADAL" clId="{4FA1546C-AAE4-4B89-86A7-C130A0B04C58}" dt="2022-06-15T18:46:04.811" v="1832" actId="1036"/>
          <ac:spMkLst>
            <pc:docMk/>
            <pc:sldMk cId="2589227480" sldId="293"/>
            <ac:spMk id="29" creationId="{7D89E1B4-6E06-4C13-9033-BCDF3E17E564}"/>
          </ac:spMkLst>
        </pc:spChg>
        <pc:spChg chg="add mod">
          <ac:chgData name="Yang, Shengming - ARS" userId="37bd5b25-7571-49cb-bfc8-588a18706c35" providerId="ADAL" clId="{4FA1546C-AAE4-4B89-86A7-C130A0B04C58}" dt="2022-06-15T18:46:04.811" v="1832" actId="1036"/>
          <ac:spMkLst>
            <pc:docMk/>
            <pc:sldMk cId="2589227480" sldId="293"/>
            <ac:spMk id="30" creationId="{D007F2F9-319D-4AF3-955D-5D3B27AAE9EF}"/>
          </ac:spMkLst>
        </pc:spChg>
        <pc:spChg chg="add mod">
          <ac:chgData name="Yang, Shengming - ARS" userId="37bd5b25-7571-49cb-bfc8-588a18706c35" providerId="ADAL" clId="{4FA1546C-AAE4-4B89-86A7-C130A0B04C58}" dt="2022-06-15T18:46:04.811" v="1832" actId="1036"/>
          <ac:spMkLst>
            <pc:docMk/>
            <pc:sldMk cId="2589227480" sldId="293"/>
            <ac:spMk id="31" creationId="{B1FDB1A6-C213-4CDC-B31C-F8DD408350DA}"/>
          </ac:spMkLst>
        </pc:spChg>
        <pc:spChg chg="add mod">
          <ac:chgData name="Yang, Shengming - ARS" userId="37bd5b25-7571-49cb-bfc8-588a18706c35" providerId="ADAL" clId="{4FA1546C-AAE4-4B89-86A7-C130A0B04C58}" dt="2022-06-15T18:46:04.811" v="1832" actId="1036"/>
          <ac:spMkLst>
            <pc:docMk/>
            <pc:sldMk cId="2589227480" sldId="293"/>
            <ac:spMk id="32" creationId="{D14C0B03-C416-4ED3-B464-9E3EBEAB8294}"/>
          </ac:spMkLst>
        </pc:spChg>
        <pc:spChg chg="add mod">
          <ac:chgData name="Yang, Shengming - ARS" userId="37bd5b25-7571-49cb-bfc8-588a18706c35" providerId="ADAL" clId="{4FA1546C-AAE4-4B89-86A7-C130A0B04C58}" dt="2022-06-15T18:46:04.811" v="1832" actId="1036"/>
          <ac:spMkLst>
            <pc:docMk/>
            <pc:sldMk cId="2589227480" sldId="293"/>
            <ac:spMk id="33" creationId="{D0E52C7A-6757-4980-8B46-372CD1CD4922}"/>
          </ac:spMkLst>
        </pc:spChg>
        <pc:spChg chg="add mod">
          <ac:chgData name="Yang, Shengming - ARS" userId="37bd5b25-7571-49cb-bfc8-588a18706c35" providerId="ADAL" clId="{4FA1546C-AAE4-4B89-86A7-C130A0B04C58}" dt="2022-06-15T18:46:04.811" v="1832" actId="1036"/>
          <ac:spMkLst>
            <pc:docMk/>
            <pc:sldMk cId="2589227480" sldId="293"/>
            <ac:spMk id="34" creationId="{4B337127-33B7-4A08-B01E-1709799B4B4D}"/>
          </ac:spMkLst>
        </pc:spChg>
        <pc:spChg chg="add mod">
          <ac:chgData name="Yang, Shengming - ARS" userId="37bd5b25-7571-49cb-bfc8-588a18706c35" providerId="ADAL" clId="{4FA1546C-AAE4-4B89-86A7-C130A0B04C58}" dt="2022-06-15T18:46:04.811" v="1832" actId="1036"/>
          <ac:spMkLst>
            <pc:docMk/>
            <pc:sldMk cId="2589227480" sldId="293"/>
            <ac:spMk id="35" creationId="{9B228087-01B6-4450-99BA-7CF7156843B0}"/>
          </ac:spMkLst>
        </pc:spChg>
        <pc:spChg chg="add mod">
          <ac:chgData name="Yang, Shengming - ARS" userId="37bd5b25-7571-49cb-bfc8-588a18706c35" providerId="ADAL" clId="{4FA1546C-AAE4-4B89-86A7-C130A0B04C58}" dt="2022-06-15T18:46:04.811" v="1832" actId="1036"/>
          <ac:spMkLst>
            <pc:docMk/>
            <pc:sldMk cId="2589227480" sldId="293"/>
            <ac:spMk id="36" creationId="{9F9DEE46-B13D-483F-8142-17B2A68B52B4}"/>
          </ac:spMkLst>
        </pc:spChg>
        <pc:spChg chg="add mod">
          <ac:chgData name="Yang, Shengming - ARS" userId="37bd5b25-7571-49cb-bfc8-588a18706c35" providerId="ADAL" clId="{4FA1546C-AAE4-4B89-86A7-C130A0B04C58}" dt="2022-06-15T18:46:04.811" v="1832" actId="1036"/>
          <ac:spMkLst>
            <pc:docMk/>
            <pc:sldMk cId="2589227480" sldId="293"/>
            <ac:spMk id="37" creationId="{DA0D0419-8F45-4529-9F96-8162059FE972}"/>
          </ac:spMkLst>
        </pc:spChg>
        <pc:spChg chg="add mod">
          <ac:chgData name="Yang, Shengming - ARS" userId="37bd5b25-7571-49cb-bfc8-588a18706c35" providerId="ADAL" clId="{4FA1546C-AAE4-4B89-86A7-C130A0B04C58}" dt="2022-06-15T18:46:04.811" v="1832" actId="1036"/>
          <ac:spMkLst>
            <pc:docMk/>
            <pc:sldMk cId="2589227480" sldId="293"/>
            <ac:spMk id="38" creationId="{5E58AC31-5DBD-4880-BA0C-EA97556CF8A2}"/>
          </ac:spMkLst>
        </pc:spChg>
        <pc:spChg chg="add mod">
          <ac:chgData name="Yang, Shengming - ARS" userId="37bd5b25-7571-49cb-bfc8-588a18706c35" providerId="ADAL" clId="{4FA1546C-AAE4-4B89-86A7-C130A0B04C58}" dt="2022-06-15T18:46:04.811" v="1832" actId="1036"/>
          <ac:spMkLst>
            <pc:docMk/>
            <pc:sldMk cId="2589227480" sldId="293"/>
            <ac:spMk id="39" creationId="{690D6783-9C68-4BF2-AF07-CB877EE3853C}"/>
          </ac:spMkLst>
        </pc:spChg>
        <pc:spChg chg="add mod">
          <ac:chgData name="Yang, Shengming - ARS" userId="37bd5b25-7571-49cb-bfc8-588a18706c35" providerId="ADAL" clId="{4FA1546C-AAE4-4B89-86A7-C130A0B04C58}" dt="2022-06-15T18:46:04.811" v="1832" actId="1036"/>
          <ac:spMkLst>
            <pc:docMk/>
            <pc:sldMk cId="2589227480" sldId="293"/>
            <ac:spMk id="40" creationId="{3DC32442-42EC-49EB-AACE-5BCCB0E37654}"/>
          </ac:spMkLst>
        </pc:spChg>
        <pc:spChg chg="add mod">
          <ac:chgData name="Yang, Shengming - ARS" userId="37bd5b25-7571-49cb-bfc8-588a18706c35" providerId="ADAL" clId="{4FA1546C-AAE4-4B89-86A7-C130A0B04C58}" dt="2022-06-15T18:46:04.811" v="1832" actId="1036"/>
          <ac:spMkLst>
            <pc:docMk/>
            <pc:sldMk cId="2589227480" sldId="293"/>
            <ac:spMk id="41" creationId="{73931615-BECF-40E4-9D21-9F7B79F4DCC0}"/>
          </ac:spMkLst>
        </pc:spChg>
        <pc:spChg chg="add mod">
          <ac:chgData name="Yang, Shengming - ARS" userId="37bd5b25-7571-49cb-bfc8-588a18706c35" providerId="ADAL" clId="{4FA1546C-AAE4-4B89-86A7-C130A0B04C58}" dt="2022-06-15T18:46:04.811" v="1832" actId="1036"/>
          <ac:spMkLst>
            <pc:docMk/>
            <pc:sldMk cId="2589227480" sldId="293"/>
            <ac:spMk id="42" creationId="{957A5AE3-8874-49BC-B4F8-2D8741B36734}"/>
          </ac:spMkLst>
        </pc:spChg>
        <pc:spChg chg="add del mod">
          <ac:chgData name="Yang, Shengming - ARS" userId="37bd5b25-7571-49cb-bfc8-588a18706c35" providerId="ADAL" clId="{4FA1546C-AAE4-4B89-86A7-C130A0B04C58}" dt="2022-06-15T16:01:52.419" v="4" actId="478"/>
          <ac:spMkLst>
            <pc:docMk/>
            <pc:sldMk cId="2589227480" sldId="293"/>
            <ac:spMk id="48" creationId="{86FC69F3-CE86-4970-8149-5F9FCBF09565}"/>
          </ac:spMkLst>
        </pc:spChg>
        <pc:spChg chg="add del mod">
          <ac:chgData name="Yang, Shengming - ARS" userId="37bd5b25-7571-49cb-bfc8-588a18706c35" providerId="ADAL" clId="{4FA1546C-AAE4-4B89-86A7-C130A0B04C58}" dt="2022-06-15T16:01:52.419" v="4" actId="478"/>
          <ac:spMkLst>
            <pc:docMk/>
            <pc:sldMk cId="2589227480" sldId="293"/>
            <ac:spMk id="49" creationId="{8A41AD58-439F-4E6E-98C6-D2BA1577B61F}"/>
          </ac:spMkLst>
        </pc:spChg>
        <pc:spChg chg="add del mod">
          <ac:chgData name="Yang, Shengming - ARS" userId="37bd5b25-7571-49cb-bfc8-588a18706c35" providerId="ADAL" clId="{4FA1546C-AAE4-4B89-86A7-C130A0B04C58}" dt="2022-06-15T16:01:52.419" v="4" actId="478"/>
          <ac:spMkLst>
            <pc:docMk/>
            <pc:sldMk cId="2589227480" sldId="293"/>
            <ac:spMk id="50" creationId="{ADFFE4B3-B7EF-4A46-8B82-41F4372C54E9}"/>
          </ac:spMkLst>
        </pc:spChg>
        <pc:spChg chg="add del mod">
          <ac:chgData name="Yang, Shengming - ARS" userId="37bd5b25-7571-49cb-bfc8-588a18706c35" providerId="ADAL" clId="{4FA1546C-AAE4-4B89-86A7-C130A0B04C58}" dt="2022-06-15T16:01:52.419" v="4" actId="478"/>
          <ac:spMkLst>
            <pc:docMk/>
            <pc:sldMk cId="2589227480" sldId="293"/>
            <ac:spMk id="51" creationId="{31372DFE-5F66-475D-93B2-320195D28869}"/>
          </ac:spMkLst>
        </pc:spChg>
        <pc:spChg chg="add del mod">
          <ac:chgData name="Yang, Shengming - ARS" userId="37bd5b25-7571-49cb-bfc8-588a18706c35" providerId="ADAL" clId="{4FA1546C-AAE4-4B89-86A7-C130A0B04C58}" dt="2022-06-15T16:01:52.419" v="4" actId="478"/>
          <ac:spMkLst>
            <pc:docMk/>
            <pc:sldMk cId="2589227480" sldId="293"/>
            <ac:spMk id="52" creationId="{92E955FC-CB3B-4BD9-9B14-86A68C61CDB6}"/>
          </ac:spMkLst>
        </pc:spChg>
        <pc:spChg chg="add del mod">
          <ac:chgData name="Yang, Shengming - ARS" userId="37bd5b25-7571-49cb-bfc8-588a18706c35" providerId="ADAL" clId="{4FA1546C-AAE4-4B89-86A7-C130A0B04C58}" dt="2022-06-15T16:01:52.419" v="4" actId="478"/>
          <ac:spMkLst>
            <pc:docMk/>
            <pc:sldMk cId="2589227480" sldId="293"/>
            <ac:spMk id="53" creationId="{F114F5FE-8C1A-4DE8-A834-8ECFE4BF1295}"/>
          </ac:spMkLst>
        </pc:spChg>
        <pc:spChg chg="add del mod">
          <ac:chgData name="Yang, Shengming - ARS" userId="37bd5b25-7571-49cb-bfc8-588a18706c35" providerId="ADAL" clId="{4FA1546C-AAE4-4B89-86A7-C130A0B04C58}" dt="2022-06-15T16:01:52.419" v="4" actId="478"/>
          <ac:spMkLst>
            <pc:docMk/>
            <pc:sldMk cId="2589227480" sldId="293"/>
            <ac:spMk id="54" creationId="{93702F0C-C1EA-44A1-BC76-1259F1BC1D8A}"/>
          </ac:spMkLst>
        </pc:spChg>
        <pc:spChg chg="add del mod">
          <ac:chgData name="Yang, Shengming - ARS" userId="37bd5b25-7571-49cb-bfc8-588a18706c35" providerId="ADAL" clId="{4FA1546C-AAE4-4B89-86A7-C130A0B04C58}" dt="2022-06-15T16:01:52.419" v="4" actId="478"/>
          <ac:spMkLst>
            <pc:docMk/>
            <pc:sldMk cId="2589227480" sldId="293"/>
            <ac:spMk id="55" creationId="{14171844-E816-49CD-8978-CF6ACC0FB495}"/>
          </ac:spMkLst>
        </pc:spChg>
        <pc:spChg chg="add del mod">
          <ac:chgData name="Yang, Shengming - ARS" userId="37bd5b25-7571-49cb-bfc8-588a18706c35" providerId="ADAL" clId="{4FA1546C-AAE4-4B89-86A7-C130A0B04C58}" dt="2022-06-15T16:01:52.419" v="4" actId="478"/>
          <ac:spMkLst>
            <pc:docMk/>
            <pc:sldMk cId="2589227480" sldId="293"/>
            <ac:spMk id="56" creationId="{CA752959-9631-4259-9F27-46B34C1D0B4E}"/>
          </ac:spMkLst>
        </pc:spChg>
        <pc:spChg chg="add del mod">
          <ac:chgData name="Yang, Shengming - ARS" userId="37bd5b25-7571-49cb-bfc8-588a18706c35" providerId="ADAL" clId="{4FA1546C-AAE4-4B89-86A7-C130A0B04C58}" dt="2022-06-15T16:01:52.419" v="4" actId="478"/>
          <ac:spMkLst>
            <pc:docMk/>
            <pc:sldMk cId="2589227480" sldId="293"/>
            <ac:spMk id="57" creationId="{5C2FB1B6-99BF-461E-BD70-B46ACB0003B0}"/>
          </ac:spMkLst>
        </pc:spChg>
        <pc:spChg chg="add del mod">
          <ac:chgData name="Yang, Shengming - ARS" userId="37bd5b25-7571-49cb-bfc8-588a18706c35" providerId="ADAL" clId="{4FA1546C-AAE4-4B89-86A7-C130A0B04C58}" dt="2022-06-15T16:01:52.419" v="4" actId="478"/>
          <ac:spMkLst>
            <pc:docMk/>
            <pc:sldMk cId="2589227480" sldId="293"/>
            <ac:spMk id="58" creationId="{397D35FC-E9B0-4F8C-8FEE-E2BEA6AEA2B3}"/>
          </ac:spMkLst>
        </pc:spChg>
        <pc:spChg chg="add del mod">
          <ac:chgData name="Yang, Shengming - ARS" userId="37bd5b25-7571-49cb-bfc8-588a18706c35" providerId="ADAL" clId="{4FA1546C-AAE4-4B89-86A7-C130A0B04C58}" dt="2022-06-15T16:01:52.419" v="4" actId="478"/>
          <ac:spMkLst>
            <pc:docMk/>
            <pc:sldMk cId="2589227480" sldId="293"/>
            <ac:spMk id="59" creationId="{77772138-1AA4-4807-822C-0E635B08C6E4}"/>
          </ac:spMkLst>
        </pc:spChg>
        <pc:spChg chg="add del mod">
          <ac:chgData name="Yang, Shengming - ARS" userId="37bd5b25-7571-49cb-bfc8-588a18706c35" providerId="ADAL" clId="{4FA1546C-AAE4-4B89-86A7-C130A0B04C58}" dt="2022-06-15T16:01:52.419" v="4" actId="478"/>
          <ac:spMkLst>
            <pc:docMk/>
            <pc:sldMk cId="2589227480" sldId="293"/>
            <ac:spMk id="60" creationId="{FD222D82-BD6C-4D11-8467-B8B55B57C8CD}"/>
          </ac:spMkLst>
        </pc:spChg>
        <pc:spChg chg="add del mod">
          <ac:chgData name="Yang, Shengming - ARS" userId="37bd5b25-7571-49cb-bfc8-588a18706c35" providerId="ADAL" clId="{4FA1546C-AAE4-4B89-86A7-C130A0B04C58}" dt="2022-06-15T16:01:52.419" v="4" actId="478"/>
          <ac:spMkLst>
            <pc:docMk/>
            <pc:sldMk cId="2589227480" sldId="293"/>
            <ac:spMk id="61" creationId="{EBC5CF5C-DF2D-4D08-AACA-323CF150E046}"/>
          </ac:spMkLst>
        </pc:spChg>
        <pc:spChg chg="add del mod">
          <ac:chgData name="Yang, Shengming - ARS" userId="37bd5b25-7571-49cb-bfc8-588a18706c35" providerId="ADAL" clId="{4FA1546C-AAE4-4B89-86A7-C130A0B04C58}" dt="2022-06-15T16:01:52.419" v="4" actId="478"/>
          <ac:spMkLst>
            <pc:docMk/>
            <pc:sldMk cId="2589227480" sldId="293"/>
            <ac:spMk id="62" creationId="{2472AA52-ADFA-4D0A-A1E5-4CDA2170412A}"/>
          </ac:spMkLst>
        </pc:spChg>
        <pc:spChg chg="add del mod">
          <ac:chgData name="Yang, Shengming - ARS" userId="37bd5b25-7571-49cb-bfc8-588a18706c35" providerId="ADAL" clId="{4FA1546C-AAE4-4B89-86A7-C130A0B04C58}" dt="2022-06-15T16:01:52.419" v="4" actId="478"/>
          <ac:spMkLst>
            <pc:docMk/>
            <pc:sldMk cId="2589227480" sldId="293"/>
            <ac:spMk id="63" creationId="{DC9CBBFA-C7D6-4E3F-9128-AF67187F54FC}"/>
          </ac:spMkLst>
        </pc:spChg>
        <pc:spChg chg="add del mod">
          <ac:chgData name="Yang, Shengming - ARS" userId="37bd5b25-7571-49cb-bfc8-588a18706c35" providerId="ADAL" clId="{4FA1546C-AAE4-4B89-86A7-C130A0B04C58}" dt="2022-06-15T16:01:52.419" v="4" actId="478"/>
          <ac:spMkLst>
            <pc:docMk/>
            <pc:sldMk cId="2589227480" sldId="293"/>
            <ac:spMk id="65" creationId="{2227E432-AB81-4802-841A-7AFA4F00BFB5}"/>
          </ac:spMkLst>
        </pc:spChg>
        <pc:spChg chg="add del mod">
          <ac:chgData name="Yang, Shengming - ARS" userId="37bd5b25-7571-49cb-bfc8-588a18706c35" providerId="ADAL" clId="{4FA1546C-AAE4-4B89-86A7-C130A0B04C58}" dt="2022-06-15T16:01:52.419" v="4" actId="478"/>
          <ac:spMkLst>
            <pc:docMk/>
            <pc:sldMk cId="2589227480" sldId="293"/>
            <ac:spMk id="66" creationId="{75761403-6550-453C-94DB-25A2C7DBEEC7}"/>
          </ac:spMkLst>
        </pc:spChg>
        <pc:spChg chg="add del mod">
          <ac:chgData name="Yang, Shengming - ARS" userId="37bd5b25-7571-49cb-bfc8-588a18706c35" providerId="ADAL" clId="{4FA1546C-AAE4-4B89-86A7-C130A0B04C58}" dt="2022-06-15T16:01:52.419" v="4" actId="478"/>
          <ac:spMkLst>
            <pc:docMk/>
            <pc:sldMk cId="2589227480" sldId="293"/>
            <ac:spMk id="67" creationId="{03A8CBDD-1AB5-4E91-B908-1E43A419E858}"/>
          </ac:spMkLst>
        </pc:spChg>
        <pc:spChg chg="add del mod">
          <ac:chgData name="Yang, Shengming - ARS" userId="37bd5b25-7571-49cb-bfc8-588a18706c35" providerId="ADAL" clId="{4FA1546C-AAE4-4B89-86A7-C130A0B04C58}" dt="2022-06-15T16:01:52.419" v="4" actId="478"/>
          <ac:spMkLst>
            <pc:docMk/>
            <pc:sldMk cId="2589227480" sldId="293"/>
            <ac:spMk id="68" creationId="{AF30F94E-8A0A-4A60-A5DA-F874BF41D5E0}"/>
          </ac:spMkLst>
        </pc:spChg>
        <pc:spChg chg="add del mod">
          <ac:chgData name="Yang, Shengming - ARS" userId="37bd5b25-7571-49cb-bfc8-588a18706c35" providerId="ADAL" clId="{4FA1546C-AAE4-4B89-86A7-C130A0B04C58}" dt="2022-06-15T16:01:52.419" v="4" actId="478"/>
          <ac:spMkLst>
            <pc:docMk/>
            <pc:sldMk cId="2589227480" sldId="293"/>
            <ac:spMk id="69" creationId="{D00021FA-06C8-41E0-B921-34DE585F056D}"/>
          </ac:spMkLst>
        </pc:spChg>
        <pc:spChg chg="add del mod">
          <ac:chgData name="Yang, Shengming - ARS" userId="37bd5b25-7571-49cb-bfc8-588a18706c35" providerId="ADAL" clId="{4FA1546C-AAE4-4B89-86A7-C130A0B04C58}" dt="2022-06-15T16:01:52.419" v="4" actId="478"/>
          <ac:spMkLst>
            <pc:docMk/>
            <pc:sldMk cId="2589227480" sldId="293"/>
            <ac:spMk id="70" creationId="{9A1E74CC-12DC-471F-871D-E2C45D95FE5B}"/>
          </ac:spMkLst>
        </pc:spChg>
        <pc:spChg chg="add del mod">
          <ac:chgData name="Yang, Shengming - ARS" userId="37bd5b25-7571-49cb-bfc8-588a18706c35" providerId="ADAL" clId="{4FA1546C-AAE4-4B89-86A7-C130A0B04C58}" dt="2022-06-15T16:01:52.419" v="4" actId="478"/>
          <ac:spMkLst>
            <pc:docMk/>
            <pc:sldMk cId="2589227480" sldId="293"/>
            <ac:spMk id="71" creationId="{1A7F613B-8A38-4B7D-8DA5-B5C812789E62}"/>
          </ac:spMkLst>
        </pc:spChg>
        <pc:spChg chg="add del mod">
          <ac:chgData name="Yang, Shengming - ARS" userId="37bd5b25-7571-49cb-bfc8-588a18706c35" providerId="ADAL" clId="{4FA1546C-AAE4-4B89-86A7-C130A0B04C58}" dt="2022-06-15T16:01:52.419" v="4" actId="478"/>
          <ac:spMkLst>
            <pc:docMk/>
            <pc:sldMk cId="2589227480" sldId="293"/>
            <ac:spMk id="72" creationId="{9D0041F1-1089-46DA-BB85-4A571F96FD24}"/>
          </ac:spMkLst>
        </pc:spChg>
        <pc:spChg chg="add del mod">
          <ac:chgData name="Yang, Shengming - ARS" userId="37bd5b25-7571-49cb-bfc8-588a18706c35" providerId="ADAL" clId="{4FA1546C-AAE4-4B89-86A7-C130A0B04C58}" dt="2022-06-15T16:01:52.419" v="4" actId="478"/>
          <ac:spMkLst>
            <pc:docMk/>
            <pc:sldMk cId="2589227480" sldId="293"/>
            <ac:spMk id="73" creationId="{906159A5-0E52-4D5D-B30E-6DDB2D2250DE}"/>
          </ac:spMkLst>
        </pc:spChg>
        <pc:spChg chg="add del mod">
          <ac:chgData name="Yang, Shengming - ARS" userId="37bd5b25-7571-49cb-bfc8-588a18706c35" providerId="ADAL" clId="{4FA1546C-AAE4-4B89-86A7-C130A0B04C58}" dt="2022-06-15T16:01:52.419" v="4" actId="478"/>
          <ac:spMkLst>
            <pc:docMk/>
            <pc:sldMk cId="2589227480" sldId="293"/>
            <ac:spMk id="74" creationId="{BCFBD326-A244-46BE-9D8E-89A5AA070A07}"/>
          </ac:spMkLst>
        </pc:spChg>
        <pc:spChg chg="add del mod">
          <ac:chgData name="Yang, Shengming - ARS" userId="37bd5b25-7571-49cb-bfc8-588a18706c35" providerId="ADAL" clId="{4FA1546C-AAE4-4B89-86A7-C130A0B04C58}" dt="2022-06-15T16:01:52.419" v="4" actId="478"/>
          <ac:spMkLst>
            <pc:docMk/>
            <pc:sldMk cId="2589227480" sldId="293"/>
            <ac:spMk id="75" creationId="{34A065B6-C47B-467B-9C15-59AE17D1376C}"/>
          </ac:spMkLst>
        </pc:spChg>
        <pc:spChg chg="add del mod">
          <ac:chgData name="Yang, Shengming - ARS" userId="37bd5b25-7571-49cb-bfc8-588a18706c35" providerId="ADAL" clId="{4FA1546C-AAE4-4B89-86A7-C130A0B04C58}" dt="2022-06-15T16:01:52.419" v="4" actId="478"/>
          <ac:spMkLst>
            <pc:docMk/>
            <pc:sldMk cId="2589227480" sldId="293"/>
            <ac:spMk id="76" creationId="{47B10823-C113-457C-9CE3-0F1B9AD8891C}"/>
          </ac:spMkLst>
        </pc:spChg>
        <pc:spChg chg="add del mod">
          <ac:chgData name="Yang, Shengming - ARS" userId="37bd5b25-7571-49cb-bfc8-588a18706c35" providerId="ADAL" clId="{4FA1546C-AAE4-4B89-86A7-C130A0B04C58}" dt="2022-06-15T16:01:52.419" v="4" actId="478"/>
          <ac:spMkLst>
            <pc:docMk/>
            <pc:sldMk cId="2589227480" sldId="293"/>
            <ac:spMk id="77" creationId="{5B7B8372-0F93-4EBD-B9AC-F1DE93ACAAB5}"/>
          </ac:spMkLst>
        </pc:spChg>
        <pc:spChg chg="add del mod">
          <ac:chgData name="Yang, Shengming - ARS" userId="37bd5b25-7571-49cb-bfc8-588a18706c35" providerId="ADAL" clId="{4FA1546C-AAE4-4B89-86A7-C130A0B04C58}" dt="2022-06-15T16:01:52.419" v="4" actId="478"/>
          <ac:spMkLst>
            <pc:docMk/>
            <pc:sldMk cId="2589227480" sldId="293"/>
            <ac:spMk id="78" creationId="{F0CA6205-6F0B-4B12-B8B4-3AA5797346FE}"/>
          </ac:spMkLst>
        </pc:spChg>
        <pc:spChg chg="add del mod">
          <ac:chgData name="Yang, Shengming - ARS" userId="37bd5b25-7571-49cb-bfc8-588a18706c35" providerId="ADAL" clId="{4FA1546C-AAE4-4B89-86A7-C130A0B04C58}" dt="2022-06-15T16:01:52.419" v="4" actId="478"/>
          <ac:spMkLst>
            <pc:docMk/>
            <pc:sldMk cId="2589227480" sldId="293"/>
            <ac:spMk id="79" creationId="{9270A7C4-0CE7-40CB-B54C-D9A4062D1738}"/>
          </ac:spMkLst>
        </pc:spChg>
        <pc:spChg chg="add del mod">
          <ac:chgData name="Yang, Shengming - ARS" userId="37bd5b25-7571-49cb-bfc8-588a18706c35" providerId="ADAL" clId="{4FA1546C-AAE4-4B89-86A7-C130A0B04C58}" dt="2022-06-15T16:01:52.419" v="4" actId="478"/>
          <ac:spMkLst>
            <pc:docMk/>
            <pc:sldMk cId="2589227480" sldId="293"/>
            <ac:spMk id="80" creationId="{5C76013D-6D40-4F4D-9D91-B3A63F308F12}"/>
          </ac:spMkLst>
        </pc:spChg>
        <pc:spChg chg="add del mod">
          <ac:chgData name="Yang, Shengming - ARS" userId="37bd5b25-7571-49cb-bfc8-588a18706c35" providerId="ADAL" clId="{4FA1546C-AAE4-4B89-86A7-C130A0B04C58}" dt="2022-06-15T16:01:52.419" v="4" actId="478"/>
          <ac:spMkLst>
            <pc:docMk/>
            <pc:sldMk cId="2589227480" sldId="293"/>
            <ac:spMk id="81" creationId="{B2F896F9-82D8-46CD-9354-84F4F1DA1E2E}"/>
          </ac:spMkLst>
        </pc:spChg>
        <pc:spChg chg="add del mod">
          <ac:chgData name="Yang, Shengming - ARS" userId="37bd5b25-7571-49cb-bfc8-588a18706c35" providerId="ADAL" clId="{4FA1546C-AAE4-4B89-86A7-C130A0B04C58}" dt="2022-06-15T16:01:52.419" v="4" actId="478"/>
          <ac:spMkLst>
            <pc:docMk/>
            <pc:sldMk cId="2589227480" sldId="293"/>
            <ac:spMk id="82" creationId="{49727D5A-6C8E-46F4-A0A0-6B41FC095FD9}"/>
          </ac:spMkLst>
        </pc:spChg>
        <pc:spChg chg="add del mod">
          <ac:chgData name="Yang, Shengming - ARS" userId="37bd5b25-7571-49cb-bfc8-588a18706c35" providerId="ADAL" clId="{4FA1546C-AAE4-4B89-86A7-C130A0B04C58}" dt="2022-06-15T16:01:52.419" v="4" actId="478"/>
          <ac:spMkLst>
            <pc:docMk/>
            <pc:sldMk cId="2589227480" sldId="293"/>
            <ac:spMk id="83" creationId="{10C8632E-0F19-4F92-AE47-DB4166399B9B}"/>
          </ac:spMkLst>
        </pc:spChg>
        <pc:spChg chg="add del mod">
          <ac:chgData name="Yang, Shengming - ARS" userId="37bd5b25-7571-49cb-bfc8-588a18706c35" providerId="ADAL" clId="{4FA1546C-AAE4-4B89-86A7-C130A0B04C58}" dt="2022-06-15T16:01:52.419" v="4" actId="478"/>
          <ac:spMkLst>
            <pc:docMk/>
            <pc:sldMk cId="2589227480" sldId="293"/>
            <ac:spMk id="84" creationId="{F9B7301C-4F6B-42DF-A4C1-34D07224D51B}"/>
          </ac:spMkLst>
        </pc:spChg>
        <pc:spChg chg="add mod">
          <ac:chgData name="Yang, Shengming - ARS" userId="37bd5b25-7571-49cb-bfc8-588a18706c35" providerId="ADAL" clId="{4FA1546C-AAE4-4B89-86A7-C130A0B04C58}" dt="2022-06-15T18:46:04.811" v="1832" actId="1036"/>
          <ac:spMkLst>
            <pc:docMk/>
            <pc:sldMk cId="2589227480" sldId="293"/>
            <ac:spMk id="94" creationId="{5A2AA21E-FE5D-476C-8E51-F3BFE7ABB020}"/>
          </ac:spMkLst>
        </pc:spChg>
        <pc:spChg chg="add mod">
          <ac:chgData name="Yang, Shengming - ARS" userId="37bd5b25-7571-49cb-bfc8-588a18706c35" providerId="ADAL" clId="{4FA1546C-AAE4-4B89-86A7-C130A0B04C58}" dt="2022-06-15T19:39:53.163" v="2571" actId="20577"/>
          <ac:spMkLst>
            <pc:docMk/>
            <pc:sldMk cId="2589227480" sldId="293"/>
            <ac:spMk id="95" creationId="{E0628C6F-7A08-4A08-BFEC-6B6405268387}"/>
          </ac:spMkLst>
        </pc:spChg>
        <pc:cxnChg chg="add mod">
          <ac:chgData name="Yang, Shengming - ARS" userId="37bd5b25-7571-49cb-bfc8-588a18706c35" providerId="ADAL" clId="{4FA1546C-AAE4-4B89-86A7-C130A0B04C58}" dt="2022-06-15T18:46:04.811" v="1832" actId="1036"/>
          <ac:cxnSpMkLst>
            <pc:docMk/>
            <pc:sldMk cId="2589227480" sldId="293"/>
            <ac:cxnSpMk id="4" creationId="{4D125AA6-BA27-490B-882C-B9EA0E1E05CD}"/>
          </ac:cxnSpMkLst>
        </pc:cxnChg>
        <pc:cxnChg chg="add mod">
          <ac:chgData name="Yang, Shengming - ARS" userId="37bd5b25-7571-49cb-bfc8-588a18706c35" providerId="ADAL" clId="{4FA1546C-AAE4-4B89-86A7-C130A0B04C58}" dt="2022-06-15T18:46:04.811" v="1832" actId="1036"/>
          <ac:cxnSpMkLst>
            <pc:docMk/>
            <pc:sldMk cId="2589227480" sldId="293"/>
            <ac:cxnSpMk id="5" creationId="{F9A1E287-8B50-4D93-9955-9708520C546D}"/>
          </ac:cxnSpMkLst>
        </pc:cxnChg>
        <pc:cxnChg chg="add mod">
          <ac:chgData name="Yang, Shengming - ARS" userId="37bd5b25-7571-49cb-bfc8-588a18706c35" providerId="ADAL" clId="{4FA1546C-AAE4-4B89-86A7-C130A0B04C58}" dt="2022-06-15T18:46:04.811" v="1832" actId="1036"/>
          <ac:cxnSpMkLst>
            <pc:docMk/>
            <pc:sldMk cId="2589227480" sldId="293"/>
            <ac:cxnSpMk id="22" creationId="{B9569366-2062-4C0E-9A57-9DFBDDFB9384}"/>
          </ac:cxnSpMkLst>
        </pc:cxnChg>
        <pc:cxnChg chg="add mod">
          <ac:chgData name="Yang, Shengming - ARS" userId="37bd5b25-7571-49cb-bfc8-588a18706c35" providerId="ADAL" clId="{4FA1546C-AAE4-4B89-86A7-C130A0B04C58}" dt="2022-06-15T18:46:04.811" v="1832" actId="1036"/>
          <ac:cxnSpMkLst>
            <pc:docMk/>
            <pc:sldMk cId="2589227480" sldId="293"/>
            <ac:cxnSpMk id="43" creationId="{95A2589F-2A7F-4DB5-A175-05F46218F674}"/>
          </ac:cxnSpMkLst>
        </pc:cxnChg>
        <pc:cxnChg chg="add mod">
          <ac:chgData name="Yang, Shengming - ARS" userId="37bd5b25-7571-49cb-bfc8-588a18706c35" providerId="ADAL" clId="{4FA1546C-AAE4-4B89-86A7-C130A0B04C58}" dt="2022-06-15T18:46:04.811" v="1832" actId="1036"/>
          <ac:cxnSpMkLst>
            <pc:docMk/>
            <pc:sldMk cId="2589227480" sldId="293"/>
            <ac:cxnSpMk id="44" creationId="{7DD600D4-68B3-48BF-B410-127EA5BAC6AE}"/>
          </ac:cxnSpMkLst>
        </pc:cxnChg>
        <pc:cxnChg chg="add mod">
          <ac:chgData name="Yang, Shengming - ARS" userId="37bd5b25-7571-49cb-bfc8-588a18706c35" providerId="ADAL" clId="{4FA1546C-AAE4-4B89-86A7-C130A0B04C58}" dt="2022-06-15T18:46:04.811" v="1832" actId="1036"/>
          <ac:cxnSpMkLst>
            <pc:docMk/>
            <pc:sldMk cId="2589227480" sldId="293"/>
            <ac:cxnSpMk id="45" creationId="{06967838-11B7-4882-9EBF-EA9919F60218}"/>
          </ac:cxnSpMkLst>
        </pc:cxnChg>
        <pc:cxnChg chg="add del mod">
          <ac:chgData name="Yang, Shengming - ARS" userId="37bd5b25-7571-49cb-bfc8-588a18706c35" providerId="ADAL" clId="{4FA1546C-AAE4-4B89-86A7-C130A0B04C58}" dt="2022-06-15T16:01:52.419" v="4" actId="478"/>
          <ac:cxnSpMkLst>
            <pc:docMk/>
            <pc:sldMk cId="2589227480" sldId="293"/>
            <ac:cxnSpMk id="46" creationId="{9BC78013-82C4-4C4B-86C3-1863A9A7A8CD}"/>
          </ac:cxnSpMkLst>
        </pc:cxnChg>
        <pc:cxnChg chg="add del mod">
          <ac:chgData name="Yang, Shengming - ARS" userId="37bd5b25-7571-49cb-bfc8-588a18706c35" providerId="ADAL" clId="{4FA1546C-AAE4-4B89-86A7-C130A0B04C58}" dt="2022-06-15T16:01:52.419" v="4" actId="478"/>
          <ac:cxnSpMkLst>
            <pc:docMk/>
            <pc:sldMk cId="2589227480" sldId="293"/>
            <ac:cxnSpMk id="47" creationId="{6FED00B0-8DE9-4382-9CC5-D89FB48B7358}"/>
          </ac:cxnSpMkLst>
        </pc:cxnChg>
        <pc:cxnChg chg="add del mod">
          <ac:chgData name="Yang, Shengming - ARS" userId="37bd5b25-7571-49cb-bfc8-588a18706c35" providerId="ADAL" clId="{4FA1546C-AAE4-4B89-86A7-C130A0B04C58}" dt="2022-06-15T16:01:52.419" v="4" actId="478"/>
          <ac:cxnSpMkLst>
            <pc:docMk/>
            <pc:sldMk cId="2589227480" sldId="293"/>
            <ac:cxnSpMk id="64" creationId="{B3E0BB8F-A4BC-45BD-ACC0-C62DAD9D79C9}"/>
          </ac:cxnSpMkLst>
        </pc:cxnChg>
        <pc:cxnChg chg="add del mod">
          <ac:chgData name="Yang, Shengming - ARS" userId="37bd5b25-7571-49cb-bfc8-588a18706c35" providerId="ADAL" clId="{4FA1546C-AAE4-4B89-86A7-C130A0B04C58}" dt="2022-06-15T16:01:52.419" v="4" actId="478"/>
          <ac:cxnSpMkLst>
            <pc:docMk/>
            <pc:sldMk cId="2589227480" sldId="293"/>
            <ac:cxnSpMk id="85" creationId="{C0FC974A-1168-46FA-99BD-E3D94E2E9E4C}"/>
          </ac:cxnSpMkLst>
        </pc:cxnChg>
        <pc:cxnChg chg="add del mod">
          <ac:chgData name="Yang, Shengming - ARS" userId="37bd5b25-7571-49cb-bfc8-588a18706c35" providerId="ADAL" clId="{4FA1546C-AAE4-4B89-86A7-C130A0B04C58}" dt="2022-06-15T16:01:52.419" v="4" actId="478"/>
          <ac:cxnSpMkLst>
            <pc:docMk/>
            <pc:sldMk cId="2589227480" sldId="293"/>
            <ac:cxnSpMk id="86" creationId="{D4340759-3E87-44F7-A798-CBAE84A676A7}"/>
          </ac:cxnSpMkLst>
        </pc:cxnChg>
        <pc:cxnChg chg="add del mod">
          <ac:chgData name="Yang, Shengming - ARS" userId="37bd5b25-7571-49cb-bfc8-588a18706c35" providerId="ADAL" clId="{4FA1546C-AAE4-4B89-86A7-C130A0B04C58}" dt="2022-06-15T16:01:52.419" v="4" actId="478"/>
          <ac:cxnSpMkLst>
            <pc:docMk/>
            <pc:sldMk cId="2589227480" sldId="293"/>
            <ac:cxnSpMk id="87" creationId="{BDC0E411-130A-4584-9D52-F2DDCC505B61}"/>
          </ac:cxnSpMkLst>
        </pc:cxnChg>
      </pc:sldChg>
      <pc:sldChg chg="addSp delSp modSp new mod modNotesTx">
        <pc:chgData name="Yang, Shengming - ARS" userId="37bd5b25-7571-49cb-bfc8-588a18706c35" providerId="ADAL" clId="{4FA1546C-AAE4-4B89-86A7-C130A0B04C58}" dt="2022-06-15T20:35:37.457" v="2963" actId="1076"/>
        <pc:sldMkLst>
          <pc:docMk/>
          <pc:sldMk cId="3317137651" sldId="294"/>
        </pc:sldMkLst>
        <pc:spChg chg="del">
          <ac:chgData name="Yang, Shengming - ARS" userId="37bd5b25-7571-49cb-bfc8-588a18706c35" providerId="ADAL" clId="{4FA1546C-AAE4-4B89-86A7-C130A0B04C58}" dt="2022-06-15T18:59:28.233" v="1834" actId="478"/>
          <ac:spMkLst>
            <pc:docMk/>
            <pc:sldMk cId="3317137651" sldId="294"/>
            <ac:spMk id="2" creationId="{D93DD3FC-218A-4D80-BF85-1B776F2F1D37}"/>
          </ac:spMkLst>
        </pc:spChg>
        <pc:spChg chg="del">
          <ac:chgData name="Yang, Shengming - ARS" userId="37bd5b25-7571-49cb-bfc8-588a18706c35" providerId="ADAL" clId="{4FA1546C-AAE4-4B89-86A7-C130A0B04C58}" dt="2022-06-15T18:59:28.233" v="1834" actId="478"/>
          <ac:spMkLst>
            <pc:docMk/>
            <pc:sldMk cId="3317137651" sldId="294"/>
            <ac:spMk id="3" creationId="{D6409E35-13EF-414A-A997-18D184EBA402}"/>
          </ac:spMkLst>
        </pc:spChg>
        <pc:spChg chg="add mod">
          <ac:chgData name="Yang, Shengming - ARS" userId="37bd5b25-7571-49cb-bfc8-588a18706c35" providerId="ADAL" clId="{4FA1546C-AAE4-4B89-86A7-C130A0B04C58}" dt="2022-06-15T20:35:37.457" v="2963" actId="1076"/>
          <ac:spMkLst>
            <pc:docMk/>
            <pc:sldMk cId="3317137651" sldId="294"/>
            <ac:spMk id="8" creationId="{E1C32CE9-6DE9-43B3-83FA-0B29EACDF6C5}"/>
          </ac:spMkLst>
        </pc:spChg>
        <pc:spChg chg="add mod">
          <ac:chgData name="Yang, Shengming - ARS" userId="37bd5b25-7571-49cb-bfc8-588a18706c35" providerId="ADAL" clId="{4FA1546C-AAE4-4B89-86A7-C130A0B04C58}" dt="2022-06-15T20:34:58.986" v="2962" actId="1076"/>
          <ac:spMkLst>
            <pc:docMk/>
            <pc:sldMk cId="3317137651" sldId="294"/>
            <ac:spMk id="10" creationId="{8FCFBE82-350D-4F58-8E39-EFDE2BA53F88}"/>
          </ac:spMkLst>
        </pc:spChg>
        <pc:spChg chg="add mod">
          <ac:chgData name="Yang, Shengming - ARS" userId="37bd5b25-7571-49cb-bfc8-588a18706c35" providerId="ADAL" clId="{4FA1546C-AAE4-4B89-86A7-C130A0B04C58}" dt="2022-06-15T20:34:58.986" v="2962" actId="1076"/>
          <ac:spMkLst>
            <pc:docMk/>
            <pc:sldMk cId="3317137651" sldId="294"/>
            <ac:spMk id="11" creationId="{34C67E29-790D-4845-A2EE-C9DBF6772E22}"/>
          </ac:spMkLst>
        </pc:spChg>
        <pc:spChg chg="add mod">
          <ac:chgData name="Yang, Shengming - ARS" userId="37bd5b25-7571-49cb-bfc8-588a18706c35" providerId="ADAL" clId="{4FA1546C-AAE4-4B89-86A7-C130A0B04C58}" dt="2022-06-15T20:34:58.986" v="2962" actId="1076"/>
          <ac:spMkLst>
            <pc:docMk/>
            <pc:sldMk cId="3317137651" sldId="294"/>
            <ac:spMk id="12" creationId="{E375B6E2-2A71-446E-ACF4-13C440C5CA17}"/>
          </ac:spMkLst>
        </pc:spChg>
        <pc:spChg chg="add mod">
          <ac:chgData name="Yang, Shengming - ARS" userId="37bd5b25-7571-49cb-bfc8-588a18706c35" providerId="ADAL" clId="{4FA1546C-AAE4-4B89-86A7-C130A0B04C58}" dt="2022-06-15T20:34:58.986" v="2962" actId="1076"/>
          <ac:spMkLst>
            <pc:docMk/>
            <pc:sldMk cId="3317137651" sldId="294"/>
            <ac:spMk id="13" creationId="{113CDD8D-230F-4321-86DD-AF3C302A5CF7}"/>
          </ac:spMkLst>
        </pc:spChg>
        <pc:spChg chg="add mod">
          <ac:chgData name="Yang, Shengming - ARS" userId="37bd5b25-7571-49cb-bfc8-588a18706c35" providerId="ADAL" clId="{4FA1546C-AAE4-4B89-86A7-C130A0B04C58}" dt="2022-06-15T20:34:58.986" v="2962" actId="1076"/>
          <ac:spMkLst>
            <pc:docMk/>
            <pc:sldMk cId="3317137651" sldId="294"/>
            <ac:spMk id="14" creationId="{25230A61-9A24-49F4-AD94-75699FAC69FE}"/>
          </ac:spMkLst>
        </pc:spChg>
        <pc:spChg chg="add mod">
          <ac:chgData name="Yang, Shengming - ARS" userId="37bd5b25-7571-49cb-bfc8-588a18706c35" providerId="ADAL" clId="{4FA1546C-AAE4-4B89-86A7-C130A0B04C58}" dt="2022-06-15T20:34:58.986" v="2962" actId="1076"/>
          <ac:spMkLst>
            <pc:docMk/>
            <pc:sldMk cId="3317137651" sldId="294"/>
            <ac:spMk id="15" creationId="{E2A3D281-D9B9-4359-AD99-7A12CFFC2469}"/>
          </ac:spMkLst>
        </pc:spChg>
        <pc:spChg chg="add mod">
          <ac:chgData name="Yang, Shengming - ARS" userId="37bd5b25-7571-49cb-bfc8-588a18706c35" providerId="ADAL" clId="{4FA1546C-AAE4-4B89-86A7-C130A0B04C58}" dt="2022-06-15T20:34:58.986" v="2962" actId="1076"/>
          <ac:spMkLst>
            <pc:docMk/>
            <pc:sldMk cId="3317137651" sldId="294"/>
            <ac:spMk id="16" creationId="{70EA226E-8A1D-4203-9757-3F9D004BBDDE}"/>
          </ac:spMkLst>
        </pc:spChg>
        <pc:spChg chg="add mod">
          <ac:chgData name="Yang, Shengming - ARS" userId="37bd5b25-7571-49cb-bfc8-588a18706c35" providerId="ADAL" clId="{4FA1546C-AAE4-4B89-86A7-C130A0B04C58}" dt="2022-06-15T20:34:58.986" v="2962" actId="1076"/>
          <ac:spMkLst>
            <pc:docMk/>
            <pc:sldMk cId="3317137651" sldId="294"/>
            <ac:spMk id="17" creationId="{EE699132-1107-4D9A-8C5F-AAABD6A677AC}"/>
          </ac:spMkLst>
        </pc:spChg>
        <pc:spChg chg="add mod">
          <ac:chgData name="Yang, Shengming - ARS" userId="37bd5b25-7571-49cb-bfc8-588a18706c35" providerId="ADAL" clId="{4FA1546C-AAE4-4B89-86A7-C130A0B04C58}" dt="2022-06-15T20:34:58.986" v="2962" actId="1076"/>
          <ac:spMkLst>
            <pc:docMk/>
            <pc:sldMk cId="3317137651" sldId="294"/>
            <ac:spMk id="19" creationId="{897F1763-2F2C-43BD-95B4-9F92881CFA6C}"/>
          </ac:spMkLst>
        </pc:spChg>
        <pc:spChg chg="add mod">
          <ac:chgData name="Yang, Shengming - ARS" userId="37bd5b25-7571-49cb-bfc8-588a18706c35" providerId="ADAL" clId="{4FA1546C-AAE4-4B89-86A7-C130A0B04C58}" dt="2022-06-15T20:34:58.986" v="2962" actId="1076"/>
          <ac:spMkLst>
            <pc:docMk/>
            <pc:sldMk cId="3317137651" sldId="294"/>
            <ac:spMk id="20" creationId="{790F631B-AFC4-4DFC-900C-1772E36890D0}"/>
          </ac:spMkLst>
        </pc:spChg>
        <pc:spChg chg="add mod">
          <ac:chgData name="Yang, Shengming - ARS" userId="37bd5b25-7571-49cb-bfc8-588a18706c35" providerId="ADAL" clId="{4FA1546C-AAE4-4B89-86A7-C130A0B04C58}" dt="2022-06-15T20:34:58.986" v="2962" actId="1076"/>
          <ac:spMkLst>
            <pc:docMk/>
            <pc:sldMk cId="3317137651" sldId="294"/>
            <ac:spMk id="21" creationId="{CC392E81-18E2-47BF-8982-80C86BA0D11A}"/>
          </ac:spMkLst>
        </pc:spChg>
        <pc:spChg chg="add mod">
          <ac:chgData name="Yang, Shengming - ARS" userId="37bd5b25-7571-49cb-bfc8-588a18706c35" providerId="ADAL" clId="{4FA1546C-AAE4-4B89-86A7-C130A0B04C58}" dt="2022-06-15T20:34:58.986" v="2962" actId="1076"/>
          <ac:spMkLst>
            <pc:docMk/>
            <pc:sldMk cId="3317137651" sldId="294"/>
            <ac:spMk id="22" creationId="{6E84DDA2-F23D-4E5E-B300-40E72399F14F}"/>
          </ac:spMkLst>
        </pc:spChg>
        <pc:graphicFrameChg chg="add mod">
          <ac:chgData name="Yang, Shengming - ARS" userId="37bd5b25-7571-49cb-bfc8-588a18706c35" providerId="ADAL" clId="{4FA1546C-AAE4-4B89-86A7-C130A0B04C58}" dt="2022-06-15T20:34:58.986" v="2962" actId="1076"/>
          <ac:graphicFrameMkLst>
            <pc:docMk/>
            <pc:sldMk cId="3317137651" sldId="294"/>
            <ac:graphicFrameMk id="4" creationId="{1126EB88-28CD-4B9E-99FD-9095D9E1C2DD}"/>
          </ac:graphicFrameMkLst>
        </pc:graphicFrameChg>
        <pc:graphicFrameChg chg="add mod">
          <ac:chgData name="Yang, Shengming - ARS" userId="37bd5b25-7571-49cb-bfc8-588a18706c35" providerId="ADAL" clId="{4FA1546C-AAE4-4B89-86A7-C130A0B04C58}" dt="2022-06-15T20:34:58.986" v="2962" actId="1076"/>
          <ac:graphicFrameMkLst>
            <pc:docMk/>
            <pc:sldMk cId="3317137651" sldId="294"/>
            <ac:graphicFrameMk id="5" creationId="{8461EFB3-125F-4A8C-9BB9-15E525D07071}"/>
          </ac:graphicFrameMkLst>
        </pc:graphicFrameChg>
        <pc:graphicFrameChg chg="add mod">
          <ac:chgData name="Yang, Shengming - ARS" userId="37bd5b25-7571-49cb-bfc8-588a18706c35" providerId="ADAL" clId="{4FA1546C-AAE4-4B89-86A7-C130A0B04C58}" dt="2022-06-15T20:34:58.986" v="2962" actId="1076"/>
          <ac:graphicFrameMkLst>
            <pc:docMk/>
            <pc:sldMk cId="3317137651" sldId="294"/>
            <ac:graphicFrameMk id="6" creationId="{B8BF5A40-FB34-4E4C-AF2E-4E34FBB6C309}"/>
          </ac:graphicFrameMkLst>
        </pc:graphicFrameChg>
        <pc:graphicFrameChg chg="add mod">
          <ac:chgData name="Yang, Shengming - ARS" userId="37bd5b25-7571-49cb-bfc8-588a18706c35" providerId="ADAL" clId="{4FA1546C-AAE4-4B89-86A7-C130A0B04C58}" dt="2022-06-15T20:34:58.986" v="2962" actId="1076"/>
          <ac:graphicFrameMkLst>
            <pc:docMk/>
            <pc:sldMk cId="3317137651" sldId="294"/>
            <ac:graphicFrameMk id="7" creationId="{8DFE45D0-B106-467B-B65C-E3F13AEB97D3}"/>
          </ac:graphicFrameMkLst>
        </pc:graphicFrameChg>
      </pc:sldChg>
      <pc:sldChg chg="addSp delSp modSp new mod modNotesTx">
        <pc:chgData name="Yang, Shengming - ARS" userId="37bd5b25-7571-49cb-bfc8-588a18706c35" providerId="ADAL" clId="{4FA1546C-AAE4-4B89-86A7-C130A0B04C58}" dt="2022-06-15T21:14:07.239" v="2976" actId="20577"/>
        <pc:sldMkLst>
          <pc:docMk/>
          <pc:sldMk cId="2983717248" sldId="295"/>
        </pc:sldMkLst>
        <pc:spChg chg="del">
          <ac:chgData name="Yang, Shengming - ARS" userId="37bd5b25-7571-49cb-bfc8-588a18706c35" providerId="ADAL" clId="{4FA1546C-AAE4-4B89-86A7-C130A0B04C58}" dt="2022-06-15T19:42:42.502" v="2574" actId="478"/>
          <ac:spMkLst>
            <pc:docMk/>
            <pc:sldMk cId="2983717248" sldId="295"/>
            <ac:spMk id="2" creationId="{5780D539-2B87-4F4F-BF7B-16FFB57F00B4}"/>
          </ac:spMkLst>
        </pc:spChg>
        <pc:spChg chg="del">
          <ac:chgData name="Yang, Shengming - ARS" userId="37bd5b25-7571-49cb-bfc8-588a18706c35" providerId="ADAL" clId="{4FA1546C-AAE4-4B89-86A7-C130A0B04C58}" dt="2022-06-15T19:42:42.502" v="2574" actId="478"/>
          <ac:spMkLst>
            <pc:docMk/>
            <pc:sldMk cId="2983717248" sldId="295"/>
            <ac:spMk id="3" creationId="{CFF4D411-69F9-4ED2-8143-7A1C1F7FB297}"/>
          </ac:spMkLst>
        </pc:spChg>
        <pc:spChg chg="add mod">
          <ac:chgData name="Yang, Shengming - ARS" userId="37bd5b25-7571-49cb-bfc8-588a18706c35" providerId="ADAL" clId="{4FA1546C-AAE4-4B89-86A7-C130A0B04C58}" dt="2022-06-15T21:14:07.239" v="2976" actId="20577"/>
          <ac:spMkLst>
            <pc:docMk/>
            <pc:sldMk cId="2983717248" sldId="295"/>
            <ac:spMk id="8" creationId="{EAE2D391-4525-4372-A2DB-B7DCCFC896CD}"/>
          </ac:spMkLst>
        </pc:spChg>
        <pc:spChg chg="add mod">
          <ac:chgData name="Yang, Shengming - ARS" userId="37bd5b25-7571-49cb-bfc8-588a18706c35" providerId="ADAL" clId="{4FA1546C-AAE4-4B89-86A7-C130A0B04C58}" dt="2022-06-15T20:21:51.525" v="2769" actId="164"/>
          <ac:spMkLst>
            <pc:docMk/>
            <pc:sldMk cId="2983717248" sldId="295"/>
            <ac:spMk id="10" creationId="{AC6F6A05-AB6E-43CD-A419-5C94D22CF921}"/>
          </ac:spMkLst>
        </pc:spChg>
        <pc:spChg chg="add mod">
          <ac:chgData name="Yang, Shengming - ARS" userId="37bd5b25-7571-49cb-bfc8-588a18706c35" providerId="ADAL" clId="{4FA1546C-AAE4-4B89-86A7-C130A0B04C58}" dt="2022-06-15T20:21:51.525" v="2769" actId="164"/>
          <ac:spMkLst>
            <pc:docMk/>
            <pc:sldMk cId="2983717248" sldId="295"/>
            <ac:spMk id="11" creationId="{D557658E-A638-46AF-9998-1F07470E23B1}"/>
          </ac:spMkLst>
        </pc:spChg>
        <pc:grpChg chg="add mod">
          <ac:chgData name="Yang, Shengming - ARS" userId="37bd5b25-7571-49cb-bfc8-588a18706c35" providerId="ADAL" clId="{4FA1546C-AAE4-4B89-86A7-C130A0B04C58}" dt="2022-06-15T20:21:55.652" v="2770" actId="1076"/>
          <ac:grpSpMkLst>
            <pc:docMk/>
            <pc:sldMk cId="2983717248" sldId="295"/>
            <ac:grpSpMk id="12" creationId="{31125B33-9867-4133-B845-71DC7469E4EC}"/>
          </ac:grpSpMkLst>
        </pc:grpChg>
        <pc:graphicFrameChg chg="add del mod">
          <ac:chgData name="Yang, Shengming - ARS" userId="37bd5b25-7571-49cb-bfc8-588a18706c35" providerId="ADAL" clId="{4FA1546C-AAE4-4B89-86A7-C130A0B04C58}" dt="2022-06-15T20:03:31.781" v="2582" actId="478"/>
          <ac:graphicFrameMkLst>
            <pc:docMk/>
            <pc:sldMk cId="2983717248" sldId="295"/>
            <ac:graphicFrameMk id="4" creationId="{3E4F9A22-9E32-41EE-AC1C-9F3F836EAD2D}"/>
          </ac:graphicFrameMkLst>
        </pc:graphicFrameChg>
        <pc:graphicFrameChg chg="add del mod">
          <ac:chgData name="Yang, Shengming - ARS" userId="37bd5b25-7571-49cb-bfc8-588a18706c35" providerId="ADAL" clId="{4FA1546C-AAE4-4B89-86A7-C130A0B04C58}" dt="2022-06-15T20:11:38.622" v="2628" actId="478"/>
          <ac:graphicFrameMkLst>
            <pc:docMk/>
            <pc:sldMk cId="2983717248" sldId="295"/>
            <ac:graphicFrameMk id="5" creationId="{BE73D9EB-B6BB-4B6D-9030-1B07B6922158}"/>
          </ac:graphicFrameMkLst>
        </pc:graphicFrameChg>
        <pc:graphicFrameChg chg="add del mod">
          <ac:chgData name="Yang, Shengming - ARS" userId="37bd5b25-7571-49cb-bfc8-588a18706c35" providerId="ADAL" clId="{4FA1546C-AAE4-4B89-86A7-C130A0B04C58}" dt="2022-06-15T20:12:45.391" v="2644" actId="478"/>
          <ac:graphicFrameMkLst>
            <pc:docMk/>
            <pc:sldMk cId="2983717248" sldId="295"/>
            <ac:graphicFrameMk id="6" creationId="{BE73D9EB-B6BB-4B6D-9030-1B07B6922158}"/>
          </ac:graphicFrameMkLst>
        </pc:graphicFrameChg>
        <pc:graphicFrameChg chg="add mod">
          <ac:chgData name="Yang, Shengming - ARS" userId="37bd5b25-7571-49cb-bfc8-588a18706c35" providerId="ADAL" clId="{4FA1546C-AAE4-4B89-86A7-C130A0B04C58}" dt="2022-06-15T20:21:51.525" v="2769" actId="164"/>
          <ac:graphicFrameMkLst>
            <pc:docMk/>
            <pc:sldMk cId="2983717248" sldId="295"/>
            <ac:graphicFrameMk id="7" creationId="{BB04B508-E7BB-433F-9BFE-53401031126B}"/>
          </ac:graphicFrameMkLst>
        </pc:graphicFrameChg>
      </pc:sldChg>
      <pc:sldChg chg="addSp delSp modSp new mod ord">
        <pc:chgData name="Yang, Shengming - ARS" userId="37bd5b25-7571-49cb-bfc8-588a18706c35" providerId="ADAL" clId="{4FA1546C-AAE4-4B89-86A7-C130A0B04C58}" dt="2022-06-16T14:19:07.013" v="3148" actId="478"/>
        <pc:sldMkLst>
          <pc:docMk/>
          <pc:sldMk cId="2009276644" sldId="296"/>
        </pc:sldMkLst>
        <pc:spChg chg="del">
          <ac:chgData name="Yang, Shengming - ARS" userId="37bd5b25-7571-49cb-bfc8-588a18706c35" providerId="ADAL" clId="{4FA1546C-AAE4-4B89-86A7-C130A0B04C58}" dt="2022-06-15T22:37:56.405" v="3003" actId="478"/>
          <ac:spMkLst>
            <pc:docMk/>
            <pc:sldMk cId="2009276644" sldId="296"/>
            <ac:spMk id="2" creationId="{EF0C1127-90F7-48B3-996B-E8D208C74F65}"/>
          </ac:spMkLst>
        </pc:spChg>
        <pc:spChg chg="del">
          <ac:chgData name="Yang, Shengming - ARS" userId="37bd5b25-7571-49cb-bfc8-588a18706c35" providerId="ADAL" clId="{4FA1546C-AAE4-4B89-86A7-C130A0B04C58}" dt="2022-06-15T22:37:56.405" v="3003" actId="478"/>
          <ac:spMkLst>
            <pc:docMk/>
            <pc:sldMk cId="2009276644" sldId="296"/>
            <ac:spMk id="3" creationId="{B7953804-8B8E-47B2-A128-60DBAF42BB99}"/>
          </ac:spMkLst>
        </pc:spChg>
        <pc:spChg chg="add mod">
          <ac:chgData name="Yang, Shengming - ARS" userId="37bd5b25-7571-49cb-bfc8-588a18706c35" providerId="ADAL" clId="{4FA1546C-AAE4-4B89-86A7-C130A0B04C58}" dt="2022-06-15T22:54:22.203" v="3134" actId="20577"/>
          <ac:spMkLst>
            <pc:docMk/>
            <pc:sldMk cId="2009276644" sldId="296"/>
            <ac:spMk id="6" creationId="{C3E6BED6-1EE8-48E5-86AA-B75C468E9D4C}"/>
          </ac:spMkLst>
        </pc:spChg>
        <pc:graphicFrameChg chg="add mod">
          <ac:chgData name="Yang, Shengming - ARS" userId="37bd5b25-7571-49cb-bfc8-588a18706c35" providerId="ADAL" clId="{4FA1546C-AAE4-4B89-86A7-C130A0B04C58}" dt="2022-06-15T22:41:42.695" v="3114"/>
          <ac:graphicFrameMkLst>
            <pc:docMk/>
            <pc:sldMk cId="2009276644" sldId="296"/>
            <ac:graphicFrameMk id="4" creationId="{0EEFB574-2781-4201-8BBC-87AB4FE082CF}"/>
          </ac:graphicFrameMkLst>
        </pc:graphicFrameChg>
        <pc:graphicFrameChg chg="add del mod">
          <ac:chgData name="Yang, Shengming - ARS" userId="37bd5b25-7571-49cb-bfc8-588a18706c35" providerId="ADAL" clId="{4FA1546C-AAE4-4B89-86A7-C130A0B04C58}" dt="2022-06-16T14:19:07.013" v="3148" actId="478"/>
          <ac:graphicFrameMkLst>
            <pc:docMk/>
            <pc:sldMk cId="2009276644" sldId="296"/>
            <ac:graphicFrameMk id="5" creationId="{D7136499-5921-4611-BF85-BDCE33D8E00D}"/>
          </ac:graphicFrameMkLst>
        </pc:graphicFrameChg>
      </pc:sldChg>
      <pc:sldChg chg="new del">
        <pc:chgData name="Yang, Shengming - ARS" userId="37bd5b25-7571-49cb-bfc8-588a18706c35" providerId="ADAL" clId="{4FA1546C-AAE4-4B89-86A7-C130A0B04C58}" dt="2022-06-16T14:14:54.323" v="3136" actId="47"/>
        <pc:sldMkLst>
          <pc:docMk/>
          <pc:sldMk cId="768961359" sldId="297"/>
        </pc:sldMkLst>
      </pc:sldChg>
      <pc:sldChg chg="modSp del mod ord">
        <pc:chgData name="Yang, Shengming - ARS" userId="37bd5b25-7571-49cb-bfc8-588a18706c35" providerId="ADAL" clId="{4FA1546C-AAE4-4B89-86A7-C130A0B04C58}" dt="2022-06-23T00:29:36.750" v="3297" actId="47"/>
        <pc:sldMkLst>
          <pc:docMk/>
          <pc:sldMk cId="4290271837" sldId="298"/>
        </pc:sldMkLst>
        <pc:spChg chg="mod">
          <ac:chgData name="Yang, Shengming - ARS" userId="37bd5b25-7571-49cb-bfc8-588a18706c35" providerId="ADAL" clId="{4FA1546C-AAE4-4B89-86A7-C130A0B04C58}" dt="2022-06-16T14:23:40.102" v="3160" actId="20577"/>
          <ac:spMkLst>
            <pc:docMk/>
            <pc:sldMk cId="4290271837" sldId="298"/>
            <ac:spMk id="8" creationId="{5515DB95-FBE6-4796-B2FD-611D25C9C78D}"/>
          </ac:spMkLst>
        </pc:spChg>
        <pc:graphicFrameChg chg="mod modGraphic">
          <ac:chgData name="Yang, Shengming - ARS" userId="37bd5b25-7571-49cb-bfc8-588a18706c35" providerId="ADAL" clId="{4FA1546C-AAE4-4B89-86A7-C130A0B04C58}" dt="2022-06-22T20:33:04.980" v="3296" actId="20577"/>
          <ac:graphicFrameMkLst>
            <pc:docMk/>
            <pc:sldMk cId="4290271837" sldId="298"/>
            <ac:graphicFrameMk id="3" creationId="{598A6666-D6A3-47EA-A96B-593FCF83FFB3}"/>
          </ac:graphicFrameMkLst>
        </pc:graphicFrameChg>
      </pc:sldChg>
    </pc:docChg>
  </pc:docChgLst>
  <pc:docChgLst>
    <pc:chgData name="Yang, Shengming - ARS" userId="37bd5b25-7571-49cb-bfc8-588a18706c35" providerId="ADAL" clId="{289504D4-974E-43B6-9BD4-CC07536E2F15}"/>
    <pc:docChg chg="undo custSel addSld delSld modSld sldOrd">
      <pc:chgData name="Yang, Shengming - ARS" userId="37bd5b25-7571-49cb-bfc8-588a18706c35" providerId="ADAL" clId="{289504D4-974E-43B6-9BD4-CC07536E2F15}" dt="2022-03-15T14:18:58.774" v="1468" actId="1076"/>
      <pc:docMkLst>
        <pc:docMk/>
      </pc:docMkLst>
      <pc:sldChg chg="delSp del mod">
        <pc:chgData name="Yang, Shengming - ARS" userId="37bd5b25-7571-49cb-bfc8-588a18706c35" providerId="ADAL" clId="{289504D4-974E-43B6-9BD4-CC07536E2F15}" dt="2022-03-03T19:34:54.196" v="928" actId="47"/>
        <pc:sldMkLst>
          <pc:docMk/>
          <pc:sldMk cId="187198215" sldId="256"/>
        </pc:sldMkLst>
        <pc:grpChg chg="del">
          <ac:chgData name="Yang, Shengming - ARS" userId="37bd5b25-7571-49cb-bfc8-588a18706c35" providerId="ADAL" clId="{289504D4-974E-43B6-9BD4-CC07536E2F15}" dt="2022-03-03T19:34:51.898" v="927" actId="478"/>
          <ac:grpSpMkLst>
            <pc:docMk/>
            <pc:sldMk cId="187198215" sldId="256"/>
            <ac:grpSpMk id="4" creationId="{4713D267-1D1C-445B-9270-5911825C9C0B}"/>
          </ac:grpSpMkLst>
        </pc:grpChg>
      </pc:sldChg>
      <pc:sldChg chg="addSp delSp modSp mod">
        <pc:chgData name="Yang, Shengming - ARS" userId="37bd5b25-7571-49cb-bfc8-588a18706c35" providerId="ADAL" clId="{289504D4-974E-43B6-9BD4-CC07536E2F15}" dt="2022-03-03T19:37:43.531" v="929" actId="1076"/>
        <pc:sldMkLst>
          <pc:docMk/>
          <pc:sldMk cId="3951076637" sldId="279"/>
        </pc:sldMkLst>
        <pc:spChg chg="mod topLvl">
          <ac:chgData name="Yang, Shengming - ARS" userId="37bd5b25-7571-49cb-bfc8-588a18706c35" providerId="ADAL" clId="{289504D4-974E-43B6-9BD4-CC07536E2F15}" dt="2022-03-01T23:40:08.702" v="907" actId="164"/>
          <ac:spMkLst>
            <pc:docMk/>
            <pc:sldMk cId="3951076637" sldId="279"/>
            <ac:spMk id="5" creationId="{145BD528-BFA0-4D45-9687-079068890D7E}"/>
          </ac:spMkLst>
        </pc:spChg>
        <pc:spChg chg="del mod topLvl">
          <ac:chgData name="Yang, Shengming - ARS" userId="37bd5b25-7571-49cb-bfc8-588a18706c35" providerId="ADAL" clId="{289504D4-974E-43B6-9BD4-CC07536E2F15}" dt="2022-03-01T23:39:50.479" v="902" actId="478"/>
          <ac:spMkLst>
            <pc:docMk/>
            <pc:sldMk cId="3951076637" sldId="279"/>
            <ac:spMk id="9" creationId="{1DBA7A38-F1C2-43F1-B07B-6DB945F9489B}"/>
          </ac:spMkLst>
        </pc:spChg>
        <pc:spChg chg="del mod topLvl">
          <ac:chgData name="Yang, Shengming - ARS" userId="37bd5b25-7571-49cb-bfc8-588a18706c35" providerId="ADAL" clId="{289504D4-974E-43B6-9BD4-CC07536E2F15}" dt="2022-03-01T23:39:50.479" v="902" actId="478"/>
          <ac:spMkLst>
            <pc:docMk/>
            <pc:sldMk cId="3951076637" sldId="279"/>
            <ac:spMk id="10" creationId="{3D2326B1-C546-4D12-8752-20DF7547E757}"/>
          </ac:spMkLst>
        </pc:spChg>
        <pc:spChg chg="del mod topLvl">
          <ac:chgData name="Yang, Shengming - ARS" userId="37bd5b25-7571-49cb-bfc8-588a18706c35" providerId="ADAL" clId="{289504D4-974E-43B6-9BD4-CC07536E2F15}" dt="2022-03-01T23:39:50.479" v="902" actId="478"/>
          <ac:spMkLst>
            <pc:docMk/>
            <pc:sldMk cId="3951076637" sldId="279"/>
            <ac:spMk id="11" creationId="{9CEA8F64-D0F9-437A-B0CD-26A049A077C5}"/>
          </ac:spMkLst>
        </pc:spChg>
        <pc:spChg chg="del mod topLvl">
          <ac:chgData name="Yang, Shengming - ARS" userId="37bd5b25-7571-49cb-bfc8-588a18706c35" providerId="ADAL" clId="{289504D4-974E-43B6-9BD4-CC07536E2F15}" dt="2022-03-01T23:39:50.479" v="902" actId="478"/>
          <ac:spMkLst>
            <pc:docMk/>
            <pc:sldMk cId="3951076637" sldId="279"/>
            <ac:spMk id="12" creationId="{9A1CB18C-708F-4490-8E3B-0E81F8B8F925}"/>
          </ac:spMkLst>
        </pc:spChg>
        <pc:spChg chg="del mod topLvl">
          <ac:chgData name="Yang, Shengming - ARS" userId="37bd5b25-7571-49cb-bfc8-588a18706c35" providerId="ADAL" clId="{289504D4-974E-43B6-9BD4-CC07536E2F15}" dt="2022-03-01T23:39:50.479" v="902" actId="478"/>
          <ac:spMkLst>
            <pc:docMk/>
            <pc:sldMk cId="3951076637" sldId="279"/>
            <ac:spMk id="13" creationId="{90553A36-194B-4661-8528-8B1849BB7519}"/>
          </ac:spMkLst>
        </pc:spChg>
        <pc:spChg chg="del mod topLvl">
          <ac:chgData name="Yang, Shengming - ARS" userId="37bd5b25-7571-49cb-bfc8-588a18706c35" providerId="ADAL" clId="{289504D4-974E-43B6-9BD4-CC07536E2F15}" dt="2022-03-01T23:39:50.479" v="902" actId="478"/>
          <ac:spMkLst>
            <pc:docMk/>
            <pc:sldMk cId="3951076637" sldId="279"/>
            <ac:spMk id="14" creationId="{C4F6644D-D88C-416B-A004-6086EFE2868C}"/>
          </ac:spMkLst>
        </pc:spChg>
        <pc:spChg chg="del mod topLvl">
          <ac:chgData name="Yang, Shengming - ARS" userId="37bd5b25-7571-49cb-bfc8-588a18706c35" providerId="ADAL" clId="{289504D4-974E-43B6-9BD4-CC07536E2F15}" dt="2022-03-01T23:39:50.479" v="902" actId="478"/>
          <ac:spMkLst>
            <pc:docMk/>
            <pc:sldMk cId="3951076637" sldId="279"/>
            <ac:spMk id="15" creationId="{F3DED48D-CE70-40FE-A39D-B971BC9389C5}"/>
          </ac:spMkLst>
        </pc:spChg>
        <pc:spChg chg="del mod topLvl">
          <ac:chgData name="Yang, Shengming - ARS" userId="37bd5b25-7571-49cb-bfc8-588a18706c35" providerId="ADAL" clId="{289504D4-974E-43B6-9BD4-CC07536E2F15}" dt="2022-03-01T23:39:50.479" v="902" actId="478"/>
          <ac:spMkLst>
            <pc:docMk/>
            <pc:sldMk cId="3951076637" sldId="279"/>
            <ac:spMk id="16" creationId="{E0E41763-64B4-493B-B8C5-44023B9A4868}"/>
          </ac:spMkLst>
        </pc:spChg>
        <pc:spChg chg="del mod topLvl">
          <ac:chgData name="Yang, Shengming - ARS" userId="37bd5b25-7571-49cb-bfc8-588a18706c35" providerId="ADAL" clId="{289504D4-974E-43B6-9BD4-CC07536E2F15}" dt="2022-03-01T23:39:50.479" v="902" actId="478"/>
          <ac:spMkLst>
            <pc:docMk/>
            <pc:sldMk cId="3951076637" sldId="279"/>
            <ac:spMk id="17" creationId="{B88AA1AD-6740-41FB-8D03-55FD7DD6881F}"/>
          </ac:spMkLst>
        </pc:spChg>
        <pc:spChg chg="del mod topLvl">
          <ac:chgData name="Yang, Shengming - ARS" userId="37bd5b25-7571-49cb-bfc8-588a18706c35" providerId="ADAL" clId="{289504D4-974E-43B6-9BD4-CC07536E2F15}" dt="2022-03-01T23:39:50.479" v="902" actId="478"/>
          <ac:spMkLst>
            <pc:docMk/>
            <pc:sldMk cId="3951076637" sldId="279"/>
            <ac:spMk id="18" creationId="{C11AFC66-BEAB-4A07-9543-1548CB6DFB82}"/>
          </ac:spMkLst>
        </pc:spChg>
        <pc:spChg chg="del mod topLvl">
          <ac:chgData name="Yang, Shengming - ARS" userId="37bd5b25-7571-49cb-bfc8-588a18706c35" providerId="ADAL" clId="{289504D4-974E-43B6-9BD4-CC07536E2F15}" dt="2022-03-01T23:39:50.479" v="902" actId="478"/>
          <ac:spMkLst>
            <pc:docMk/>
            <pc:sldMk cId="3951076637" sldId="279"/>
            <ac:spMk id="19" creationId="{749D19CB-F2A5-4F3D-9AA1-9B63159D6EB5}"/>
          </ac:spMkLst>
        </pc:spChg>
        <pc:spChg chg="del mod topLvl">
          <ac:chgData name="Yang, Shengming - ARS" userId="37bd5b25-7571-49cb-bfc8-588a18706c35" providerId="ADAL" clId="{289504D4-974E-43B6-9BD4-CC07536E2F15}" dt="2022-03-01T23:39:50.479" v="902" actId="478"/>
          <ac:spMkLst>
            <pc:docMk/>
            <pc:sldMk cId="3951076637" sldId="279"/>
            <ac:spMk id="20" creationId="{47C1E7A6-3888-4BF6-AF81-7889EAB920DA}"/>
          </ac:spMkLst>
        </pc:spChg>
        <pc:spChg chg="del mod topLvl">
          <ac:chgData name="Yang, Shengming - ARS" userId="37bd5b25-7571-49cb-bfc8-588a18706c35" providerId="ADAL" clId="{289504D4-974E-43B6-9BD4-CC07536E2F15}" dt="2022-03-01T23:39:50.479" v="902" actId="478"/>
          <ac:spMkLst>
            <pc:docMk/>
            <pc:sldMk cId="3951076637" sldId="279"/>
            <ac:spMk id="21" creationId="{63AD6A1F-A67A-4E9B-B1F2-1AAA334BDE29}"/>
          </ac:spMkLst>
        </pc:spChg>
        <pc:spChg chg="del mod topLvl">
          <ac:chgData name="Yang, Shengming - ARS" userId="37bd5b25-7571-49cb-bfc8-588a18706c35" providerId="ADAL" clId="{289504D4-974E-43B6-9BD4-CC07536E2F15}" dt="2022-03-01T23:39:50.479" v="902" actId="478"/>
          <ac:spMkLst>
            <pc:docMk/>
            <pc:sldMk cId="3951076637" sldId="279"/>
            <ac:spMk id="22" creationId="{2277B4F2-190F-4C43-BA86-871B416D3C6D}"/>
          </ac:spMkLst>
        </pc:spChg>
        <pc:spChg chg="del mod topLvl">
          <ac:chgData name="Yang, Shengming - ARS" userId="37bd5b25-7571-49cb-bfc8-588a18706c35" providerId="ADAL" clId="{289504D4-974E-43B6-9BD4-CC07536E2F15}" dt="2022-03-01T23:39:50.479" v="902" actId="478"/>
          <ac:spMkLst>
            <pc:docMk/>
            <pc:sldMk cId="3951076637" sldId="279"/>
            <ac:spMk id="23" creationId="{8E58034F-46E8-4DEB-A53C-A4EFA9DF7AE5}"/>
          </ac:spMkLst>
        </pc:spChg>
        <pc:spChg chg="del mod topLvl">
          <ac:chgData name="Yang, Shengming - ARS" userId="37bd5b25-7571-49cb-bfc8-588a18706c35" providerId="ADAL" clId="{289504D4-974E-43B6-9BD4-CC07536E2F15}" dt="2022-03-01T23:39:50.479" v="902" actId="478"/>
          <ac:spMkLst>
            <pc:docMk/>
            <pc:sldMk cId="3951076637" sldId="279"/>
            <ac:spMk id="24" creationId="{119F3634-2A44-4A1E-B9A1-20D2CD30BFE8}"/>
          </ac:spMkLst>
        </pc:spChg>
        <pc:spChg chg="del mod topLvl">
          <ac:chgData name="Yang, Shengming - ARS" userId="37bd5b25-7571-49cb-bfc8-588a18706c35" providerId="ADAL" clId="{289504D4-974E-43B6-9BD4-CC07536E2F15}" dt="2022-03-01T23:39:50.479" v="902" actId="478"/>
          <ac:spMkLst>
            <pc:docMk/>
            <pc:sldMk cId="3951076637" sldId="279"/>
            <ac:spMk id="25" creationId="{DEDD0E87-E7AD-4F9C-810D-65C7C9B37EB3}"/>
          </ac:spMkLst>
        </pc:spChg>
        <pc:spChg chg="del mod topLvl">
          <ac:chgData name="Yang, Shengming - ARS" userId="37bd5b25-7571-49cb-bfc8-588a18706c35" providerId="ADAL" clId="{289504D4-974E-43B6-9BD4-CC07536E2F15}" dt="2022-03-01T23:39:50.479" v="902" actId="478"/>
          <ac:spMkLst>
            <pc:docMk/>
            <pc:sldMk cId="3951076637" sldId="279"/>
            <ac:spMk id="26" creationId="{8EF545B0-FBB5-4A8A-AC3B-7EC09B4C7B60}"/>
          </ac:spMkLst>
        </pc:spChg>
        <pc:spChg chg="del mod topLvl">
          <ac:chgData name="Yang, Shengming - ARS" userId="37bd5b25-7571-49cb-bfc8-588a18706c35" providerId="ADAL" clId="{289504D4-974E-43B6-9BD4-CC07536E2F15}" dt="2022-03-01T23:39:50.479" v="902" actId="478"/>
          <ac:spMkLst>
            <pc:docMk/>
            <pc:sldMk cId="3951076637" sldId="279"/>
            <ac:spMk id="27" creationId="{2579254F-6C34-4A01-B85F-1044A5595F64}"/>
          </ac:spMkLst>
        </pc:spChg>
        <pc:spChg chg="del mod topLvl">
          <ac:chgData name="Yang, Shengming - ARS" userId="37bd5b25-7571-49cb-bfc8-588a18706c35" providerId="ADAL" clId="{289504D4-974E-43B6-9BD4-CC07536E2F15}" dt="2022-03-01T23:39:50.479" v="902" actId="478"/>
          <ac:spMkLst>
            <pc:docMk/>
            <pc:sldMk cId="3951076637" sldId="279"/>
            <ac:spMk id="28" creationId="{2681E759-E980-4D0E-8A19-3C6930055144}"/>
          </ac:spMkLst>
        </pc:spChg>
        <pc:spChg chg="del mod topLvl">
          <ac:chgData name="Yang, Shengming - ARS" userId="37bd5b25-7571-49cb-bfc8-588a18706c35" providerId="ADAL" clId="{289504D4-974E-43B6-9BD4-CC07536E2F15}" dt="2022-03-01T23:39:50.479" v="902" actId="478"/>
          <ac:spMkLst>
            <pc:docMk/>
            <pc:sldMk cId="3951076637" sldId="279"/>
            <ac:spMk id="29" creationId="{36469305-C272-4EBC-894D-2CF648336826}"/>
          </ac:spMkLst>
        </pc:spChg>
        <pc:spChg chg="mod topLvl">
          <ac:chgData name="Yang, Shengming - ARS" userId="37bd5b25-7571-49cb-bfc8-588a18706c35" providerId="ADAL" clId="{289504D4-974E-43B6-9BD4-CC07536E2F15}" dt="2022-03-01T23:40:08.702" v="907" actId="164"/>
          <ac:spMkLst>
            <pc:docMk/>
            <pc:sldMk cId="3951076637" sldId="279"/>
            <ac:spMk id="31" creationId="{8C88D3CF-522A-4F82-9D1E-F2BA0C73E44A}"/>
          </ac:spMkLst>
        </pc:spChg>
        <pc:spChg chg="mod">
          <ac:chgData name="Yang, Shengming - ARS" userId="37bd5b25-7571-49cb-bfc8-588a18706c35" providerId="ADAL" clId="{289504D4-974E-43B6-9BD4-CC07536E2F15}" dt="2022-03-01T23:40:16.288" v="910" actId="1076"/>
          <ac:spMkLst>
            <pc:docMk/>
            <pc:sldMk cId="3951076637" sldId="279"/>
            <ac:spMk id="33" creationId="{A3CCCF6D-3F3C-4533-B4BB-23BC1ECC5268}"/>
          </ac:spMkLst>
        </pc:spChg>
        <pc:grpChg chg="del">
          <ac:chgData name="Yang, Shengming - ARS" userId="37bd5b25-7571-49cb-bfc8-588a18706c35" providerId="ADAL" clId="{289504D4-974E-43B6-9BD4-CC07536E2F15}" dt="2022-03-01T23:39:46.177" v="901" actId="165"/>
          <ac:grpSpMkLst>
            <pc:docMk/>
            <pc:sldMk cId="3951076637" sldId="279"/>
            <ac:grpSpMk id="4" creationId="{AFBEF914-C123-4457-BA33-D246EBC7B174}"/>
          </ac:grpSpMkLst>
        </pc:grpChg>
        <pc:grpChg chg="add mod">
          <ac:chgData name="Yang, Shengming - ARS" userId="37bd5b25-7571-49cb-bfc8-588a18706c35" providerId="ADAL" clId="{289504D4-974E-43B6-9BD4-CC07536E2F15}" dt="2022-03-03T19:37:43.531" v="929" actId="1076"/>
          <ac:grpSpMkLst>
            <pc:docMk/>
            <pc:sldMk cId="3951076637" sldId="279"/>
            <ac:grpSpMk id="30" creationId="{50962A51-58E8-4470-B29C-EE836E9FB46F}"/>
          </ac:grpSpMkLst>
        </pc:grpChg>
        <pc:grpChg chg="mod">
          <ac:chgData name="Yang, Shengming - ARS" userId="37bd5b25-7571-49cb-bfc8-588a18706c35" providerId="ADAL" clId="{289504D4-974E-43B6-9BD4-CC07536E2F15}" dt="2022-03-01T23:40:08.702" v="907" actId="164"/>
          <ac:grpSpMkLst>
            <pc:docMk/>
            <pc:sldMk cId="3951076637" sldId="279"/>
            <ac:grpSpMk id="49" creationId="{C0231E8A-E728-4F57-9567-B5F93B699AA5}"/>
          </ac:grpSpMkLst>
        </pc:grpChg>
        <pc:graphicFrameChg chg="mod">
          <ac:chgData name="Yang, Shengming - ARS" userId="37bd5b25-7571-49cb-bfc8-588a18706c35" providerId="ADAL" clId="{289504D4-974E-43B6-9BD4-CC07536E2F15}" dt="2022-03-01T23:40:13.964" v="909" actId="1076"/>
          <ac:graphicFrameMkLst>
            <pc:docMk/>
            <pc:sldMk cId="3951076637" sldId="279"/>
            <ac:graphicFrameMk id="36" creationId="{6F1D622B-363F-4DE5-B31A-0E65AA636F7D}"/>
          </ac:graphicFrameMkLst>
        </pc:graphicFrameChg>
        <pc:picChg chg="add del mod">
          <ac:chgData name="Yang, Shengming - ARS" userId="37bd5b25-7571-49cb-bfc8-588a18706c35" providerId="ADAL" clId="{289504D4-974E-43B6-9BD4-CC07536E2F15}" dt="2022-03-01T23:39:38.419" v="900" actId="478"/>
          <ac:picMkLst>
            <pc:docMk/>
            <pc:sldMk cId="3951076637" sldId="279"/>
            <ac:picMk id="3" creationId="{58C293D0-1D7A-4D60-BF2F-84BF4F92FD55}"/>
          </ac:picMkLst>
        </pc:picChg>
        <pc:picChg chg="del mod topLvl">
          <ac:chgData name="Yang, Shengming - ARS" userId="37bd5b25-7571-49cb-bfc8-588a18706c35" providerId="ADAL" clId="{289504D4-974E-43B6-9BD4-CC07536E2F15}" dt="2022-03-01T23:39:50.479" v="902" actId="478"/>
          <ac:picMkLst>
            <pc:docMk/>
            <pc:sldMk cId="3951076637" sldId="279"/>
            <ac:picMk id="6" creationId="{D5D3F2C3-992B-4E29-AC45-94D57298A263}"/>
          </ac:picMkLst>
        </pc:picChg>
        <pc:picChg chg="del mod topLvl">
          <ac:chgData name="Yang, Shengming - ARS" userId="37bd5b25-7571-49cb-bfc8-588a18706c35" providerId="ADAL" clId="{289504D4-974E-43B6-9BD4-CC07536E2F15}" dt="2022-03-01T23:39:50.479" v="902" actId="478"/>
          <ac:picMkLst>
            <pc:docMk/>
            <pc:sldMk cId="3951076637" sldId="279"/>
            <ac:picMk id="7" creationId="{E65D33FD-4A8B-4730-B051-114648063CC8}"/>
          </ac:picMkLst>
        </pc:picChg>
        <pc:picChg chg="del">
          <ac:chgData name="Yang, Shengming - ARS" userId="37bd5b25-7571-49cb-bfc8-588a18706c35" providerId="ADAL" clId="{289504D4-974E-43B6-9BD4-CC07536E2F15}" dt="2022-03-01T23:39:36.456" v="899" actId="478"/>
          <ac:picMkLst>
            <pc:docMk/>
            <pc:sldMk cId="3951076637" sldId="279"/>
            <ac:picMk id="8" creationId="{03A0FCB9-0014-44CD-9C1E-29A0071AF403}"/>
          </ac:picMkLst>
        </pc:picChg>
        <pc:cxnChg chg="del mod topLvl">
          <ac:chgData name="Yang, Shengming - ARS" userId="37bd5b25-7571-49cb-bfc8-588a18706c35" providerId="ADAL" clId="{289504D4-974E-43B6-9BD4-CC07536E2F15}" dt="2022-03-01T23:39:50.479" v="902" actId="478"/>
          <ac:cxnSpMkLst>
            <pc:docMk/>
            <pc:sldMk cId="3951076637" sldId="279"/>
            <ac:cxnSpMk id="32" creationId="{0ED014C2-BD9C-48CA-9230-869B95F1C1B6}"/>
          </ac:cxnSpMkLst>
        </pc:cxnChg>
      </pc:sldChg>
      <pc:sldChg chg="addSp modSp mod">
        <pc:chgData name="Yang, Shengming - ARS" userId="37bd5b25-7571-49cb-bfc8-588a18706c35" providerId="ADAL" clId="{289504D4-974E-43B6-9BD4-CC07536E2F15}" dt="2022-03-14T20:21:03.125" v="1466"/>
        <pc:sldMkLst>
          <pc:docMk/>
          <pc:sldMk cId="2943728638" sldId="280"/>
        </pc:sldMkLst>
        <pc:graphicFrameChg chg="add mod">
          <ac:chgData name="Yang, Shengming - ARS" userId="37bd5b25-7571-49cb-bfc8-588a18706c35" providerId="ADAL" clId="{289504D4-974E-43B6-9BD4-CC07536E2F15}" dt="2022-03-14T20:21:03.125" v="1466"/>
          <ac:graphicFrameMkLst>
            <pc:docMk/>
            <pc:sldMk cId="2943728638" sldId="280"/>
            <ac:graphicFrameMk id="4" creationId="{960B72F8-A520-4409-90DD-5C5A356D878C}"/>
          </ac:graphicFrameMkLst>
        </pc:graphicFrameChg>
        <pc:graphicFrameChg chg="add mod">
          <ac:chgData name="Yang, Shengming - ARS" userId="37bd5b25-7571-49cb-bfc8-588a18706c35" providerId="ADAL" clId="{289504D4-974E-43B6-9BD4-CC07536E2F15}" dt="2022-03-08T22:42:11.732" v="1095" actId="14100"/>
          <ac:graphicFrameMkLst>
            <pc:docMk/>
            <pc:sldMk cId="2943728638" sldId="280"/>
            <ac:graphicFrameMk id="5" creationId="{A6BECD3C-A5FE-45BD-B54B-E0305306921F}"/>
          </ac:graphicFrameMkLst>
        </pc:graphicFrameChg>
      </pc:sldChg>
      <pc:sldChg chg="addSp delSp modSp mod modNotesTx">
        <pc:chgData name="Yang, Shengming - ARS" userId="37bd5b25-7571-49cb-bfc8-588a18706c35" providerId="ADAL" clId="{289504D4-974E-43B6-9BD4-CC07536E2F15}" dt="2022-03-15T14:18:58.774" v="1468" actId="1076"/>
        <pc:sldMkLst>
          <pc:docMk/>
          <pc:sldMk cId="2625937353" sldId="284"/>
        </pc:sldMkLst>
        <pc:spChg chg="mod">
          <ac:chgData name="Yang, Shengming - ARS" userId="37bd5b25-7571-49cb-bfc8-588a18706c35" providerId="ADAL" clId="{289504D4-974E-43B6-9BD4-CC07536E2F15}" dt="2022-03-07T21:11:04.579" v="931" actId="1035"/>
          <ac:spMkLst>
            <pc:docMk/>
            <pc:sldMk cId="2625937353" sldId="284"/>
            <ac:spMk id="19" creationId="{0F7A8E18-9C7A-4C86-B619-6CCC77F46459}"/>
          </ac:spMkLst>
        </pc:spChg>
        <pc:spChg chg="mod">
          <ac:chgData name="Yang, Shengming - ARS" userId="37bd5b25-7571-49cb-bfc8-588a18706c35" providerId="ADAL" clId="{289504D4-974E-43B6-9BD4-CC07536E2F15}" dt="2022-03-15T13:58:15.435" v="1467" actId="1076"/>
          <ac:spMkLst>
            <pc:docMk/>
            <pc:sldMk cId="2625937353" sldId="284"/>
            <ac:spMk id="56" creationId="{00540A4C-C19C-4E64-AB2E-B2E1D10D227C}"/>
          </ac:spMkLst>
        </pc:spChg>
        <pc:spChg chg="mod">
          <ac:chgData name="Yang, Shengming - ARS" userId="37bd5b25-7571-49cb-bfc8-588a18706c35" providerId="ADAL" clId="{289504D4-974E-43B6-9BD4-CC07536E2F15}" dt="2022-03-15T14:18:58.774" v="1468" actId="1076"/>
          <ac:spMkLst>
            <pc:docMk/>
            <pc:sldMk cId="2625937353" sldId="284"/>
            <ac:spMk id="58" creationId="{E35FD13C-0112-48E9-A639-5752462E9D4B}"/>
          </ac:spMkLst>
        </pc:spChg>
        <pc:spChg chg="add mod">
          <ac:chgData name="Yang, Shengming - ARS" userId="37bd5b25-7571-49cb-bfc8-588a18706c35" providerId="ADAL" clId="{289504D4-974E-43B6-9BD4-CC07536E2F15}" dt="2022-02-25T20:26:22.530" v="75" actId="1076"/>
          <ac:spMkLst>
            <pc:docMk/>
            <pc:sldMk cId="2625937353" sldId="284"/>
            <ac:spMk id="60" creationId="{0DB11815-8202-4994-85EF-4706FA09510A}"/>
          </ac:spMkLst>
        </pc:spChg>
        <pc:spChg chg="add mod">
          <ac:chgData name="Yang, Shengming - ARS" userId="37bd5b25-7571-49cb-bfc8-588a18706c35" providerId="ADAL" clId="{289504D4-974E-43B6-9BD4-CC07536E2F15}" dt="2022-02-25T20:27:18.498" v="92" actId="1076"/>
          <ac:spMkLst>
            <pc:docMk/>
            <pc:sldMk cId="2625937353" sldId="284"/>
            <ac:spMk id="61" creationId="{454345CC-B2D1-4E4D-BCF9-CF14117A7BE8}"/>
          </ac:spMkLst>
        </pc:spChg>
        <pc:picChg chg="add del mod modCrop">
          <ac:chgData name="Yang, Shengming - ARS" userId="37bd5b25-7571-49cb-bfc8-588a18706c35" providerId="ADAL" clId="{289504D4-974E-43B6-9BD4-CC07536E2F15}" dt="2022-02-25T20:25:31.897" v="58" actId="478"/>
          <ac:picMkLst>
            <pc:docMk/>
            <pc:sldMk cId="2625937353" sldId="284"/>
            <ac:picMk id="8" creationId="{FA48A28C-2E82-4932-8BE4-5374AB3D1EDD}"/>
          </ac:picMkLst>
        </pc:picChg>
        <pc:picChg chg="add mod">
          <ac:chgData name="Yang, Shengming - ARS" userId="37bd5b25-7571-49cb-bfc8-588a18706c35" providerId="ADAL" clId="{289504D4-974E-43B6-9BD4-CC07536E2F15}" dt="2022-02-25T20:25:44.795" v="62" actId="14100"/>
          <ac:picMkLst>
            <pc:docMk/>
            <pc:sldMk cId="2625937353" sldId="284"/>
            <ac:picMk id="10" creationId="{E2E97180-D489-4853-AC1F-78DB9CF14B40}"/>
          </ac:picMkLst>
        </pc:picChg>
        <pc:picChg chg="del">
          <ac:chgData name="Yang, Shengming - ARS" userId="37bd5b25-7571-49cb-bfc8-588a18706c35" providerId="ADAL" clId="{289504D4-974E-43B6-9BD4-CC07536E2F15}" dt="2022-02-25T20:25:35.875" v="59" actId="478"/>
          <ac:picMkLst>
            <pc:docMk/>
            <pc:sldMk cId="2625937353" sldId="284"/>
            <ac:picMk id="57" creationId="{43355438-3992-4775-9C8D-31AC12E5A819}"/>
          </ac:picMkLst>
        </pc:picChg>
        <pc:picChg chg="add del mod">
          <ac:chgData name="Yang, Shengming - ARS" userId="37bd5b25-7571-49cb-bfc8-588a18706c35" providerId="ADAL" clId="{289504D4-974E-43B6-9BD4-CC07536E2F15}" dt="2022-02-25T20:25:28.066" v="56" actId="478"/>
          <ac:picMkLst>
            <pc:docMk/>
            <pc:sldMk cId="2625937353" sldId="284"/>
            <ac:picMk id="59" creationId="{294D3E28-10DF-462C-8243-4E3C2ABB8E35}"/>
          </ac:picMkLst>
        </pc:picChg>
      </pc:sldChg>
      <pc:sldChg chg="modSp mod">
        <pc:chgData name="Yang, Shengming - ARS" userId="37bd5b25-7571-49cb-bfc8-588a18706c35" providerId="ADAL" clId="{289504D4-974E-43B6-9BD4-CC07536E2F15}" dt="2022-03-08T21:00:10.441" v="969" actId="1076"/>
        <pc:sldMkLst>
          <pc:docMk/>
          <pc:sldMk cId="2301416017" sldId="285"/>
        </pc:sldMkLst>
        <pc:picChg chg="mod">
          <ac:chgData name="Yang, Shengming - ARS" userId="37bd5b25-7571-49cb-bfc8-588a18706c35" providerId="ADAL" clId="{289504D4-974E-43B6-9BD4-CC07536E2F15}" dt="2022-03-08T21:00:10.441" v="969" actId="1076"/>
          <ac:picMkLst>
            <pc:docMk/>
            <pc:sldMk cId="2301416017" sldId="285"/>
            <ac:picMk id="5" creationId="{3381DD81-F4CB-4116-AB31-33C2B9C41158}"/>
          </ac:picMkLst>
        </pc:picChg>
        <pc:picChg chg="mod">
          <ac:chgData name="Yang, Shengming - ARS" userId="37bd5b25-7571-49cb-bfc8-588a18706c35" providerId="ADAL" clId="{289504D4-974E-43B6-9BD4-CC07536E2F15}" dt="2022-03-08T21:00:10.441" v="969" actId="1076"/>
          <ac:picMkLst>
            <pc:docMk/>
            <pc:sldMk cId="2301416017" sldId="285"/>
            <ac:picMk id="9" creationId="{D2106145-624E-4A03-AC6D-2880EE6214C5}"/>
          </ac:picMkLst>
        </pc:picChg>
        <pc:picChg chg="mod">
          <ac:chgData name="Yang, Shengming - ARS" userId="37bd5b25-7571-49cb-bfc8-588a18706c35" providerId="ADAL" clId="{289504D4-974E-43B6-9BD4-CC07536E2F15}" dt="2022-03-08T21:00:10.441" v="969" actId="1076"/>
          <ac:picMkLst>
            <pc:docMk/>
            <pc:sldMk cId="2301416017" sldId="285"/>
            <ac:picMk id="10" creationId="{05A166F1-4B35-440B-8A66-9471844B2815}"/>
          </ac:picMkLst>
        </pc:picChg>
      </pc:sldChg>
      <pc:sldChg chg="modSp mod">
        <pc:chgData name="Yang, Shengming - ARS" userId="37bd5b25-7571-49cb-bfc8-588a18706c35" providerId="ADAL" clId="{289504D4-974E-43B6-9BD4-CC07536E2F15}" dt="2022-03-01T23:41:44.333" v="913" actId="1037"/>
        <pc:sldMkLst>
          <pc:docMk/>
          <pc:sldMk cId="2028917921" sldId="286"/>
        </pc:sldMkLst>
        <pc:picChg chg="mod">
          <ac:chgData name="Yang, Shengming - ARS" userId="37bd5b25-7571-49cb-bfc8-588a18706c35" providerId="ADAL" clId="{289504D4-974E-43B6-9BD4-CC07536E2F15}" dt="2022-03-01T23:41:44.333" v="913" actId="1037"/>
          <ac:picMkLst>
            <pc:docMk/>
            <pc:sldMk cId="2028917921" sldId="286"/>
            <ac:picMk id="3" creationId="{47515810-1A32-4C86-A72B-3D11768C8C9D}"/>
          </ac:picMkLst>
        </pc:picChg>
      </pc:sldChg>
      <pc:sldChg chg="addSp delSp modSp mod modNotesTx">
        <pc:chgData name="Yang, Shengming - ARS" userId="37bd5b25-7571-49cb-bfc8-588a18706c35" providerId="ADAL" clId="{289504D4-974E-43B6-9BD4-CC07536E2F15}" dt="2022-03-08T22:43:10.767" v="1101" actId="1037"/>
        <pc:sldMkLst>
          <pc:docMk/>
          <pc:sldMk cId="4208113970" sldId="288"/>
        </pc:sldMkLst>
        <pc:spChg chg="add mod">
          <ac:chgData name="Yang, Shengming - ARS" userId="37bd5b25-7571-49cb-bfc8-588a18706c35" providerId="ADAL" clId="{289504D4-974E-43B6-9BD4-CC07536E2F15}" dt="2022-03-08T22:39:35.700" v="1087" actId="20577"/>
          <ac:spMkLst>
            <pc:docMk/>
            <pc:sldMk cId="4208113970" sldId="288"/>
            <ac:spMk id="18" creationId="{3AF29D4B-F9E8-4DC8-9D02-E37CA61EADD7}"/>
          </ac:spMkLst>
        </pc:spChg>
        <pc:picChg chg="add mod modCrop">
          <ac:chgData name="Yang, Shengming - ARS" userId="37bd5b25-7571-49cb-bfc8-588a18706c35" providerId="ADAL" clId="{289504D4-974E-43B6-9BD4-CC07536E2F15}" dt="2022-03-08T22:03:34.597" v="1019" actId="732"/>
          <ac:picMkLst>
            <pc:docMk/>
            <pc:sldMk cId="4208113970" sldId="288"/>
            <ac:picMk id="3" creationId="{66F4523C-2859-48DE-99E1-CB7C8576EDF8}"/>
          </ac:picMkLst>
        </pc:picChg>
        <pc:picChg chg="add mod modCrop">
          <ac:chgData name="Yang, Shengming - ARS" userId="37bd5b25-7571-49cb-bfc8-588a18706c35" providerId="ADAL" clId="{289504D4-974E-43B6-9BD4-CC07536E2F15}" dt="2022-03-08T17:23:58.677" v="963" actId="1076"/>
          <ac:picMkLst>
            <pc:docMk/>
            <pc:sldMk cId="4208113970" sldId="288"/>
            <ac:picMk id="5" creationId="{EF3B4D23-3ECD-4D6E-9A9C-EFC5B37D9611}"/>
          </ac:picMkLst>
        </pc:picChg>
        <pc:picChg chg="add mod modCrop">
          <ac:chgData name="Yang, Shengming - ARS" userId="37bd5b25-7571-49cb-bfc8-588a18706c35" providerId="ADAL" clId="{289504D4-974E-43B6-9BD4-CC07536E2F15}" dt="2022-03-08T17:23:43.060" v="960" actId="14100"/>
          <ac:picMkLst>
            <pc:docMk/>
            <pc:sldMk cId="4208113970" sldId="288"/>
            <ac:picMk id="7" creationId="{3909BBB6-BA7D-42FF-A43C-5940B8AC5FA8}"/>
          </ac:picMkLst>
        </pc:picChg>
        <pc:picChg chg="add del mod">
          <ac:chgData name="Yang, Shengming - ARS" userId="37bd5b25-7571-49cb-bfc8-588a18706c35" providerId="ADAL" clId="{289504D4-974E-43B6-9BD4-CC07536E2F15}" dt="2022-03-08T17:27:29.368" v="967" actId="478"/>
          <ac:picMkLst>
            <pc:docMk/>
            <pc:sldMk cId="4208113970" sldId="288"/>
            <ac:picMk id="9" creationId="{BB83AABB-0828-4151-ADED-68E9A38B452F}"/>
          </ac:picMkLst>
        </pc:picChg>
        <pc:picChg chg="del mod">
          <ac:chgData name="Yang, Shengming - ARS" userId="37bd5b25-7571-49cb-bfc8-588a18706c35" providerId="ADAL" clId="{289504D4-974E-43B6-9BD4-CC07536E2F15}" dt="2022-03-08T17:22:04.179" v="932" actId="478"/>
          <ac:picMkLst>
            <pc:docMk/>
            <pc:sldMk cId="4208113970" sldId="288"/>
            <ac:picMk id="11" creationId="{61543F96-5AEF-48F7-A896-6222CD062B93}"/>
          </ac:picMkLst>
        </pc:picChg>
        <pc:picChg chg="del">
          <ac:chgData name="Yang, Shengming - ARS" userId="37bd5b25-7571-49cb-bfc8-588a18706c35" providerId="ADAL" clId="{289504D4-974E-43B6-9BD4-CC07536E2F15}" dt="2022-03-08T17:22:04.179" v="932" actId="478"/>
          <ac:picMkLst>
            <pc:docMk/>
            <pc:sldMk cId="4208113970" sldId="288"/>
            <ac:picMk id="13" creationId="{7C857758-7BB1-4B2C-9389-B4776791175A}"/>
          </ac:picMkLst>
        </pc:picChg>
        <pc:picChg chg="del">
          <ac:chgData name="Yang, Shengming - ARS" userId="37bd5b25-7571-49cb-bfc8-588a18706c35" providerId="ADAL" clId="{289504D4-974E-43B6-9BD4-CC07536E2F15}" dt="2022-03-08T17:22:04.179" v="932" actId="478"/>
          <ac:picMkLst>
            <pc:docMk/>
            <pc:sldMk cId="4208113970" sldId="288"/>
            <ac:picMk id="14" creationId="{378C07F1-338D-484D-AC20-21B17222885B}"/>
          </ac:picMkLst>
        </pc:picChg>
        <pc:picChg chg="add del mod">
          <ac:chgData name="Yang, Shengming - ARS" userId="37bd5b25-7571-49cb-bfc8-588a18706c35" providerId="ADAL" clId="{289504D4-974E-43B6-9BD4-CC07536E2F15}" dt="2022-03-08T22:39:43.714" v="1088" actId="478"/>
          <ac:picMkLst>
            <pc:docMk/>
            <pc:sldMk cId="4208113970" sldId="288"/>
            <ac:picMk id="1026" creationId="{A3C49CAD-078E-4F46-8B6B-76DA48AF9441}"/>
          </ac:picMkLst>
        </pc:picChg>
        <pc:cxnChg chg="add mod">
          <ac:chgData name="Yang, Shengming - ARS" userId="37bd5b25-7571-49cb-bfc8-588a18706c35" providerId="ADAL" clId="{289504D4-974E-43B6-9BD4-CC07536E2F15}" dt="2022-03-08T22:43:10.767" v="1101" actId="1037"/>
          <ac:cxnSpMkLst>
            <pc:docMk/>
            <pc:sldMk cId="4208113970" sldId="288"/>
            <ac:cxnSpMk id="12" creationId="{B1465CC9-BB79-4062-B4D0-D09AED9F8095}"/>
          </ac:cxnSpMkLst>
        </pc:cxnChg>
        <pc:cxnChg chg="add mod">
          <ac:chgData name="Yang, Shengming - ARS" userId="37bd5b25-7571-49cb-bfc8-588a18706c35" providerId="ADAL" clId="{289504D4-974E-43B6-9BD4-CC07536E2F15}" dt="2022-03-08T22:42:53.119" v="1097" actId="1076"/>
          <ac:cxnSpMkLst>
            <pc:docMk/>
            <pc:sldMk cId="4208113970" sldId="288"/>
            <ac:cxnSpMk id="19" creationId="{437C8ECA-757C-455A-8F5D-C5C186043E13}"/>
          </ac:cxnSpMkLst>
        </pc:cxnChg>
        <pc:cxnChg chg="add mod">
          <ac:chgData name="Yang, Shengming - ARS" userId="37bd5b25-7571-49cb-bfc8-588a18706c35" providerId="ADAL" clId="{289504D4-974E-43B6-9BD4-CC07536E2F15}" dt="2022-03-08T22:43:03.544" v="1099" actId="1076"/>
          <ac:cxnSpMkLst>
            <pc:docMk/>
            <pc:sldMk cId="4208113970" sldId="288"/>
            <ac:cxnSpMk id="20" creationId="{39A73C54-12D3-4DB5-9D5A-6BA5AAF5FD29}"/>
          </ac:cxnSpMkLst>
        </pc:cxnChg>
      </pc:sldChg>
      <pc:sldChg chg="modSp mod ord">
        <pc:chgData name="Yang, Shengming - ARS" userId="37bd5b25-7571-49cb-bfc8-588a18706c35" providerId="ADAL" clId="{289504D4-974E-43B6-9BD4-CC07536E2F15}" dt="2022-03-08T21:04:44.650" v="971"/>
        <pc:sldMkLst>
          <pc:docMk/>
          <pc:sldMk cId="3220999384" sldId="289"/>
        </pc:sldMkLst>
        <pc:picChg chg="mod">
          <ac:chgData name="Yang, Shengming - ARS" userId="37bd5b25-7571-49cb-bfc8-588a18706c35" providerId="ADAL" clId="{289504D4-974E-43B6-9BD4-CC07536E2F15}" dt="2022-03-03T19:30:24.296" v="918" actId="1038"/>
          <ac:picMkLst>
            <pc:docMk/>
            <pc:sldMk cId="3220999384" sldId="289"/>
            <ac:picMk id="7" creationId="{4130D544-0AFF-4C09-8DFD-EEDB9373AD51}"/>
          </ac:picMkLst>
        </pc:picChg>
        <pc:picChg chg="mod">
          <ac:chgData name="Yang, Shengming - ARS" userId="37bd5b25-7571-49cb-bfc8-588a18706c35" providerId="ADAL" clId="{289504D4-974E-43B6-9BD4-CC07536E2F15}" dt="2022-03-03T19:30:28.616" v="926" actId="1038"/>
          <ac:picMkLst>
            <pc:docMk/>
            <pc:sldMk cId="3220999384" sldId="289"/>
            <ac:picMk id="9" creationId="{C5B88DC7-B98B-477C-B267-D0F84E4D58E2}"/>
          </ac:picMkLst>
        </pc:picChg>
        <pc:picChg chg="mod">
          <ac:chgData name="Yang, Shengming - ARS" userId="37bd5b25-7571-49cb-bfc8-588a18706c35" providerId="ADAL" clId="{289504D4-974E-43B6-9BD4-CC07536E2F15}" dt="2022-03-03T19:30:11.676" v="914" actId="1076"/>
          <ac:picMkLst>
            <pc:docMk/>
            <pc:sldMk cId="3220999384" sldId="289"/>
            <ac:picMk id="10" creationId="{21D12051-BEF0-4E1F-8275-3E630826FCA4}"/>
          </ac:picMkLst>
        </pc:picChg>
      </pc:sldChg>
      <pc:sldChg chg="addSp delSp modSp mod ord">
        <pc:chgData name="Yang, Shengming - ARS" userId="37bd5b25-7571-49cb-bfc8-588a18706c35" providerId="ADAL" clId="{289504D4-974E-43B6-9BD4-CC07536E2F15}" dt="2022-03-08T21:25:56.963" v="978" actId="1036"/>
        <pc:sldMkLst>
          <pc:docMk/>
          <pc:sldMk cId="2200906561" sldId="290"/>
        </pc:sldMkLst>
        <pc:spChg chg="add mod">
          <ac:chgData name="Yang, Shengming - ARS" userId="37bd5b25-7571-49cb-bfc8-588a18706c35" providerId="ADAL" clId="{289504D4-974E-43B6-9BD4-CC07536E2F15}" dt="2022-03-01T23:34:12.445" v="806" actId="14100"/>
          <ac:spMkLst>
            <pc:docMk/>
            <pc:sldMk cId="2200906561" sldId="290"/>
            <ac:spMk id="2" creationId="{A2F7D376-CEC0-4D66-B142-AEEB489FFC22}"/>
          </ac:spMkLst>
        </pc:spChg>
        <pc:spChg chg="mod">
          <ac:chgData name="Yang, Shengming - ARS" userId="37bd5b25-7571-49cb-bfc8-588a18706c35" providerId="ADAL" clId="{289504D4-974E-43B6-9BD4-CC07536E2F15}" dt="2022-03-01T17:27:16.508" v="105"/>
          <ac:spMkLst>
            <pc:docMk/>
            <pc:sldMk cId="2200906561" sldId="290"/>
            <ac:spMk id="4" creationId="{946EAD36-829D-4435-8EF5-838177F33C5A}"/>
          </ac:spMkLst>
        </pc:spChg>
        <pc:spChg chg="mod">
          <ac:chgData name="Yang, Shengming - ARS" userId="37bd5b25-7571-49cb-bfc8-588a18706c35" providerId="ADAL" clId="{289504D4-974E-43B6-9BD4-CC07536E2F15}" dt="2022-03-01T17:27:16.508" v="105"/>
          <ac:spMkLst>
            <pc:docMk/>
            <pc:sldMk cId="2200906561" sldId="290"/>
            <ac:spMk id="8" creationId="{36DC9297-1576-4510-ADFC-BA715607ECFF}"/>
          </ac:spMkLst>
        </pc:spChg>
        <pc:spChg chg="del mod">
          <ac:chgData name="Yang, Shengming - ARS" userId="37bd5b25-7571-49cb-bfc8-588a18706c35" providerId="ADAL" clId="{289504D4-974E-43B6-9BD4-CC07536E2F15}" dt="2022-03-01T23:31:56.604" v="745" actId="478"/>
          <ac:spMkLst>
            <pc:docMk/>
            <pc:sldMk cId="2200906561" sldId="290"/>
            <ac:spMk id="9" creationId="{326B85DA-5FEB-49AA-9B1D-779F6E66A986}"/>
          </ac:spMkLst>
        </pc:spChg>
        <pc:spChg chg="mod">
          <ac:chgData name="Yang, Shengming - ARS" userId="37bd5b25-7571-49cb-bfc8-588a18706c35" providerId="ADAL" clId="{289504D4-974E-43B6-9BD4-CC07536E2F15}" dt="2022-03-01T17:27:16.508" v="105"/>
          <ac:spMkLst>
            <pc:docMk/>
            <pc:sldMk cId="2200906561" sldId="290"/>
            <ac:spMk id="10" creationId="{7577A3C2-6B22-48DB-89A8-C899A30379FD}"/>
          </ac:spMkLst>
        </pc:spChg>
        <pc:spChg chg="mod">
          <ac:chgData name="Yang, Shengming - ARS" userId="37bd5b25-7571-49cb-bfc8-588a18706c35" providerId="ADAL" clId="{289504D4-974E-43B6-9BD4-CC07536E2F15}" dt="2022-03-01T17:27:16.508" v="105"/>
          <ac:spMkLst>
            <pc:docMk/>
            <pc:sldMk cId="2200906561" sldId="290"/>
            <ac:spMk id="11" creationId="{6DF76095-3890-4934-B864-6AB8F0D85EEF}"/>
          </ac:spMkLst>
        </pc:spChg>
        <pc:spChg chg="mod">
          <ac:chgData name="Yang, Shengming - ARS" userId="37bd5b25-7571-49cb-bfc8-588a18706c35" providerId="ADAL" clId="{289504D4-974E-43B6-9BD4-CC07536E2F15}" dt="2022-03-01T17:27:16.508" v="105"/>
          <ac:spMkLst>
            <pc:docMk/>
            <pc:sldMk cId="2200906561" sldId="290"/>
            <ac:spMk id="12" creationId="{E5827669-7030-4353-B4CC-725E09EEFE08}"/>
          </ac:spMkLst>
        </pc:spChg>
        <pc:spChg chg="mod">
          <ac:chgData name="Yang, Shengming - ARS" userId="37bd5b25-7571-49cb-bfc8-588a18706c35" providerId="ADAL" clId="{289504D4-974E-43B6-9BD4-CC07536E2F15}" dt="2022-03-01T17:27:16.508" v="105"/>
          <ac:spMkLst>
            <pc:docMk/>
            <pc:sldMk cId="2200906561" sldId="290"/>
            <ac:spMk id="13" creationId="{8112C84C-854D-4441-B88D-98E52681B89E}"/>
          </ac:spMkLst>
        </pc:spChg>
        <pc:spChg chg="mod">
          <ac:chgData name="Yang, Shengming - ARS" userId="37bd5b25-7571-49cb-bfc8-588a18706c35" providerId="ADAL" clId="{289504D4-974E-43B6-9BD4-CC07536E2F15}" dt="2022-03-01T17:27:16.508" v="105"/>
          <ac:spMkLst>
            <pc:docMk/>
            <pc:sldMk cId="2200906561" sldId="290"/>
            <ac:spMk id="14" creationId="{CF673D4A-1F3B-427A-9185-5D9A4B8C25E1}"/>
          </ac:spMkLst>
        </pc:spChg>
        <pc:spChg chg="mod">
          <ac:chgData name="Yang, Shengming - ARS" userId="37bd5b25-7571-49cb-bfc8-588a18706c35" providerId="ADAL" clId="{289504D4-974E-43B6-9BD4-CC07536E2F15}" dt="2022-03-01T17:27:16.508" v="105"/>
          <ac:spMkLst>
            <pc:docMk/>
            <pc:sldMk cId="2200906561" sldId="290"/>
            <ac:spMk id="15" creationId="{CFB31429-3063-48DA-88D9-23E75DB9A022}"/>
          </ac:spMkLst>
        </pc:spChg>
        <pc:spChg chg="mod">
          <ac:chgData name="Yang, Shengming - ARS" userId="37bd5b25-7571-49cb-bfc8-588a18706c35" providerId="ADAL" clId="{289504D4-974E-43B6-9BD4-CC07536E2F15}" dt="2022-03-01T17:27:16.508" v="105"/>
          <ac:spMkLst>
            <pc:docMk/>
            <pc:sldMk cId="2200906561" sldId="290"/>
            <ac:spMk id="16" creationId="{48BD50A8-49FF-42A1-BDB1-8C2573F79500}"/>
          </ac:spMkLst>
        </pc:spChg>
        <pc:spChg chg="mod">
          <ac:chgData name="Yang, Shengming - ARS" userId="37bd5b25-7571-49cb-bfc8-588a18706c35" providerId="ADAL" clId="{289504D4-974E-43B6-9BD4-CC07536E2F15}" dt="2022-03-01T17:27:16.508" v="105"/>
          <ac:spMkLst>
            <pc:docMk/>
            <pc:sldMk cId="2200906561" sldId="290"/>
            <ac:spMk id="17" creationId="{1EC31783-90F6-467C-8121-E38373278FCF}"/>
          </ac:spMkLst>
        </pc:spChg>
        <pc:spChg chg="mod">
          <ac:chgData name="Yang, Shengming - ARS" userId="37bd5b25-7571-49cb-bfc8-588a18706c35" providerId="ADAL" clId="{289504D4-974E-43B6-9BD4-CC07536E2F15}" dt="2022-03-01T17:27:16.508" v="105"/>
          <ac:spMkLst>
            <pc:docMk/>
            <pc:sldMk cId="2200906561" sldId="290"/>
            <ac:spMk id="18" creationId="{BA11BEFD-3271-4E11-ACEF-D831709EDAEA}"/>
          </ac:spMkLst>
        </pc:spChg>
        <pc:spChg chg="mod">
          <ac:chgData name="Yang, Shengming - ARS" userId="37bd5b25-7571-49cb-bfc8-588a18706c35" providerId="ADAL" clId="{289504D4-974E-43B6-9BD4-CC07536E2F15}" dt="2022-03-01T17:27:16.508" v="105"/>
          <ac:spMkLst>
            <pc:docMk/>
            <pc:sldMk cId="2200906561" sldId="290"/>
            <ac:spMk id="19" creationId="{1128A898-0A6B-4CAE-BD68-DCE3F7A825B3}"/>
          </ac:spMkLst>
        </pc:spChg>
        <pc:spChg chg="mod">
          <ac:chgData name="Yang, Shengming - ARS" userId="37bd5b25-7571-49cb-bfc8-588a18706c35" providerId="ADAL" clId="{289504D4-974E-43B6-9BD4-CC07536E2F15}" dt="2022-03-01T17:27:16.508" v="105"/>
          <ac:spMkLst>
            <pc:docMk/>
            <pc:sldMk cId="2200906561" sldId="290"/>
            <ac:spMk id="20" creationId="{14870B67-087F-4D69-B242-8E11FF755D47}"/>
          </ac:spMkLst>
        </pc:spChg>
        <pc:spChg chg="mod">
          <ac:chgData name="Yang, Shengming - ARS" userId="37bd5b25-7571-49cb-bfc8-588a18706c35" providerId="ADAL" clId="{289504D4-974E-43B6-9BD4-CC07536E2F15}" dt="2022-03-01T17:27:16.508" v="105"/>
          <ac:spMkLst>
            <pc:docMk/>
            <pc:sldMk cId="2200906561" sldId="290"/>
            <ac:spMk id="21" creationId="{7876C165-0C4C-455D-880A-30131CBDAA61}"/>
          </ac:spMkLst>
        </pc:spChg>
        <pc:spChg chg="mod">
          <ac:chgData name="Yang, Shengming - ARS" userId="37bd5b25-7571-49cb-bfc8-588a18706c35" providerId="ADAL" clId="{289504D4-974E-43B6-9BD4-CC07536E2F15}" dt="2022-03-01T17:27:16.508" v="105"/>
          <ac:spMkLst>
            <pc:docMk/>
            <pc:sldMk cId="2200906561" sldId="290"/>
            <ac:spMk id="22" creationId="{0B214CA8-4C71-480A-BB1B-6D6D9E5F1C87}"/>
          </ac:spMkLst>
        </pc:spChg>
        <pc:spChg chg="mod">
          <ac:chgData name="Yang, Shengming - ARS" userId="37bd5b25-7571-49cb-bfc8-588a18706c35" providerId="ADAL" clId="{289504D4-974E-43B6-9BD4-CC07536E2F15}" dt="2022-03-01T17:27:16.508" v="105"/>
          <ac:spMkLst>
            <pc:docMk/>
            <pc:sldMk cId="2200906561" sldId="290"/>
            <ac:spMk id="23" creationId="{1240F30C-4674-4C01-8826-F1FD0915D997}"/>
          </ac:spMkLst>
        </pc:spChg>
        <pc:spChg chg="mod">
          <ac:chgData name="Yang, Shengming - ARS" userId="37bd5b25-7571-49cb-bfc8-588a18706c35" providerId="ADAL" clId="{289504D4-974E-43B6-9BD4-CC07536E2F15}" dt="2022-03-01T17:27:16.508" v="105"/>
          <ac:spMkLst>
            <pc:docMk/>
            <pc:sldMk cId="2200906561" sldId="290"/>
            <ac:spMk id="24" creationId="{B813E31A-A06D-48CF-98D4-5B1F8FFBB3CA}"/>
          </ac:spMkLst>
        </pc:spChg>
        <pc:spChg chg="mod">
          <ac:chgData name="Yang, Shengming - ARS" userId="37bd5b25-7571-49cb-bfc8-588a18706c35" providerId="ADAL" clId="{289504D4-974E-43B6-9BD4-CC07536E2F15}" dt="2022-03-01T17:27:16.508" v="105"/>
          <ac:spMkLst>
            <pc:docMk/>
            <pc:sldMk cId="2200906561" sldId="290"/>
            <ac:spMk id="25" creationId="{3BBD6B91-7B8F-4F4E-8AC8-E8DF9B00A6D7}"/>
          </ac:spMkLst>
        </pc:spChg>
        <pc:spChg chg="mod">
          <ac:chgData name="Yang, Shengming - ARS" userId="37bd5b25-7571-49cb-bfc8-588a18706c35" providerId="ADAL" clId="{289504D4-974E-43B6-9BD4-CC07536E2F15}" dt="2022-03-01T17:27:16.508" v="105"/>
          <ac:spMkLst>
            <pc:docMk/>
            <pc:sldMk cId="2200906561" sldId="290"/>
            <ac:spMk id="26" creationId="{CCFFA158-CE20-44CB-A116-E63DB440439E}"/>
          </ac:spMkLst>
        </pc:spChg>
        <pc:spChg chg="mod">
          <ac:chgData name="Yang, Shengming - ARS" userId="37bd5b25-7571-49cb-bfc8-588a18706c35" providerId="ADAL" clId="{289504D4-974E-43B6-9BD4-CC07536E2F15}" dt="2022-03-01T17:27:16.508" v="105"/>
          <ac:spMkLst>
            <pc:docMk/>
            <pc:sldMk cId="2200906561" sldId="290"/>
            <ac:spMk id="27" creationId="{501719DD-DE10-48AB-9913-6DB8693F41B5}"/>
          </ac:spMkLst>
        </pc:spChg>
        <pc:spChg chg="mod">
          <ac:chgData name="Yang, Shengming - ARS" userId="37bd5b25-7571-49cb-bfc8-588a18706c35" providerId="ADAL" clId="{289504D4-974E-43B6-9BD4-CC07536E2F15}" dt="2022-03-01T17:27:16.508" v="105"/>
          <ac:spMkLst>
            <pc:docMk/>
            <pc:sldMk cId="2200906561" sldId="290"/>
            <ac:spMk id="28" creationId="{60712AB3-9316-40E4-AE3A-0DFBC08DEBB5}"/>
          </ac:spMkLst>
        </pc:spChg>
        <pc:spChg chg="mod">
          <ac:chgData name="Yang, Shengming - ARS" userId="37bd5b25-7571-49cb-bfc8-588a18706c35" providerId="ADAL" clId="{289504D4-974E-43B6-9BD4-CC07536E2F15}" dt="2022-03-01T17:27:16.508" v="105"/>
          <ac:spMkLst>
            <pc:docMk/>
            <pc:sldMk cId="2200906561" sldId="290"/>
            <ac:spMk id="29" creationId="{7A4DE73A-2EB8-45B0-A9E5-7F7B4F25B69A}"/>
          </ac:spMkLst>
        </pc:spChg>
        <pc:spChg chg="mod">
          <ac:chgData name="Yang, Shengming - ARS" userId="37bd5b25-7571-49cb-bfc8-588a18706c35" providerId="ADAL" clId="{289504D4-974E-43B6-9BD4-CC07536E2F15}" dt="2022-03-01T17:27:16.508" v="105"/>
          <ac:spMkLst>
            <pc:docMk/>
            <pc:sldMk cId="2200906561" sldId="290"/>
            <ac:spMk id="30" creationId="{28A40EE9-1728-4EB0-BE8D-68F65172E0EB}"/>
          </ac:spMkLst>
        </pc:spChg>
        <pc:spChg chg="add mod">
          <ac:chgData name="Yang, Shengming - ARS" userId="37bd5b25-7571-49cb-bfc8-588a18706c35" providerId="ADAL" clId="{289504D4-974E-43B6-9BD4-CC07536E2F15}" dt="2022-03-01T23:33:38.250" v="802" actId="1035"/>
          <ac:spMkLst>
            <pc:docMk/>
            <pc:sldMk cId="2200906561" sldId="290"/>
            <ac:spMk id="33" creationId="{77A24B76-A729-4DC5-8F5A-2DB0F984B97A}"/>
          </ac:spMkLst>
        </pc:spChg>
        <pc:spChg chg="add mod">
          <ac:chgData name="Yang, Shengming - ARS" userId="37bd5b25-7571-49cb-bfc8-588a18706c35" providerId="ADAL" clId="{289504D4-974E-43B6-9BD4-CC07536E2F15}" dt="2022-03-01T23:33:38.250" v="802" actId="1035"/>
          <ac:spMkLst>
            <pc:docMk/>
            <pc:sldMk cId="2200906561" sldId="290"/>
            <ac:spMk id="34" creationId="{89A6CE6C-E56F-4061-9F1A-069127A5E4C0}"/>
          </ac:spMkLst>
        </pc:spChg>
        <pc:spChg chg="add mod">
          <ac:chgData name="Yang, Shengming - ARS" userId="37bd5b25-7571-49cb-bfc8-588a18706c35" providerId="ADAL" clId="{289504D4-974E-43B6-9BD4-CC07536E2F15}" dt="2022-03-01T23:33:38.250" v="802" actId="1035"/>
          <ac:spMkLst>
            <pc:docMk/>
            <pc:sldMk cId="2200906561" sldId="290"/>
            <ac:spMk id="35" creationId="{2D895EAE-B738-4D0C-82F6-46E78806A5F4}"/>
          </ac:spMkLst>
        </pc:spChg>
        <pc:spChg chg="add mod">
          <ac:chgData name="Yang, Shengming - ARS" userId="37bd5b25-7571-49cb-bfc8-588a18706c35" providerId="ADAL" clId="{289504D4-974E-43B6-9BD4-CC07536E2F15}" dt="2022-03-01T23:33:38.250" v="802" actId="1035"/>
          <ac:spMkLst>
            <pc:docMk/>
            <pc:sldMk cId="2200906561" sldId="290"/>
            <ac:spMk id="36" creationId="{DBF3A838-897B-412E-AD15-4C8FB837AFF4}"/>
          </ac:spMkLst>
        </pc:spChg>
        <pc:spChg chg="add mod">
          <ac:chgData name="Yang, Shengming - ARS" userId="37bd5b25-7571-49cb-bfc8-588a18706c35" providerId="ADAL" clId="{289504D4-974E-43B6-9BD4-CC07536E2F15}" dt="2022-03-01T23:33:38.250" v="802" actId="1035"/>
          <ac:spMkLst>
            <pc:docMk/>
            <pc:sldMk cId="2200906561" sldId="290"/>
            <ac:spMk id="37" creationId="{21A3EEC1-D831-4CEA-BE58-3F6F6C54B6C2}"/>
          </ac:spMkLst>
        </pc:spChg>
        <pc:spChg chg="add mod">
          <ac:chgData name="Yang, Shengming - ARS" userId="37bd5b25-7571-49cb-bfc8-588a18706c35" providerId="ADAL" clId="{289504D4-974E-43B6-9BD4-CC07536E2F15}" dt="2022-03-01T23:33:38.250" v="802" actId="1035"/>
          <ac:spMkLst>
            <pc:docMk/>
            <pc:sldMk cId="2200906561" sldId="290"/>
            <ac:spMk id="38" creationId="{0944D13C-54FA-43B8-BBC3-29B5FFE75A46}"/>
          </ac:spMkLst>
        </pc:spChg>
        <pc:spChg chg="add mod">
          <ac:chgData name="Yang, Shengming - ARS" userId="37bd5b25-7571-49cb-bfc8-588a18706c35" providerId="ADAL" clId="{289504D4-974E-43B6-9BD4-CC07536E2F15}" dt="2022-03-01T23:33:38.250" v="802" actId="1035"/>
          <ac:spMkLst>
            <pc:docMk/>
            <pc:sldMk cId="2200906561" sldId="290"/>
            <ac:spMk id="39" creationId="{95CF3898-BB6B-412C-B065-75BFC472289E}"/>
          </ac:spMkLst>
        </pc:spChg>
        <pc:spChg chg="add mod">
          <ac:chgData name="Yang, Shengming - ARS" userId="37bd5b25-7571-49cb-bfc8-588a18706c35" providerId="ADAL" clId="{289504D4-974E-43B6-9BD4-CC07536E2F15}" dt="2022-03-01T23:33:38.250" v="802" actId="1035"/>
          <ac:spMkLst>
            <pc:docMk/>
            <pc:sldMk cId="2200906561" sldId="290"/>
            <ac:spMk id="53" creationId="{472A017D-0015-4852-A108-99DB3C7D9201}"/>
          </ac:spMkLst>
        </pc:spChg>
        <pc:spChg chg="add mod">
          <ac:chgData name="Yang, Shengming - ARS" userId="37bd5b25-7571-49cb-bfc8-588a18706c35" providerId="ADAL" clId="{289504D4-974E-43B6-9BD4-CC07536E2F15}" dt="2022-03-01T23:33:38.250" v="802" actId="1035"/>
          <ac:spMkLst>
            <pc:docMk/>
            <pc:sldMk cId="2200906561" sldId="290"/>
            <ac:spMk id="54" creationId="{256A1F56-CBCA-453A-916A-82BDD8E4766A}"/>
          </ac:spMkLst>
        </pc:spChg>
        <pc:spChg chg="add mod">
          <ac:chgData name="Yang, Shengming - ARS" userId="37bd5b25-7571-49cb-bfc8-588a18706c35" providerId="ADAL" clId="{289504D4-974E-43B6-9BD4-CC07536E2F15}" dt="2022-03-01T23:33:38.250" v="802" actId="1035"/>
          <ac:spMkLst>
            <pc:docMk/>
            <pc:sldMk cId="2200906561" sldId="290"/>
            <ac:spMk id="55" creationId="{6AC55977-2C63-42C9-B5E1-0F8350EF00A9}"/>
          </ac:spMkLst>
        </pc:spChg>
        <pc:spChg chg="add mod">
          <ac:chgData name="Yang, Shengming - ARS" userId="37bd5b25-7571-49cb-bfc8-588a18706c35" providerId="ADAL" clId="{289504D4-974E-43B6-9BD4-CC07536E2F15}" dt="2022-03-01T23:39:18.159" v="898" actId="1076"/>
          <ac:spMkLst>
            <pc:docMk/>
            <pc:sldMk cId="2200906561" sldId="290"/>
            <ac:spMk id="58" creationId="{127FACC4-AEA3-45C6-A512-B76CA41EF55B}"/>
          </ac:spMkLst>
        </pc:spChg>
        <pc:spChg chg="add mod">
          <ac:chgData name="Yang, Shengming - ARS" userId="37bd5b25-7571-49cb-bfc8-588a18706c35" providerId="ADAL" clId="{289504D4-974E-43B6-9BD4-CC07536E2F15}" dt="2022-03-01T23:34:17.187" v="809" actId="1035"/>
          <ac:spMkLst>
            <pc:docMk/>
            <pc:sldMk cId="2200906561" sldId="290"/>
            <ac:spMk id="60" creationId="{DD355DBD-69B4-4C1F-A384-0380D48C32B0}"/>
          </ac:spMkLst>
        </pc:spChg>
        <pc:grpChg chg="add del mod">
          <ac:chgData name="Yang, Shengming - ARS" userId="37bd5b25-7571-49cb-bfc8-588a18706c35" providerId="ADAL" clId="{289504D4-974E-43B6-9BD4-CC07536E2F15}" dt="2022-03-01T23:14:10.911" v="642" actId="478"/>
          <ac:grpSpMkLst>
            <pc:docMk/>
            <pc:sldMk cId="2200906561" sldId="290"/>
            <ac:grpSpMk id="3" creationId="{4081E69B-73AC-43EF-BCC1-391DE6A2E7B6}"/>
          </ac:grpSpMkLst>
        </pc:grpChg>
        <pc:picChg chg="mod">
          <ac:chgData name="Yang, Shengming - ARS" userId="37bd5b25-7571-49cb-bfc8-588a18706c35" providerId="ADAL" clId="{289504D4-974E-43B6-9BD4-CC07536E2F15}" dt="2022-03-01T17:27:16.508" v="105"/>
          <ac:picMkLst>
            <pc:docMk/>
            <pc:sldMk cId="2200906561" sldId="290"/>
            <ac:picMk id="5" creationId="{3BAFD58E-D957-4E0D-81C7-5238AEDA6B5E}"/>
          </ac:picMkLst>
        </pc:picChg>
        <pc:picChg chg="mod">
          <ac:chgData name="Yang, Shengming - ARS" userId="37bd5b25-7571-49cb-bfc8-588a18706c35" providerId="ADAL" clId="{289504D4-974E-43B6-9BD4-CC07536E2F15}" dt="2022-03-01T17:27:16.508" v="105"/>
          <ac:picMkLst>
            <pc:docMk/>
            <pc:sldMk cId="2200906561" sldId="290"/>
            <ac:picMk id="6" creationId="{929ECBF2-E638-4F2F-B072-9478FC4B239E}"/>
          </ac:picMkLst>
        </pc:picChg>
        <pc:picChg chg="mod">
          <ac:chgData name="Yang, Shengming - ARS" userId="37bd5b25-7571-49cb-bfc8-588a18706c35" providerId="ADAL" clId="{289504D4-974E-43B6-9BD4-CC07536E2F15}" dt="2022-03-01T17:27:16.508" v="105"/>
          <ac:picMkLst>
            <pc:docMk/>
            <pc:sldMk cId="2200906561" sldId="290"/>
            <ac:picMk id="7" creationId="{6D222787-D72D-48FD-AD19-42ECC769C878}"/>
          </ac:picMkLst>
        </pc:picChg>
        <pc:picChg chg="add mod">
          <ac:chgData name="Yang, Shengming - ARS" userId="37bd5b25-7571-49cb-bfc8-588a18706c35" providerId="ADAL" clId="{289504D4-974E-43B6-9BD4-CC07536E2F15}" dt="2022-03-01T23:33:38.250" v="802" actId="1035"/>
          <ac:picMkLst>
            <pc:docMk/>
            <pc:sldMk cId="2200906561" sldId="290"/>
            <ac:picMk id="32" creationId="{9B5FC26D-2091-4B11-8195-3875F8DFCCEA}"/>
          </ac:picMkLst>
        </pc:picChg>
        <pc:cxnChg chg="mod">
          <ac:chgData name="Yang, Shengming - ARS" userId="37bd5b25-7571-49cb-bfc8-588a18706c35" providerId="ADAL" clId="{289504D4-974E-43B6-9BD4-CC07536E2F15}" dt="2022-03-01T17:27:16.508" v="105"/>
          <ac:cxnSpMkLst>
            <pc:docMk/>
            <pc:sldMk cId="2200906561" sldId="290"/>
            <ac:cxnSpMk id="31" creationId="{5E253C47-8A83-4DB1-AB8F-C21EA6B09A54}"/>
          </ac:cxnSpMkLst>
        </pc:cxnChg>
        <pc:cxnChg chg="add mod">
          <ac:chgData name="Yang, Shengming - ARS" userId="37bd5b25-7571-49cb-bfc8-588a18706c35" providerId="ADAL" clId="{289504D4-974E-43B6-9BD4-CC07536E2F15}" dt="2022-03-01T23:33:38.250" v="802" actId="1035"/>
          <ac:cxnSpMkLst>
            <pc:docMk/>
            <pc:sldMk cId="2200906561" sldId="290"/>
            <ac:cxnSpMk id="40" creationId="{AB1CABE9-60A7-4332-A43E-6D328985B38F}"/>
          </ac:cxnSpMkLst>
        </pc:cxnChg>
        <pc:cxnChg chg="add mod">
          <ac:chgData name="Yang, Shengming - ARS" userId="37bd5b25-7571-49cb-bfc8-588a18706c35" providerId="ADAL" clId="{289504D4-974E-43B6-9BD4-CC07536E2F15}" dt="2022-03-01T23:33:38.250" v="802" actId="1035"/>
          <ac:cxnSpMkLst>
            <pc:docMk/>
            <pc:sldMk cId="2200906561" sldId="290"/>
            <ac:cxnSpMk id="41" creationId="{AA870F86-3D05-46BA-B90E-A85661962AB5}"/>
          </ac:cxnSpMkLst>
        </pc:cxnChg>
        <pc:cxnChg chg="add mod">
          <ac:chgData name="Yang, Shengming - ARS" userId="37bd5b25-7571-49cb-bfc8-588a18706c35" providerId="ADAL" clId="{289504D4-974E-43B6-9BD4-CC07536E2F15}" dt="2022-03-01T23:33:38.250" v="802" actId="1035"/>
          <ac:cxnSpMkLst>
            <pc:docMk/>
            <pc:sldMk cId="2200906561" sldId="290"/>
            <ac:cxnSpMk id="42" creationId="{3AB0FFAE-9AFA-4E18-86B1-FE88A43BFE6B}"/>
          </ac:cxnSpMkLst>
        </pc:cxnChg>
        <pc:cxnChg chg="add mod">
          <ac:chgData name="Yang, Shengming - ARS" userId="37bd5b25-7571-49cb-bfc8-588a18706c35" providerId="ADAL" clId="{289504D4-974E-43B6-9BD4-CC07536E2F15}" dt="2022-03-01T23:33:38.250" v="802" actId="1035"/>
          <ac:cxnSpMkLst>
            <pc:docMk/>
            <pc:sldMk cId="2200906561" sldId="290"/>
            <ac:cxnSpMk id="43" creationId="{6512070E-123F-49F2-B5B8-951CB03E962D}"/>
          </ac:cxnSpMkLst>
        </pc:cxnChg>
        <pc:cxnChg chg="add mod">
          <ac:chgData name="Yang, Shengming - ARS" userId="37bd5b25-7571-49cb-bfc8-588a18706c35" providerId="ADAL" clId="{289504D4-974E-43B6-9BD4-CC07536E2F15}" dt="2022-03-01T23:33:38.250" v="802" actId="1035"/>
          <ac:cxnSpMkLst>
            <pc:docMk/>
            <pc:sldMk cId="2200906561" sldId="290"/>
            <ac:cxnSpMk id="44" creationId="{62BA9983-333A-45F0-94A5-1E94EDB9ADF9}"/>
          </ac:cxnSpMkLst>
        </pc:cxnChg>
        <pc:cxnChg chg="add mod">
          <ac:chgData name="Yang, Shengming - ARS" userId="37bd5b25-7571-49cb-bfc8-588a18706c35" providerId="ADAL" clId="{289504D4-974E-43B6-9BD4-CC07536E2F15}" dt="2022-03-01T23:33:38.250" v="802" actId="1035"/>
          <ac:cxnSpMkLst>
            <pc:docMk/>
            <pc:sldMk cId="2200906561" sldId="290"/>
            <ac:cxnSpMk id="45" creationId="{8742B4A1-04A3-44F0-B4CE-ABE220043032}"/>
          </ac:cxnSpMkLst>
        </pc:cxnChg>
        <pc:cxnChg chg="add mod">
          <ac:chgData name="Yang, Shengming - ARS" userId="37bd5b25-7571-49cb-bfc8-588a18706c35" providerId="ADAL" clId="{289504D4-974E-43B6-9BD4-CC07536E2F15}" dt="2022-03-01T23:33:38.250" v="802" actId="1035"/>
          <ac:cxnSpMkLst>
            <pc:docMk/>
            <pc:sldMk cId="2200906561" sldId="290"/>
            <ac:cxnSpMk id="46" creationId="{97C8592F-5FA8-4CCF-8703-6485971FAAF1}"/>
          </ac:cxnSpMkLst>
        </pc:cxnChg>
        <pc:cxnChg chg="add mod">
          <ac:chgData name="Yang, Shengming - ARS" userId="37bd5b25-7571-49cb-bfc8-588a18706c35" providerId="ADAL" clId="{289504D4-974E-43B6-9BD4-CC07536E2F15}" dt="2022-03-01T23:33:38.250" v="802" actId="1035"/>
          <ac:cxnSpMkLst>
            <pc:docMk/>
            <pc:sldMk cId="2200906561" sldId="290"/>
            <ac:cxnSpMk id="47" creationId="{BF23A8AF-112E-4468-BE99-E8A45BDDB97A}"/>
          </ac:cxnSpMkLst>
        </pc:cxnChg>
        <pc:cxnChg chg="add mod">
          <ac:chgData name="Yang, Shengming - ARS" userId="37bd5b25-7571-49cb-bfc8-588a18706c35" providerId="ADAL" clId="{289504D4-974E-43B6-9BD4-CC07536E2F15}" dt="2022-03-01T23:33:38.250" v="802" actId="1035"/>
          <ac:cxnSpMkLst>
            <pc:docMk/>
            <pc:sldMk cId="2200906561" sldId="290"/>
            <ac:cxnSpMk id="48" creationId="{FF3CFF44-B4BF-4F86-8BD5-DED17FFC3FCD}"/>
          </ac:cxnSpMkLst>
        </pc:cxnChg>
        <pc:cxnChg chg="add mod">
          <ac:chgData name="Yang, Shengming - ARS" userId="37bd5b25-7571-49cb-bfc8-588a18706c35" providerId="ADAL" clId="{289504D4-974E-43B6-9BD4-CC07536E2F15}" dt="2022-03-01T23:33:38.250" v="802" actId="1035"/>
          <ac:cxnSpMkLst>
            <pc:docMk/>
            <pc:sldMk cId="2200906561" sldId="290"/>
            <ac:cxnSpMk id="49" creationId="{83764279-2293-4094-89A5-86D090512CB5}"/>
          </ac:cxnSpMkLst>
        </pc:cxnChg>
        <pc:cxnChg chg="add mod">
          <ac:chgData name="Yang, Shengming - ARS" userId="37bd5b25-7571-49cb-bfc8-588a18706c35" providerId="ADAL" clId="{289504D4-974E-43B6-9BD4-CC07536E2F15}" dt="2022-03-01T23:33:38.250" v="802" actId="1035"/>
          <ac:cxnSpMkLst>
            <pc:docMk/>
            <pc:sldMk cId="2200906561" sldId="290"/>
            <ac:cxnSpMk id="50" creationId="{27EB8523-F95C-4106-BF4D-405564A2E44A}"/>
          </ac:cxnSpMkLst>
        </pc:cxnChg>
        <pc:cxnChg chg="add mod">
          <ac:chgData name="Yang, Shengming - ARS" userId="37bd5b25-7571-49cb-bfc8-588a18706c35" providerId="ADAL" clId="{289504D4-974E-43B6-9BD4-CC07536E2F15}" dt="2022-03-01T23:33:38.250" v="802" actId="1035"/>
          <ac:cxnSpMkLst>
            <pc:docMk/>
            <pc:sldMk cId="2200906561" sldId="290"/>
            <ac:cxnSpMk id="51" creationId="{2D9853D5-9625-4B43-88CF-B313DDC91569}"/>
          </ac:cxnSpMkLst>
        </pc:cxnChg>
        <pc:cxnChg chg="add mod">
          <ac:chgData name="Yang, Shengming - ARS" userId="37bd5b25-7571-49cb-bfc8-588a18706c35" providerId="ADAL" clId="{289504D4-974E-43B6-9BD4-CC07536E2F15}" dt="2022-03-01T23:33:38.250" v="802" actId="1035"/>
          <ac:cxnSpMkLst>
            <pc:docMk/>
            <pc:sldMk cId="2200906561" sldId="290"/>
            <ac:cxnSpMk id="52" creationId="{4297ACDF-85C0-4987-AF58-299FE3ECD858}"/>
          </ac:cxnSpMkLst>
        </pc:cxnChg>
        <pc:cxnChg chg="add mod">
          <ac:chgData name="Yang, Shengming - ARS" userId="37bd5b25-7571-49cb-bfc8-588a18706c35" providerId="ADAL" clId="{289504D4-974E-43B6-9BD4-CC07536E2F15}" dt="2022-03-08T21:25:56.963" v="978" actId="1036"/>
          <ac:cxnSpMkLst>
            <pc:docMk/>
            <pc:sldMk cId="2200906561" sldId="290"/>
            <ac:cxnSpMk id="57" creationId="{08E779B1-90CA-4359-BC50-8CBA26A4F260}"/>
          </ac:cxnSpMkLst>
        </pc:cxnChg>
      </pc:sldChg>
      <pc:sldChg chg="addSp delSp modSp new del mod modNotesTx">
        <pc:chgData name="Yang, Shengming - ARS" userId="37bd5b25-7571-49cb-bfc8-588a18706c35" providerId="ADAL" clId="{289504D4-974E-43B6-9BD4-CC07536E2F15}" dt="2022-03-03T19:38:25.002" v="930" actId="47"/>
        <pc:sldMkLst>
          <pc:docMk/>
          <pc:sldMk cId="752224780" sldId="291"/>
        </pc:sldMkLst>
        <pc:spChg chg="del">
          <ac:chgData name="Yang, Shengming - ARS" userId="37bd5b25-7571-49cb-bfc8-588a18706c35" providerId="ADAL" clId="{289504D4-974E-43B6-9BD4-CC07536E2F15}" dt="2022-03-01T22:43:50.050" v="112" actId="478"/>
          <ac:spMkLst>
            <pc:docMk/>
            <pc:sldMk cId="752224780" sldId="291"/>
            <ac:spMk id="2" creationId="{99ECE07D-F662-4D66-A533-ACE8DF5511B2}"/>
          </ac:spMkLst>
        </pc:spChg>
        <pc:spChg chg="del">
          <ac:chgData name="Yang, Shengming - ARS" userId="37bd5b25-7571-49cb-bfc8-588a18706c35" providerId="ADAL" clId="{289504D4-974E-43B6-9BD4-CC07536E2F15}" dt="2022-03-01T22:43:50.050" v="112" actId="478"/>
          <ac:spMkLst>
            <pc:docMk/>
            <pc:sldMk cId="752224780" sldId="291"/>
            <ac:spMk id="3" creationId="{8D5C4AD2-606C-406E-BE1F-089C29F6B6B8}"/>
          </ac:spMkLst>
        </pc:spChg>
        <pc:spChg chg="add mod">
          <ac:chgData name="Yang, Shengming - ARS" userId="37bd5b25-7571-49cb-bfc8-588a18706c35" providerId="ADAL" clId="{289504D4-974E-43B6-9BD4-CC07536E2F15}" dt="2022-03-01T22:46:57.231" v="184" actId="20577"/>
          <ac:spMkLst>
            <pc:docMk/>
            <pc:sldMk cId="752224780" sldId="291"/>
            <ac:spMk id="7" creationId="{3373AF5B-45AB-4915-9291-B9A733430EFF}"/>
          </ac:spMkLst>
        </pc:spChg>
        <pc:spChg chg="add mod">
          <ac:chgData name="Yang, Shengming - ARS" userId="37bd5b25-7571-49cb-bfc8-588a18706c35" providerId="ADAL" clId="{289504D4-974E-43B6-9BD4-CC07536E2F15}" dt="2022-03-01T22:47:03.735" v="188" actId="20577"/>
          <ac:spMkLst>
            <pc:docMk/>
            <pc:sldMk cId="752224780" sldId="291"/>
            <ac:spMk id="8" creationId="{5925FBB2-C043-4E60-AF92-0E9FA1F030F7}"/>
          </ac:spMkLst>
        </pc:spChg>
        <pc:spChg chg="add mod">
          <ac:chgData name="Yang, Shengming - ARS" userId="37bd5b25-7571-49cb-bfc8-588a18706c35" providerId="ADAL" clId="{289504D4-974E-43B6-9BD4-CC07536E2F15}" dt="2022-03-01T22:46:23.167" v="172" actId="1037"/>
          <ac:spMkLst>
            <pc:docMk/>
            <pc:sldMk cId="752224780" sldId="291"/>
            <ac:spMk id="9" creationId="{2A1139A0-AEE6-4DE4-A9FF-CA77AF49E8D7}"/>
          </ac:spMkLst>
        </pc:spChg>
        <pc:spChg chg="add mod">
          <ac:chgData name="Yang, Shengming - ARS" userId="37bd5b25-7571-49cb-bfc8-588a18706c35" providerId="ADAL" clId="{289504D4-974E-43B6-9BD4-CC07536E2F15}" dt="2022-03-01T22:46:29.284" v="176" actId="1037"/>
          <ac:spMkLst>
            <pc:docMk/>
            <pc:sldMk cId="752224780" sldId="291"/>
            <ac:spMk id="10" creationId="{10CAC8F9-1C66-48A7-8AD7-4AFEA71CF1AB}"/>
          </ac:spMkLst>
        </pc:spChg>
        <pc:spChg chg="add mod">
          <ac:chgData name="Yang, Shengming - ARS" userId="37bd5b25-7571-49cb-bfc8-588a18706c35" providerId="ADAL" clId="{289504D4-974E-43B6-9BD4-CC07536E2F15}" dt="2022-03-01T22:46:35.266" v="182" actId="1038"/>
          <ac:spMkLst>
            <pc:docMk/>
            <pc:sldMk cId="752224780" sldId="291"/>
            <ac:spMk id="11" creationId="{440A343F-5FE6-41BC-B26F-D96A6698DF3D}"/>
          </ac:spMkLst>
        </pc:spChg>
        <pc:spChg chg="add mod">
          <ac:chgData name="Yang, Shengming - ARS" userId="37bd5b25-7571-49cb-bfc8-588a18706c35" providerId="ADAL" clId="{289504D4-974E-43B6-9BD4-CC07536E2F15}" dt="2022-03-01T22:51:53.546" v="192" actId="207"/>
          <ac:spMkLst>
            <pc:docMk/>
            <pc:sldMk cId="752224780" sldId="291"/>
            <ac:spMk id="12" creationId="{DD0A8EB0-E1BD-4AC9-907E-DC869E858B59}"/>
          </ac:spMkLst>
        </pc:spChg>
        <pc:spChg chg="add mod">
          <ac:chgData name="Yang, Shengming - ARS" userId="37bd5b25-7571-49cb-bfc8-588a18706c35" providerId="ADAL" clId="{289504D4-974E-43B6-9BD4-CC07536E2F15}" dt="2022-03-01T22:52:35.807" v="212" actId="1076"/>
          <ac:spMkLst>
            <pc:docMk/>
            <pc:sldMk cId="752224780" sldId="291"/>
            <ac:spMk id="13" creationId="{C63D76E0-620D-401C-AE31-DF0D127ADA21}"/>
          </ac:spMkLst>
        </pc:spChg>
        <pc:spChg chg="add mod">
          <ac:chgData name="Yang, Shengming - ARS" userId="37bd5b25-7571-49cb-bfc8-588a18706c35" providerId="ADAL" clId="{289504D4-974E-43B6-9BD4-CC07536E2F15}" dt="2022-03-01T23:02:41.617" v="522" actId="113"/>
          <ac:spMkLst>
            <pc:docMk/>
            <pc:sldMk cId="752224780" sldId="291"/>
            <ac:spMk id="42" creationId="{2796FECB-39D9-4D83-A048-5B94318B3E31}"/>
          </ac:spMkLst>
        </pc:spChg>
        <pc:spChg chg="add mod">
          <ac:chgData name="Yang, Shengming - ARS" userId="37bd5b25-7571-49cb-bfc8-588a18706c35" providerId="ADAL" clId="{289504D4-974E-43B6-9BD4-CC07536E2F15}" dt="2022-03-01T23:02:51.315" v="526" actId="1076"/>
          <ac:spMkLst>
            <pc:docMk/>
            <pc:sldMk cId="752224780" sldId="291"/>
            <ac:spMk id="43" creationId="{097713F8-6D8A-4EEA-B56E-A01E74738801}"/>
          </ac:spMkLst>
        </pc:spChg>
        <pc:spChg chg="add mod">
          <ac:chgData name="Yang, Shengming - ARS" userId="37bd5b25-7571-49cb-bfc8-588a18706c35" providerId="ADAL" clId="{289504D4-974E-43B6-9BD4-CC07536E2F15}" dt="2022-03-01T23:03:24.155" v="537" actId="20577"/>
          <ac:spMkLst>
            <pc:docMk/>
            <pc:sldMk cId="752224780" sldId="291"/>
            <ac:spMk id="44" creationId="{A658A146-F3B7-4DF6-AB8E-22076BB9FE2C}"/>
          </ac:spMkLst>
        </pc:spChg>
        <pc:spChg chg="add mod">
          <ac:chgData name="Yang, Shengming - ARS" userId="37bd5b25-7571-49cb-bfc8-588a18706c35" providerId="ADAL" clId="{289504D4-974E-43B6-9BD4-CC07536E2F15}" dt="2022-03-01T23:13:12.234" v="636" actId="20577"/>
          <ac:spMkLst>
            <pc:docMk/>
            <pc:sldMk cId="752224780" sldId="291"/>
            <ac:spMk id="46" creationId="{41DBE3C0-4D2C-45F7-82E0-0EAFF0E4F071}"/>
          </ac:spMkLst>
        </pc:spChg>
        <pc:picChg chg="add mod">
          <ac:chgData name="Yang, Shengming - ARS" userId="37bd5b25-7571-49cb-bfc8-588a18706c35" providerId="ADAL" clId="{289504D4-974E-43B6-9BD4-CC07536E2F15}" dt="2022-03-01T22:43:55.665" v="114" actId="1076"/>
          <ac:picMkLst>
            <pc:docMk/>
            <pc:sldMk cId="752224780" sldId="291"/>
            <ac:picMk id="5" creationId="{04003696-5478-483F-8618-150F75332112}"/>
          </ac:picMkLst>
        </pc:picChg>
        <pc:cxnChg chg="add mod">
          <ac:chgData name="Yang, Shengming - ARS" userId="37bd5b25-7571-49cb-bfc8-588a18706c35" providerId="ADAL" clId="{289504D4-974E-43B6-9BD4-CC07536E2F15}" dt="2022-03-01T23:07:25.143" v="540" actId="1037"/>
          <ac:cxnSpMkLst>
            <pc:docMk/>
            <pc:sldMk cId="752224780" sldId="291"/>
            <ac:cxnSpMk id="15" creationId="{685B4171-5FF2-42B5-A601-B9DB5F42870A}"/>
          </ac:cxnSpMkLst>
        </pc:cxnChg>
        <pc:cxnChg chg="add mod">
          <ac:chgData name="Yang, Shengming - ARS" userId="37bd5b25-7571-49cb-bfc8-588a18706c35" providerId="ADAL" clId="{289504D4-974E-43B6-9BD4-CC07536E2F15}" dt="2022-03-01T22:54:52.251" v="284" actId="1035"/>
          <ac:cxnSpMkLst>
            <pc:docMk/>
            <pc:sldMk cId="752224780" sldId="291"/>
            <ac:cxnSpMk id="16" creationId="{157063A4-94B2-4A7A-A206-7F4A2E36E9B5}"/>
          </ac:cxnSpMkLst>
        </pc:cxnChg>
        <pc:cxnChg chg="add mod">
          <ac:chgData name="Yang, Shengming - ARS" userId="37bd5b25-7571-49cb-bfc8-588a18706c35" providerId="ADAL" clId="{289504D4-974E-43B6-9BD4-CC07536E2F15}" dt="2022-03-01T22:55:09.697" v="286" actId="1076"/>
          <ac:cxnSpMkLst>
            <pc:docMk/>
            <pc:sldMk cId="752224780" sldId="291"/>
            <ac:cxnSpMk id="19" creationId="{21BF23F0-AFB5-4A4E-89BF-3B858EE548DC}"/>
          </ac:cxnSpMkLst>
        </pc:cxnChg>
        <pc:cxnChg chg="add mod">
          <ac:chgData name="Yang, Shengming - ARS" userId="37bd5b25-7571-49cb-bfc8-588a18706c35" providerId="ADAL" clId="{289504D4-974E-43B6-9BD4-CC07536E2F15}" dt="2022-03-01T22:55:28.182" v="289" actId="1076"/>
          <ac:cxnSpMkLst>
            <pc:docMk/>
            <pc:sldMk cId="752224780" sldId="291"/>
            <ac:cxnSpMk id="20" creationId="{21C1874D-A47B-4FB5-8489-CF144980CE1D}"/>
          </ac:cxnSpMkLst>
        </pc:cxnChg>
        <pc:cxnChg chg="add mod">
          <ac:chgData name="Yang, Shengming - ARS" userId="37bd5b25-7571-49cb-bfc8-588a18706c35" providerId="ADAL" clId="{289504D4-974E-43B6-9BD4-CC07536E2F15}" dt="2022-03-01T23:07:31.592" v="541" actId="1076"/>
          <ac:cxnSpMkLst>
            <pc:docMk/>
            <pc:sldMk cId="752224780" sldId="291"/>
            <ac:cxnSpMk id="22" creationId="{F021EBB7-CA00-45E4-B5AA-077E9E4EEE6D}"/>
          </ac:cxnSpMkLst>
        </pc:cxnChg>
        <pc:cxnChg chg="add mod">
          <ac:chgData name="Yang, Shengming - ARS" userId="37bd5b25-7571-49cb-bfc8-588a18706c35" providerId="ADAL" clId="{289504D4-974E-43B6-9BD4-CC07536E2F15}" dt="2022-03-01T22:59:32.948" v="440" actId="1037"/>
          <ac:cxnSpMkLst>
            <pc:docMk/>
            <pc:sldMk cId="752224780" sldId="291"/>
            <ac:cxnSpMk id="24" creationId="{47C947F4-D92A-4580-89F9-2F886F85CD63}"/>
          </ac:cxnSpMkLst>
        </pc:cxnChg>
        <pc:cxnChg chg="add mod">
          <ac:chgData name="Yang, Shengming - ARS" userId="37bd5b25-7571-49cb-bfc8-588a18706c35" providerId="ADAL" clId="{289504D4-974E-43B6-9BD4-CC07536E2F15}" dt="2022-03-01T22:57:09.454" v="298" actId="1076"/>
          <ac:cxnSpMkLst>
            <pc:docMk/>
            <pc:sldMk cId="752224780" sldId="291"/>
            <ac:cxnSpMk id="25" creationId="{6965931D-D7AE-4756-8E09-40E23470929D}"/>
          </ac:cxnSpMkLst>
        </pc:cxnChg>
        <pc:cxnChg chg="add mod">
          <ac:chgData name="Yang, Shengming - ARS" userId="37bd5b25-7571-49cb-bfc8-588a18706c35" providerId="ADAL" clId="{289504D4-974E-43B6-9BD4-CC07536E2F15}" dt="2022-03-01T22:57:59.512" v="398" actId="1038"/>
          <ac:cxnSpMkLst>
            <pc:docMk/>
            <pc:sldMk cId="752224780" sldId="291"/>
            <ac:cxnSpMk id="26" creationId="{C51D1643-5AE1-4C21-B51D-95C5720025F9}"/>
          </ac:cxnSpMkLst>
        </pc:cxnChg>
        <pc:cxnChg chg="add mod">
          <ac:chgData name="Yang, Shengming - ARS" userId="37bd5b25-7571-49cb-bfc8-588a18706c35" providerId="ADAL" clId="{289504D4-974E-43B6-9BD4-CC07536E2F15}" dt="2022-03-01T22:57:48.834" v="377" actId="1038"/>
          <ac:cxnSpMkLst>
            <pc:docMk/>
            <pc:sldMk cId="752224780" sldId="291"/>
            <ac:cxnSpMk id="27" creationId="{6E952C3F-1270-48CD-94FF-FBA408A969A4}"/>
          </ac:cxnSpMkLst>
        </pc:cxnChg>
        <pc:cxnChg chg="add mod">
          <ac:chgData name="Yang, Shengming - ARS" userId="37bd5b25-7571-49cb-bfc8-588a18706c35" providerId="ADAL" clId="{289504D4-974E-43B6-9BD4-CC07536E2F15}" dt="2022-03-01T22:59:03.414" v="433" actId="1037"/>
          <ac:cxnSpMkLst>
            <pc:docMk/>
            <pc:sldMk cId="752224780" sldId="291"/>
            <ac:cxnSpMk id="28" creationId="{0276FE8F-23C5-46AC-9FD5-2F866915D0BE}"/>
          </ac:cxnSpMkLst>
        </pc:cxnChg>
        <pc:cxnChg chg="add mod">
          <ac:chgData name="Yang, Shengming - ARS" userId="37bd5b25-7571-49cb-bfc8-588a18706c35" providerId="ADAL" clId="{289504D4-974E-43B6-9BD4-CC07536E2F15}" dt="2022-03-01T23:01:48.513" v="511" actId="1038"/>
          <ac:cxnSpMkLst>
            <pc:docMk/>
            <pc:sldMk cId="752224780" sldId="291"/>
            <ac:cxnSpMk id="35" creationId="{79C4BDF4-43CA-4724-B4A2-AC302DDC8B4C}"/>
          </ac:cxnSpMkLst>
        </pc:cxnChg>
        <pc:cxnChg chg="add mod">
          <ac:chgData name="Yang, Shengming - ARS" userId="37bd5b25-7571-49cb-bfc8-588a18706c35" providerId="ADAL" clId="{289504D4-974E-43B6-9BD4-CC07536E2F15}" dt="2022-03-01T23:00:56.948" v="468" actId="1035"/>
          <ac:cxnSpMkLst>
            <pc:docMk/>
            <pc:sldMk cId="752224780" sldId="291"/>
            <ac:cxnSpMk id="36" creationId="{BED439FD-D78D-435C-BCBE-FE47D8A83EF5}"/>
          </ac:cxnSpMkLst>
        </pc:cxnChg>
        <pc:cxnChg chg="add del mod">
          <ac:chgData name="Yang, Shengming - ARS" userId="37bd5b25-7571-49cb-bfc8-588a18706c35" providerId="ADAL" clId="{289504D4-974E-43B6-9BD4-CC07536E2F15}" dt="2022-03-01T23:01:53.036" v="512" actId="478"/>
          <ac:cxnSpMkLst>
            <pc:docMk/>
            <pc:sldMk cId="752224780" sldId="291"/>
            <ac:cxnSpMk id="37" creationId="{A16D3BC8-ABCA-432F-A75B-32448E4C0758}"/>
          </ac:cxnSpMkLst>
        </pc:cxnChg>
        <pc:cxnChg chg="add del mod">
          <ac:chgData name="Yang, Shengming - ARS" userId="37bd5b25-7571-49cb-bfc8-588a18706c35" providerId="ADAL" clId="{289504D4-974E-43B6-9BD4-CC07536E2F15}" dt="2022-03-01T23:01:54.514" v="513" actId="478"/>
          <ac:cxnSpMkLst>
            <pc:docMk/>
            <pc:sldMk cId="752224780" sldId="291"/>
            <ac:cxnSpMk id="38" creationId="{C6690468-BF96-411F-8F04-329702E5B38B}"/>
          </ac:cxnSpMkLst>
        </pc:cxnChg>
        <pc:cxnChg chg="add mod">
          <ac:chgData name="Yang, Shengming - ARS" userId="37bd5b25-7571-49cb-bfc8-588a18706c35" providerId="ADAL" clId="{289504D4-974E-43B6-9BD4-CC07536E2F15}" dt="2022-03-01T23:01:26.572" v="494" actId="1037"/>
          <ac:cxnSpMkLst>
            <pc:docMk/>
            <pc:sldMk cId="752224780" sldId="291"/>
            <ac:cxnSpMk id="39" creationId="{BA6AFE08-AB95-400F-AB5C-11AF2C6B7E52}"/>
          </ac:cxnSpMkLst>
        </pc:cxnChg>
      </pc:sldChg>
      <pc:sldChg chg="addSp delSp modSp new mod">
        <pc:chgData name="Yang, Shengming - ARS" userId="37bd5b25-7571-49cb-bfc8-588a18706c35" providerId="ADAL" clId="{289504D4-974E-43B6-9BD4-CC07536E2F15}" dt="2022-03-14T20:08:32.400" v="1460"/>
        <pc:sldMkLst>
          <pc:docMk/>
          <pc:sldMk cId="2612662908" sldId="291"/>
        </pc:sldMkLst>
        <pc:spChg chg="del">
          <ac:chgData name="Yang, Shengming - ARS" userId="37bd5b25-7571-49cb-bfc8-588a18706c35" providerId="ADAL" clId="{289504D4-974E-43B6-9BD4-CC07536E2F15}" dt="2022-03-08T22:04:05.882" v="1035" actId="478"/>
          <ac:spMkLst>
            <pc:docMk/>
            <pc:sldMk cId="2612662908" sldId="291"/>
            <ac:spMk id="2" creationId="{D208C11A-4ADB-422B-8592-8AC0B6A8C0E4}"/>
          </ac:spMkLst>
        </pc:spChg>
        <pc:spChg chg="del">
          <ac:chgData name="Yang, Shengming - ARS" userId="37bd5b25-7571-49cb-bfc8-588a18706c35" providerId="ADAL" clId="{289504D4-974E-43B6-9BD4-CC07536E2F15}" dt="2022-03-08T22:04:05.882" v="1035" actId="478"/>
          <ac:spMkLst>
            <pc:docMk/>
            <pc:sldMk cId="2612662908" sldId="291"/>
            <ac:spMk id="3" creationId="{C5B994D7-2548-45E0-82E9-24B4E45090F0}"/>
          </ac:spMkLst>
        </pc:spChg>
        <pc:graphicFrameChg chg="add mod">
          <ac:chgData name="Yang, Shengming - ARS" userId="37bd5b25-7571-49cb-bfc8-588a18706c35" providerId="ADAL" clId="{289504D4-974E-43B6-9BD4-CC07536E2F15}" dt="2022-03-14T20:06:36.881" v="1423" actId="692"/>
          <ac:graphicFrameMkLst>
            <pc:docMk/>
            <pc:sldMk cId="2612662908" sldId="291"/>
            <ac:graphicFrameMk id="3" creationId="{A23EADC5-C859-42E3-8F1E-4CBC938FAC24}"/>
          </ac:graphicFrameMkLst>
        </pc:graphicFrameChg>
        <pc:graphicFrameChg chg="add mod">
          <ac:chgData name="Yang, Shengming - ARS" userId="37bd5b25-7571-49cb-bfc8-588a18706c35" providerId="ADAL" clId="{289504D4-974E-43B6-9BD4-CC07536E2F15}" dt="2022-03-14T20:08:32.400" v="1460"/>
          <ac:graphicFrameMkLst>
            <pc:docMk/>
            <pc:sldMk cId="2612662908" sldId="291"/>
            <ac:graphicFrameMk id="4" creationId="{AF0C9DC2-7F75-4392-8AD8-30F8C704BE39}"/>
          </ac:graphicFrameMkLst>
        </pc:graphicFrameChg>
        <pc:graphicFrameChg chg="add mod">
          <ac:chgData name="Yang, Shengming - ARS" userId="37bd5b25-7571-49cb-bfc8-588a18706c35" providerId="ADAL" clId="{289504D4-974E-43B6-9BD4-CC07536E2F15}" dt="2022-03-14T20:07:28.100" v="1433" actId="1076"/>
          <ac:graphicFrameMkLst>
            <pc:docMk/>
            <pc:sldMk cId="2612662908" sldId="291"/>
            <ac:graphicFrameMk id="5" creationId="{25B94C1A-E3B8-474E-AE3E-021E8785827F}"/>
          </ac:graphicFrameMkLst>
        </pc:graphicFrameChg>
        <pc:graphicFrameChg chg="add mod">
          <ac:chgData name="Yang, Shengming - ARS" userId="37bd5b25-7571-49cb-bfc8-588a18706c35" providerId="ADAL" clId="{289504D4-974E-43B6-9BD4-CC07536E2F15}" dt="2022-03-14T20:07:15.339" v="1430" actId="1076"/>
          <ac:graphicFrameMkLst>
            <pc:docMk/>
            <pc:sldMk cId="2612662908" sldId="291"/>
            <ac:graphicFrameMk id="6" creationId="{E5F88FCE-25A4-4CB8-AACA-95B26C014EB8}"/>
          </ac:graphicFrameMkLst>
        </pc:graphicFrameChg>
        <pc:graphicFrameChg chg="add del mod">
          <ac:chgData name="Yang, Shengming - ARS" userId="37bd5b25-7571-49cb-bfc8-588a18706c35" providerId="ADAL" clId="{289504D4-974E-43B6-9BD4-CC07536E2F15}" dt="2022-03-14T19:43:03.182" v="1245" actId="478"/>
          <ac:graphicFrameMkLst>
            <pc:docMk/>
            <pc:sldMk cId="2612662908" sldId="291"/>
            <ac:graphicFrameMk id="7" creationId="{A28CAF90-053E-4B4C-A35E-3334C509E48A}"/>
          </ac:graphicFrameMkLst>
        </pc:graphicFrameChg>
        <pc:graphicFrameChg chg="add del mod">
          <ac:chgData name="Yang, Shengming - ARS" userId="37bd5b25-7571-49cb-bfc8-588a18706c35" providerId="ADAL" clId="{289504D4-974E-43B6-9BD4-CC07536E2F15}" dt="2022-03-14T20:01:16.935" v="1384" actId="478"/>
          <ac:graphicFrameMkLst>
            <pc:docMk/>
            <pc:sldMk cId="2612662908" sldId="291"/>
            <ac:graphicFrameMk id="8" creationId="{29FD3362-6470-4A56-8F3E-06509F399B90}"/>
          </ac:graphicFrameMkLst>
        </pc:graphicFrameChg>
        <pc:graphicFrameChg chg="add mod">
          <ac:chgData name="Yang, Shengming - ARS" userId="37bd5b25-7571-49cb-bfc8-588a18706c35" providerId="ADAL" clId="{289504D4-974E-43B6-9BD4-CC07536E2F15}" dt="2022-03-14T20:07:41.228" v="1438" actId="1076"/>
          <ac:graphicFrameMkLst>
            <pc:docMk/>
            <pc:sldMk cId="2612662908" sldId="291"/>
            <ac:graphicFrameMk id="9" creationId="{A28CAF90-053E-4B4C-A35E-3334C509E48A}"/>
          </ac:graphicFrameMkLst>
        </pc:graphicFrameChg>
      </pc:sldChg>
      <pc:sldChg chg="addSp delSp modSp new mod">
        <pc:chgData name="Yang, Shengming - ARS" userId="37bd5b25-7571-49cb-bfc8-588a18706c35" providerId="ADAL" clId="{289504D4-974E-43B6-9BD4-CC07536E2F15}" dt="2022-03-10T20:51:47.144" v="1208" actId="1035"/>
        <pc:sldMkLst>
          <pc:docMk/>
          <pc:sldMk cId="3303732898" sldId="292"/>
        </pc:sldMkLst>
        <pc:spChg chg="del">
          <ac:chgData name="Yang, Shengming - ARS" userId="37bd5b25-7571-49cb-bfc8-588a18706c35" providerId="ADAL" clId="{289504D4-974E-43B6-9BD4-CC07536E2F15}" dt="2022-03-10T17:50:40.001" v="1103" actId="478"/>
          <ac:spMkLst>
            <pc:docMk/>
            <pc:sldMk cId="3303732898" sldId="292"/>
            <ac:spMk id="2" creationId="{BC42EFD7-2C7B-4589-A595-F4724D1C62FE}"/>
          </ac:spMkLst>
        </pc:spChg>
        <pc:spChg chg="del">
          <ac:chgData name="Yang, Shengming - ARS" userId="37bd5b25-7571-49cb-bfc8-588a18706c35" providerId="ADAL" clId="{289504D4-974E-43B6-9BD4-CC07536E2F15}" dt="2022-03-10T17:50:40.001" v="1103" actId="478"/>
          <ac:spMkLst>
            <pc:docMk/>
            <pc:sldMk cId="3303732898" sldId="292"/>
            <ac:spMk id="3" creationId="{0B052E09-9238-4476-8889-E6018B560862}"/>
          </ac:spMkLst>
        </pc:spChg>
        <pc:spChg chg="add mod">
          <ac:chgData name="Yang, Shengming - ARS" userId="37bd5b25-7571-49cb-bfc8-588a18706c35" providerId="ADAL" clId="{289504D4-974E-43B6-9BD4-CC07536E2F15}" dt="2022-03-10T20:51:18.880" v="1205" actId="164"/>
          <ac:spMkLst>
            <pc:docMk/>
            <pc:sldMk cId="3303732898" sldId="292"/>
            <ac:spMk id="22" creationId="{00F6C502-272F-49AD-BECC-933B11469C1D}"/>
          </ac:spMkLst>
        </pc:spChg>
        <pc:spChg chg="add mod">
          <ac:chgData name="Yang, Shengming - ARS" userId="37bd5b25-7571-49cb-bfc8-588a18706c35" providerId="ADAL" clId="{289504D4-974E-43B6-9BD4-CC07536E2F15}" dt="2022-03-10T20:51:31.347" v="1206" actId="164"/>
          <ac:spMkLst>
            <pc:docMk/>
            <pc:sldMk cId="3303732898" sldId="292"/>
            <ac:spMk id="23" creationId="{658E2519-E077-4E67-9FD6-2AAA3E10AF0A}"/>
          </ac:spMkLst>
        </pc:spChg>
        <pc:spChg chg="add mod">
          <ac:chgData name="Yang, Shengming - ARS" userId="37bd5b25-7571-49cb-bfc8-588a18706c35" providerId="ADAL" clId="{289504D4-974E-43B6-9BD4-CC07536E2F15}" dt="2022-03-10T20:51:47.144" v="1208" actId="1035"/>
          <ac:spMkLst>
            <pc:docMk/>
            <pc:sldMk cId="3303732898" sldId="292"/>
            <ac:spMk id="24" creationId="{F5230C90-8B03-497A-A7D3-46ABAC7EDC6C}"/>
          </ac:spMkLst>
        </pc:spChg>
        <pc:spChg chg="add mod">
          <ac:chgData name="Yang, Shengming - ARS" userId="37bd5b25-7571-49cb-bfc8-588a18706c35" providerId="ADAL" clId="{289504D4-974E-43B6-9BD4-CC07536E2F15}" dt="2022-03-10T18:29:48.979" v="1203" actId="20577"/>
          <ac:spMkLst>
            <pc:docMk/>
            <pc:sldMk cId="3303732898" sldId="292"/>
            <ac:spMk id="25" creationId="{4EACCFF3-F2BD-4277-9A0E-BEB8DE9A5800}"/>
          </ac:spMkLst>
        </pc:spChg>
        <pc:grpChg chg="add mod">
          <ac:chgData name="Yang, Shengming - ARS" userId="37bd5b25-7571-49cb-bfc8-588a18706c35" providerId="ADAL" clId="{289504D4-974E-43B6-9BD4-CC07536E2F15}" dt="2022-03-10T20:51:18.880" v="1205" actId="164"/>
          <ac:grpSpMkLst>
            <pc:docMk/>
            <pc:sldMk cId="3303732898" sldId="292"/>
            <ac:grpSpMk id="26" creationId="{A3D0ACD7-2E5A-42E4-BB0A-71709D99F326}"/>
          </ac:grpSpMkLst>
        </pc:grpChg>
        <pc:grpChg chg="add mod">
          <ac:chgData name="Yang, Shengming - ARS" userId="37bd5b25-7571-49cb-bfc8-588a18706c35" providerId="ADAL" clId="{289504D4-974E-43B6-9BD4-CC07536E2F15}" dt="2022-03-10T20:51:31.347" v="1206" actId="164"/>
          <ac:grpSpMkLst>
            <pc:docMk/>
            <pc:sldMk cId="3303732898" sldId="292"/>
            <ac:grpSpMk id="27" creationId="{2BA56E12-C47D-466D-BFD5-D4B4BE312DBF}"/>
          </ac:grpSpMkLst>
        </pc:grpChg>
        <pc:grpChg chg="add mod">
          <ac:chgData name="Yang, Shengming - ARS" userId="37bd5b25-7571-49cb-bfc8-588a18706c35" providerId="ADAL" clId="{289504D4-974E-43B6-9BD4-CC07536E2F15}" dt="2022-03-10T20:51:39.846" v="1207" actId="164"/>
          <ac:grpSpMkLst>
            <pc:docMk/>
            <pc:sldMk cId="3303732898" sldId="292"/>
            <ac:grpSpMk id="28" creationId="{529E0546-3289-4E40-A50D-18026BCE5512}"/>
          </ac:grpSpMkLst>
        </pc:grpChg>
        <pc:picChg chg="add del mod">
          <ac:chgData name="Yang, Shengming - ARS" userId="37bd5b25-7571-49cb-bfc8-588a18706c35" providerId="ADAL" clId="{289504D4-974E-43B6-9BD4-CC07536E2F15}" dt="2022-03-10T18:25:00.738" v="1138"/>
          <ac:picMkLst>
            <pc:docMk/>
            <pc:sldMk cId="3303732898" sldId="292"/>
            <ac:picMk id="3" creationId="{E3156843-C5D4-430C-85F0-22E98612FD12}"/>
          </ac:picMkLst>
        </pc:picChg>
        <pc:picChg chg="add mod">
          <ac:chgData name="Yang, Shengming - ARS" userId="37bd5b25-7571-49cb-bfc8-588a18706c35" providerId="ADAL" clId="{289504D4-974E-43B6-9BD4-CC07536E2F15}" dt="2022-03-10T20:51:18.880" v="1205" actId="164"/>
          <ac:picMkLst>
            <pc:docMk/>
            <pc:sldMk cId="3303732898" sldId="292"/>
            <ac:picMk id="5" creationId="{A8C64EAA-B587-4899-9C77-160403AAA9AE}"/>
          </ac:picMkLst>
        </pc:picChg>
        <pc:picChg chg="add del mod">
          <ac:chgData name="Yang, Shengming - ARS" userId="37bd5b25-7571-49cb-bfc8-588a18706c35" providerId="ADAL" clId="{289504D4-974E-43B6-9BD4-CC07536E2F15}" dt="2022-03-10T18:25:00.738" v="1138"/>
          <ac:picMkLst>
            <pc:docMk/>
            <pc:sldMk cId="3303732898" sldId="292"/>
            <ac:picMk id="6" creationId="{A33815B7-F926-4CF2-A2F5-1B00A706B24F}"/>
          </ac:picMkLst>
        </pc:picChg>
        <pc:picChg chg="add mod">
          <ac:chgData name="Yang, Shengming - ARS" userId="37bd5b25-7571-49cb-bfc8-588a18706c35" providerId="ADAL" clId="{289504D4-974E-43B6-9BD4-CC07536E2F15}" dt="2022-03-10T20:51:31.347" v="1206" actId="164"/>
          <ac:picMkLst>
            <pc:docMk/>
            <pc:sldMk cId="3303732898" sldId="292"/>
            <ac:picMk id="7" creationId="{CC16B74A-60E8-4BCC-AEB5-6A8944624F4D}"/>
          </ac:picMkLst>
        </pc:picChg>
        <pc:picChg chg="add mod">
          <ac:chgData name="Yang, Shengming - ARS" userId="37bd5b25-7571-49cb-bfc8-588a18706c35" providerId="ADAL" clId="{289504D4-974E-43B6-9BD4-CC07536E2F15}" dt="2022-03-10T20:51:39.846" v="1207" actId="164"/>
          <ac:picMkLst>
            <pc:docMk/>
            <pc:sldMk cId="3303732898" sldId="292"/>
            <ac:picMk id="9" creationId="{D7AD336E-62A3-40D7-99D4-C9914B4C4C2C}"/>
          </ac:picMkLst>
        </pc:picChg>
        <pc:picChg chg="add del mod">
          <ac:chgData name="Yang, Shengming - ARS" userId="37bd5b25-7571-49cb-bfc8-588a18706c35" providerId="ADAL" clId="{289504D4-974E-43B6-9BD4-CC07536E2F15}" dt="2022-03-10T18:25:00.738" v="1138"/>
          <ac:picMkLst>
            <pc:docMk/>
            <pc:sldMk cId="3303732898" sldId="292"/>
            <ac:picMk id="10" creationId="{5FCB94F3-9897-4CB8-B47C-3D428D23B5A4}"/>
          </ac:picMkLst>
        </pc:picChg>
        <pc:picChg chg="add mod">
          <ac:chgData name="Yang, Shengming - ARS" userId="37bd5b25-7571-49cb-bfc8-588a18706c35" providerId="ADAL" clId="{289504D4-974E-43B6-9BD4-CC07536E2F15}" dt="2022-03-10T18:24:45.330" v="1126" actId="571"/>
          <ac:picMkLst>
            <pc:docMk/>
            <pc:sldMk cId="3303732898" sldId="292"/>
            <ac:picMk id="11" creationId="{4BD553C8-288F-4D35-8C61-DBB9F2358125}"/>
          </ac:picMkLst>
        </pc:picChg>
        <pc:picChg chg="add mod">
          <ac:chgData name="Yang, Shengming - ARS" userId="37bd5b25-7571-49cb-bfc8-588a18706c35" providerId="ADAL" clId="{289504D4-974E-43B6-9BD4-CC07536E2F15}" dt="2022-03-10T18:24:45.330" v="1126" actId="571"/>
          <ac:picMkLst>
            <pc:docMk/>
            <pc:sldMk cId="3303732898" sldId="292"/>
            <ac:picMk id="12" creationId="{A196987A-DFF7-47DA-9ECD-427CA41C3BCD}"/>
          </ac:picMkLst>
        </pc:picChg>
        <pc:picChg chg="add mod">
          <ac:chgData name="Yang, Shengming - ARS" userId="37bd5b25-7571-49cb-bfc8-588a18706c35" providerId="ADAL" clId="{289504D4-974E-43B6-9BD4-CC07536E2F15}" dt="2022-03-10T18:24:45.330" v="1126" actId="571"/>
          <ac:picMkLst>
            <pc:docMk/>
            <pc:sldMk cId="3303732898" sldId="292"/>
            <ac:picMk id="13" creationId="{FFE12D57-BCA3-4D6D-9467-7032971BB99E}"/>
          </ac:picMkLst>
        </pc:picChg>
        <pc:picChg chg="add mod">
          <ac:chgData name="Yang, Shengming - ARS" userId="37bd5b25-7571-49cb-bfc8-588a18706c35" providerId="ADAL" clId="{289504D4-974E-43B6-9BD4-CC07536E2F15}" dt="2022-03-10T18:24:58.011" v="1134" actId="571"/>
          <ac:picMkLst>
            <pc:docMk/>
            <pc:sldMk cId="3303732898" sldId="292"/>
            <ac:picMk id="14" creationId="{9762DD45-BEA7-455E-AE79-5877541EDED9}"/>
          </ac:picMkLst>
        </pc:picChg>
        <pc:picChg chg="add mod">
          <ac:chgData name="Yang, Shengming - ARS" userId="37bd5b25-7571-49cb-bfc8-588a18706c35" providerId="ADAL" clId="{289504D4-974E-43B6-9BD4-CC07536E2F15}" dt="2022-03-10T18:24:58.011" v="1134" actId="571"/>
          <ac:picMkLst>
            <pc:docMk/>
            <pc:sldMk cId="3303732898" sldId="292"/>
            <ac:picMk id="15" creationId="{F556D223-89B6-43BD-A3B3-C2D1EACEF258}"/>
          </ac:picMkLst>
        </pc:picChg>
        <pc:picChg chg="add del mod">
          <ac:chgData name="Yang, Shengming - ARS" userId="37bd5b25-7571-49cb-bfc8-588a18706c35" providerId="ADAL" clId="{289504D4-974E-43B6-9BD4-CC07536E2F15}" dt="2022-03-10T20:50:54.683" v="1204" actId="478"/>
          <ac:picMkLst>
            <pc:docMk/>
            <pc:sldMk cId="3303732898" sldId="292"/>
            <ac:picMk id="17" creationId="{FDE7A0DF-73FF-4DCF-AEE9-D1F66D0684CE}"/>
          </ac:picMkLst>
        </pc:picChg>
        <pc:picChg chg="add del mod">
          <ac:chgData name="Yang, Shengming - ARS" userId="37bd5b25-7571-49cb-bfc8-588a18706c35" providerId="ADAL" clId="{289504D4-974E-43B6-9BD4-CC07536E2F15}" dt="2022-03-10T20:50:54.683" v="1204" actId="478"/>
          <ac:picMkLst>
            <pc:docMk/>
            <pc:sldMk cId="3303732898" sldId="292"/>
            <ac:picMk id="19" creationId="{DE99F9FF-C4D4-4404-AAB8-365488781162}"/>
          </ac:picMkLst>
        </pc:picChg>
        <pc:picChg chg="add del mod">
          <ac:chgData name="Yang, Shengming - ARS" userId="37bd5b25-7571-49cb-bfc8-588a18706c35" providerId="ADAL" clId="{289504D4-974E-43B6-9BD4-CC07536E2F15}" dt="2022-03-10T20:50:54.683" v="1204" actId="478"/>
          <ac:picMkLst>
            <pc:docMk/>
            <pc:sldMk cId="3303732898" sldId="292"/>
            <ac:picMk id="21" creationId="{D9DA51B5-5123-40AF-BB79-5039F293F7BC}"/>
          </ac:picMkLst>
        </pc:picChg>
      </pc:sldChg>
    </pc:docChg>
  </pc:docChgLst>
  <pc:docChgLst>
    <pc:chgData name="Yang, Shengming - ARS" userId="37bd5b25-7571-49cb-bfc8-588a18706c35" providerId="ADAL" clId="{73BA1FA4-9FF7-406E-A355-CA3B9319D1EF}"/>
    <pc:docChg chg="undo custSel addSld modSld sldOrd">
      <pc:chgData name="Yang, Shengming - ARS" userId="37bd5b25-7571-49cb-bfc8-588a18706c35" providerId="ADAL" clId="{73BA1FA4-9FF7-406E-A355-CA3B9319D1EF}" dt="2022-02-24T03:31:32.621" v="518"/>
      <pc:docMkLst>
        <pc:docMk/>
      </pc:docMkLst>
      <pc:sldChg chg="modSp mod ord">
        <pc:chgData name="Yang, Shengming - ARS" userId="37bd5b25-7571-49cb-bfc8-588a18706c35" providerId="ADAL" clId="{73BA1FA4-9FF7-406E-A355-CA3B9319D1EF}" dt="2022-02-18T18:18:38.060" v="224"/>
        <pc:sldMkLst>
          <pc:docMk/>
          <pc:sldMk cId="1327558011" sldId="276"/>
        </pc:sldMkLst>
        <pc:spChg chg="mod">
          <ac:chgData name="Yang, Shengming - ARS" userId="37bd5b25-7571-49cb-bfc8-588a18706c35" providerId="ADAL" clId="{73BA1FA4-9FF7-406E-A355-CA3B9319D1EF}" dt="2022-02-17T22:33:37.155" v="29" actId="20577"/>
          <ac:spMkLst>
            <pc:docMk/>
            <pc:sldMk cId="1327558011" sldId="276"/>
            <ac:spMk id="26" creationId="{557EC437-7B38-4A6E-97F8-966514E076E1}"/>
          </ac:spMkLst>
        </pc:spChg>
      </pc:sldChg>
      <pc:sldChg chg="addSp delSp modSp mod modNotesTx">
        <pc:chgData name="Yang, Shengming - ARS" userId="37bd5b25-7571-49cb-bfc8-588a18706c35" providerId="ADAL" clId="{73BA1FA4-9FF7-406E-A355-CA3B9319D1EF}" dt="2022-02-18T23:01:00.990" v="450" actId="164"/>
        <pc:sldMkLst>
          <pc:docMk/>
          <pc:sldMk cId="3951076637" sldId="279"/>
        </pc:sldMkLst>
        <pc:spChg chg="add del mod">
          <ac:chgData name="Yang, Shengming - ARS" userId="37bd5b25-7571-49cb-bfc8-588a18706c35" providerId="ADAL" clId="{73BA1FA4-9FF7-406E-A355-CA3B9319D1EF}" dt="2022-02-18T23:01:00.990" v="450" actId="164"/>
          <ac:spMkLst>
            <pc:docMk/>
            <pc:sldMk cId="3951076637" sldId="279"/>
            <ac:spMk id="35" creationId="{88071EA3-5D2C-44FE-B04C-3F420FF1A797}"/>
          </ac:spMkLst>
        </pc:spChg>
        <pc:spChg chg="add mod">
          <ac:chgData name="Yang, Shengming - ARS" userId="37bd5b25-7571-49cb-bfc8-588a18706c35" providerId="ADAL" clId="{73BA1FA4-9FF7-406E-A355-CA3B9319D1EF}" dt="2022-02-18T23:01:00.990" v="450" actId="164"/>
          <ac:spMkLst>
            <pc:docMk/>
            <pc:sldMk cId="3951076637" sldId="279"/>
            <ac:spMk id="41" creationId="{4ED00229-25CF-4B71-862F-47E567DD6907}"/>
          </ac:spMkLst>
        </pc:spChg>
        <pc:spChg chg="add mod">
          <ac:chgData name="Yang, Shengming - ARS" userId="37bd5b25-7571-49cb-bfc8-588a18706c35" providerId="ADAL" clId="{73BA1FA4-9FF7-406E-A355-CA3B9319D1EF}" dt="2022-02-18T23:01:00.990" v="450" actId="164"/>
          <ac:spMkLst>
            <pc:docMk/>
            <pc:sldMk cId="3951076637" sldId="279"/>
            <ac:spMk id="42" creationId="{A79F5BC6-9DE1-45AC-8C5E-EB61788D4266}"/>
          </ac:spMkLst>
        </pc:spChg>
        <pc:spChg chg="add mod">
          <ac:chgData name="Yang, Shengming - ARS" userId="37bd5b25-7571-49cb-bfc8-588a18706c35" providerId="ADAL" clId="{73BA1FA4-9FF7-406E-A355-CA3B9319D1EF}" dt="2022-02-18T23:01:00.990" v="450" actId="164"/>
          <ac:spMkLst>
            <pc:docMk/>
            <pc:sldMk cId="3951076637" sldId="279"/>
            <ac:spMk id="43" creationId="{2231B456-CD2F-4FDF-90E8-3764DE82DFC0}"/>
          </ac:spMkLst>
        </pc:spChg>
        <pc:spChg chg="add mod">
          <ac:chgData name="Yang, Shengming - ARS" userId="37bd5b25-7571-49cb-bfc8-588a18706c35" providerId="ADAL" clId="{73BA1FA4-9FF7-406E-A355-CA3B9319D1EF}" dt="2022-02-18T23:01:00.990" v="450" actId="164"/>
          <ac:spMkLst>
            <pc:docMk/>
            <pc:sldMk cId="3951076637" sldId="279"/>
            <ac:spMk id="44" creationId="{E2D00A27-FE20-4DDC-AF85-E2C84AB2F70D}"/>
          </ac:spMkLst>
        </pc:spChg>
        <pc:grpChg chg="add mod">
          <ac:chgData name="Yang, Shengming - ARS" userId="37bd5b25-7571-49cb-bfc8-588a18706c35" providerId="ADAL" clId="{73BA1FA4-9FF7-406E-A355-CA3B9319D1EF}" dt="2022-02-18T23:01:00.990" v="450" actId="164"/>
          <ac:grpSpMkLst>
            <pc:docMk/>
            <pc:sldMk cId="3951076637" sldId="279"/>
            <ac:grpSpMk id="49" creationId="{C0231E8A-E728-4F57-9567-B5F93B699AA5}"/>
          </ac:grpSpMkLst>
        </pc:grpChg>
        <pc:graphicFrameChg chg="add mod">
          <ac:chgData name="Yang, Shengming - ARS" userId="37bd5b25-7571-49cb-bfc8-588a18706c35" providerId="ADAL" clId="{73BA1FA4-9FF7-406E-A355-CA3B9319D1EF}" dt="2022-02-18T22:52:16.523" v="343" actId="1076"/>
          <ac:graphicFrameMkLst>
            <pc:docMk/>
            <pc:sldMk cId="3951076637" sldId="279"/>
            <ac:graphicFrameMk id="36" creationId="{6F1D622B-363F-4DE5-B31A-0E65AA636F7D}"/>
          </ac:graphicFrameMkLst>
        </pc:graphicFrameChg>
        <pc:picChg chg="add del mod">
          <ac:chgData name="Yang, Shengming - ARS" userId="37bd5b25-7571-49cb-bfc8-588a18706c35" providerId="ADAL" clId="{73BA1FA4-9FF7-406E-A355-CA3B9319D1EF}" dt="2022-02-18T22:54:36.355" v="344" actId="478"/>
          <ac:picMkLst>
            <pc:docMk/>
            <pc:sldMk cId="3951076637" sldId="279"/>
            <ac:picMk id="3" creationId="{7B91685B-8DE6-4902-B8D9-81B59B5BD5C3}"/>
          </ac:picMkLst>
        </pc:picChg>
        <pc:picChg chg="del">
          <ac:chgData name="Yang, Shengming - ARS" userId="37bd5b25-7571-49cb-bfc8-588a18706c35" providerId="ADAL" clId="{73BA1FA4-9FF7-406E-A355-CA3B9319D1EF}" dt="2022-02-18T20:31:15.587" v="326" actId="478"/>
          <ac:picMkLst>
            <pc:docMk/>
            <pc:sldMk cId="3951076637" sldId="279"/>
            <ac:picMk id="30" creationId="{121D0B31-5F7E-439F-8FDF-148E33A12C9B}"/>
          </ac:picMkLst>
        </pc:picChg>
        <pc:picChg chg="add del mod">
          <ac:chgData name="Yang, Shengming - ARS" userId="37bd5b25-7571-49cb-bfc8-588a18706c35" providerId="ADAL" clId="{73BA1FA4-9FF7-406E-A355-CA3B9319D1EF}" dt="2022-02-18T22:55:24.075" v="357" actId="478"/>
          <ac:picMkLst>
            <pc:docMk/>
            <pc:sldMk cId="3951076637" sldId="279"/>
            <ac:picMk id="38" creationId="{3A404D67-7746-4FA5-A122-B9C6E43B7DAC}"/>
          </ac:picMkLst>
        </pc:picChg>
        <pc:picChg chg="add del mod">
          <ac:chgData name="Yang, Shengming - ARS" userId="37bd5b25-7571-49cb-bfc8-588a18706c35" providerId="ADAL" clId="{73BA1FA4-9FF7-406E-A355-CA3B9319D1EF}" dt="2022-02-18T22:59:23.288" v="412" actId="478"/>
          <ac:picMkLst>
            <pc:docMk/>
            <pc:sldMk cId="3951076637" sldId="279"/>
            <ac:picMk id="40" creationId="{0558C519-C7B8-4D34-A691-5F2031D93DD7}"/>
          </ac:picMkLst>
        </pc:picChg>
        <pc:picChg chg="add del mod">
          <ac:chgData name="Yang, Shengming - ARS" userId="37bd5b25-7571-49cb-bfc8-588a18706c35" providerId="ADAL" clId="{73BA1FA4-9FF7-406E-A355-CA3B9319D1EF}" dt="2022-02-18T22:59:12.193" v="409" actId="478"/>
          <ac:picMkLst>
            <pc:docMk/>
            <pc:sldMk cId="3951076637" sldId="279"/>
            <ac:picMk id="46" creationId="{E9CE3130-ED48-41A3-9877-B3993AC33B90}"/>
          </ac:picMkLst>
        </pc:picChg>
        <pc:picChg chg="add mod ord">
          <ac:chgData name="Yang, Shengming - ARS" userId="37bd5b25-7571-49cb-bfc8-588a18706c35" providerId="ADAL" clId="{73BA1FA4-9FF7-406E-A355-CA3B9319D1EF}" dt="2022-02-18T23:01:00.990" v="450" actId="164"/>
          <ac:picMkLst>
            <pc:docMk/>
            <pc:sldMk cId="3951076637" sldId="279"/>
            <ac:picMk id="48" creationId="{F67EFA2E-A2AE-409F-8ED6-2ABC8981BF59}"/>
          </ac:picMkLst>
        </pc:picChg>
      </pc:sldChg>
      <pc:sldChg chg="ord">
        <pc:chgData name="Yang, Shengming - ARS" userId="37bd5b25-7571-49cb-bfc8-588a18706c35" providerId="ADAL" clId="{73BA1FA4-9FF7-406E-A355-CA3B9319D1EF}" dt="2022-02-18T18:50:00.384" v="230"/>
        <pc:sldMkLst>
          <pc:docMk/>
          <pc:sldMk cId="2943728638" sldId="280"/>
        </pc:sldMkLst>
      </pc:sldChg>
      <pc:sldChg chg="addSp delSp modSp mod modNotesTx">
        <pc:chgData name="Yang, Shengming - ARS" userId="37bd5b25-7571-49cb-bfc8-588a18706c35" providerId="ADAL" clId="{73BA1FA4-9FF7-406E-A355-CA3B9319D1EF}" dt="2022-02-18T18:54:45.639" v="263"/>
        <pc:sldMkLst>
          <pc:docMk/>
          <pc:sldMk cId="1658013936" sldId="287"/>
        </pc:sldMkLst>
        <pc:spChg chg="mod">
          <ac:chgData name="Yang, Shengming - ARS" userId="37bd5b25-7571-49cb-bfc8-588a18706c35" providerId="ADAL" clId="{73BA1FA4-9FF7-406E-A355-CA3B9319D1EF}" dt="2022-02-18T18:09:30.281" v="196" actId="1038"/>
          <ac:spMkLst>
            <pc:docMk/>
            <pc:sldMk cId="1658013936" sldId="287"/>
            <ac:spMk id="16" creationId="{B7B2EC02-8BA0-46AE-94E8-3EAFFE586302}"/>
          </ac:spMkLst>
        </pc:spChg>
        <pc:spChg chg="mod">
          <ac:chgData name="Yang, Shengming - ARS" userId="37bd5b25-7571-49cb-bfc8-588a18706c35" providerId="ADAL" clId="{73BA1FA4-9FF7-406E-A355-CA3B9319D1EF}" dt="2022-02-18T18:11:48.694" v="212" actId="1076"/>
          <ac:spMkLst>
            <pc:docMk/>
            <pc:sldMk cId="1658013936" sldId="287"/>
            <ac:spMk id="18" creationId="{DB4A7B80-04F4-4694-9635-269D7B93FAB8}"/>
          </ac:spMkLst>
        </pc:spChg>
        <pc:spChg chg="mod">
          <ac:chgData name="Yang, Shengming - ARS" userId="37bd5b25-7571-49cb-bfc8-588a18706c35" providerId="ADAL" clId="{73BA1FA4-9FF7-406E-A355-CA3B9319D1EF}" dt="2022-02-18T18:53:52.030" v="260" actId="20577"/>
          <ac:spMkLst>
            <pc:docMk/>
            <pc:sldMk cId="1658013936" sldId="287"/>
            <ac:spMk id="26" creationId="{557EC437-7B38-4A6E-97F8-966514E076E1}"/>
          </ac:spMkLst>
        </pc:spChg>
        <pc:spChg chg="mod">
          <ac:chgData name="Yang, Shengming - ARS" userId="37bd5b25-7571-49cb-bfc8-588a18706c35" providerId="ADAL" clId="{73BA1FA4-9FF7-406E-A355-CA3B9319D1EF}" dt="2022-02-18T18:11:38.258" v="211" actId="404"/>
          <ac:spMkLst>
            <pc:docMk/>
            <pc:sldMk cId="1658013936" sldId="287"/>
            <ac:spMk id="27" creationId="{93D67171-A90F-4D90-B3D3-C8C3BD804DF3}"/>
          </ac:spMkLst>
        </pc:spChg>
        <pc:spChg chg="mod">
          <ac:chgData name="Yang, Shengming - ARS" userId="37bd5b25-7571-49cb-bfc8-588a18706c35" providerId="ADAL" clId="{73BA1FA4-9FF7-406E-A355-CA3B9319D1EF}" dt="2022-02-18T18:11:53.188" v="213" actId="1076"/>
          <ac:spMkLst>
            <pc:docMk/>
            <pc:sldMk cId="1658013936" sldId="287"/>
            <ac:spMk id="28" creationId="{D716D1A0-A1CE-4DF1-BF62-0045C30619D6}"/>
          </ac:spMkLst>
        </pc:spChg>
        <pc:spChg chg="add mod">
          <ac:chgData name="Yang, Shengming - ARS" userId="37bd5b25-7571-49cb-bfc8-588a18706c35" providerId="ADAL" clId="{73BA1FA4-9FF7-406E-A355-CA3B9319D1EF}" dt="2022-02-18T18:12:41.391" v="218" actId="1076"/>
          <ac:spMkLst>
            <pc:docMk/>
            <pc:sldMk cId="1658013936" sldId="287"/>
            <ac:spMk id="40" creationId="{4ADC4297-4F6D-4975-858B-B7B53439234C}"/>
          </ac:spMkLst>
        </pc:spChg>
        <pc:spChg chg="add mod">
          <ac:chgData name="Yang, Shengming - ARS" userId="37bd5b25-7571-49cb-bfc8-588a18706c35" providerId="ADAL" clId="{73BA1FA4-9FF7-406E-A355-CA3B9319D1EF}" dt="2022-02-18T17:43:21.363" v="157" actId="20577"/>
          <ac:spMkLst>
            <pc:docMk/>
            <pc:sldMk cId="1658013936" sldId="287"/>
            <ac:spMk id="41" creationId="{0EAC1524-5625-450E-8543-B43575C52F5D}"/>
          </ac:spMkLst>
        </pc:spChg>
        <pc:spChg chg="add mod">
          <ac:chgData name="Yang, Shengming - ARS" userId="37bd5b25-7571-49cb-bfc8-588a18706c35" providerId="ADAL" clId="{73BA1FA4-9FF7-406E-A355-CA3B9319D1EF}" dt="2022-02-18T18:12:00.354" v="215" actId="1076"/>
          <ac:spMkLst>
            <pc:docMk/>
            <pc:sldMk cId="1658013936" sldId="287"/>
            <ac:spMk id="44" creationId="{979412E0-B832-4DC7-B7B2-06AAE60DED71}"/>
          </ac:spMkLst>
        </pc:spChg>
        <pc:graphicFrameChg chg="add mod">
          <ac:chgData name="Yang, Shengming - ARS" userId="37bd5b25-7571-49cb-bfc8-588a18706c35" providerId="ADAL" clId="{73BA1FA4-9FF7-406E-A355-CA3B9319D1EF}" dt="2022-02-18T18:54:45.639" v="263"/>
          <ac:graphicFrameMkLst>
            <pc:docMk/>
            <pc:sldMk cId="1658013936" sldId="287"/>
            <ac:graphicFrameMk id="34" creationId="{C87DD994-6237-4F88-AF77-8EF5403E3B8C}"/>
          </ac:graphicFrameMkLst>
        </pc:graphicFrameChg>
        <pc:picChg chg="mod">
          <ac:chgData name="Yang, Shengming - ARS" userId="37bd5b25-7571-49cb-bfc8-588a18706c35" providerId="ADAL" clId="{73BA1FA4-9FF7-406E-A355-CA3B9319D1EF}" dt="2022-02-18T18:09:30.281" v="196" actId="1038"/>
          <ac:picMkLst>
            <pc:docMk/>
            <pc:sldMk cId="1658013936" sldId="287"/>
            <ac:picMk id="14" creationId="{4FE97BDE-EC44-4359-BC83-63F3A53D94A1}"/>
          </ac:picMkLst>
        </pc:picChg>
        <pc:cxnChg chg="mod">
          <ac:chgData name="Yang, Shengming - ARS" userId="37bd5b25-7571-49cb-bfc8-588a18706c35" providerId="ADAL" clId="{73BA1FA4-9FF7-406E-A355-CA3B9319D1EF}" dt="2022-02-18T18:09:30.281" v="196" actId="1038"/>
          <ac:cxnSpMkLst>
            <pc:docMk/>
            <pc:sldMk cId="1658013936" sldId="287"/>
            <ac:cxnSpMk id="4" creationId="{7323C978-CD2D-4425-8B78-301E4142303F}"/>
          </ac:cxnSpMkLst>
        </pc:cxnChg>
        <pc:cxnChg chg="mod">
          <ac:chgData name="Yang, Shengming - ARS" userId="37bd5b25-7571-49cb-bfc8-588a18706c35" providerId="ADAL" clId="{73BA1FA4-9FF7-406E-A355-CA3B9319D1EF}" dt="2022-02-18T18:08:10.309" v="194" actId="1037"/>
          <ac:cxnSpMkLst>
            <pc:docMk/>
            <pc:sldMk cId="1658013936" sldId="287"/>
            <ac:cxnSpMk id="12" creationId="{CF8AF98E-D611-4EE4-B63B-47ABEAA70C8D}"/>
          </ac:cxnSpMkLst>
        </pc:cxnChg>
        <pc:cxnChg chg="del">
          <ac:chgData name="Yang, Shengming - ARS" userId="37bd5b25-7571-49cb-bfc8-588a18706c35" providerId="ADAL" clId="{73BA1FA4-9FF7-406E-A355-CA3B9319D1EF}" dt="2022-02-17T22:34:13.514" v="30" actId="478"/>
          <ac:cxnSpMkLst>
            <pc:docMk/>
            <pc:sldMk cId="1658013936" sldId="287"/>
            <ac:cxnSpMk id="34" creationId="{CD9C69E7-995C-432C-8155-C8741858946E}"/>
          </ac:cxnSpMkLst>
        </pc:cxnChg>
      </pc:sldChg>
      <pc:sldChg chg="addSp delSp modSp new mod">
        <pc:chgData name="Yang, Shengming - ARS" userId="37bd5b25-7571-49cb-bfc8-588a18706c35" providerId="ADAL" clId="{73BA1FA4-9FF7-406E-A355-CA3B9319D1EF}" dt="2022-02-24T03:31:32.621" v="518"/>
        <pc:sldMkLst>
          <pc:docMk/>
          <pc:sldMk cId="4208113970" sldId="288"/>
        </pc:sldMkLst>
        <pc:spChg chg="del">
          <ac:chgData name="Yang, Shengming - ARS" userId="37bd5b25-7571-49cb-bfc8-588a18706c35" providerId="ADAL" clId="{73BA1FA4-9FF7-406E-A355-CA3B9319D1EF}" dt="2022-02-17T22:56:40.548" v="38" actId="478"/>
          <ac:spMkLst>
            <pc:docMk/>
            <pc:sldMk cId="4208113970" sldId="288"/>
            <ac:spMk id="2" creationId="{AB29608C-B853-438A-AFEF-6F59DA25799B}"/>
          </ac:spMkLst>
        </pc:spChg>
        <pc:spChg chg="del">
          <ac:chgData name="Yang, Shengming - ARS" userId="37bd5b25-7571-49cb-bfc8-588a18706c35" providerId="ADAL" clId="{73BA1FA4-9FF7-406E-A355-CA3B9319D1EF}" dt="2022-02-17T22:56:40.548" v="38" actId="478"/>
          <ac:spMkLst>
            <pc:docMk/>
            <pc:sldMk cId="4208113970" sldId="288"/>
            <ac:spMk id="3" creationId="{7906FE8C-7117-4FEF-BF3B-783125544883}"/>
          </ac:spMkLst>
        </pc:spChg>
        <pc:picChg chg="add del mod modCrop">
          <ac:chgData name="Yang, Shengming - ARS" userId="37bd5b25-7571-49cb-bfc8-588a18706c35" providerId="ADAL" clId="{73BA1FA4-9FF7-406E-A355-CA3B9319D1EF}" dt="2022-02-17T23:04:35.997" v="123" actId="478"/>
          <ac:picMkLst>
            <pc:docMk/>
            <pc:sldMk cId="4208113970" sldId="288"/>
            <ac:picMk id="5" creationId="{9643421D-CC3A-4AB9-84DA-85489BF54172}"/>
          </ac:picMkLst>
        </pc:picChg>
        <pc:picChg chg="add del mod modCrop">
          <ac:chgData name="Yang, Shengming - ARS" userId="37bd5b25-7571-49cb-bfc8-588a18706c35" providerId="ADAL" clId="{73BA1FA4-9FF7-406E-A355-CA3B9319D1EF}" dt="2022-02-17T23:04:49.307" v="127" actId="478"/>
          <ac:picMkLst>
            <pc:docMk/>
            <pc:sldMk cId="4208113970" sldId="288"/>
            <ac:picMk id="7" creationId="{4130D544-0AFF-4C09-8DFD-EEDB9373AD51}"/>
          </ac:picMkLst>
        </pc:picChg>
        <pc:picChg chg="add del mod modCrop">
          <ac:chgData name="Yang, Shengming - ARS" userId="37bd5b25-7571-49cb-bfc8-588a18706c35" providerId="ADAL" clId="{73BA1FA4-9FF7-406E-A355-CA3B9319D1EF}" dt="2022-02-17T23:04:17.804" v="117" actId="478"/>
          <ac:picMkLst>
            <pc:docMk/>
            <pc:sldMk cId="4208113970" sldId="288"/>
            <ac:picMk id="9" creationId="{C5B88DC7-B98B-477C-B267-D0F84E4D58E2}"/>
          </ac:picMkLst>
        </pc:picChg>
        <pc:picChg chg="add del mod">
          <ac:chgData name="Yang, Shengming - ARS" userId="37bd5b25-7571-49cb-bfc8-588a18706c35" providerId="ADAL" clId="{73BA1FA4-9FF7-406E-A355-CA3B9319D1EF}" dt="2022-02-17T23:04:57.755" v="128" actId="478"/>
          <ac:picMkLst>
            <pc:docMk/>
            <pc:sldMk cId="4208113970" sldId="288"/>
            <ac:picMk id="10" creationId="{21D12051-BEF0-4E1F-8275-3E630826FCA4}"/>
          </ac:picMkLst>
        </pc:picChg>
        <pc:picChg chg="add mod">
          <ac:chgData name="Yang, Shengming - ARS" userId="37bd5b25-7571-49cb-bfc8-588a18706c35" providerId="ADAL" clId="{73BA1FA4-9FF7-406E-A355-CA3B9319D1EF}" dt="2022-02-24T03:31:32.621" v="518"/>
          <ac:picMkLst>
            <pc:docMk/>
            <pc:sldMk cId="4208113970" sldId="288"/>
            <ac:picMk id="11" creationId="{61543F96-5AEF-48F7-A896-6222CD062B93}"/>
          </ac:picMkLst>
        </pc:picChg>
        <pc:picChg chg="add del mod">
          <ac:chgData name="Yang, Shengming - ARS" userId="37bd5b25-7571-49cb-bfc8-588a18706c35" providerId="ADAL" clId="{73BA1FA4-9FF7-406E-A355-CA3B9319D1EF}" dt="2022-02-17T23:04:31.275" v="120" actId="478"/>
          <ac:picMkLst>
            <pc:docMk/>
            <pc:sldMk cId="4208113970" sldId="288"/>
            <ac:picMk id="12" creationId="{43BB6166-12AA-4DD3-A391-731074169C10}"/>
          </ac:picMkLst>
        </pc:picChg>
        <pc:picChg chg="add mod">
          <ac:chgData name="Yang, Shengming - ARS" userId="37bd5b25-7571-49cb-bfc8-588a18706c35" providerId="ADAL" clId="{73BA1FA4-9FF7-406E-A355-CA3B9319D1EF}" dt="2022-02-18T18:33:48.468" v="227" actId="1076"/>
          <ac:picMkLst>
            <pc:docMk/>
            <pc:sldMk cId="4208113970" sldId="288"/>
            <ac:picMk id="13" creationId="{7C857758-7BB1-4B2C-9389-B4776791175A}"/>
          </ac:picMkLst>
        </pc:picChg>
        <pc:picChg chg="add mod">
          <ac:chgData name="Yang, Shengming - ARS" userId="37bd5b25-7571-49cb-bfc8-588a18706c35" providerId="ADAL" clId="{73BA1FA4-9FF7-406E-A355-CA3B9319D1EF}" dt="2022-02-24T03:26:49.701" v="486" actId="1038"/>
          <ac:picMkLst>
            <pc:docMk/>
            <pc:sldMk cId="4208113970" sldId="288"/>
            <ac:picMk id="14" creationId="{378C07F1-338D-484D-AC20-21B17222885B}"/>
          </ac:picMkLst>
        </pc:picChg>
      </pc:sldChg>
      <pc:sldChg chg="add">
        <pc:chgData name="Yang, Shengming - ARS" userId="37bd5b25-7571-49cb-bfc8-588a18706c35" providerId="ADAL" clId="{73BA1FA4-9FF7-406E-A355-CA3B9319D1EF}" dt="2022-02-17T23:04:07.538" v="114" actId="2890"/>
        <pc:sldMkLst>
          <pc:docMk/>
          <pc:sldMk cId="3220999384" sldId="289"/>
        </pc:sldMkLst>
      </pc:sldChg>
      <pc:sldChg chg="addSp delSp modSp new mod">
        <pc:chgData name="Yang, Shengming - ARS" userId="37bd5b25-7571-49cb-bfc8-588a18706c35" providerId="ADAL" clId="{73BA1FA4-9FF7-406E-A355-CA3B9319D1EF}" dt="2022-02-18T20:25:13.632" v="325" actId="1076"/>
        <pc:sldMkLst>
          <pc:docMk/>
          <pc:sldMk cId="2200906561" sldId="290"/>
        </pc:sldMkLst>
        <pc:spChg chg="del">
          <ac:chgData name="Yang, Shengming - ARS" userId="37bd5b25-7571-49cb-bfc8-588a18706c35" providerId="ADAL" clId="{73BA1FA4-9FF7-406E-A355-CA3B9319D1EF}" dt="2022-02-18T19:21:45.231" v="265" actId="478"/>
          <ac:spMkLst>
            <pc:docMk/>
            <pc:sldMk cId="2200906561" sldId="290"/>
            <ac:spMk id="2" creationId="{F10849D5-9DED-4EA6-8B9F-BB67DCD598CD}"/>
          </ac:spMkLst>
        </pc:spChg>
        <pc:spChg chg="del">
          <ac:chgData name="Yang, Shengming - ARS" userId="37bd5b25-7571-49cb-bfc8-588a18706c35" providerId="ADAL" clId="{73BA1FA4-9FF7-406E-A355-CA3B9319D1EF}" dt="2022-02-18T19:21:45.231" v="265" actId="478"/>
          <ac:spMkLst>
            <pc:docMk/>
            <pc:sldMk cId="2200906561" sldId="290"/>
            <ac:spMk id="3" creationId="{B563AD90-3C4C-48CF-B5D2-F2891A7BEEAF}"/>
          </ac:spMkLst>
        </pc:spChg>
        <pc:spChg chg="add del mod">
          <ac:chgData name="Yang, Shengming - ARS" userId="37bd5b25-7571-49cb-bfc8-588a18706c35" providerId="ADAL" clId="{73BA1FA4-9FF7-406E-A355-CA3B9319D1EF}" dt="2022-02-18T20:24:46.324" v="315" actId="478"/>
          <ac:spMkLst>
            <pc:docMk/>
            <pc:sldMk cId="2200906561" sldId="290"/>
            <ac:spMk id="5" creationId="{093A9F08-7D84-4732-A8C5-9B6F46AD8A45}"/>
          </ac:spMkLst>
        </pc:spChg>
        <pc:spChg chg="add del mod">
          <ac:chgData name="Yang, Shengming - ARS" userId="37bd5b25-7571-49cb-bfc8-588a18706c35" providerId="ADAL" clId="{73BA1FA4-9FF7-406E-A355-CA3B9319D1EF}" dt="2022-02-18T20:24:48.113" v="316" actId="478"/>
          <ac:spMkLst>
            <pc:docMk/>
            <pc:sldMk cId="2200906561" sldId="290"/>
            <ac:spMk id="7" creationId="{ABECF8B5-389F-4E67-881B-A95469EF60AA}"/>
          </ac:spMkLst>
        </pc:spChg>
        <pc:spChg chg="add mod">
          <ac:chgData name="Yang, Shengming - ARS" userId="37bd5b25-7571-49cb-bfc8-588a18706c35" providerId="ADAL" clId="{73BA1FA4-9FF7-406E-A355-CA3B9319D1EF}" dt="2022-02-18T20:25:13.632" v="325" actId="1076"/>
          <ac:spMkLst>
            <pc:docMk/>
            <pc:sldMk cId="2200906561" sldId="290"/>
            <ac:spMk id="9" creationId="{326B85DA-5FEB-49AA-9B1D-779F6E66A986}"/>
          </ac:spMkLst>
        </pc:spChg>
      </pc:sldChg>
    </pc:docChg>
  </pc:docChgLst>
  <pc:docChgLst>
    <pc:chgData name="Yang, Shengming - ARS" userId="37bd5b25-7571-49cb-bfc8-588a18706c35" providerId="ADAL" clId="{D37E7023-24B4-488B-82AC-5E5A99F64B29}"/>
    <pc:docChg chg="undo custSel delSld modSld">
      <pc:chgData name="Yang, Shengming - ARS" userId="37bd5b25-7571-49cb-bfc8-588a18706c35" providerId="ADAL" clId="{D37E7023-24B4-488B-82AC-5E5A99F64B29}" dt="2022-01-27T19:58:26.674" v="612" actId="20577"/>
      <pc:docMkLst>
        <pc:docMk/>
      </pc:docMkLst>
      <pc:sldChg chg="addSp delSp modSp mod modNotesTx">
        <pc:chgData name="Yang, Shengming - ARS" userId="37bd5b25-7571-49cb-bfc8-588a18706c35" providerId="ADAL" clId="{D37E7023-24B4-488B-82AC-5E5A99F64B29}" dt="2022-01-27T19:49:24.237" v="452" actId="1076"/>
        <pc:sldMkLst>
          <pc:docMk/>
          <pc:sldMk cId="1525299809" sldId="275"/>
        </pc:sldMkLst>
        <pc:spChg chg="add mod">
          <ac:chgData name="Yang, Shengming - ARS" userId="37bd5b25-7571-49cb-bfc8-588a18706c35" providerId="ADAL" clId="{D37E7023-24B4-488B-82AC-5E5A99F64B29}" dt="2022-01-27T16:37:54.496" v="428" actId="164"/>
          <ac:spMkLst>
            <pc:docMk/>
            <pc:sldMk cId="1525299809" sldId="275"/>
            <ac:spMk id="3" creationId="{E888CEB0-32B8-4D3E-AF97-26E24DBED6A2}"/>
          </ac:spMkLst>
        </pc:spChg>
        <pc:spChg chg="add del">
          <ac:chgData name="Yang, Shengming - ARS" userId="37bd5b25-7571-49cb-bfc8-588a18706c35" providerId="ADAL" clId="{D37E7023-24B4-488B-82AC-5E5A99F64B29}" dt="2022-01-27T16:35:46.953" v="390" actId="478"/>
          <ac:spMkLst>
            <pc:docMk/>
            <pc:sldMk cId="1525299809" sldId="275"/>
            <ac:spMk id="4" creationId="{73808741-A5B7-4321-AEF7-F5F6C39B6CDB}"/>
          </ac:spMkLst>
        </pc:spChg>
        <pc:spChg chg="mod">
          <ac:chgData name="Yang, Shengming - ARS" userId="37bd5b25-7571-49cb-bfc8-588a18706c35" providerId="ADAL" clId="{D37E7023-24B4-488B-82AC-5E5A99F64B29}" dt="2022-01-27T19:49:24.237" v="452" actId="1076"/>
          <ac:spMkLst>
            <pc:docMk/>
            <pc:sldMk cId="1525299809" sldId="275"/>
            <ac:spMk id="7" creationId="{59EC5E2F-A06C-44C2-9BC7-5083B8DB0158}"/>
          </ac:spMkLst>
        </pc:spChg>
        <pc:spChg chg="mod">
          <ac:chgData name="Yang, Shengming - ARS" userId="37bd5b25-7571-49cb-bfc8-588a18706c35" providerId="ADAL" clId="{D37E7023-24B4-488B-82AC-5E5A99F64B29}" dt="2022-01-27T19:49:24.237" v="452" actId="1076"/>
          <ac:spMkLst>
            <pc:docMk/>
            <pc:sldMk cId="1525299809" sldId="275"/>
            <ac:spMk id="12" creationId="{521E7359-7336-437C-8A90-B14583285988}"/>
          </ac:spMkLst>
        </pc:spChg>
        <pc:spChg chg="mod">
          <ac:chgData name="Yang, Shengming - ARS" userId="37bd5b25-7571-49cb-bfc8-588a18706c35" providerId="ADAL" clId="{D37E7023-24B4-488B-82AC-5E5A99F64B29}" dt="2022-01-27T19:49:24.237" v="452" actId="1076"/>
          <ac:spMkLst>
            <pc:docMk/>
            <pc:sldMk cId="1525299809" sldId="275"/>
            <ac:spMk id="13" creationId="{50A0EE90-3932-4530-A2F6-B29B53FA3754}"/>
          </ac:spMkLst>
        </pc:spChg>
        <pc:spChg chg="mod">
          <ac:chgData name="Yang, Shengming - ARS" userId="37bd5b25-7571-49cb-bfc8-588a18706c35" providerId="ADAL" clId="{D37E7023-24B4-488B-82AC-5E5A99F64B29}" dt="2022-01-27T19:49:24.237" v="452" actId="1076"/>
          <ac:spMkLst>
            <pc:docMk/>
            <pc:sldMk cId="1525299809" sldId="275"/>
            <ac:spMk id="17" creationId="{EF72585C-D2AF-45D3-97AC-199E08312281}"/>
          </ac:spMkLst>
        </pc:spChg>
        <pc:spChg chg="del mod">
          <ac:chgData name="Yang, Shengming - ARS" userId="37bd5b25-7571-49cb-bfc8-588a18706c35" providerId="ADAL" clId="{D37E7023-24B4-488B-82AC-5E5A99F64B29}" dt="2022-01-27T16:18:50.331" v="13" actId="478"/>
          <ac:spMkLst>
            <pc:docMk/>
            <pc:sldMk cId="1525299809" sldId="275"/>
            <ac:spMk id="22" creationId="{4D948ADA-E9AF-42DA-8B05-03DACB9C498C}"/>
          </ac:spMkLst>
        </pc:spChg>
        <pc:spChg chg="mod">
          <ac:chgData name="Yang, Shengming - ARS" userId="37bd5b25-7571-49cb-bfc8-588a18706c35" providerId="ADAL" clId="{D37E7023-24B4-488B-82AC-5E5A99F64B29}" dt="2022-01-27T19:49:24.237" v="452" actId="1076"/>
          <ac:spMkLst>
            <pc:docMk/>
            <pc:sldMk cId="1525299809" sldId="275"/>
            <ac:spMk id="23" creationId="{EE0E463B-8D9C-4CD8-A0EC-C0A58991BB7D}"/>
          </ac:spMkLst>
        </pc:spChg>
        <pc:spChg chg="del mod">
          <ac:chgData name="Yang, Shengming - ARS" userId="37bd5b25-7571-49cb-bfc8-588a18706c35" providerId="ADAL" clId="{D37E7023-24B4-488B-82AC-5E5A99F64B29}" dt="2022-01-27T16:18:50.331" v="13" actId="478"/>
          <ac:spMkLst>
            <pc:docMk/>
            <pc:sldMk cId="1525299809" sldId="275"/>
            <ac:spMk id="24" creationId="{4162F7BC-929B-45B6-BA7F-921891A36F89}"/>
          </ac:spMkLst>
        </pc:spChg>
        <pc:spChg chg="mod">
          <ac:chgData name="Yang, Shengming - ARS" userId="37bd5b25-7571-49cb-bfc8-588a18706c35" providerId="ADAL" clId="{D37E7023-24B4-488B-82AC-5E5A99F64B29}" dt="2022-01-27T19:49:24.237" v="452" actId="1076"/>
          <ac:spMkLst>
            <pc:docMk/>
            <pc:sldMk cId="1525299809" sldId="275"/>
            <ac:spMk id="26" creationId="{B9CCD95B-3889-4379-A2D1-2FC056F98C66}"/>
          </ac:spMkLst>
        </pc:spChg>
        <pc:spChg chg="mod">
          <ac:chgData name="Yang, Shengming - ARS" userId="37bd5b25-7571-49cb-bfc8-588a18706c35" providerId="ADAL" clId="{D37E7023-24B4-488B-82AC-5E5A99F64B29}" dt="2022-01-27T19:49:24.237" v="452" actId="1076"/>
          <ac:spMkLst>
            <pc:docMk/>
            <pc:sldMk cId="1525299809" sldId="275"/>
            <ac:spMk id="27" creationId="{A025DAFC-93D1-4F78-945F-66FA9798F458}"/>
          </ac:spMkLst>
        </pc:spChg>
        <pc:spChg chg="add mod">
          <ac:chgData name="Yang, Shengming - ARS" userId="37bd5b25-7571-49cb-bfc8-588a18706c35" providerId="ADAL" clId="{D37E7023-24B4-488B-82AC-5E5A99F64B29}" dt="2022-01-27T19:49:24.237" v="452" actId="1076"/>
          <ac:spMkLst>
            <pc:docMk/>
            <pc:sldMk cId="1525299809" sldId="275"/>
            <ac:spMk id="29" creationId="{715CB5B5-537D-4983-A660-F90C40946944}"/>
          </ac:spMkLst>
        </pc:spChg>
        <pc:spChg chg="add mod">
          <ac:chgData name="Yang, Shengming - ARS" userId="37bd5b25-7571-49cb-bfc8-588a18706c35" providerId="ADAL" clId="{D37E7023-24B4-488B-82AC-5E5A99F64B29}" dt="2022-01-27T19:49:24.237" v="452" actId="1076"/>
          <ac:spMkLst>
            <pc:docMk/>
            <pc:sldMk cId="1525299809" sldId="275"/>
            <ac:spMk id="30" creationId="{C224467D-B63C-431B-940C-424E4BB0DB94}"/>
          </ac:spMkLst>
        </pc:spChg>
        <pc:spChg chg="add mod">
          <ac:chgData name="Yang, Shengming - ARS" userId="37bd5b25-7571-49cb-bfc8-588a18706c35" providerId="ADAL" clId="{D37E7023-24B4-488B-82AC-5E5A99F64B29}" dt="2022-01-27T19:49:24.237" v="452" actId="1076"/>
          <ac:spMkLst>
            <pc:docMk/>
            <pc:sldMk cId="1525299809" sldId="275"/>
            <ac:spMk id="31" creationId="{94E1D290-E962-4DC5-9BCF-50A122D814DD}"/>
          </ac:spMkLst>
        </pc:spChg>
        <pc:spChg chg="add mod">
          <ac:chgData name="Yang, Shengming - ARS" userId="37bd5b25-7571-49cb-bfc8-588a18706c35" providerId="ADAL" clId="{D37E7023-24B4-488B-82AC-5E5A99F64B29}" dt="2022-01-27T19:49:24.237" v="452" actId="1076"/>
          <ac:spMkLst>
            <pc:docMk/>
            <pc:sldMk cId="1525299809" sldId="275"/>
            <ac:spMk id="32" creationId="{1B62C987-43F5-4DE2-8AF8-592FEF0B282D}"/>
          </ac:spMkLst>
        </pc:spChg>
        <pc:grpChg chg="add mod">
          <ac:chgData name="Yang, Shengming - ARS" userId="37bd5b25-7571-49cb-bfc8-588a18706c35" providerId="ADAL" clId="{D37E7023-24B4-488B-82AC-5E5A99F64B29}" dt="2022-01-27T19:49:24.237" v="452" actId="1076"/>
          <ac:grpSpMkLst>
            <pc:docMk/>
            <pc:sldMk cId="1525299809" sldId="275"/>
            <ac:grpSpMk id="10" creationId="{9EB0F5CE-09DF-447B-B0F0-E641528ECE92}"/>
          </ac:grpSpMkLst>
        </pc:grpChg>
        <pc:picChg chg="mod">
          <ac:chgData name="Yang, Shengming - ARS" userId="37bd5b25-7571-49cb-bfc8-588a18706c35" providerId="ADAL" clId="{D37E7023-24B4-488B-82AC-5E5A99F64B29}" dt="2022-01-27T19:49:24.237" v="452" actId="1076"/>
          <ac:picMkLst>
            <pc:docMk/>
            <pc:sldMk cId="1525299809" sldId="275"/>
            <ac:picMk id="5" creationId="{47886F41-8483-490F-AFEC-C9F34925FEB4}"/>
          </ac:picMkLst>
        </pc:picChg>
        <pc:picChg chg="mod">
          <ac:chgData name="Yang, Shengming - ARS" userId="37bd5b25-7571-49cb-bfc8-588a18706c35" providerId="ADAL" clId="{D37E7023-24B4-488B-82AC-5E5A99F64B29}" dt="2022-01-27T19:49:24.237" v="452" actId="1076"/>
          <ac:picMkLst>
            <pc:docMk/>
            <pc:sldMk cId="1525299809" sldId="275"/>
            <ac:picMk id="9" creationId="{8A5CA8A6-E525-4485-ADF9-36221A12B462}"/>
          </ac:picMkLst>
        </pc:picChg>
        <pc:picChg chg="mod">
          <ac:chgData name="Yang, Shengming - ARS" userId="37bd5b25-7571-49cb-bfc8-588a18706c35" providerId="ADAL" clId="{D37E7023-24B4-488B-82AC-5E5A99F64B29}" dt="2022-01-27T19:49:24.237" v="452" actId="1076"/>
          <ac:picMkLst>
            <pc:docMk/>
            <pc:sldMk cId="1525299809" sldId="275"/>
            <ac:picMk id="15" creationId="{59E8A476-E459-49E7-BC90-C0244CB29CE8}"/>
          </ac:picMkLst>
        </pc:picChg>
        <pc:picChg chg="mod">
          <ac:chgData name="Yang, Shengming - ARS" userId="37bd5b25-7571-49cb-bfc8-588a18706c35" providerId="ADAL" clId="{D37E7023-24B4-488B-82AC-5E5A99F64B29}" dt="2022-01-27T19:49:24.237" v="452" actId="1076"/>
          <ac:picMkLst>
            <pc:docMk/>
            <pc:sldMk cId="1525299809" sldId="275"/>
            <ac:picMk id="18" creationId="{DC957572-5F76-4953-A205-6FFE95C92F40}"/>
          </ac:picMkLst>
        </pc:picChg>
        <pc:picChg chg="mod">
          <ac:chgData name="Yang, Shengming - ARS" userId="37bd5b25-7571-49cb-bfc8-588a18706c35" providerId="ADAL" clId="{D37E7023-24B4-488B-82AC-5E5A99F64B29}" dt="2022-01-27T19:49:24.237" v="452" actId="1076"/>
          <ac:picMkLst>
            <pc:docMk/>
            <pc:sldMk cId="1525299809" sldId="275"/>
            <ac:picMk id="19" creationId="{596237EC-86BA-4274-95FA-01770DA46B69}"/>
          </ac:picMkLst>
        </pc:picChg>
        <pc:picChg chg="del mod">
          <ac:chgData name="Yang, Shengming - ARS" userId="37bd5b25-7571-49cb-bfc8-588a18706c35" providerId="ADAL" clId="{D37E7023-24B4-488B-82AC-5E5A99F64B29}" dt="2022-01-27T16:18:46.066" v="12" actId="478"/>
          <ac:picMkLst>
            <pc:docMk/>
            <pc:sldMk cId="1525299809" sldId="275"/>
            <ac:picMk id="20" creationId="{82B004C6-1B02-4AAE-9F53-D06DA1D4183C}"/>
          </ac:picMkLst>
        </pc:picChg>
        <pc:picChg chg="mod">
          <ac:chgData name="Yang, Shengming - ARS" userId="37bd5b25-7571-49cb-bfc8-588a18706c35" providerId="ADAL" clId="{D37E7023-24B4-488B-82AC-5E5A99F64B29}" dt="2022-01-27T19:49:24.237" v="452" actId="1076"/>
          <ac:picMkLst>
            <pc:docMk/>
            <pc:sldMk cId="1525299809" sldId="275"/>
            <ac:picMk id="21" creationId="{678FCA89-43B8-45BE-8851-22EE7A6E7A89}"/>
          </ac:picMkLst>
        </pc:picChg>
        <pc:picChg chg="add mod">
          <ac:chgData name="Yang, Shengming - ARS" userId="37bd5b25-7571-49cb-bfc8-588a18706c35" providerId="ADAL" clId="{D37E7023-24B4-488B-82AC-5E5A99F64B29}" dt="2022-01-27T19:49:24.237" v="452" actId="1076"/>
          <ac:picMkLst>
            <pc:docMk/>
            <pc:sldMk cId="1525299809" sldId="275"/>
            <ac:picMk id="28" creationId="{5B78FAF8-81AD-4BE8-8D4D-D67EB64B4388}"/>
          </ac:picMkLst>
        </pc:picChg>
        <pc:cxnChg chg="add mod">
          <ac:chgData name="Yang, Shengming - ARS" userId="37bd5b25-7571-49cb-bfc8-588a18706c35" providerId="ADAL" clId="{D37E7023-24B4-488B-82AC-5E5A99F64B29}" dt="2022-01-27T16:37:54.496" v="428" actId="164"/>
          <ac:cxnSpMkLst>
            <pc:docMk/>
            <pc:sldMk cId="1525299809" sldId="275"/>
            <ac:cxnSpMk id="8" creationId="{D0FAFBD5-ACC8-4431-8A0C-DF282A6B392A}"/>
          </ac:cxnSpMkLst>
        </pc:cxnChg>
      </pc:sldChg>
      <pc:sldChg chg="del">
        <pc:chgData name="Yang, Shengming - ARS" userId="37bd5b25-7571-49cb-bfc8-588a18706c35" providerId="ADAL" clId="{D37E7023-24B4-488B-82AC-5E5A99F64B29}" dt="2022-01-27T16:41:11.055" v="449" actId="47"/>
        <pc:sldMkLst>
          <pc:docMk/>
          <pc:sldMk cId="1104748975" sldId="281"/>
        </pc:sldMkLst>
      </pc:sldChg>
      <pc:sldChg chg="addSp modSp mod modNotesTx">
        <pc:chgData name="Yang, Shengming - ARS" userId="37bd5b25-7571-49cb-bfc8-588a18706c35" providerId="ADAL" clId="{D37E7023-24B4-488B-82AC-5E5A99F64B29}" dt="2022-01-27T19:58:26.674" v="612" actId="20577"/>
        <pc:sldMkLst>
          <pc:docMk/>
          <pc:sldMk cId="2625937353" sldId="284"/>
        </pc:sldMkLst>
        <pc:spChg chg="add mod">
          <ac:chgData name="Yang, Shengming - ARS" userId="37bd5b25-7571-49cb-bfc8-588a18706c35" providerId="ADAL" clId="{D37E7023-24B4-488B-82AC-5E5A99F64B29}" dt="2022-01-27T19:56:07.538" v="568" actId="1036"/>
          <ac:spMkLst>
            <pc:docMk/>
            <pc:sldMk cId="2625937353" sldId="284"/>
            <ac:spMk id="4" creationId="{215B0B4D-DB32-4008-B80D-26D338070DDC}"/>
          </ac:spMkLst>
        </pc:spChg>
        <pc:spChg chg="mod">
          <ac:chgData name="Yang, Shengming - ARS" userId="37bd5b25-7571-49cb-bfc8-588a18706c35" providerId="ADAL" clId="{D37E7023-24B4-488B-82AC-5E5A99F64B29}" dt="2022-01-27T19:50:06.590" v="453" actId="14100"/>
          <ac:spMkLst>
            <pc:docMk/>
            <pc:sldMk cId="2625937353" sldId="284"/>
            <ac:spMk id="29" creationId="{C0EAD2EE-9202-427B-889B-A230C6AD52EE}"/>
          </ac:spMkLst>
        </pc:spChg>
        <pc:spChg chg="mod">
          <ac:chgData name="Yang, Shengming - ARS" userId="37bd5b25-7571-49cb-bfc8-588a18706c35" providerId="ADAL" clId="{D37E7023-24B4-488B-82AC-5E5A99F64B29}" dt="2022-01-27T19:55:58.109" v="556" actId="1035"/>
          <ac:spMkLst>
            <pc:docMk/>
            <pc:sldMk cId="2625937353" sldId="284"/>
            <ac:spMk id="45" creationId="{561A173B-C821-49F3-875D-7AFC1E02CE2F}"/>
          </ac:spMkLst>
        </pc:spChg>
        <pc:spChg chg="mod">
          <ac:chgData name="Yang, Shengming - ARS" userId="37bd5b25-7571-49cb-bfc8-588a18706c35" providerId="ADAL" clId="{D37E7023-24B4-488B-82AC-5E5A99F64B29}" dt="2022-01-27T19:55:58.109" v="556" actId="1035"/>
          <ac:spMkLst>
            <pc:docMk/>
            <pc:sldMk cId="2625937353" sldId="284"/>
            <ac:spMk id="46" creationId="{1C334073-8210-401F-ABDE-84BF451B23A4}"/>
          </ac:spMkLst>
        </pc:spChg>
        <pc:spChg chg="mod">
          <ac:chgData name="Yang, Shengming - ARS" userId="37bd5b25-7571-49cb-bfc8-588a18706c35" providerId="ADAL" clId="{D37E7023-24B4-488B-82AC-5E5A99F64B29}" dt="2022-01-27T19:55:58.109" v="556" actId="1035"/>
          <ac:spMkLst>
            <pc:docMk/>
            <pc:sldMk cId="2625937353" sldId="284"/>
            <ac:spMk id="47" creationId="{D320BB33-AD7F-4672-849A-58E930A112F8}"/>
          </ac:spMkLst>
        </pc:spChg>
        <pc:spChg chg="mod">
          <ac:chgData name="Yang, Shengming - ARS" userId="37bd5b25-7571-49cb-bfc8-588a18706c35" providerId="ADAL" clId="{D37E7023-24B4-488B-82AC-5E5A99F64B29}" dt="2022-01-27T19:55:58.109" v="556" actId="1035"/>
          <ac:spMkLst>
            <pc:docMk/>
            <pc:sldMk cId="2625937353" sldId="284"/>
            <ac:spMk id="48" creationId="{FAD047C0-A68E-42D3-ABA2-034D858DAD9A}"/>
          </ac:spMkLst>
        </pc:spChg>
        <pc:spChg chg="add mod">
          <ac:chgData name="Yang, Shengming - ARS" userId="37bd5b25-7571-49cb-bfc8-588a18706c35" providerId="ADAL" clId="{D37E7023-24B4-488B-82AC-5E5A99F64B29}" dt="2022-01-27T19:57:28.850" v="596" actId="1076"/>
          <ac:spMkLst>
            <pc:docMk/>
            <pc:sldMk cId="2625937353" sldId="284"/>
            <ac:spMk id="51" creationId="{AC4DD17F-CEB8-44C0-AA25-BDE0B8D786EB}"/>
          </ac:spMkLst>
        </pc:spChg>
        <pc:spChg chg="add mod">
          <ac:chgData name="Yang, Shengming - ARS" userId="37bd5b25-7571-49cb-bfc8-588a18706c35" providerId="ADAL" clId="{D37E7023-24B4-488B-82AC-5E5A99F64B29}" dt="2022-01-27T19:57:49.072" v="603" actId="113"/>
          <ac:spMkLst>
            <pc:docMk/>
            <pc:sldMk cId="2625937353" sldId="284"/>
            <ac:spMk id="52" creationId="{963E53D2-EA4C-48D0-898F-B1CA99C7AFD8}"/>
          </ac:spMkLst>
        </pc:spChg>
        <pc:spChg chg="add mod">
          <ac:chgData name="Yang, Shengming - ARS" userId="37bd5b25-7571-49cb-bfc8-588a18706c35" providerId="ADAL" clId="{D37E7023-24B4-488B-82AC-5E5A99F64B29}" dt="2022-01-27T19:57:58.033" v="606" actId="20577"/>
          <ac:spMkLst>
            <pc:docMk/>
            <pc:sldMk cId="2625937353" sldId="284"/>
            <ac:spMk id="53" creationId="{6D0568C5-093C-4831-8518-1D6A40EF0B8B}"/>
          </ac:spMkLst>
        </pc:spChg>
        <pc:spChg chg="add mod">
          <ac:chgData name="Yang, Shengming - ARS" userId="37bd5b25-7571-49cb-bfc8-588a18706c35" providerId="ADAL" clId="{D37E7023-24B4-488B-82AC-5E5A99F64B29}" dt="2022-01-27T19:58:14.368" v="609" actId="20577"/>
          <ac:spMkLst>
            <pc:docMk/>
            <pc:sldMk cId="2625937353" sldId="284"/>
            <ac:spMk id="54" creationId="{4FD89DBB-46A0-4095-8335-45FC145DE04E}"/>
          </ac:spMkLst>
        </pc:spChg>
        <pc:spChg chg="add mod">
          <ac:chgData name="Yang, Shengming - ARS" userId="37bd5b25-7571-49cb-bfc8-588a18706c35" providerId="ADAL" clId="{D37E7023-24B4-488B-82AC-5E5A99F64B29}" dt="2022-01-27T19:58:26.674" v="612" actId="20577"/>
          <ac:spMkLst>
            <pc:docMk/>
            <pc:sldMk cId="2625937353" sldId="284"/>
            <ac:spMk id="55" creationId="{A6D270E6-0520-4418-8296-0E03A15207C8}"/>
          </ac:spMkLst>
        </pc:spChg>
        <pc:picChg chg="mod">
          <ac:chgData name="Yang, Shengming - ARS" userId="37bd5b25-7571-49cb-bfc8-588a18706c35" providerId="ADAL" clId="{D37E7023-24B4-488B-82AC-5E5A99F64B29}" dt="2022-01-27T19:55:58.109" v="556" actId="1035"/>
          <ac:picMkLst>
            <pc:docMk/>
            <pc:sldMk cId="2625937353" sldId="284"/>
            <ac:picMk id="2" creationId="{7556588D-D216-4384-B5CD-01DA16987B6F}"/>
          </ac:picMkLst>
        </pc:picChg>
        <pc:picChg chg="mod">
          <ac:chgData name="Yang, Shengming - ARS" userId="37bd5b25-7571-49cb-bfc8-588a18706c35" providerId="ADAL" clId="{D37E7023-24B4-488B-82AC-5E5A99F64B29}" dt="2022-01-27T19:55:58.109" v="556" actId="1035"/>
          <ac:picMkLst>
            <pc:docMk/>
            <pc:sldMk cId="2625937353" sldId="284"/>
            <ac:picMk id="35" creationId="{745C001A-D968-411D-967A-269A9A402FD0}"/>
          </ac:picMkLst>
        </pc:picChg>
        <pc:picChg chg="mod">
          <ac:chgData name="Yang, Shengming - ARS" userId="37bd5b25-7571-49cb-bfc8-588a18706c35" providerId="ADAL" clId="{D37E7023-24B4-488B-82AC-5E5A99F64B29}" dt="2022-01-27T19:55:58.109" v="556" actId="1035"/>
          <ac:picMkLst>
            <pc:docMk/>
            <pc:sldMk cId="2625937353" sldId="284"/>
            <ac:picMk id="37" creationId="{C2B3FB3C-31C6-4288-924D-874795D58FEB}"/>
          </ac:picMkLst>
        </pc:picChg>
        <pc:picChg chg="mod">
          <ac:chgData name="Yang, Shengming - ARS" userId="37bd5b25-7571-49cb-bfc8-588a18706c35" providerId="ADAL" clId="{D37E7023-24B4-488B-82AC-5E5A99F64B29}" dt="2022-01-27T19:55:58.109" v="556" actId="1035"/>
          <ac:picMkLst>
            <pc:docMk/>
            <pc:sldMk cId="2625937353" sldId="284"/>
            <ac:picMk id="38" creationId="{B7A19B21-874C-4169-B186-FCABA8034826}"/>
          </ac:picMkLst>
        </pc:picChg>
        <pc:cxnChg chg="add mod">
          <ac:chgData name="Yang, Shengming - ARS" userId="37bd5b25-7571-49cb-bfc8-588a18706c35" providerId="ADAL" clId="{D37E7023-24B4-488B-82AC-5E5A99F64B29}" dt="2022-01-27T19:56:15.212" v="577" actId="1035"/>
          <ac:cxnSpMkLst>
            <pc:docMk/>
            <pc:sldMk cId="2625937353" sldId="284"/>
            <ac:cxnSpMk id="7" creationId="{B1A2A7DD-56EE-46A1-AF79-4F81A8F667E2}"/>
          </ac:cxnSpMkLst>
        </pc:cxnChg>
        <pc:cxnChg chg="add mod">
          <ac:chgData name="Yang, Shengming - ARS" userId="37bd5b25-7571-49cb-bfc8-588a18706c35" providerId="ADAL" clId="{D37E7023-24B4-488B-82AC-5E5A99F64B29}" dt="2022-01-27T19:56:46.085" v="586" actId="1038"/>
          <ac:cxnSpMkLst>
            <pc:docMk/>
            <pc:sldMk cId="2625937353" sldId="284"/>
            <ac:cxnSpMk id="9" creationId="{37F714AF-2B51-4404-97B1-0F18158EF1AF}"/>
          </ac:cxnSpMkLst>
        </pc:cxnChg>
        <pc:cxnChg chg="add mod">
          <ac:chgData name="Yang, Shengming - ARS" userId="37bd5b25-7571-49cb-bfc8-588a18706c35" providerId="ADAL" clId="{D37E7023-24B4-488B-82AC-5E5A99F64B29}" dt="2022-01-27T19:57:05.257" v="592" actId="1038"/>
          <ac:cxnSpMkLst>
            <pc:docMk/>
            <pc:sldMk cId="2625937353" sldId="284"/>
            <ac:cxnSpMk id="49" creationId="{69131EF0-17FC-423F-B4DE-37C47DC1FC58}"/>
          </ac:cxnSpMkLst>
        </pc:cxnChg>
        <pc:cxnChg chg="add mod">
          <ac:chgData name="Yang, Shengming - ARS" userId="37bd5b25-7571-49cb-bfc8-588a18706c35" providerId="ADAL" clId="{D37E7023-24B4-488B-82AC-5E5A99F64B29}" dt="2022-01-27T19:56:53.530" v="589" actId="1076"/>
          <ac:cxnSpMkLst>
            <pc:docMk/>
            <pc:sldMk cId="2625937353" sldId="284"/>
            <ac:cxnSpMk id="50" creationId="{DD9D9641-10E3-4914-92C5-30DBAD145F35}"/>
          </ac:cxnSpMkLst>
        </pc:cxnChg>
      </pc:sldChg>
      <pc:sldChg chg="modSp mod">
        <pc:chgData name="Yang, Shengming - ARS" userId="37bd5b25-7571-49cb-bfc8-588a18706c35" providerId="ADAL" clId="{D37E7023-24B4-488B-82AC-5E5A99F64B29}" dt="2022-01-27T17:21:40.823" v="451" actId="1076"/>
        <pc:sldMkLst>
          <pc:docMk/>
          <pc:sldMk cId="2301416017" sldId="285"/>
        </pc:sldMkLst>
        <pc:picChg chg="mod">
          <ac:chgData name="Yang, Shengming - ARS" userId="37bd5b25-7571-49cb-bfc8-588a18706c35" providerId="ADAL" clId="{D37E7023-24B4-488B-82AC-5E5A99F64B29}" dt="2022-01-27T17:21:40.823" v="451" actId="1076"/>
          <ac:picMkLst>
            <pc:docMk/>
            <pc:sldMk cId="2301416017" sldId="285"/>
            <ac:picMk id="5" creationId="{3381DD81-F4CB-4116-AB31-33C2B9C41158}"/>
          </ac:picMkLst>
        </pc:picChg>
        <pc:picChg chg="mod">
          <ac:chgData name="Yang, Shengming - ARS" userId="37bd5b25-7571-49cb-bfc8-588a18706c35" providerId="ADAL" clId="{D37E7023-24B4-488B-82AC-5E5A99F64B29}" dt="2022-01-27T17:21:31.023" v="450" actId="1076"/>
          <ac:picMkLst>
            <pc:docMk/>
            <pc:sldMk cId="2301416017" sldId="285"/>
            <ac:picMk id="10" creationId="{05A166F1-4B35-440B-8A66-9471844B2815}"/>
          </ac:picMkLst>
        </pc:picChg>
      </pc:sldChg>
    </pc:docChg>
  </pc:docChgLst>
  <pc:docChgLst>
    <pc:chgData name="Yang, Shengming - ARS" userId="37bd5b25-7571-49cb-bfc8-588a18706c35" providerId="ADAL" clId="{1CEC4EA3-DB05-44BE-AF57-7E2779412AED}"/>
    <pc:docChg chg="undo redo custSel addSld modSld sldOrd">
      <pc:chgData name="Yang, Shengming - ARS" userId="37bd5b25-7571-49cb-bfc8-588a18706c35" providerId="ADAL" clId="{1CEC4EA3-DB05-44BE-AF57-7E2779412AED}" dt="2021-12-23T19:45:07.913" v="2112" actId="1037"/>
      <pc:docMkLst>
        <pc:docMk/>
      </pc:docMkLst>
      <pc:sldChg chg="ord">
        <pc:chgData name="Yang, Shengming - ARS" userId="37bd5b25-7571-49cb-bfc8-588a18706c35" providerId="ADAL" clId="{1CEC4EA3-DB05-44BE-AF57-7E2779412AED}" dt="2021-12-22T20:53:48.615" v="2098"/>
        <pc:sldMkLst>
          <pc:docMk/>
          <pc:sldMk cId="187198215" sldId="256"/>
        </pc:sldMkLst>
      </pc:sldChg>
      <pc:sldChg chg="addSp delSp modSp mod">
        <pc:chgData name="Yang, Shengming - ARS" userId="37bd5b25-7571-49cb-bfc8-588a18706c35" providerId="ADAL" clId="{1CEC4EA3-DB05-44BE-AF57-7E2779412AED}" dt="2021-12-02T22:13:06.346" v="1082" actId="478"/>
        <pc:sldMkLst>
          <pc:docMk/>
          <pc:sldMk cId="1525299809" sldId="275"/>
        </pc:sldMkLst>
        <pc:spChg chg="mod">
          <ac:chgData name="Yang, Shengming - ARS" userId="37bd5b25-7571-49cb-bfc8-588a18706c35" providerId="ADAL" clId="{1CEC4EA3-DB05-44BE-AF57-7E2779412AED}" dt="2021-12-02T22:12:18.547" v="1079" actId="1076"/>
          <ac:spMkLst>
            <pc:docMk/>
            <pc:sldMk cId="1525299809" sldId="275"/>
            <ac:spMk id="7" creationId="{59EC5E2F-A06C-44C2-9BC7-5083B8DB0158}"/>
          </ac:spMkLst>
        </pc:spChg>
        <pc:spChg chg="mod">
          <ac:chgData name="Yang, Shengming - ARS" userId="37bd5b25-7571-49cb-bfc8-588a18706c35" providerId="ADAL" clId="{1CEC4EA3-DB05-44BE-AF57-7E2779412AED}" dt="2021-12-02T22:12:18.547" v="1079" actId="1076"/>
          <ac:spMkLst>
            <pc:docMk/>
            <pc:sldMk cId="1525299809" sldId="275"/>
            <ac:spMk id="12" creationId="{521E7359-7336-437C-8A90-B14583285988}"/>
          </ac:spMkLst>
        </pc:spChg>
        <pc:spChg chg="mod">
          <ac:chgData name="Yang, Shengming - ARS" userId="37bd5b25-7571-49cb-bfc8-588a18706c35" providerId="ADAL" clId="{1CEC4EA3-DB05-44BE-AF57-7E2779412AED}" dt="2021-12-01T23:59:58.370" v="985" actId="1035"/>
          <ac:spMkLst>
            <pc:docMk/>
            <pc:sldMk cId="1525299809" sldId="275"/>
            <ac:spMk id="13" creationId="{50A0EE90-3932-4530-A2F6-B29B53FA3754}"/>
          </ac:spMkLst>
        </pc:spChg>
        <pc:spChg chg="add del mod">
          <ac:chgData name="Yang, Shengming - ARS" userId="37bd5b25-7571-49cb-bfc8-588a18706c35" providerId="ADAL" clId="{1CEC4EA3-DB05-44BE-AF57-7E2779412AED}" dt="2021-12-02T22:13:06.346" v="1082" actId="478"/>
          <ac:spMkLst>
            <pc:docMk/>
            <pc:sldMk cId="1525299809" sldId="275"/>
            <ac:spMk id="14" creationId="{307A9350-3668-45A2-AF7F-F848504A6A35}"/>
          </ac:spMkLst>
        </pc:spChg>
        <pc:spChg chg="mod">
          <ac:chgData name="Yang, Shengming - ARS" userId="37bd5b25-7571-49cb-bfc8-588a18706c35" providerId="ADAL" clId="{1CEC4EA3-DB05-44BE-AF57-7E2779412AED}" dt="2021-12-02T22:12:18.547" v="1079" actId="1076"/>
          <ac:spMkLst>
            <pc:docMk/>
            <pc:sldMk cId="1525299809" sldId="275"/>
            <ac:spMk id="17" creationId="{EF72585C-D2AF-45D3-97AC-199E08312281}"/>
          </ac:spMkLst>
        </pc:spChg>
        <pc:spChg chg="add mod">
          <ac:chgData name="Yang, Shengming - ARS" userId="37bd5b25-7571-49cb-bfc8-588a18706c35" providerId="ADAL" clId="{1CEC4EA3-DB05-44BE-AF57-7E2779412AED}" dt="2021-12-02T22:11:40.562" v="1070" actId="164"/>
          <ac:spMkLst>
            <pc:docMk/>
            <pc:sldMk cId="1525299809" sldId="275"/>
            <ac:spMk id="22" creationId="{4D948ADA-E9AF-42DA-8B05-03DACB9C498C}"/>
          </ac:spMkLst>
        </pc:spChg>
        <pc:spChg chg="mod">
          <ac:chgData name="Yang, Shengming - ARS" userId="37bd5b25-7571-49cb-bfc8-588a18706c35" providerId="ADAL" clId="{1CEC4EA3-DB05-44BE-AF57-7E2779412AED}" dt="2021-12-02T22:12:18.547" v="1079" actId="1076"/>
          <ac:spMkLst>
            <pc:docMk/>
            <pc:sldMk cId="1525299809" sldId="275"/>
            <ac:spMk id="23" creationId="{EE0E463B-8D9C-4CD8-A0EC-C0A58991BB7D}"/>
          </ac:spMkLst>
        </pc:spChg>
        <pc:spChg chg="add mod">
          <ac:chgData name="Yang, Shengming - ARS" userId="37bd5b25-7571-49cb-bfc8-588a18706c35" providerId="ADAL" clId="{1CEC4EA3-DB05-44BE-AF57-7E2779412AED}" dt="2021-12-02T22:11:40.562" v="1070" actId="164"/>
          <ac:spMkLst>
            <pc:docMk/>
            <pc:sldMk cId="1525299809" sldId="275"/>
            <ac:spMk id="24" creationId="{4162F7BC-929B-45B6-BA7F-921891A36F89}"/>
          </ac:spMkLst>
        </pc:spChg>
        <pc:spChg chg="mod">
          <ac:chgData name="Yang, Shengming - ARS" userId="37bd5b25-7571-49cb-bfc8-588a18706c35" providerId="ADAL" clId="{1CEC4EA3-DB05-44BE-AF57-7E2779412AED}" dt="2021-12-02T22:12:18.547" v="1079" actId="1076"/>
          <ac:spMkLst>
            <pc:docMk/>
            <pc:sldMk cId="1525299809" sldId="275"/>
            <ac:spMk id="25" creationId="{A876130B-ED92-4416-90CA-563FA5FCBC5F}"/>
          </ac:spMkLst>
        </pc:spChg>
        <pc:spChg chg="add mod">
          <ac:chgData name="Yang, Shengming - ARS" userId="37bd5b25-7571-49cb-bfc8-588a18706c35" providerId="ADAL" clId="{1CEC4EA3-DB05-44BE-AF57-7E2779412AED}" dt="2021-12-02T22:11:40.562" v="1070" actId="164"/>
          <ac:spMkLst>
            <pc:docMk/>
            <pc:sldMk cId="1525299809" sldId="275"/>
            <ac:spMk id="26" creationId="{B9CCD95B-3889-4379-A2D1-2FC056F98C66}"/>
          </ac:spMkLst>
        </pc:spChg>
        <pc:spChg chg="add mod">
          <ac:chgData name="Yang, Shengming - ARS" userId="37bd5b25-7571-49cb-bfc8-588a18706c35" providerId="ADAL" clId="{1CEC4EA3-DB05-44BE-AF57-7E2779412AED}" dt="2021-12-02T22:11:40.562" v="1070" actId="164"/>
          <ac:spMkLst>
            <pc:docMk/>
            <pc:sldMk cId="1525299809" sldId="275"/>
            <ac:spMk id="27" creationId="{A025DAFC-93D1-4F78-945F-66FA9798F458}"/>
          </ac:spMkLst>
        </pc:spChg>
        <pc:grpChg chg="add mod">
          <ac:chgData name="Yang, Shengming - ARS" userId="37bd5b25-7571-49cb-bfc8-588a18706c35" providerId="ADAL" clId="{1CEC4EA3-DB05-44BE-AF57-7E2779412AED}" dt="2021-12-02T22:12:34.074" v="1080" actId="1076"/>
          <ac:grpSpMkLst>
            <pc:docMk/>
            <pc:sldMk cId="1525299809" sldId="275"/>
            <ac:grpSpMk id="2" creationId="{F4EE9DA4-CB9F-486A-923F-388B16F5FCA0}"/>
          </ac:grpSpMkLst>
        </pc:grpChg>
        <pc:grpChg chg="add mod">
          <ac:chgData name="Yang, Shengming - ARS" userId="37bd5b25-7571-49cb-bfc8-588a18706c35" providerId="ADAL" clId="{1CEC4EA3-DB05-44BE-AF57-7E2779412AED}" dt="2021-12-02T22:11:40.562" v="1070" actId="164"/>
          <ac:grpSpMkLst>
            <pc:docMk/>
            <pc:sldMk cId="1525299809" sldId="275"/>
            <ac:grpSpMk id="16" creationId="{6CE4D0D7-A763-4BAE-8CC2-D0BA38EEC42E}"/>
          </ac:grpSpMkLst>
        </pc:grpChg>
        <pc:picChg chg="add del mod">
          <ac:chgData name="Yang, Shengming - ARS" userId="37bd5b25-7571-49cb-bfc8-588a18706c35" providerId="ADAL" clId="{1CEC4EA3-DB05-44BE-AF57-7E2779412AED}" dt="2021-12-01T23:12:11.258" v="72" actId="22"/>
          <ac:picMkLst>
            <pc:docMk/>
            <pc:sldMk cId="1525299809" sldId="275"/>
            <ac:picMk id="4" creationId="{A80C1CA3-0CE0-465C-A984-55570D653F13}"/>
          </ac:picMkLst>
        </pc:picChg>
        <pc:picChg chg="mod">
          <ac:chgData name="Yang, Shengming - ARS" userId="37bd5b25-7571-49cb-bfc8-588a18706c35" providerId="ADAL" clId="{1CEC4EA3-DB05-44BE-AF57-7E2779412AED}" dt="2021-12-02T22:12:18.547" v="1079" actId="1076"/>
          <ac:picMkLst>
            <pc:docMk/>
            <pc:sldMk cId="1525299809" sldId="275"/>
            <ac:picMk id="5" creationId="{47886F41-8483-490F-AFEC-C9F34925FEB4}"/>
          </ac:picMkLst>
        </pc:picChg>
        <pc:picChg chg="mod">
          <ac:chgData name="Yang, Shengming - ARS" userId="37bd5b25-7571-49cb-bfc8-588a18706c35" providerId="ADAL" clId="{1CEC4EA3-DB05-44BE-AF57-7E2779412AED}" dt="2021-12-02T22:12:18.547" v="1079" actId="1076"/>
          <ac:picMkLst>
            <pc:docMk/>
            <pc:sldMk cId="1525299809" sldId="275"/>
            <ac:picMk id="9" creationId="{8A5CA8A6-E525-4485-ADF9-36221A12B462}"/>
          </ac:picMkLst>
        </pc:picChg>
        <pc:picChg chg="mod">
          <ac:chgData name="Yang, Shengming - ARS" userId="37bd5b25-7571-49cb-bfc8-588a18706c35" providerId="ADAL" clId="{1CEC4EA3-DB05-44BE-AF57-7E2779412AED}" dt="2021-12-02T22:12:18.547" v="1079" actId="1076"/>
          <ac:picMkLst>
            <pc:docMk/>
            <pc:sldMk cId="1525299809" sldId="275"/>
            <ac:picMk id="15" creationId="{59E8A476-E459-49E7-BC90-C0244CB29CE8}"/>
          </ac:picMkLst>
        </pc:picChg>
        <pc:picChg chg="mod">
          <ac:chgData name="Yang, Shengming - ARS" userId="37bd5b25-7571-49cb-bfc8-588a18706c35" providerId="ADAL" clId="{1CEC4EA3-DB05-44BE-AF57-7E2779412AED}" dt="2021-12-02T22:01:43.889" v="1002" actId="14100"/>
          <ac:picMkLst>
            <pc:docMk/>
            <pc:sldMk cId="1525299809" sldId="275"/>
            <ac:picMk id="18" creationId="{DC957572-5F76-4953-A205-6FFE95C92F40}"/>
          </ac:picMkLst>
        </pc:picChg>
        <pc:picChg chg="mod">
          <ac:chgData name="Yang, Shengming - ARS" userId="37bd5b25-7571-49cb-bfc8-588a18706c35" providerId="ADAL" clId="{1CEC4EA3-DB05-44BE-AF57-7E2779412AED}" dt="2021-12-02T22:12:18.547" v="1079" actId="1076"/>
          <ac:picMkLst>
            <pc:docMk/>
            <pc:sldMk cId="1525299809" sldId="275"/>
            <ac:picMk id="19" creationId="{596237EC-86BA-4274-95FA-01770DA46B69}"/>
          </ac:picMkLst>
        </pc:picChg>
        <pc:picChg chg="mod">
          <ac:chgData name="Yang, Shengming - ARS" userId="37bd5b25-7571-49cb-bfc8-588a18706c35" providerId="ADAL" clId="{1CEC4EA3-DB05-44BE-AF57-7E2779412AED}" dt="2021-12-02T22:11:50.317" v="1076" actId="1038"/>
          <ac:picMkLst>
            <pc:docMk/>
            <pc:sldMk cId="1525299809" sldId="275"/>
            <ac:picMk id="20" creationId="{82B004C6-1B02-4AAE-9F53-D06DA1D4183C}"/>
          </ac:picMkLst>
        </pc:picChg>
        <pc:picChg chg="mod">
          <ac:chgData name="Yang, Shengming - ARS" userId="37bd5b25-7571-49cb-bfc8-588a18706c35" providerId="ADAL" clId="{1CEC4EA3-DB05-44BE-AF57-7E2779412AED}" dt="2021-12-02T22:12:18.547" v="1079" actId="1076"/>
          <ac:picMkLst>
            <pc:docMk/>
            <pc:sldMk cId="1525299809" sldId="275"/>
            <ac:picMk id="21" creationId="{678FCA89-43B8-45BE-8851-22EE7A6E7A89}"/>
          </ac:picMkLst>
        </pc:picChg>
      </pc:sldChg>
      <pc:sldChg chg="addSp delSp modSp new mod">
        <pc:chgData name="Yang, Shengming - ARS" userId="37bd5b25-7571-49cb-bfc8-588a18706c35" providerId="ADAL" clId="{1CEC4EA3-DB05-44BE-AF57-7E2779412AED}" dt="2021-12-23T19:45:07.913" v="2112" actId="1037"/>
        <pc:sldMkLst>
          <pc:docMk/>
          <pc:sldMk cId="1327558011" sldId="276"/>
        </pc:sldMkLst>
        <pc:spChg chg="add del">
          <ac:chgData name="Yang, Shengming - ARS" userId="37bd5b25-7571-49cb-bfc8-588a18706c35" providerId="ADAL" clId="{1CEC4EA3-DB05-44BE-AF57-7E2779412AED}" dt="2021-12-01T23:29:52.703" v="78" actId="478"/>
          <ac:spMkLst>
            <pc:docMk/>
            <pc:sldMk cId="1327558011" sldId="276"/>
            <ac:spMk id="2" creationId="{723B58EE-3585-49F8-9A1D-A240C225E60D}"/>
          </ac:spMkLst>
        </pc:spChg>
        <pc:spChg chg="add del">
          <ac:chgData name="Yang, Shengming - ARS" userId="37bd5b25-7571-49cb-bfc8-588a18706c35" providerId="ADAL" clId="{1CEC4EA3-DB05-44BE-AF57-7E2779412AED}" dt="2021-12-01T23:29:52.703" v="78" actId="478"/>
          <ac:spMkLst>
            <pc:docMk/>
            <pc:sldMk cId="1327558011" sldId="276"/>
            <ac:spMk id="3" creationId="{0C1C5AC5-8B83-4B2A-A163-09D2DA7D2269}"/>
          </ac:spMkLst>
        </pc:spChg>
        <pc:spChg chg="add del mod">
          <ac:chgData name="Yang, Shengming - ARS" userId="37bd5b25-7571-49cb-bfc8-588a18706c35" providerId="ADAL" clId="{1CEC4EA3-DB05-44BE-AF57-7E2779412AED}" dt="2021-12-01T23:29:47.380" v="76"/>
          <ac:spMkLst>
            <pc:docMk/>
            <pc:sldMk cId="1327558011" sldId="276"/>
            <ac:spMk id="7" creationId="{7E46E0E5-BB9E-44F8-8D6A-842B44DB0A47}"/>
          </ac:spMkLst>
        </pc:spChg>
        <pc:spChg chg="add del mod">
          <ac:chgData name="Yang, Shengming - ARS" userId="37bd5b25-7571-49cb-bfc8-588a18706c35" providerId="ADAL" clId="{1CEC4EA3-DB05-44BE-AF57-7E2779412AED}" dt="2021-12-01T23:29:47.380" v="76"/>
          <ac:spMkLst>
            <pc:docMk/>
            <pc:sldMk cId="1327558011" sldId="276"/>
            <ac:spMk id="8" creationId="{5460B423-280A-41A1-BE43-A49C3B469594}"/>
          </ac:spMkLst>
        </pc:spChg>
        <pc:spChg chg="add del mod">
          <ac:chgData name="Yang, Shengming - ARS" userId="37bd5b25-7571-49cb-bfc8-588a18706c35" providerId="ADAL" clId="{1CEC4EA3-DB05-44BE-AF57-7E2779412AED}" dt="2021-12-01T23:29:47.380" v="76"/>
          <ac:spMkLst>
            <pc:docMk/>
            <pc:sldMk cId="1327558011" sldId="276"/>
            <ac:spMk id="9" creationId="{00B6E138-4B98-43DD-A293-5FD523EA9044}"/>
          </ac:spMkLst>
        </pc:spChg>
        <pc:spChg chg="add del mod">
          <ac:chgData name="Yang, Shengming - ARS" userId="37bd5b25-7571-49cb-bfc8-588a18706c35" providerId="ADAL" clId="{1CEC4EA3-DB05-44BE-AF57-7E2779412AED}" dt="2021-12-01T23:29:47.380" v="76"/>
          <ac:spMkLst>
            <pc:docMk/>
            <pc:sldMk cId="1327558011" sldId="276"/>
            <ac:spMk id="10" creationId="{6BD9CA6D-B8DE-43F4-A6EC-1D1BC0855CE6}"/>
          </ac:spMkLst>
        </pc:spChg>
        <pc:spChg chg="add del mod">
          <ac:chgData name="Yang, Shengming - ARS" userId="37bd5b25-7571-49cb-bfc8-588a18706c35" providerId="ADAL" clId="{1CEC4EA3-DB05-44BE-AF57-7E2779412AED}" dt="2021-12-01T23:29:47.380" v="76"/>
          <ac:spMkLst>
            <pc:docMk/>
            <pc:sldMk cId="1327558011" sldId="276"/>
            <ac:spMk id="11" creationId="{C0CA89E4-43EC-409B-8E13-87895460CCA5}"/>
          </ac:spMkLst>
        </pc:spChg>
        <pc:spChg chg="add del mod">
          <ac:chgData name="Yang, Shengming - ARS" userId="37bd5b25-7571-49cb-bfc8-588a18706c35" providerId="ADAL" clId="{1CEC4EA3-DB05-44BE-AF57-7E2779412AED}" dt="2021-12-01T23:29:47.380" v="76"/>
          <ac:spMkLst>
            <pc:docMk/>
            <pc:sldMk cId="1327558011" sldId="276"/>
            <ac:spMk id="12" creationId="{2C05E07F-1F0B-45EA-8034-057A3E651EDB}"/>
          </ac:spMkLst>
        </pc:spChg>
        <pc:spChg chg="add del mod">
          <ac:chgData name="Yang, Shengming - ARS" userId="37bd5b25-7571-49cb-bfc8-588a18706c35" providerId="ADAL" clId="{1CEC4EA3-DB05-44BE-AF57-7E2779412AED}" dt="2021-12-01T23:29:47.380" v="76"/>
          <ac:spMkLst>
            <pc:docMk/>
            <pc:sldMk cId="1327558011" sldId="276"/>
            <ac:spMk id="13" creationId="{CCFB574E-0FBA-4402-B656-E883160D1338}"/>
          </ac:spMkLst>
        </pc:spChg>
        <pc:spChg chg="add del mod">
          <ac:chgData name="Yang, Shengming - ARS" userId="37bd5b25-7571-49cb-bfc8-588a18706c35" providerId="ADAL" clId="{1CEC4EA3-DB05-44BE-AF57-7E2779412AED}" dt="2021-12-01T23:29:47.380" v="76"/>
          <ac:spMkLst>
            <pc:docMk/>
            <pc:sldMk cId="1327558011" sldId="276"/>
            <ac:spMk id="14" creationId="{FA463342-9FEF-4297-BF20-D6D64643A751}"/>
          </ac:spMkLst>
        </pc:spChg>
        <pc:spChg chg="add mod">
          <ac:chgData name="Yang, Shengming - ARS" userId="37bd5b25-7571-49cb-bfc8-588a18706c35" providerId="ADAL" clId="{1CEC4EA3-DB05-44BE-AF57-7E2779412AED}" dt="2021-12-22T20:24:14.446" v="2096" actId="14100"/>
          <ac:spMkLst>
            <pc:docMk/>
            <pc:sldMk cId="1327558011" sldId="276"/>
            <ac:spMk id="18" creationId="{DB4A7B80-04F4-4694-9635-269D7B93FAB8}"/>
          </ac:spMkLst>
        </pc:spChg>
        <pc:spChg chg="add mod">
          <ac:chgData name="Yang, Shengming - ARS" userId="37bd5b25-7571-49cb-bfc8-588a18706c35" providerId="ADAL" clId="{1CEC4EA3-DB05-44BE-AF57-7E2779412AED}" dt="2021-12-22T20:18:56.062" v="2028" actId="207"/>
          <ac:spMkLst>
            <pc:docMk/>
            <pc:sldMk cId="1327558011" sldId="276"/>
            <ac:spMk id="19" creationId="{27F8DD3C-80AD-48AB-8EFA-F850B3C34DE3}"/>
          </ac:spMkLst>
        </pc:spChg>
        <pc:spChg chg="add mod">
          <ac:chgData name="Yang, Shengming - ARS" userId="37bd5b25-7571-49cb-bfc8-588a18706c35" providerId="ADAL" clId="{1CEC4EA3-DB05-44BE-AF57-7E2779412AED}" dt="2021-12-01T23:30:19.157" v="82" actId="1076"/>
          <ac:spMkLst>
            <pc:docMk/>
            <pc:sldMk cId="1327558011" sldId="276"/>
            <ac:spMk id="20" creationId="{62CDE6E2-BA1A-48A7-85F8-B39551A96D35}"/>
          </ac:spMkLst>
        </pc:spChg>
        <pc:spChg chg="add mod">
          <ac:chgData name="Yang, Shengming - ARS" userId="37bd5b25-7571-49cb-bfc8-588a18706c35" providerId="ADAL" clId="{1CEC4EA3-DB05-44BE-AF57-7E2779412AED}" dt="2021-12-01T23:30:19.157" v="82" actId="1076"/>
          <ac:spMkLst>
            <pc:docMk/>
            <pc:sldMk cId="1327558011" sldId="276"/>
            <ac:spMk id="21" creationId="{DE08A5F3-A209-4864-B1A4-E0FBE1E8CC2D}"/>
          </ac:spMkLst>
        </pc:spChg>
        <pc:spChg chg="add mod">
          <ac:chgData name="Yang, Shengming - ARS" userId="37bd5b25-7571-49cb-bfc8-588a18706c35" providerId="ADAL" clId="{1CEC4EA3-DB05-44BE-AF57-7E2779412AED}" dt="2021-12-01T23:30:19.157" v="82" actId="1076"/>
          <ac:spMkLst>
            <pc:docMk/>
            <pc:sldMk cId="1327558011" sldId="276"/>
            <ac:spMk id="22" creationId="{AF3F4660-366A-452D-88A8-E3DAF32F069D}"/>
          </ac:spMkLst>
        </pc:spChg>
        <pc:spChg chg="add mod">
          <ac:chgData name="Yang, Shengming - ARS" userId="37bd5b25-7571-49cb-bfc8-588a18706c35" providerId="ADAL" clId="{1CEC4EA3-DB05-44BE-AF57-7E2779412AED}" dt="2021-12-01T23:30:19.157" v="82" actId="1076"/>
          <ac:spMkLst>
            <pc:docMk/>
            <pc:sldMk cId="1327558011" sldId="276"/>
            <ac:spMk id="23" creationId="{0F5CAEC3-2F3B-498D-A713-21B9156DF953}"/>
          </ac:spMkLst>
        </pc:spChg>
        <pc:spChg chg="add del mod">
          <ac:chgData name="Yang, Shengming - ARS" userId="37bd5b25-7571-49cb-bfc8-588a18706c35" providerId="ADAL" clId="{1CEC4EA3-DB05-44BE-AF57-7E2779412AED}" dt="2021-12-22T20:08:27.113" v="2009" actId="478"/>
          <ac:spMkLst>
            <pc:docMk/>
            <pc:sldMk cId="1327558011" sldId="276"/>
            <ac:spMk id="24" creationId="{666B6B69-E7A3-4ACF-B033-07A7747744AE}"/>
          </ac:spMkLst>
        </pc:spChg>
        <pc:spChg chg="add del mod">
          <ac:chgData name="Yang, Shengming - ARS" userId="37bd5b25-7571-49cb-bfc8-588a18706c35" providerId="ADAL" clId="{1CEC4EA3-DB05-44BE-AF57-7E2779412AED}" dt="2021-12-22T20:08:24.632" v="2008" actId="478"/>
          <ac:spMkLst>
            <pc:docMk/>
            <pc:sldMk cId="1327558011" sldId="276"/>
            <ac:spMk id="25" creationId="{4934FF44-6D06-4A7E-97D6-90295BB0E2B4}"/>
          </ac:spMkLst>
        </pc:spChg>
        <pc:spChg chg="add mod">
          <ac:chgData name="Yang, Shengming - ARS" userId="37bd5b25-7571-49cb-bfc8-588a18706c35" providerId="ADAL" clId="{1CEC4EA3-DB05-44BE-AF57-7E2779412AED}" dt="2021-12-01T23:46:06.875" v="780" actId="14100"/>
          <ac:spMkLst>
            <pc:docMk/>
            <pc:sldMk cId="1327558011" sldId="276"/>
            <ac:spMk id="26" creationId="{557EC437-7B38-4A6E-97F8-966514E076E1}"/>
          </ac:spMkLst>
        </pc:spChg>
        <pc:spChg chg="add mod">
          <ac:chgData name="Yang, Shengming - ARS" userId="37bd5b25-7571-49cb-bfc8-588a18706c35" providerId="ADAL" clId="{1CEC4EA3-DB05-44BE-AF57-7E2779412AED}" dt="2021-12-22T20:19:54.273" v="2080" actId="14100"/>
          <ac:spMkLst>
            <pc:docMk/>
            <pc:sldMk cId="1327558011" sldId="276"/>
            <ac:spMk id="27" creationId="{93D67171-A90F-4D90-B3D3-C8C3BD804DF3}"/>
          </ac:spMkLst>
        </pc:spChg>
        <pc:spChg chg="add mod">
          <ac:chgData name="Yang, Shengming - ARS" userId="37bd5b25-7571-49cb-bfc8-588a18706c35" providerId="ADAL" clId="{1CEC4EA3-DB05-44BE-AF57-7E2779412AED}" dt="2021-12-22T20:20:17.718" v="2093" actId="1037"/>
          <ac:spMkLst>
            <pc:docMk/>
            <pc:sldMk cId="1327558011" sldId="276"/>
            <ac:spMk id="28" creationId="{D716D1A0-A1CE-4DF1-BF62-0045C30619D6}"/>
          </ac:spMkLst>
        </pc:spChg>
        <pc:picChg chg="add del mod ord modCrop">
          <ac:chgData name="Yang, Shengming - ARS" userId="37bd5b25-7571-49cb-bfc8-588a18706c35" providerId="ADAL" clId="{1CEC4EA3-DB05-44BE-AF57-7E2779412AED}" dt="2021-12-23T19:44:37.644" v="2107" actId="478"/>
          <ac:picMkLst>
            <pc:docMk/>
            <pc:sldMk cId="1327558011" sldId="276"/>
            <ac:picMk id="3" creationId="{47515810-1A32-4C86-A72B-3D11768C8C9D}"/>
          </ac:picMkLst>
        </pc:picChg>
        <pc:picChg chg="add del mod">
          <ac:chgData name="Yang, Shengming - ARS" userId="37bd5b25-7571-49cb-bfc8-588a18706c35" providerId="ADAL" clId="{1CEC4EA3-DB05-44BE-AF57-7E2779412AED}" dt="2021-12-01T23:29:47.380" v="76"/>
          <ac:picMkLst>
            <pc:docMk/>
            <pc:sldMk cId="1327558011" sldId="276"/>
            <ac:picMk id="4" creationId="{6E1ED88A-FE5E-448D-B7E2-F7B8005A0E5B}"/>
          </ac:picMkLst>
        </pc:picChg>
        <pc:picChg chg="add del mod">
          <ac:chgData name="Yang, Shengming - ARS" userId="37bd5b25-7571-49cb-bfc8-588a18706c35" providerId="ADAL" clId="{1CEC4EA3-DB05-44BE-AF57-7E2779412AED}" dt="2021-12-01T23:29:47.380" v="76"/>
          <ac:picMkLst>
            <pc:docMk/>
            <pc:sldMk cId="1327558011" sldId="276"/>
            <ac:picMk id="5" creationId="{1CB5EFE4-291E-4DB0-AEC6-4FC1122B2821}"/>
          </ac:picMkLst>
        </pc:picChg>
        <pc:picChg chg="add del mod modCrop">
          <ac:chgData name="Yang, Shengming - ARS" userId="37bd5b25-7571-49cb-bfc8-588a18706c35" providerId="ADAL" clId="{1CEC4EA3-DB05-44BE-AF57-7E2779412AED}" dt="2021-12-22T19:32:44.785" v="1978" actId="478"/>
          <ac:picMkLst>
            <pc:docMk/>
            <pc:sldMk cId="1327558011" sldId="276"/>
            <ac:picMk id="5" creationId="{3381DD81-F4CB-4116-AB31-33C2B9C41158}"/>
          </ac:picMkLst>
        </pc:picChg>
        <pc:picChg chg="add del mod">
          <ac:chgData name="Yang, Shengming - ARS" userId="37bd5b25-7571-49cb-bfc8-588a18706c35" providerId="ADAL" clId="{1CEC4EA3-DB05-44BE-AF57-7E2779412AED}" dt="2021-12-01T23:29:47.380" v="76"/>
          <ac:picMkLst>
            <pc:docMk/>
            <pc:sldMk cId="1327558011" sldId="276"/>
            <ac:picMk id="6" creationId="{9398DC8A-AFC5-4744-88CF-4B53A1E4DC87}"/>
          </ac:picMkLst>
        </pc:picChg>
        <pc:picChg chg="add del mod modCrop">
          <ac:chgData name="Yang, Shengming - ARS" userId="37bd5b25-7571-49cb-bfc8-588a18706c35" providerId="ADAL" clId="{1CEC4EA3-DB05-44BE-AF57-7E2779412AED}" dt="2021-12-22T17:49:41.990" v="1936" actId="478"/>
          <ac:picMkLst>
            <pc:docMk/>
            <pc:sldMk cId="1327558011" sldId="276"/>
            <ac:picMk id="7" creationId="{B991E4E1-A418-4A59-B1C9-F6BB8A5A7A7F}"/>
          </ac:picMkLst>
        </pc:picChg>
        <pc:picChg chg="add del mod modCrop">
          <ac:chgData name="Yang, Shengming - ARS" userId="37bd5b25-7571-49cb-bfc8-588a18706c35" providerId="ADAL" clId="{1CEC4EA3-DB05-44BE-AF57-7E2779412AED}" dt="2021-12-22T19:32:44.256" v="1977" actId="478"/>
          <ac:picMkLst>
            <pc:docMk/>
            <pc:sldMk cId="1327558011" sldId="276"/>
            <ac:picMk id="9" creationId="{D2106145-624E-4A03-AC6D-2880EE6214C5}"/>
          </ac:picMkLst>
        </pc:picChg>
        <pc:picChg chg="add mod ord modCrop">
          <ac:chgData name="Yang, Shengming - ARS" userId="37bd5b25-7571-49cb-bfc8-588a18706c35" providerId="ADAL" clId="{1CEC4EA3-DB05-44BE-AF57-7E2779412AED}" dt="2021-12-22T20:19:40.060" v="2061" actId="1037"/>
          <ac:picMkLst>
            <pc:docMk/>
            <pc:sldMk cId="1327558011" sldId="276"/>
            <ac:picMk id="10" creationId="{05A166F1-4B35-440B-8A66-9471844B2815}"/>
          </ac:picMkLst>
        </pc:picChg>
        <pc:picChg chg="add del mod ord modCrop">
          <ac:chgData name="Yang, Shengming - ARS" userId="37bd5b25-7571-49cb-bfc8-588a18706c35" providerId="ADAL" clId="{1CEC4EA3-DB05-44BE-AF57-7E2779412AED}" dt="2021-12-23T19:44:03.529" v="2103" actId="478"/>
          <ac:picMkLst>
            <pc:docMk/>
            <pc:sldMk cId="1327558011" sldId="276"/>
            <ac:picMk id="12" creationId="{6DE83228-71C3-4269-A8A6-2B8B65F5CCFF}"/>
          </ac:picMkLst>
        </pc:picChg>
        <pc:picChg chg="add mod ord">
          <ac:chgData name="Yang, Shengming - ARS" userId="37bd5b25-7571-49cb-bfc8-588a18706c35" providerId="ADAL" clId="{1CEC4EA3-DB05-44BE-AF57-7E2779412AED}" dt="2021-12-23T19:45:07.913" v="2112" actId="1037"/>
          <ac:picMkLst>
            <pc:docMk/>
            <pc:sldMk cId="1327558011" sldId="276"/>
            <ac:picMk id="13" creationId="{7337B5DD-D9CC-4FD6-9539-A6256FEF0D65}"/>
          </ac:picMkLst>
        </pc:picChg>
        <pc:picChg chg="add mod ord">
          <ac:chgData name="Yang, Shengming - ARS" userId="37bd5b25-7571-49cb-bfc8-588a18706c35" providerId="ADAL" clId="{1CEC4EA3-DB05-44BE-AF57-7E2779412AED}" dt="2021-12-23T19:44:48.658" v="2109" actId="167"/>
          <ac:picMkLst>
            <pc:docMk/>
            <pc:sldMk cId="1327558011" sldId="276"/>
            <ac:picMk id="14" creationId="{4FE97BDE-EC44-4359-BC83-63F3A53D94A1}"/>
          </ac:picMkLst>
        </pc:picChg>
        <pc:picChg chg="add del mod">
          <ac:chgData name="Yang, Shengming - ARS" userId="37bd5b25-7571-49cb-bfc8-588a18706c35" providerId="ADAL" clId="{1CEC4EA3-DB05-44BE-AF57-7E2779412AED}" dt="2021-12-22T19:30:14.752" v="1953" actId="478"/>
          <ac:picMkLst>
            <pc:docMk/>
            <pc:sldMk cId="1327558011" sldId="276"/>
            <ac:picMk id="15" creationId="{5D284B7B-1E42-4AFB-BAFB-26A7ECED02F4}"/>
          </ac:picMkLst>
        </pc:picChg>
        <pc:picChg chg="add del mod">
          <ac:chgData name="Yang, Shengming - ARS" userId="37bd5b25-7571-49cb-bfc8-588a18706c35" providerId="ADAL" clId="{1CEC4EA3-DB05-44BE-AF57-7E2779412AED}" dt="2021-12-22T19:30:15.313" v="1954" actId="478"/>
          <ac:picMkLst>
            <pc:docMk/>
            <pc:sldMk cId="1327558011" sldId="276"/>
            <ac:picMk id="16" creationId="{D0A0019A-9F34-4D53-8E9B-BA0D87793C36}"/>
          </ac:picMkLst>
        </pc:picChg>
        <pc:picChg chg="add del mod ord">
          <ac:chgData name="Yang, Shengming - ARS" userId="37bd5b25-7571-49cb-bfc8-588a18706c35" providerId="ADAL" clId="{1CEC4EA3-DB05-44BE-AF57-7E2779412AED}" dt="2021-12-22T20:18:43.624" v="2027" actId="167"/>
          <ac:picMkLst>
            <pc:docMk/>
            <pc:sldMk cId="1327558011" sldId="276"/>
            <ac:picMk id="17" creationId="{D41D87DC-71F0-406C-ACAE-7C86675098DF}"/>
          </ac:picMkLst>
        </pc:picChg>
      </pc:sldChg>
      <pc:sldChg chg="addSp delSp modSp new mod">
        <pc:chgData name="Yang, Shengming - ARS" userId="37bd5b25-7571-49cb-bfc8-588a18706c35" providerId="ADAL" clId="{1CEC4EA3-DB05-44BE-AF57-7E2779412AED}" dt="2021-12-01T23:52:30.595" v="982" actId="1076"/>
        <pc:sldMkLst>
          <pc:docMk/>
          <pc:sldMk cId="2338164932" sldId="277"/>
        </pc:sldMkLst>
        <pc:spChg chg="del">
          <ac:chgData name="Yang, Shengming - ARS" userId="37bd5b25-7571-49cb-bfc8-588a18706c35" providerId="ADAL" clId="{1CEC4EA3-DB05-44BE-AF57-7E2779412AED}" dt="2021-12-01T23:31:03.858" v="193" actId="478"/>
          <ac:spMkLst>
            <pc:docMk/>
            <pc:sldMk cId="2338164932" sldId="277"/>
            <ac:spMk id="2" creationId="{728A7D8B-F7B1-492C-9A1A-60FFDA88367D}"/>
          </ac:spMkLst>
        </pc:spChg>
        <pc:spChg chg="del">
          <ac:chgData name="Yang, Shengming - ARS" userId="37bd5b25-7571-49cb-bfc8-588a18706c35" providerId="ADAL" clId="{1CEC4EA3-DB05-44BE-AF57-7E2779412AED}" dt="2021-12-01T23:31:05.115" v="194" actId="478"/>
          <ac:spMkLst>
            <pc:docMk/>
            <pc:sldMk cId="2338164932" sldId="277"/>
            <ac:spMk id="3" creationId="{6111AE31-EA02-4F39-9E72-828201652876}"/>
          </ac:spMkLst>
        </pc:spChg>
        <pc:spChg chg="add mod">
          <ac:chgData name="Yang, Shengming - ARS" userId="37bd5b25-7571-49cb-bfc8-588a18706c35" providerId="ADAL" clId="{1CEC4EA3-DB05-44BE-AF57-7E2779412AED}" dt="2021-12-01T23:32:33.992" v="201" actId="14100"/>
          <ac:spMkLst>
            <pc:docMk/>
            <pc:sldMk cId="2338164932" sldId="277"/>
            <ac:spMk id="4" creationId="{327864F8-1AF9-48FF-8153-91701A03977B}"/>
          </ac:spMkLst>
        </pc:spChg>
        <pc:spChg chg="add mod">
          <ac:chgData name="Yang, Shengming - ARS" userId="37bd5b25-7571-49cb-bfc8-588a18706c35" providerId="ADAL" clId="{1CEC4EA3-DB05-44BE-AF57-7E2779412AED}" dt="2021-12-01T23:52:30.595" v="982" actId="1076"/>
          <ac:spMkLst>
            <pc:docMk/>
            <pc:sldMk cId="2338164932" sldId="277"/>
            <ac:spMk id="7" creationId="{A3D35586-BD6A-4FE2-808B-FA9714C5DBB9}"/>
          </ac:spMkLst>
        </pc:spChg>
        <pc:spChg chg="add mod">
          <ac:chgData name="Yang, Shengming - ARS" userId="37bd5b25-7571-49cb-bfc8-588a18706c35" providerId="ADAL" clId="{1CEC4EA3-DB05-44BE-AF57-7E2779412AED}" dt="2021-12-01T23:52:30.595" v="982" actId="1076"/>
          <ac:spMkLst>
            <pc:docMk/>
            <pc:sldMk cId="2338164932" sldId="277"/>
            <ac:spMk id="8" creationId="{42555822-7078-4F85-B25D-30C1D9D934BD}"/>
          </ac:spMkLst>
        </pc:spChg>
        <pc:spChg chg="add mod">
          <ac:chgData name="Yang, Shengming - ARS" userId="37bd5b25-7571-49cb-bfc8-588a18706c35" providerId="ADAL" clId="{1CEC4EA3-DB05-44BE-AF57-7E2779412AED}" dt="2021-12-01T23:52:30.595" v="982" actId="1076"/>
          <ac:spMkLst>
            <pc:docMk/>
            <pc:sldMk cId="2338164932" sldId="277"/>
            <ac:spMk id="9" creationId="{ACF661F1-6CE1-44C8-9915-E53CDBFA7B63}"/>
          </ac:spMkLst>
        </pc:spChg>
        <pc:spChg chg="add mod">
          <ac:chgData name="Yang, Shengming - ARS" userId="37bd5b25-7571-49cb-bfc8-588a18706c35" providerId="ADAL" clId="{1CEC4EA3-DB05-44BE-AF57-7E2779412AED}" dt="2021-12-01T23:52:30.595" v="982" actId="1076"/>
          <ac:spMkLst>
            <pc:docMk/>
            <pc:sldMk cId="2338164932" sldId="277"/>
            <ac:spMk id="11" creationId="{7239F33E-AD20-49E6-902F-B73EC6258D4B}"/>
          </ac:spMkLst>
        </pc:spChg>
        <pc:spChg chg="add mod">
          <ac:chgData name="Yang, Shengming - ARS" userId="37bd5b25-7571-49cb-bfc8-588a18706c35" providerId="ADAL" clId="{1CEC4EA3-DB05-44BE-AF57-7E2779412AED}" dt="2021-12-01T23:32:33.992" v="201" actId="14100"/>
          <ac:spMkLst>
            <pc:docMk/>
            <pc:sldMk cId="2338164932" sldId="277"/>
            <ac:spMk id="12" creationId="{E6D8814D-51B2-4292-BAC4-B3F2C8897A0A}"/>
          </ac:spMkLst>
        </pc:spChg>
        <pc:spChg chg="add mod">
          <ac:chgData name="Yang, Shengming - ARS" userId="37bd5b25-7571-49cb-bfc8-588a18706c35" providerId="ADAL" clId="{1CEC4EA3-DB05-44BE-AF57-7E2779412AED}" dt="2021-12-01T23:52:30.595" v="982" actId="1076"/>
          <ac:spMkLst>
            <pc:docMk/>
            <pc:sldMk cId="2338164932" sldId="277"/>
            <ac:spMk id="14" creationId="{DAB78677-6D06-432A-BCD6-E04FE82D5685}"/>
          </ac:spMkLst>
        </pc:spChg>
        <pc:spChg chg="add mod">
          <ac:chgData name="Yang, Shengming - ARS" userId="37bd5b25-7571-49cb-bfc8-588a18706c35" providerId="ADAL" clId="{1CEC4EA3-DB05-44BE-AF57-7E2779412AED}" dt="2021-12-01T23:52:30.595" v="982" actId="1076"/>
          <ac:spMkLst>
            <pc:docMk/>
            <pc:sldMk cId="2338164932" sldId="277"/>
            <ac:spMk id="15" creationId="{3864D079-E178-4514-9A88-6B9FD98734A4}"/>
          </ac:spMkLst>
        </pc:spChg>
        <pc:spChg chg="add mod">
          <ac:chgData name="Yang, Shengming - ARS" userId="37bd5b25-7571-49cb-bfc8-588a18706c35" providerId="ADAL" clId="{1CEC4EA3-DB05-44BE-AF57-7E2779412AED}" dt="2021-12-01T23:52:30.595" v="982" actId="1076"/>
          <ac:spMkLst>
            <pc:docMk/>
            <pc:sldMk cId="2338164932" sldId="277"/>
            <ac:spMk id="24" creationId="{77100186-872C-426D-A183-A632241A907F}"/>
          </ac:spMkLst>
        </pc:spChg>
        <pc:spChg chg="add mod">
          <ac:chgData name="Yang, Shengming - ARS" userId="37bd5b25-7571-49cb-bfc8-588a18706c35" providerId="ADAL" clId="{1CEC4EA3-DB05-44BE-AF57-7E2779412AED}" dt="2021-12-01T23:32:33.992" v="201" actId="14100"/>
          <ac:spMkLst>
            <pc:docMk/>
            <pc:sldMk cId="2338164932" sldId="277"/>
            <ac:spMk id="25" creationId="{A0451547-3B00-4C7C-8802-76D22D0B3C4E}"/>
          </ac:spMkLst>
        </pc:spChg>
        <pc:spChg chg="add mod">
          <ac:chgData name="Yang, Shengming - ARS" userId="37bd5b25-7571-49cb-bfc8-588a18706c35" providerId="ADAL" clId="{1CEC4EA3-DB05-44BE-AF57-7E2779412AED}" dt="2021-12-01T23:52:30.595" v="982" actId="1076"/>
          <ac:spMkLst>
            <pc:docMk/>
            <pc:sldMk cId="2338164932" sldId="277"/>
            <ac:spMk id="28" creationId="{34CD60B6-BEC4-4EFA-A66E-7485135F6CFF}"/>
          </ac:spMkLst>
        </pc:spChg>
        <pc:spChg chg="add mod">
          <ac:chgData name="Yang, Shengming - ARS" userId="37bd5b25-7571-49cb-bfc8-588a18706c35" providerId="ADAL" clId="{1CEC4EA3-DB05-44BE-AF57-7E2779412AED}" dt="2021-12-01T23:52:30.595" v="982" actId="1076"/>
          <ac:spMkLst>
            <pc:docMk/>
            <pc:sldMk cId="2338164932" sldId="277"/>
            <ac:spMk id="30" creationId="{A394E1F8-BAD6-4AAC-9CB9-53287D112279}"/>
          </ac:spMkLst>
        </pc:spChg>
        <pc:spChg chg="add mod">
          <ac:chgData name="Yang, Shengming - ARS" userId="37bd5b25-7571-49cb-bfc8-588a18706c35" providerId="ADAL" clId="{1CEC4EA3-DB05-44BE-AF57-7E2779412AED}" dt="2021-12-01T23:52:30.595" v="982" actId="1076"/>
          <ac:spMkLst>
            <pc:docMk/>
            <pc:sldMk cId="2338164932" sldId="277"/>
            <ac:spMk id="31" creationId="{D0C7CC23-CEB5-4396-980D-625B8772C86D}"/>
          </ac:spMkLst>
        </pc:spChg>
        <pc:spChg chg="add mod">
          <ac:chgData name="Yang, Shengming - ARS" userId="37bd5b25-7571-49cb-bfc8-588a18706c35" providerId="ADAL" clId="{1CEC4EA3-DB05-44BE-AF57-7E2779412AED}" dt="2021-12-01T23:52:30.595" v="982" actId="1076"/>
          <ac:spMkLst>
            <pc:docMk/>
            <pc:sldMk cId="2338164932" sldId="277"/>
            <ac:spMk id="32" creationId="{67C98EFE-9C99-484F-A423-AA1826EF0B0B}"/>
          </ac:spMkLst>
        </pc:spChg>
        <pc:spChg chg="add mod">
          <ac:chgData name="Yang, Shengming - ARS" userId="37bd5b25-7571-49cb-bfc8-588a18706c35" providerId="ADAL" clId="{1CEC4EA3-DB05-44BE-AF57-7E2779412AED}" dt="2021-12-01T23:52:30.595" v="982" actId="1076"/>
          <ac:spMkLst>
            <pc:docMk/>
            <pc:sldMk cId="2338164932" sldId="277"/>
            <ac:spMk id="33" creationId="{C06B46B4-7FE1-4D21-9576-E6E499E89C28}"/>
          </ac:spMkLst>
        </pc:spChg>
        <pc:spChg chg="add mod">
          <ac:chgData name="Yang, Shengming - ARS" userId="37bd5b25-7571-49cb-bfc8-588a18706c35" providerId="ADAL" clId="{1CEC4EA3-DB05-44BE-AF57-7E2779412AED}" dt="2021-12-01T23:32:33.992" v="201" actId="14100"/>
          <ac:spMkLst>
            <pc:docMk/>
            <pc:sldMk cId="2338164932" sldId="277"/>
            <ac:spMk id="34" creationId="{98406564-1BCE-451A-BB23-839381D5B6A9}"/>
          </ac:spMkLst>
        </pc:spChg>
        <pc:spChg chg="add mod">
          <ac:chgData name="Yang, Shengming - ARS" userId="37bd5b25-7571-49cb-bfc8-588a18706c35" providerId="ADAL" clId="{1CEC4EA3-DB05-44BE-AF57-7E2779412AED}" dt="2021-12-01T23:51:56.487" v="970" actId="1076"/>
          <ac:spMkLst>
            <pc:docMk/>
            <pc:sldMk cId="2338164932" sldId="277"/>
            <ac:spMk id="35" creationId="{AF0B610E-81AE-45AA-BE91-3A074F40C5EE}"/>
          </ac:spMkLst>
        </pc:spChg>
        <pc:spChg chg="add mod">
          <ac:chgData name="Yang, Shengming - ARS" userId="37bd5b25-7571-49cb-bfc8-588a18706c35" providerId="ADAL" clId="{1CEC4EA3-DB05-44BE-AF57-7E2779412AED}" dt="2021-12-01T23:52:30.595" v="982" actId="1076"/>
          <ac:spMkLst>
            <pc:docMk/>
            <pc:sldMk cId="2338164932" sldId="277"/>
            <ac:spMk id="36" creationId="{4CB62AB7-EA9A-40FD-94C4-5F40A116414D}"/>
          </ac:spMkLst>
        </pc:spChg>
        <pc:spChg chg="add mod">
          <ac:chgData name="Yang, Shengming - ARS" userId="37bd5b25-7571-49cb-bfc8-588a18706c35" providerId="ADAL" clId="{1CEC4EA3-DB05-44BE-AF57-7E2779412AED}" dt="2021-12-01T23:52:30.595" v="982" actId="1076"/>
          <ac:spMkLst>
            <pc:docMk/>
            <pc:sldMk cId="2338164932" sldId="277"/>
            <ac:spMk id="37" creationId="{754E176E-B4BB-400A-B7EE-74E4F5B5C122}"/>
          </ac:spMkLst>
        </pc:spChg>
        <pc:spChg chg="add mod">
          <ac:chgData name="Yang, Shengming - ARS" userId="37bd5b25-7571-49cb-bfc8-588a18706c35" providerId="ADAL" clId="{1CEC4EA3-DB05-44BE-AF57-7E2779412AED}" dt="2021-12-01T23:52:30.595" v="982" actId="1076"/>
          <ac:spMkLst>
            <pc:docMk/>
            <pc:sldMk cId="2338164932" sldId="277"/>
            <ac:spMk id="38" creationId="{8C2D1CD4-9040-4797-905A-5771CE165C82}"/>
          </ac:spMkLst>
        </pc:spChg>
        <pc:spChg chg="add mod">
          <ac:chgData name="Yang, Shengming - ARS" userId="37bd5b25-7571-49cb-bfc8-588a18706c35" providerId="ADAL" clId="{1CEC4EA3-DB05-44BE-AF57-7E2779412AED}" dt="2021-12-01T23:52:30.595" v="982" actId="1076"/>
          <ac:spMkLst>
            <pc:docMk/>
            <pc:sldMk cId="2338164932" sldId="277"/>
            <ac:spMk id="39" creationId="{34A716DA-9228-49F6-9E76-3813E1DA9BFC}"/>
          </ac:spMkLst>
        </pc:spChg>
        <pc:spChg chg="add mod">
          <ac:chgData name="Yang, Shengming - ARS" userId="37bd5b25-7571-49cb-bfc8-588a18706c35" providerId="ADAL" clId="{1CEC4EA3-DB05-44BE-AF57-7E2779412AED}" dt="2021-12-01T23:52:30.595" v="982" actId="1076"/>
          <ac:spMkLst>
            <pc:docMk/>
            <pc:sldMk cId="2338164932" sldId="277"/>
            <ac:spMk id="40" creationId="{361ADB74-A2C3-46CC-9327-A2B0964D717A}"/>
          </ac:spMkLst>
        </pc:spChg>
        <pc:spChg chg="add mod">
          <ac:chgData name="Yang, Shengming - ARS" userId="37bd5b25-7571-49cb-bfc8-588a18706c35" providerId="ADAL" clId="{1CEC4EA3-DB05-44BE-AF57-7E2779412AED}" dt="2021-12-01T23:52:17.867" v="980" actId="14100"/>
          <ac:spMkLst>
            <pc:docMk/>
            <pc:sldMk cId="2338164932" sldId="277"/>
            <ac:spMk id="76" creationId="{6147EB84-2895-4307-9090-3D0D591FEAE9}"/>
          </ac:spMkLst>
        </pc:spChg>
        <pc:cxnChg chg="add mod">
          <ac:chgData name="Yang, Shengming - ARS" userId="37bd5b25-7571-49cb-bfc8-588a18706c35" providerId="ADAL" clId="{1CEC4EA3-DB05-44BE-AF57-7E2779412AED}" dt="2021-12-01T23:52:30.595" v="982" actId="1076"/>
          <ac:cxnSpMkLst>
            <pc:docMk/>
            <pc:sldMk cId="2338164932" sldId="277"/>
            <ac:cxnSpMk id="5" creationId="{C280D1A0-E619-472D-B962-D7BB43CB4642}"/>
          </ac:cxnSpMkLst>
        </pc:cxnChg>
        <pc:cxnChg chg="add mod">
          <ac:chgData name="Yang, Shengming - ARS" userId="37bd5b25-7571-49cb-bfc8-588a18706c35" providerId="ADAL" clId="{1CEC4EA3-DB05-44BE-AF57-7E2779412AED}" dt="2021-12-01T23:52:30.595" v="982" actId="1076"/>
          <ac:cxnSpMkLst>
            <pc:docMk/>
            <pc:sldMk cId="2338164932" sldId="277"/>
            <ac:cxnSpMk id="6" creationId="{081B810E-59C1-4960-A8E9-7D06890CB976}"/>
          </ac:cxnSpMkLst>
        </pc:cxnChg>
        <pc:cxnChg chg="add mod">
          <ac:chgData name="Yang, Shengming - ARS" userId="37bd5b25-7571-49cb-bfc8-588a18706c35" providerId="ADAL" clId="{1CEC4EA3-DB05-44BE-AF57-7E2779412AED}" dt="2021-12-01T23:52:30.595" v="982" actId="1076"/>
          <ac:cxnSpMkLst>
            <pc:docMk/>
            <pc:sldMk cId="2338164932" sldId="277"/>
            <ac:cxnSpMk id="10" creationId="{E437BF3B-2DB7-456F-AD4B-006336880030}"/>
          </ac:cxnSpMkLst>
        </pc:cxnChg>
        <pc:cxnChg chg="add mod">
          <ac:chgData name="Yang, Shengming - ARS" userId="37bd5b25-7571-49cb-bfc8-588a18706c35" providerId="ADAL" clId="{1CEC4EA3-DB05-44BE-AF57-7E2779412AED}" dt="2021-12-01T23:52:30.595" v="982" actId="1076"/>
          <ac:cxnSpMkLst>
            <pc:docMk/>
            <pc:sldMk cId="2338164932" sldId="277"/>
            <ac:cxnSpMk id="13" creationId="{2CB789A5-9AF5-4C81-9503-51042581E924}"/>
          </ac:cxnSpMkLst>
        </pc:cxnChg>
        <pc:cxnChg chg="add mod">
          <ac:chgData name="Yang, Shengming - ARS" userId="37bd5b25-7571-49cb-bfc8-588a18706c35" providerId="ADAL" clId="{1CEC4EA3-DB05-44BE-AF57-7E2779412AED}" dt="2021-12-01T23:52:30.595" v="982" actId="1076"/>
          <ac:cxnSpMkLst>
            <pc:docMk/>
            <pc:sldMk cId="2338164932" sldId="277"/>
            <ac:cxnSpMk id="16" creationId="{A8E15AF5-A1A7-435E-B938-56D64E126FB0}"/>
          </ac:cxnSpMkLst>
        </pc:cxnChg>
        <pc:cxnChg chg="add mod">
          <ac:chgData name="Yang, Shengming - ARS" userId="37bd5b25-7571-49cb-bfc8-588a18706c35" providerId="ADAL" clId="{1CEC4EA3-DB05-44BE-AF57-7E2779412AED}" dt="2021-12-01T23:52:30.595" v="982" actId="1076"/>
          <ac:cxnSpMkLst>
            <pc:docMk/>
            <pc:sldMk cId="2338164932" sldId="277"/>
            <ac:cxnSpMk id="17" creationId="{278E7179-8422-48AC-8DF4-4813C14D1D47}"/>
          </ac:cxnSpMkLst>
        </pc:cxnChg>
        <pc:cxnChg chg="add mod">
          <ac:chgData name="Yang, Shengming - ARS" userId="37bd5b25-7571-49cb-bfc8-588a18706c35" providerId="ADAL" clId="{1CEC4EA3-DB05-44BE-AF57-7E2779412AED}" dt="2021-12-01T23:52:30.595" v="982" actId="1076"/>
          <ac:cxnSpMkLst>
            <pc:docMk/>
            <pc:sldMk cId="2338164932" sldId="277"/>
            <ac:cxnSpMk id="18" creationId="{35BB3255-75B0-4E3C-9360-8B2AB71D2C1F}"/>
          </ac:cxnSpMkLst>
        </pc:cxnChg>
        <pc:cxnChg chg="add mod">
          <ac:chgData name="Yang, Shengming - ARS" userId="37bd5b25-7571-49cb-bfc8-588a18706c35" providerId="ADAL" clId="{1CEC4EA3-DB05-44BE-AF57-7E2779412AED}" dt="2021-12-01T23:52:30.595" v="982" actId="1076"/>
          <ac:cxnSpMkLst>
            <pc:docMk/>
            <pc:sldMk cId="2338164932" sldId="277"/>
            <ac:cxnSpMk id="19" creationId="{25E0BE3D-2FFE-4BAC-8B39-FCB0A50FABA0}"/>
          </ac:cxnSpMkLst>
        </pc:cxnChg>
        <pc:cxnChg chg="add mod">
          <ac:chgData name="Yang, Shengming - ARS" userId="37bd5b25-7571-49cb-bfc8-588a18706c35" providerId="ADAL" clId="{1CEC4EA3-DB05-44BE-AF57-7E2779412AED}" dt="2021-12-01T23:52:30.595" v="982" actId="1076"/>
          <ac:cxnSpMkLst>
            <pc:docMk/>
            <pc:sldMk cId="2338164932" sldId="277"/>
            <ac:cxnSpMk id="20" creationId="{9102A972-1223-4915-AD82-1DBC29E04B4B}"/>
          </ac:cxnSpMkLst>
        </pc:cxnChg>
        <pc:cxnChg chg="add mod">
          <ac:chgData name="Yang, Shengming - ARS" userId="37bd5b25-7571-49cb-bfc8-588a18706c35" providerId="ADAL" clId="{1CEC4EA3-DB05-44BE-AF57-7E2779412AED}" dt="2021-12-01T23:52:30.595" v="982" actId="1076"/>
          <ac:cxnSpMkLst>
            <pc:docMk/>
            <pc:sldMk cId="2338164932" sldId="277"/>
            <ac:cxnSpMk id="21" creationId="{C7EECC96-3EB2-4331-A664-AF1FDCA408B1}"/>
          </ac:cxnSpMkLst>
        </pc:cxnChg>
        <pc:cxnChg chg="add mod">
          <ac:chgData name="Yang, Shengming - ARS" userId="37bd5b25-7571-49cb-bfc8-588a18706c35" providerId="ADAL" clId="{1CEC4EA3-DB05-44BE-AF57-7E2779412AED}" dt="2021-12-01T23:52:30.595" v="982" actId="1076"/>
          <ac:cxnSpMkLst>
            <pc:docMk/>
            <pc:sldMk cId="2338164932" sldId="277"/>
            <ac:cxnSpMk id="22" creationId="{9077870D-6131-463B-B574-8413AFF56AF8}"/>
          </ac:cxnSpMkLst>
        </pc:cxnChg>
        <pc:cxnChg chg="add mod">
          <ac:chgData name="Yang, Shengming - ARS" userId="37bd5b25-7571-49cb-bfc8-588a18706c35" providerId="ADAL" clId="{1CEC4EA3-DB05-44BE-AF57-7E2779412AED}" dt="2021-12-01T23:52:30.595" v="982" actId="1076"/>
          <ac:cxnSpMkLst>
            <pc:docMk/>
            <pc:sldMk cId="2338164932" sldId="277"/>
            <ac:cxnSpMk id="23" creationId="{09447729-9490-458D-B1A4-6F8472F46086}"/>
          </ac:cxnSpMkLst>
        </pc:cxnChg>
        <pc:cxnChg chg="add mod">
          <ac:chgData name="Yang, Shengming - ARS" userId="37bd5b25-7571-49cb-bfc8-588a18706c35" providerId="ADAL" clId="{1CEC4EA3-DB05-44BE-AF57-7E2779412AED}" dt="2021-12-01T23:52:30.595" v="982" actId="1076"/>
          <ac:cxnSpMkLst>
            <pc:docMk/>
            <pc:sldMk cId="2338164932" sldId="277"/>
            <ac:cxnSpMk id="26" creationId="{31AB6231-0E89-4298-8537-1192B72AB47C}"/>
          </ac:cxnSpMkLst>
        </pc:cxnChg>
        <pc:cxnChg chg="add mod">
          <ac:chgData name="Yang, Shengming - ARS" userId="37bd5b25-7571-49cb-bfc8-588a18706c35" providerId="ADAL" clId="{1CEC4EA3-DB05-44BE-AF57-7E2779412AED}" dt="2021-12-01T23:52:30.595" v="982" actId="1076"/>
          <ac:cxnSpMkLst>
            <pc:docMk/>
            <pc:sldMk cId="2338164932" sldId="277"/>
            <ac:cxnSpMk id="27" creationId="{C212F65D-5149-4C30-97FA-04BD3B35D5C5}"/>
          </ac:cxnSpMkLst>
        </pc:cxnChg>
        <pc:cxnChg chg="add mod">
          <ac:chgData name="Yang, Shengming - ARS" userId="37bd5b25-7571-49cb-bfc8-588a18706c35" providerId="ADAL" clId="{1CEC4EA3-DB05-44BE-AF57-7E2779412AED}" dt="2021-12-01T23:52:30.595" v="982" actId="1076"/>
          <ac:cxnSpMkLst>
            <pc:docMk/>
            <pc:sldMk cId="2338164932" sldId="277"/>
            <ac:cxnSpMk id="29" creationId="{83E026B4-35C6-4C9F-8965-B6E8B89DF339}"/>
          </ac:cxnSpMkLst>
        </pc:cxnChg>
      </pc:sldChg>
      <pc:sldChg chg="addSp delSp modSp new mod">
        <pc:chgData name="Yang, Shengming - ARS" userId="37bd5b25-7571-49cb-bfc8-588a18706c35" providerId="ADAL" clId="{1CEC4EA3-DB05-44BE-AF57-7E2779412AED}" dt="2021-12-01T23:44:59.024" v="766" actId="14100"/>
        <pc:sldMkLst>
          <pc:docMk/>
          <pc:sldMk cId="887383785" sldId="278"/>
        </pc:sldMkLst>
        <pc:spChg chg="del">
          <ac:chgData name="Yang, Shengming - ARS" userId="37bd5b25-7571-49cb-bfc8-588a18706c35" providerId="ADAL" clId="{1CEC4EA3-DB05-44BE-AF57-7E2779412AED}" dt="2021-12-01T23:44:05.370" v="751" actId="478"/>
          <ac:spMkLst>
            <pc:docMk/>
            <pc:sldMk cId="887383785" sldId="278"/>
            <ac:spMk id="2" creationId="{314B20EA-FE22-41B2-BB17-666155644240}"/>
          </ac:spMkLst>
        </pc:spChg>
        <pc:spChg chg="del">
          <ac:chgData name="Yang, Shengming - ARS" userId="37bd5b25-7571-49cb-bfc8-588a18706c35" providerId="ADAL" clId="{1CEC4EA3-DB05-44BE-AF57-7E2779412AED}" dt="2021-12-01T23:44:05.370" v="751" actId="478"/>
          <ac:spMkLst>
            <pc:docMk/>
            <pc:sldMk cId="887383785" sldId="278"/>
            <ac:spMk id="3" creationId="{E1448CDD-84DB-4FDD-AA5F-6C8ED2529851}"/>
          </ac:spMkLst>
        </pc:spChg>
        <pc:graphicFrameChg chg="add mod modGraphic">
          <ac:chgData name="Yang, Shengming - ARS" userId="37bd5b25-7571-49cb-bfc8-588a18706c35" providerId="ADAL" clId="{1CEC4EA3-DB05-44BE-AF57-7E2779412AED}" dt="2021-12-01T23:44:59.024" v="766" actId="14100"/>
          <ac:graphicFrameMkLst>
            <pc:docMk/>
            <pc:sldMk cId="887383785" sldId="278"/>
            <ac:graphicFrameMk id="4" creationId="{12240337-9653-4844-83C7-8964481C8519}"/>
          </ac:graphicFrameMkLst>
        </pc:graphicFrameChg>
      </pc:sldChg>
      <pc:sldChg chg="addSp delSp modSp new mod ord">
        <pc:chgData name="Yang, Shengming - ARS" userId="37bd5b25-7571-49cb-bfc8-588a18706c35" providerId="ADAL" clId="{1CEC4EA3-DB05-44BE-AF57-7E2779412AED}" dt="2021-12-20T16:17:29.333" v="1898"/>
        <pc:sldMkLst>
          <pc:docMk/>
          <pc:sldMk cId="3951076637" sldId="279"/>
        </pc:sldMkLst>
        <pc:spChg chg="del">
          <ac:chgData name="Yang, Shengming - ARS" userId="37bd5b25-7571-49cb-bfc8-588a18706c35" providerId="ADAL" clId="{1CEC4EA3-DB05-44BE-AF57-7E2779412AED}" dt="2021-12-06T17:48:35.479" v="1094" actId="478"/>
          <ac:spMkLst>
            <pc:docMk/>
            <pc:sldMk cId="3951076637" sldId="279"/>
            <ac:spMk id="2" creationId="{728DFCB7-5E2F-4D0C-B571-6C54E4DB481F}"/>
          </ac:spMkLst>
        </pc:spChg>
        <pc:spChg chg="del">
          <ac:chgData name="Yang, Shengming - ARS" userId="37bd5b25-7571-49cb-bfc8-588a18706c35" providerId="ADAL" clId="{1CEC4EA3-DB05-44BE-AF57-7E2779412AED}" dt="2021-12-06T17:48:31.856" v="1093" actId="478"/>
          <ac:spMkLst>
            <pc:docMk/>
            <pc:sldMk cId="3951076637" sldId="279"/>
            <ac:spMk id="3" creationId="{2C65469C-A1B0-4D26-BA57-90CD8EC2903C}"/>
          </ac:spMkLst>
        </pc:spChg>
        <pc:spChg chg="mod">
          <ac:chgData name="Yang, Shengming - ARS" userId="37bd5b25-7571-49cb-bfc8-588a18706c35" providerId="ADAL" clId="{1CEC4EA3-DB05-44BE-AF57-7E2779412AED}" dt="2021-12-06T17:49:09.761" v="1100" actId="255"/>
          <ac:spMkLst>
            <pc:docMk/>
            <pc:sldMk cId="3951076637" sldId="279"/>
            <ac:spMk id="5" creationId="{145BD528-BFA0-4D45-9687-079068890D7E}"/>
          </ac:spMkLst>
        </pc:spChg>
        <pc:spChg chg="mod">
          <ac:chgData name="Yang, Shengming - ARS" userId="37bd5b25-7571-49cb-bfc8-588a18706c35" providerId="ADAL" clId="{1CEC4EA3-DB05-44BE-AF57-7E2779412AED}" dt="2021-12-06T17:49:09.761" v="1100" actId="255"/>
          <ac:spMkLst>
            <pc:docMk/>
            <pc:sldMk cId="3951076637" sldId="279"/>
            <ac:spMk id="9" creationId="{1DBA7A38-F1C2-43F1-B07B-6DB945F9489B}"/>
          </ac:spMkLst>
        </pc:spChg>
        <pc:spChg chg="mod">
          <ac:chgData name="Yang, Shengming - ARS" userId="37bd5b25-7571-49cb-bfc8-588a18706c35" providerId="ADAL" clId="{1CEC4EA3-DB05-44BE-AF57-7E2779412AED}" dt="2021-12-06T17:49:09.761" v="1100" actId="255"/>
          <ac:spMkLst>
            <pc:docMk/>
            <pc:sldMk cId="3951076637" sldId="279"/>
            <ac:spMk id="10" creationId="{3D2326B1-C546-4D12-8752-20DF7547E757}"/>
          </ac:spMkLst>
        </pc:spChg>
        <pc:spChg chg="mod">
          <ac:chgData name="Yang, Shengming - ARS" userId="37bd5b25-7571-49cb-bfc8-588a18706c35" providerId="ADAL" clId="{1CEC4EA3-DB05-44BE-AF57-7E2779412AED}" dt="2021-12-06T17:49:09.761" v="1100" actId="255"/>
          <ac:spMkLst>
            <pc:docMk/>
            <pc:sldMk cId="3951076637" sldId="279"/>
            <ac:spMk id="11" creationId="{9CEA8F64-D0F9-437A-B0CD-26A049A077C5}"/>
          </ac:spMkLst>
        </pc:spChg>
        <pc:spChg chg="mod">
          <ac:chgData name="Yang, Shengming - ARS" userId="37bd5b25-7571-49cb-bfc8-588a18706c35" providerId="ADAL" clId="{1CEC4EA3-DB05-44BE-AF57-7E2779412AED}" dt="2021-12-06T17:49:09.761" v="1100" actId="255"/>
          <ac:spMkLst>
            <pc:docMk/>
            <pc:sldMk cId="3951076637" sldId="279"/>
            <ac:spMk id="12" creationId="{9A1CB18C-708F-4490-8E3B-0E81F8B8F925}"/>
          </ac:spMkLst>
        </pc:spChg>
        <pc:spChg chg="mod">
          <ac:chgData name="Yang, Shengming - ARS" userId="37bd5b25-7571-49cb-bfc8-588a18706c35" providerId="ADAL" clId="{1CEC4EA3-DB05-44BE-AF57-7E2779412AED}" dt="2021-12-06T17:49:09.761" v="1100" actId="255"/>
          <ac:spMkLst>
            <pc:docMk/>
            <pc:sldMk cId="3951076637" sldId="279"/>
            <ac:spMk id="13" creationId="{90553A36-194B-4661-8528-8B1849BB7519}"/>
          </ac:spMkLst>
        </pc:spChg>
        <pc:spChg chg="mod">
          <ac:chgData name="Yang, Shengming - ARS" userId="37bd5b25-7571-49cb-bfc8-588a18706c35" providerId="ADAL" clId="{1CEC4EA3-DB05-44BE-AF57-7E2779412AED}" dt="2021-12-06T17:49:09.761" v="1100" actId="255"/>
          <ac:spMkLst>
            <pc:docMk/>
            <pc:sldMk cId="3951076637" sldId="279"/>
            <ac:spMk id="14" creationId="{C4F6644D-D88C-416B-A004-6086EFE2868C}"/>
          </ac:spMkLst>
        </pc:spChg>
        <pc:spChg chg="mod">
          <ac:chgData name="Yang, Shengming - ARS" userId="37bd5b25-7571-49cb-bfc8-588a18706c35" providerId="ADAL" clId="{1CEC4EA3-DB05-44BE-AF57-7E2779412AED}" dt="2021-12-06T17:49:09.761" v="1100" actId="255"/>
          <ac:spMkLst>
            <pc:docMk/>
            <pc:sldMk cId="3951076637" sldId="279"/>
            <ac:spMk id="15" creationId="{F3DED48D-CE70-40FE-A39D-B971BC9389C5}"/>
          </ac:spMkLst>
        </pc:spChg>
        <pc:spChg chg="mod">
          <ac:chgData name="Yang, Shengming - ARS" userId="37bd5b25-7571-49cb-bfc8-588a18706c35" providerId="ADAL" clId="{1CEC4EA3-DB05-44BE-AF57-7E2779412AED}" dt="2021-12-06T17:49:09.761" v="1100" actId="255"/>
          <ac:spMkLst>
            <pc:docMk/>
            <pc:sldMk cId="3951076637" sldId="279"/>
            <ac:spMk id="16" creationId="{E0E41763-64B4-493B-B8C5-44023B9A4868}"/>
          </ac:spMkLst>
        </pc:spChg>
        <pc:spChg chg="mod">
          <ac:chgData name="Yang, Shengming - ARS" userId="37bd5b25-7571-49cb-bfc8-588a18706c35" providerId="ADAL" clId="{1CEC4EA3-DB05-44BE-AF57-7E2779412AED}" dt="2021-12-06T17:49:09.761" v="1100" actId="255"/>
          <ac:spMkLst>
            <pc:docMk/>
            <pc:sldMk cId="3951076637" sldId="279"/>
            <ac:spMk id="17" creationId="{B88AA1AD-6740-41FB-8D03-55FD7DD6881F}"/>
          </ac:spMkLst>
        </pc:spChg>
        <pc:spChg chg="mod">
          <ac:chgData name="Yang, Shengming - ARS" userId="37bd5b25-7571-49cb-bfc8-588a18706c35" providerId="ADAL" clId="{1CEC4EA3-DB05-44BE-AF57-7E2779412AED}" dt="2021-12-06T17:49:09.761" v="1100" actId="255"/>
          <ac:spMkLst>
            <pc:docMk/>
            <pc:sldMk cId="3951076637" sldId="279"/>
            <ac:spMk id="18" creationId="{C11AFC66-BEAB-4A07-9543-1548CB6DFB82}"/>
          </ac:spMkLst>
        </pc:spChg>
        <pc:spChg chg="mod">
          <ac:chgData name="Yang, Shengming - ARS" userId="37bd5b25-7571-49cb-bfc8-588a18706c35" providerId="ADAL" clId="{1CEC4EA3-DB05-44BE-AF57-7E2779412AED}" dt="2021-12-06T17:49:09.761" v="1100" actId="255"/>
          <ac:spMkLst>
            <pc:docMk/>
            <pc:sldMk cId="3951076637" sldId="279"/>
            <ac:spMk id="19" creationId="{749D19CB-F2A5-4F3D-9AA1-9B63159D6EB5}"/>
          </ac:spMkLst>
        </pc:spChg>
        <pc:spChg chg="mod">
          <ac:chgData name="Yang, Shengming - ARS" userId="37bd5b25-7571-49cb-bfc8-588a18706c35" providerId="ADAL" clId="{1CEC4EA3-DB05-44BE-AF57-7E2779412AED}" dt="2021-12-06T17:49:09.761" v="1100" actId="255"/>
          <ac:spMkLst>
            <pc:docMk/>
            <pc:sldMk cId="3951076637" sldId="279"/>
            <ac:spMk id="20" creationId="{47C1E7A6-3888-4BF6-AF81-7889EAB920DA}"/>
          </ac:spMkLst>
        </pc:spChg>
        <pc:spChg chg="mod">
          <ac:chgData name="Yang, Shengming - ARS" userId="37bd5b25-7571-49cb-bfc8-588a18706c35" providerId="ADAL" clId="{1CEC4EA3-DB05-44BE-AF57-7E2779412AED}" dt="2021-12-06T17:49:09.761" v="1100" actId="255"/>
          <ac:spMkLst>
            <pc:docMk/>
            <pc:sldMk cId="3951076637" sldId="279"/>
            <ac:spMk id="21" creationId="{63AD6A1F-A67A-4E9B-B1F2-1AAA334BDE29}"/>
          </ac:spMkLst>
        </pc:spChg>
        <pc:spChg chg="mod">
          <ac:chgData name="Yang, Shengming - ARS" userId="37bd5b25-7571-49cb-bfc8-588a18706c35" providerId="ADAL" clId="{1CEC4EA3-DB05-44BE-AF57-7E2779412AED}" dt="2021-12-06T17:49:09.761" v="1100" actId="255"/>
          <ac:spMkLst>
            <pc:docMk/>
            <pc:sldMk cId="3951076637" sldId="279"/>
            <ac:spMk id="22" creationId="{2277B4F2-190F-4C43-BA86-871B416D3C6D}"/>
          </ac:spMkLst>
        </pc:spChg>
        <pc:spChg chg="mod">
          <ac:chgData name="Yang, Shengming - ARS" userId="37bd5b25-7571-49cb-bfc8-588a18706c35" providerId="ADAL" clId="{1CEC4EA3-DB05-44BE-AF57-7E2779412AED}" dt="2021-12-06T17:49:09.761" v="1100" actId="255"/>
          <ac:spMkLst>
            <pc:docMk/>
            <pc:sldMk cId="3951076637" sldId="279"/>
            <ac:spMk id="23" creationId="{8E58034F-46E8-4DEB-A53C-A4EFA9DF7AE5}"/>
          </ac:spMkLst>
        </pc:spChg>
        <pc:spChg chg="mod">
          <ac:chgData name="Yang, Shengming - ARS" userId="37bd5b25-7571-49cb-bfc8-588a18706c35" providerId="ADAL" clId="{1CEC4EA3-DB05-44BE-AF57-7E2779412AED}" dt="2021-12-06T17:49:09.761" v="1100" actId="255"/>
          <ac:spMkLst>
            <pc:docMk/>
            <pc:sldMk cId="3951076637" sldId="279"/>
            <ac:spMk id="24" creationId="{119F3634-2A44-4A1E-B9A1-20D2CD30BFE8}"/>
          </ac:spMkLst>
        </pc:spChg>
        <pc:spChg chg="mod">
          <ac:chgData name="Yang, Shengming - ARS" userId="37bd5b25-7571-49cb-bfc8-588a18706c35" providerId="ADAL" clId="{1CEC4EA3-DB05-44BE-AF57-7E2779412AED}" dt="2021-12-06T17:49:09.761" v="1100" actId="255"/>
          <ac:spMkLst>
            <pc:docMk/>
            <pc:sldMk cId="3951076637" sldId="279"/>
            <ac:spMk id="25" creationId="{DEDD0E87-E7AD-4F9C-810D-65C7C9B37EB3}"/>
          </ac:spMkLst>
        </pc:spChg>
        <pc:spChg chg="mod">
          <ac:chgData name="Yang, Shengming - ARS" userId="37bd5b25-7571-49cb-bfc8-588a18706c35" providerId="ADAL" clId="{1CEC4EA3-DB05-44BE-AF57-7E2779412AED}" dt="2021-12-06T17:49:09.761" v="1100" actId="255"/>
          <ac:spMkLst>
            <pc:docMk/>
            <pc:sldMk cId="3951076637" sldId="279"/>
            <ac:spMk id="26" creationId="{8EF545B0-FBB5-4A8A-AC3B-7EC09B4C7B60}"/>
          </ac:spMkLst>
        </pc:spChg>
        <pc:spChg chg="mod">
          <ac:chgData name="Yang, Shengming - ARS" userId="37bd5b25-7571-49cb-bfc8-588a18706c35" providerId="ADAL" clId="{1CEC4EA3-DB05-44BE-AF57-7E2779412AED}" dt="2021-12-06T17:49:09.761" v="1100" actId="255"/>
          <ac:spMkLst>
            <pc:docMk/>
            <pc:sldMk cId="3951076637" sldId="279"/>
            <ac:spMk id="27" creationId="{2579254F-6C34-4A01-B85F-1044A5595F64}"/>
          </ac:spMkLst>
        </pc:spChg>
        <pc:spChg chg="mod">
          <ac:chgData name="Yang, Shengming - ARS" userId="37bd5b25-7571-49cb-bfc8-588a18706c35" providerId="ADAL" clId="{1CEC4EA3-DB05-44BE-AF57-7E2779412AED}" dt="2021-12-06T17:49:09.761" v="1100" actId="255"/>
          <ac:spMkLst>
            <pc:docMk/>
            <pc:sldMk cId="3951076637" sldId="279"/>
            <ac:spMk id="28" creationId="{2681E759-E980-4D0E-8A19-3C6930055144}"/>
          </ac:spMkLst>
        </pc:spChg>
        <pc:spChg chg="mod">
          <ac:chgData name="Yang, Shengming - ARS" userId="37bd5b25-7571-49cb-bfc8-588a18706c35" providerId="ADAL" clId="{1CEC4EA3-DB05-44BE-AF57-7E2779412AED}" dt="2021-12-06T17:49:09.761" v="1100" actId="255"/>
          <ac:spMkLst>
            <pc:docMk/>
            <pc:sldMk cId="3951076637" sldId="279"/>
            <ac:spMk id="29" creationId="{36469305-C272-4EBC-894D-2CF648336826}"/>
          </ac:spMkLst>
        </pc:spChg>
        <pc:spChg chg="mod">
          <ac:chgData name="Yang, Shengming - ARS" userId="37bd5b25-7571-49cb-bfc8-588a18706c35" providerId="ADAL" clId="{1CEC4EA3-DB05-44BE-AF57-7E2779412AED}" dt="2021-12-06T17:49:09.761" v="1100" actId="255"/>
          <ac:spMkLst>
            <pc:docMk/>
            <pc:sldMk cId="3951076637" sldId="279"/>
            <ac:spMk id="31" creationId="{8C88D3CF-522A-4F82-9D1E-F2BA0C73E44A}"/>
          </ac:spMkLst>
        </pc:spChg>
        <pc:grpChg chg="add mod">
          <ac:chgData name="Yang, Shengming - ARS" userId="37bd5b25-7571-49cb-bfc8-588a18706c35" providerId="ADAL" clId="{1CEC4EA3-DB05-44BE-AF57-7E2779412AED}" dt="2021-12-13T15:24:58.276" v="1311" actId="1076"/>
          <ac:grpSpMkLst>
            <pc:docMk/>
            <pc:sldMk cId="3951076637" sldId="279"/>
            <ac:grpSpMk id="4" creationId="{AFBEF914-C123-4457-BA33-D246EBC7B174}"/>
          </ac:grpSpMkLst>
        </pc:grpChg>
        <pc:picChg chg="mod">
          <ac:chgData name="Yang, Shengming - ARS" userId="37bd5b25-7571-49cb-bfc8-588a18706c35" providerId="ADAL" clId="{1CEC4EA3-DB05-44BE-AF57-7E2779412AED}" dt="2021-12-06T17:48:15.720" v="1084"/>
          <ac:picMkLst>
            <pc:docMk/>
            <pc:sldMk cId="3951076637" sldId="279"/>
            <ac:picMk id="6" creationId="{D5D3F2C3-992B-4E29-AC45-94D57298A263}"/>
          </ac:picMkLst>
        </pc:picChg>
        <pc:picChg chg="mod">
          <ac:chgData name="Yang, Shengming - ARS" userId="37bd5b25-7571-49cb-bfc8-588a18706c35" providerId="ADAL" clId="{1CEC4EA3-DB05-44BE-AF57-7E2779412AED}" dt="2021-12-06T17:48:15.720" v="1084"/>
          <ac:picMkLst>
            <pc:docMk/>
            <pc:sldMk cId="3951076637" sldId="279"/>
            <ac:picMk id="7" creationId="{E65D33FD-4A8B-4730-B051-114648063CC8}"/>
          </ac:picMkLst>
        </pc:picChg>
        <pc:picChg chg="mod">
          <ac:chgData name="Yang, Shengming - ARS" userId="37bd5b25-7571-49cb-bfc8-588a18706c35" providerId="ADAL" clId="{1CEC4EA3-DB05-44BE-AF57-7E2779412AED}" dt="2021-12-06T17:48:15.720" v="1084"/>
          <ac:picMkLst>
            <pc:docMk/>
            <pc:sldMk cId="3951076637" sldId="279"/>
            <ac:picMk id="8" creationId="{03A0FCB9-0014-44CD-9C1E-29A0071AF403}"/>
          </ac:picMkLst>
        </pc:picChg>
        <pc:picChg chg="mod">
          <ac:chgData name="Yang, Shengming - ARS" userId="37bd5b25-7571-49cb-bfc8-588a18706c35" providerId="ADAL" clId="{1CEC4EA3-DB05-44BE-AF57-7E2779412AED}" dt="2021-12-13T15:24:48.338" v="1310" actId="1076"/>
          <ac:picMkLst>
            <pc:docMk/>
            <pc:sldMk cId="3951076637" sldId="279"/>
            <ac:picMk id="30" creationId="{121D0B31-5F7E-439F-8FDF-148E33A12C9B}"/>
          </ac:picMkLst>
        </pc:picChg>
        <pc:cxnChg chg="mod">
          <ac:chgData name="Yang, Shengming - ARS" userId="37bd5b25-7571-49cb-bfc8-588a18706c35" providerId="ADAL" clId="{1CEC4EA3-DB05-44BE-AF57-7E2779412AED}" dt="2021-12-06T17:48:15.720" v="1084"/>
          <ac:cxnSpMkLst>
            <pc:docMk/>
            <pc:sldMk cId="3951076637" sldId="279"/>
            <ac:cxnSpMk id="32" creationId="{0ED014C2-BD9C-48CA-9230-869B95F1C1B6}"/>
          </ac:cxnSpMkLst>
        </pc:cxnChg>
      </pc:sldChg>
      <pc:sldChg chg="addSp delSp modSp new mod">
        <pc:chgData name="Yang, Shengming - ARS" userId="37bd5b25-7571-49cb-bfc8-588a18706c35" providerId="ADAL" clId="{1CEC4EA3-DB05-44BE-AF57-7E2779412AED}" dt="2021-12-08T18:54:03.960" v="1208" actId="1076"/>
        <pc:sldMkLst>
          <pc:docMk/>
          <pc:sldMk cId="2943728638" sldId="280"/>
        </pc:sldMkLst>
        <pc:spChg chg="del">
          <ac:chgData name="Yang, Shengming - ARS" userId="37bd5b25-7571-49cb-bfc8-588a18706c35" providerId="ADAL" clId="{1CEC4EA3-DB05-44BE-AF57-7E2779412AED}" dt="2021-12-08T16:21:19.408" v="1121" actId="478"/>
          <ac:spMkLst>
            <pc:docMk/>
            <pc:sldMk cId="2943728638" sldId="280"/>
            <ac:spMk id="2" creationId="{B51E652E-D2FC-4D48-8087-A1F950BE5727}"/>
          </ac:spMkLst>
        </pc:spChg>
        <pc:spChg chg="del mod">
          <ac:chgData name="Yang, Shengming - ARS" userId="37bd5b25-7571-49cb-bfc8-588a18706c35" providerId="ADAL" clId="{1CEC4EA3-DB05-44BE-AF57-7E2779412AED}" dt="2021-12-08T16:21:13.279" v="1119" actId="478"/>
          <ac:spMkLst>
            <pc:docMk/>
            <pc:sldMk cId="2943728638" sldId="280"/>
            <ac:spMk id="3" creationId="{388544ED-8267-450B-8A07-45CD100E700E}"/>
          </ac:spMkLst>
        </pc:spChg>
        <pc:spChg chg="add del mod">
          <ac:chgData name="Yang, Shengming - ARS" userId="37bd5b25-7571-49cb-bfc8-588a18706c35" providerId="ADAL" clId="{1CEC4EA3-DB05-44BE-AF57-7E2779412AED}" dt="2021-12-08T18:53:50.761" v="1205" actId="478"/>
          <ac:spMkLst>
            <pc:docMk/>
            <pc:sldMk cId="2943728638" sldId="280"/>
            <ac:spMk id="5" creationId="{3536617E-1BA2-4306-87E2-94E17F93A1C4}"/>
          </ac:spMkLst>
        </pc:spChg>
        <pc:spChg chg="add del mod">
          <ac:chgData name="Yang, Shengming - ARS" userId="37bd5b25-7571-49cb-bfc8-588a18706c35" providerId="ADAL" clId="{1CEC4EA3-DB05-44BE-AF57-7E2779412AED}" dt="2021-12-08T18:53:57.243" v="1206" actId="478"/>
          <ac:spMkLst>
            <pc:docMk/>
            <pc:sldMk cId="2943728638" sldId="280"/>
            <ac:spMk id="6" creationId="{A8A0E309-8391-424E-8D03-208DB2BCD810}"/>
          </ac:spMkLst>
        </pc:spChg>
        <pc:spChg chg="add del mod">
          <ac:chgData name="Yang, Shengming - ARS" userId="37bd5b25-7571-49cb-bfc8-588a18706c35" providerId="ADAL" clId="{1CEC4EA3-DB05-44BE-AF57-7E2779412AED}" dt="2021-12-08T18:53:57.243" v="1206" actId="478"/>
          <ac:spMkLst>
            <pc:docMk/>
            <pc:sldMk cId="2943728638" sldId="280"/>
            <ac:spMk id="7" creationId="{2917777C-F9D6-43C5-9101-F2D17AFAA31B}"/>
          </ac:spMkLst>
        </pc:spChg>
        <pc:spChg chg="add del mod">
          <ac:chgData name="Yang, Shengming - ARS" userId="37bd5b25-7571-49cb-bfc8-588a18706c35" providerId="ADAL" clId="{1CEC4EA3-DB05-44BE-AF57-7E2779412AED}" dt="2021-12-08T18:53:57.243" v="1206" actId="478"/>
          <ac:spMkLst>
            <pc:docMk/>
            <pc:sldMk cId="2943728638" sldId="280"/>
            <ac:spMk id="8" creationId="{E7B2515A-6A47-4169-8C54-FB6DF31C2F8B}"/>
          </ac:spMkLst>
        </pc:spChg>
        <pc:spChg chg="add del mod">
          <ac:chgData name="Yang, Shengming - ARS" userId="37bd5b25-7571-49cb-bfc8-588a18706c35" providerId="ADAL" clId="{1CEC4EA3-DB05-44BE-AF57-7E2779412AED}" dt="2021-12-08T18:53:57.243" v="1206" actId="478"/>
          <ac:spMkLst>
            <pc:docMk/>
            <pc:sldMk cId="2943728638" sldId="280"/>
            <ac:spMk id="9" creationId="{10F04274-2379-4852-9243-9B709DD8FE66}"/>
          </ac:spMkLst>
        </pc:spChg>
        <pc:spChg chg="add del mod">
          <ac:chgData name="Yang, Shengming - ARS" userId="37bd5b25-7571-49cb-bfc8-588a18706c35" providerId="ADAL" clId="{1CEC4EA3-DB05-44BE-AF57-7E2779412AED}" dt="2021-12-08T18:53:50.761" v="1205" actId="478"/>
          <ac:spMkLst>
            <pc:docMk/>
            <pc:sldMk cId="2943728638" sldId="280"/>
            <ac:spMk id="10" creationId="{69341816-BA84-4B7D-A956-E21569141471}"/>
          </ac:spMkLst>
        </pc:spChg>
        <pc:spChg chg="add mod">
          <ac:chgData name="Yang, Shengming - ARS" userId="37bd5b25-7571-49cb-bfc8-588a18706c35" providerId="ADAL" clId="{1CEC4EA3-DB05-44BE-AF57-7E2779412AED}" dt="2021-12-08T18:54:00.249" v="1207" actId="1076"/>
          <ac:spMkLst>
            <pc:docMk/>
            <pc:sldMk cId="2943728638" sldId="280"/>
            <ac:spMk id="12" creationId="{7A0C94AB-AB8A-4555-AA02-A6F3CCFAF47B}"/>
          </ac:spMkLst>
        </pc:spChg>
        <pc:graphicFrameChg chg="add mod">
          <ac:chgData name="Yang, Shengming - ARS" userId="37bd5b25-7571-49cb-bfc8-588a18706c35" providerId="ADAL" clId="{1CEC4EA3-DB05-44BE-AF57-7E2779412AED}" dt="2021-12-08T18:54:03.960" v="1208" actId="1076"/>
          <ac:graphicFrameMkLst>
            <pc:docMk/>
            <pc:sldMk cId="2943728638" sldId="280"/>
            <ac:graphicFrameMk id="11" creationId="{E6938A52-A21B-46C3-8EC5-EF88A90920AD}"/>
          </ac:graphicFrameMkLst>
        </pc:graphicFrameChg>
      </pc:sldChg>
      <pc:sldChg chg="delSp mod">
        <pc:chgData name="Yang, Shengming - ARS" userId="37bd5b25-7571-49cb-bfc8-588a18706c35" providerId="ADAL" clId="{1CEC4EA3-DB05-44BE-AF57-7E2779412AED}" dt="2021-12-16T19:32:16.441" v="1313" actId="478"/>
        <pc:sldMkLst>
          <pc:docMk/>
          <pc:sldMk cId="1104748975" sldId="281"/>
        </pc:sldMkLst>
        <pc:picChg chg="del">
          <ac:chgData name="Yang, Shengming - ARS" userId="37bd5b25-7571-49cb-bfc8-588a18706c35" providerId="ADAL" clId="{1CEC4EA3-DB05-44BE-AF57-7E2779412AED}" dt="2021-12-16T19:32:16.441" v="1313" actId="478"/>
          <ac:picMkLst>
            <pc:docMk/>
            <pc:sldMk cId="1104748975" sldId="281"/>
            <ac:picMk id="5" creationId="{268BE0B8-DA26-4BA7-BBC9-1F2701F84E01}"/>
          </ac:picMkLst>
        </pc:picChg>
        <pc:picChg chg="del">
          <ac:chgData name="Yang, Shengming - ARS" userId="37bd5b25-7571-49cb-bfc8-588a18706c35" providerId="ADAL" clId="{1CEC4EA3-DB05-44BE-AF57-7E2779412AED}" dt="2021-12-16T19:32:15.855" v="1312" actId="478"/>
          <ac:picMkLst>
            <pc:docMk/>
            <pc:sldMk cId="1104748975" sldId="281"/>
            <ac:picMk id="9" creationId="{44F233FB-2819-41D0-9AF4-54786682BBC0}"/>
          </ac:picMkLst>
        </pc:picChg>
      </pc:sldChg>
      <pc:sldChg chg="addSp delSp modSp new mod">
        <pc:chgData name="Yang, Shengming - ARS" userId="37bd5b25-7571-49cb-bfc8-588a18706c35" providerId="ADAL" clId="{1CEC4EA3-DB05-44BE-AF57-7E2779412AED}" dt="2021-12-17T19:25:10.407" v="1376" actId="21"/>
        <pc:sldMkLst>
          <pc:docMk/>
          <pc:sldMk cId="1705255663" sldId="282"/>
        </pc:sldMkLst>
        <pc:spChg chg="del">
          <ac:chgData name="Yang, Shengming - ARS" userId="37bd5b25-7571-49cb-bfc8-588a18706c35" providerId="ADAL" clId="{1CEC4EA3-DB05-44BE-AF57-7E2779412AED}" dt="2021-12-10T18:42:32.562" v="1210" actId="478"/>
          <ac:spMkLst>
            <pc:docMk/>
            <pc:sldMk cId="1705255663" sldId="282"/>
            <ac:spMk id="2" creationId="{DB944BA2-C0EA-4843-B061-EB5A884480B0}"/>
          </ac:spMkLst>
        </pc:spChg>
        <pc:spChg chg="del">
          <ac:chgData name="Yang, Shengming - ARS" userId="37bd5b25-7571-49cb-bfc8-588a18706c35" providerId="ADAL" clId="{1CEC4EA3-DB05-44BE-AF57-7E2779412AED}" dt="2021-12-10T18:42:32.562" v="1210" actId="478"/>
          <ac:spMkLst>
            <pc:docMk/>
            <pc:sldMk cId="1705255663" sldId="282"/>
            <ac:spMk id="3" creationId="{12C1210D-6CF4-4C58-8EDA-7EDF42BE7504}"/>
          </ac:spMkLst>
        </pc:spChg>
        <pc:spChg chg="add mod">
          <ac:chgData name="Yang, Shengming - ARS" userId="37bd5b25-7571-49cb-bfc8-588a18706c35" providerId="ADAL" clId="{1CEC4EA3-DB05-44BE-AF57-7E2779412AED}" dt="2021-12-16T19:45:46.853" v="1352" actId="404"/>
          <ac:spMkLst>
            <pc:docMk/>
            <pc:sldMk cId="1705255663" sldId="282"/>
            <ac:spMk id="4" creationId="{6803CA9D-13EE-4B97-90E9-5ACCDFE5FC3F}"/>
          </ac:spMkLst>
        </pc:spChg>
        <pc:spChg chg="add mod">
          <ac:chgData name="Yang, Shengming - ARS" userId="37bd5b25-7571-49cb-bfc8-588a18706c35" providerId="ADAL" clId="{1CEC4EA3-DB05-44BE-AF57-7E2779412AED}" dt="2021-12-10T18:44:35.659" v="1304" actId="1076"/>
          <ac:spMkLst>
            <pc:docMk/>
            <pc:sldMk cId="1705255663" sldId="282"/>
            <ac:spMk id="5" creationId="{B1448A8A-544D-438F-A286-694D3FDB58FE}"/>
          </ac:spMkLst>
        </pc:spChg>
        <pc:spChg chg="add mod">
          <ac:chgData name="Yang, Shengming - ARS" userId="37bd5b25-7571-49cb-bfc8-588a18706c35" providerId="ADAL" clId="{1CEC4EA3-DB05-44BE-AF57-7E2779412AED}" dt="2021-12-16T19:45:46.853" v="1352" actId="404"/>
          <ac:spMkLst>
            <pc:docMk/>
            <pc:sldMk cId="1705255663" sldId="282"/>
            <ac:spMk id="6" creationId="{565B2CCC-9E63-4D2E-9A47-DE9222FABAA9}"/>
          </ac:spMkLst>
        </pc:spChg>
        <pc:spChg chg="add mod">
          <ac:chgData name="Yang, Shengming - ARS" userId="37bd5b25-7571-49cb-bfc8-588a18706c35" providerId="ADAL" clId="{1CEC4EA3-DB05-44BE-AF57-7E2779412AED}" dt="2021-12-16T19:45:46.853" v="1352" actId="404"/>
          <ac:spMkLst>
            <pc:docMk/>
            <pc:sldMk cId="1705255663" sldId="282"/>
            <ac:spMk id="7" creationId="{44BAA3C1-28BB-4D76-A02E-FC5544EA2535}"/>
          </ac:spMkLst>
        </pc:spChg>
        <pc:spChg chg="add del mod">
          <ac:chgData name="Yang, Shengming - ARS" userId="37bd5b25-7571-49cb-bfc8-588a18706c35" providerId="ADAL" clId="{1CEC4EA3-DB05-44BE-AF57-7E2779412AED}" dt="2021-12-17T19:25:10.407" v="1376" actId="21"/>
          <ac:spMkLst>
            <pc:docMk/>
            <pc:sldMk cId="1705255663" sldId="282"/>
            <ac:spMk id="9" creationId="{A2C97B91-6271-4345-996F-8330209F9B49}"/>
          </ac:spMkLst>
        </pc:spChg>
        <pc:spChg chg="add del mod">
          <ac:chgData name="Yang, Shengming - ARS" userId="37bd5b25-7571-49cb-bfc8-588a18706c35" providerId="ADAL" clId="{1CEC4EA3-DB05-44BE-AF57-7E2779412AED}" dt="2021-12-17T19:25:10.407" v="1376" actId="21"/>
          <ac:spMkLst>
            <pc:docMk/>
            <pc:sldMk cId="1705255663" sldId="282"/>
            <ac:spMk id="10" creationId="{90CF2A94-EDB8-48E5-9D18-168AC82424CF}"/>
          </ac:spMkLst>
        </pc:spChg>
        <pc:spChg chg="add del mod">
          <ac:chgData name="Yang, Shengming - ARS" userId="37bd5b25-7571-49cb-bfc8-588a18706c35" providerId="ADAL" clId="{1CEC4EA3-DB05-44BE-AF57-7E2779412AED}" dt="2021-12-17T19:25:10.407" v="1376" actId="21"/>
          <ac:spMkLst>
            <pc:docMk/>
            <pc:sldMk cId="1705255663" sldId="282"/>
            <ac:spMk id="11" creationId="{39D94598-D1BA-455B-8FFC-874C040049FA}"/>
          </ac:spMkLst>
        </pc:spChg>
        <pc:spChg chg="add del mod">
          <ac:chgData name="Yang, Shengming - ARS" userId="37bd5b25-7571-49cb-bfc8-588a18706c35" providerId="ADAL" clId="{1CEC4EA3-DB05-44BE-AF57-7E2779412AED}" dt="2021-12-17T19:25:10.407" v="1376" actId="21"/>
          <ac:spMkLst>
            <pc:docMk/>
            <pc:sldMk cId="1705255663" sldId="282"/>
            <ac:spMk id="12" creationId="{A55BD882-FC2F-4D27-9757-F4435CDF4802}"/>
          </ac:spMkLst>
        </pc:spChg>
        <pc:spChg chg="add del mod">
          <ac:chgData name="Yang, Shengming - ARS" userId="37bd5b25-7571-49cb-bfc8-588a18706c35" providerId="ADAL" clId="{1CEC4EA3-DB05-44BE-AF57-7E2779412AED}" dt="2021-12-17T19:25:10.407" v="1376" actId="21"/>
          <ac:spMkLst>
            <pc:docMk/>
            <pc:sldMk cId="1705255663" sldId="282"/>
            <ac:spMk id="13" creationId="{FF53C586-10C1-4FE1-96F6-AF8CC4D9E8FC}"/>
          </ac:spMkLst>
        </pc:spChg>
        <pc:spChg chg="add del mod">
          <ac:chgData name="Yang, Shengming - ARS" userId="37bd5b25-7571-49cb-bfc8-588a18706c35" providerId="ADAL" clId="{1CEC4EA3-DB05-44BE-AF57-7E2779412AED}" dt="2021-12-17T19:25:10.407" v="1376" actId="21"/>
          <ac:spMkLst>
            <pc:docMk/>
            <pc:sldMk cId="1705255663" sldId="282"/>
            <ac:spMk id="14" creationId="{A915411F-8DBD-426D-8EAC-812B36DB50F6}"/>
          </ac:spMkLst>
        </pc:spChg>
        <pc:picChg chg="add mod">
          <ac:chgData name="Yang, Shengming - ARS" userId="37bd5b25-7571-49cb-bfc8-588a18706c35" providerId="ADAL" clId="{1CEC4EA3-DB05-44BE-AF57-7E2779412AED}" dt="2021-12-16T19:45:43.872" v="1347" actId="1076"/>
          <ac:picMkLst>
            <pc:docMk/>
            <pc:sldMk cId="1705255663" sldId="282"/>
            <ac:picMk id="3" creationId="{4D0CFDD5-3BF9-4979-86AD-60EDDA799CAE}"/>
          </ac:picMkLst>
        </pc:picChg>
        <pc:picChg chg="add del mod modCrop">
          <ac:chgData name="Yang, Shengming - ARS" userId="37bd5b25-7571-49cb-bfc8-588a18706c35" providerId="ADAL" clId="{1CEC4EA3-DB05-44BE-AF57-7E2779412AED}" dt="2021-12-17T19:25:10.407" v="1376" actId="21"/>
          <ac:picMkLst>
            <pc:docMk/>
            <pc:sldMk cId="1705255663" sldId="282"/>
            <ac:picMk id="8" creationId="{086F982F-E701-4A51-B69A-FEB24B454EDC}"/>
          </ac:picMkLst>
        </pc:picChg>
      </pc:sldChg>
      <pc:sldChg chg="addSp delSp modSp new mod ord">
        <pc:chgData name="Yang, Shengming - ARS" userId="37bd5b25-7571-49cb-bfc8-588a18706c35" providerId="ADAL" clId="{1CEC4EA3-DB05-44BE-AF57-7E2779412AED}" dt="2021-12-17T22:12:37.619" v="1893"/>
        <pc:sldMkLst>
          <pc:docMk/>
          <pc:sldMk cId="3161562260" sldId="283"/>
        </pc:sldMkLst>
        <pc:spChg chg="del">
          <ac:chgData name="Yang, Shengming - ARS" userId="37bd5b25-7571-49cb-bfc8-588a18706c35" providerId="ADAL" clId="{1CEC4EA3-DB05-44BE-AF57-7E2779412AED}" dt="2021-12-17T19:25:15.811" v="1377" actId="478"/>
          <ac:spMkLst>
            <pc:docMk/>
            <pc:sldMk cId="3161562260" sldId="283"/>
            <ac:spMk id="2" creationId="{9CA5E1DF-2C08-4681-8A48-CC5FDCA964CD}"/>
          </ac:spMkLst>
        </pc:spChg>
        <pc:spChg chg="del mod">
          <ac:chgData name="Yang, Shengming - ARS" userId="37bd5b25-7571-49cb-bfc8-588a18706c35" providerId="ADAL" clId="{1CEC4EA3-DB05-44BE-AF57-7E2779412AED}" dt="2021-12-17T19:25:24.148" v="1381" actId="478"/>
          <ac:spMkLst>
            <pc:docMk/>
            <pc:sldMk cId="3161562260" sldId="283"/>
            <ac:spMk id="3" creationId="{8E9ED299-84F3-496D-AEBD-B1FC11F97E02}"/>
          </ac:spMkLst>
        </pc:spChg>
        <pc:spChg chg="add mod">
          <ac:chgData name="Yang, Shengming - ARS" userId="37bd5b25-7571-49cb-bfc8-588a18706c35" providerId="ADAL" clId="{1CEC4EA3-DB05-44BE-AF57-7E2779412AED}" dt="2021-12-17T19:39:41.285" v="1592" actId="1076"/>
          <ac:spMkLst>
            <pc:docMk/>
            <pc:sldMk cId="3161562260" sldId="283"/>
            <ac:spMk id="5" creationId="{E2BD0D26-E684-4309-A4E1-0F3D7206D0E0}"/>
          </ac:spMkLst>
        </pc:spChg>
        <pc:spChg chg="add mod">
          <ac:chgData name="Yang, Shengming - ARS" userId="37bd5b25-7571-49cb-bfc8-588a18706c35" providerId="ADAL" clId="{1CEC4EA3-DB05-44BE-AF57-7E2779412AED}" dt="2021-12-17T19:25:27.605" v="1383" actId="1076"/>
          <ac:spMkLst>
            <pc:docMk/>
            <pc:sldMk cId="3161562260" sldId="283"/>
            <ac:spMk id="6" creationId="{00CB93E8-3871-4314-915D-1A6D23580C12}"/>
          </ac:spMkLst>
        </pc:spChg>
        <pc:spChg chg="add mod">
          <ac:chgData name="Yang, Shengming - ARS" userId="37bd5b25-7571-49cb-bfc8-588a18706c35" providerId="ADAL" clId="{1CEC4EA3-DB05-44BE-AF57-7E2779412AED}" dt="2021-12-17T19:39:41.285" v="1592" actId="1076"/>
          <ac:spMkLst>
            <pc:docMk/>
            <pc:sldMk cId="3161562260" sldId="283"/>
            <ac:spMk id="7" creationId="{6B5D02AE-A96B-4B49-AC76-99C0549859AF}"/>
          </ac:spMkLst>
        </pc:spChg>
        <pc:spChg chg="add mod">
          <ac:chgData name="Yang, Shengming - ARS" userId="37bd5b25-7571-49cb-bfc8-588a18706c35" providerId="ADAL" clId="{1CEC4EA3-DB05-44BE-AF57-7E2779412AED}" dt="2021-12-17T19:39:41.285" v="1592" actId="1076"/>
          <ac:spMkLst>
            <pc:docMk/>
            <pc:sldMk cId="3161562260" sldId="283"/>
            <ac:spMk id="8" creationId="{8F9B1C04-E6D0-4D94-BFBA-5FE59E2C2A0B}"/>
          </ac:spMkLst>
        </pc:spChg>
        <pc:spChg chg="add mod">
          <ac:chgData name="Yang, Shengming - ARS" userId="37bd5b25-7571-49cb-bfc8-588a18706c35" providerId="ADAL" clId="{1CEC4EA3-DB05-44BE-AF57-7E2779412AED}" dt="2021-12-17T19:39:41.285" v="1592" actId="1076"/>
          <ac:spMkLst>
            <pc:docMk/>
            <pc:sldMk cId="3161562260" sldId="283"/>
            <ac:spMk id="9" creationId="{BDB59B55-CAEF-4FA2-A583-5811AAAE98BD}"/>
          </ac:spMkLst>
        </pc:spChg>
        <pc:spChg chg="add mod">
          <ac:chgData name="Yang, Shengming - ARS" userId="37bd5b25-7571-49cb-bfc8-588a18706c35" providerId="ADAL" clId="{1CEC4EA3-DB05-44BE-AF57-7E2779412AED}" dt="2021-12-17T19:39:41.285" v="1592" actId="1076"/>
          <ac:spMkLst>
            <pc:docMk/>
            <pc:sldMk cId="3161562260" sldId="283"/>
            <ac:spMk id="10" creationId="{D66E3EA0-349D-4810-BFE8-1863FB98957A}"/>
          </ac:spMkLst>
        </pc:spChg>
        <pc:spChg chg="add mod">
          <ac:chgData name="Yang, Shengming - ARS" userId="37bd5b25-7571-49cb-bfc8-588a18706c35" providerId="ADAL" clId="{1CEC4EA3-DB05-44BE-AF57-7E2779412AED}" dt="2021-12-17T19:31:20.805" v="1520" actId="14100"/>
          <ac:spMkLst>
            <pc:docMk/>
            <pc:sldMk cId="3161562260" sldId="283"/>
            <ac:spMk id="15" creationId="{D0C186DE-5306-4BCD-AFC5-6B935AAE1E14}"/>
          </ac:spMkLst>
        </pc:spChg>
        <pc:spChg chg="add mod">
          <ac:chgData name="Yang, Shengming - ARS" userId="37bd5b25-7571-49cb-bfc8-588a18706c35" providerId="ADAL" clId="{1CEC4EA3-DB05-44BE-AF57-7E2779412AED}" dt="2021-12-17T19:31:20.805" v="1520" actId="14100"/>
          <ac:spMkLst>
            <pc:docMk/>
            <pc:sldMk cId="3161562260" sldId="283"/>
            <ac:spMk id="16" creationId="{73417ACE-C7C7-46D4-AB92-3B4BE10A8B80}"/>
          </ac:spMkLst>
        </pc:spChg>
        <pc:spChg chg="add mod">
          <ac:chgData name="Yang, Shengming - ARS" userId="37bd5b25-7571-49cb-bfc8-588a18706c35" providerId="ADAL" clId="{1CEC4EA3-DB05-44BE-AF57-7E2779412AED}" dt="2021-12-17T19:31:20.805" v="1520" actId="14100"/>
          <ac:spMkLst>
            <pc:docMk/>
            <pc:sldMk cId="3161562260" sldId="283"/>
            <ac:spMk id="17" creationId="{EF30B42F-B2D3-4F6C-82E9-5EE0601F2E0B}"/>
          </ac:spMkLst>
        </pc:spChg>
        <pc:spChg chg="add mod">
          <ac:chgData name="Yang, Shengming - ARS" userId="37bd5b25-7571-49cb-bfc8-588a18706c35" providerId="ADAL" clId="{1CEC4EA3-DB05-44BE-AF57-7E2779412AED}" dt="2021-12-17T19:32:56.339" v="1546" actId="1076"/>
          <ac:spMkLst>
            <pc:docMk/>
            <pc:sldMk cId="3161562260" sldId="283"/>
            <ac:spMk id="18" creationId="{BBB310B0-79EF-49D9-AEDB-5498AF731FED}"/>
          </ac:spMkLst>
        </pc:spChg>
        <pc:spChg chg="add mod">
          <ac:chgData name="Yang, Shengming - ARS" userId="37bd5b25-7571-49cb-bfc8-588a18706c35" providerId="ADAL" clId="{1CEC4EA3-DB05-44BE-AF57-7E2779412AED}" dt="2021-12-17T19:33:17.107" v="1549" actId="1076"/>
          <ac:spMkLst>
            <pc:docMk/>
            <pc:sldMk cId="3161562260" sldId="283"/>
            <ac:spMk id="19" creationId="{0F7A8E18-9C7A-4C86-B619-6CCC77F46459}"/>
          </ac:spMkLst>
        </pc:spChg>
        <pc:spChg chg="add mod">
          <ac:chgData name="Yang, Shengming - ARS" userId="37bd5b25-7571-49cb-bfc8-588a18706c35" providerId="ADAL" clId="{1CEC4EA3-DB05-44BE-AF57-7E2779412AED}" dt="2021-12-17T19:34:35.676" v="1560" actId="1036"/>
          <ac:spMkLst>
            <pc:docMk/>
            <pc:sldMk cId="3161562260" sldId="283"/>
            <ac:spMk id="20" creationId="{87DBDD65-7C4B-4A09-9FE8-241947E11861}"/>
          </ac:spMkLst>
        </pc:spChg>
        <pc:spChg chg="add del mod">
          <ac:chgData name="Yang, Shengming - ARS" userId="37bd5b25-7571-49cb-bfc8-588a18706c35" providerId="ADAL" clId="{1CEC4EA3-DB05-44BE-AF57-7E2779412AED}" dt="2021-12-17T19:35:30.823" v="1569" actId="478"/>
          <ac:spMkLst>
            <pc:docMk/>
            <pc:sldMk cId="3161562260" sldId="283"/>
            <ac:spMk id="21" creationId="{29B57C36-2D16-4171-91D6-29880FD6EAC4}"/>
          </ac:spMkLst>
        </pc:spChg>
        <pc:spChg chg="add del mod">
          <ac:chgData name="Yang, Shengming - ARS" userId="37bd5b25-7571-49cb-bfc8-588a18706c35" providerId="ADAL" clId="{1CEC4EA3-DB05-44BE-AF57-7E2779412AED}" dt="2021-12-17T19:35:22.217" v="1566" actId="478"/>
          <ac:spMkLst>
            <pc:docMk/>
            <pc:sldMk cId="3161562260" sldId="283"/>
            <ac:spMk id="22" creationId="{4EB91606-BD82-4175-984E-43D8D334F332}"/>
          </ac:spMkLst>
        </pc:spChg>
        <pc:spChg chg="add mod">
          <ac:chgData name="Yang, Shengming - ARS" userId="37bd5b25-7571-49cb-bfc8-588a18706c35" providerId="ADAL" clId="{1CEC4EA3-DB05-44BE-AF57-7E2779412AED}" dt="2021-12-17T21:59:05.806" v="1747" actId="1037"/>
          <ac:spMkLst>
            <pc:docMk/>
            <pc:sldMk cId="3161562260" sldId="283"/>
            <ac:spMk id="23" creationId="{3FD2A3E2-01CC-4C02-AED0-6F57BD63ABCB}"/>
          </ac:spMkLst>
        </pc:spChg>
        <pc:spChg chg="add mod">
          <ac:chgData name="Yang, Shengming - ARS" userId="37bd5b25-7571-49cb-bfc8-588a18706c35" providerId="ADAL" clId="{1CEC4EA3-DB05-44BE-AF57-7E2779412AED}" dt="2021-12-17T19:35:40.900" v="1570" actId="1076"/>
          <ac:spMkLst>
            <pc:docMk/>
            <pc:sldMk cId="3161562260" sldId="283"/>
            <ac:spMk id="24" creationId="{E4BAC983-E2D0-4C6B-8CC1-1847A1AEE69F}"/>
          </ac:spMkLst>
        </pc:spChg>
        <pc:spChg chg="add mod">
          <ac:chgData name="Yang, Shengming - ARS" userId="37bd5b25-7571-49cb-bfc8-588a18706c35" providerId="ADAL" clId="{1CEC4EA3-DB05-44BE-AF57-7E2779412AED}" dt="2021-12-17T19:36:00.871" v="1572" actId="1076"/>
          <ac:spMkLst>
            <pc:docMk/>
            <pc:sldMk cId="3161562260" sldId="283"/>
            <ac:spMk id="25" creationId="{29C3D798-A15C-4CBD-B7D3-CC694441C8C7}"/>
          </ac:spMkLst>
        </pc:spChg>
        <pc:spChg chg="add mod">
          <ac:chgData name="Yang, Shengming - ARS" userId="37bd5b25-7571-49cb-bfc8-588a18706c35" providerId="ADAL" clId="{1CEC4EA3-DB05-44BE-AF57-7E2779412AED}" dt="2021-12-17T19:38:22.006" v="1589" actId="1076"/>
          <ac:spMkLst>
            <pc:docMk/>
            <pc:sldMk cId="3161562260" sldId="283"/>
            <ac:spMk id="26" creationId="{9B898974-7798-463F-9982-05850CAB45A5}"/>
          </ac:spMkLst>
        </pc:spChg>
        <pc:spChg chg="add del">
          <ac:chgData name="Yang, Shengming - ARS" userId="37bd5b25-7571-49cb-bfc8-588a18706c35" providerId="ADAL" clId="{1CEC4EA3-DB05-44BE-AF57-7E2779412AED}" dt="2021-12-17T19:37:17.512" v="1576" actId="478"/>
          <ac:spMkLst>
            <pc:docMk/>
            <pc:sldMk cId="3161562260" sldId="283"/>
            <ac:spMk id="28" creationId="{CE151DAA-6817-4FE4-9A5F-4F75199524CE}"/>
          </ac:spMkLst>
        </pc:spChg>
        <pc:spChg chg="add mod">
          <ac:chgData name="Yang, Shengming - ARS" userId="37bd5b25-7571-49cb-bfc8-588a18706c35" providerId="ADAL" clId="{1CEC4EA3-DB05-44BE-AF57-7E2779412AED}" dt="2021-12-17T19:38:28.578" v="1590" actId="1076"/>
          <ac:spMkLst>
            <pc:docMk/>
            <pc:sldMk cId="3161562260" sldId="283"/>
            <ac:spMk id="29" creationId="{C0EAD2EE-9202-427B-889B-A230C6AD52EE}"/>
          </ac:spMkLst>
        </pc:spChg>
        <pc:spChg chg="add mod">
          <ac:chgData name="Yang, Shengming - ARS" userId="37bd5b25-7571-49cb-bfc8-588a18706c35" providerId="ADAL" clId="{1CEC4EA3-DB05-44BE-AF57-7E2779412AED}" dt="2021-12-17T19:38:08.964" v="1586" actId="1076"/>
          <ac:spMkLst>
            <pc:docMk/>
            <pc:sldMk cId="3161562260" sldId="283"/>
            <ac:spMk id="30" creationId="{DB087481-6A71-47A6-9AC7-BB8CE779FA0F}"/>
          </ac:spMkLst>
        </pc:spChg>
        <pc:spChg chg="add mod">
          <ac:chgData name="Yang, Shengming - ARS" userId="37bd5b25-7571-49cb-bfc8-588a18706c35" providerId="ADAL" clId="{1CEC4EA3-DB05-44BE-AF57-7E2779412AED}" dt="2021-12-17T19:38:12.396" v="1587" actId="1076"/>
          <ac:spMkLst>
            <pc:docMk/>
            <pc:sldMk cId="3161562260" sldId="283"/>
            <ac:spMk id="31" creationId="{42E39D23-7995-444E-BD3E-C1F018FFE1B7}"/>
          </ac:spMkLst>
        </pc:spChg>
        <pc:picChg chg="add mod">
          <ac:chgData name="Yang, Shengming - ARS" userId="37bd5b25-7571-49cb-bfc8-588a18706c35" providerId="ADAL" clId="{1CEC4EA3-DB05-44BE-AF57-7E2779412AED}" dt="2021-12-17T19:39:41.285" v="1592" actId="1076"/>
          <ac:picMkLst>
            <pc:docMk/>
            <pc:sldMk cId="3161562260" sldId="283"/>
            <ac:picMk id="4" creationId="{B60F58E5-0C68-4CD5-B42C-7DE9F2F4B61D}"/>
          </ac:picMkLst>
        </pc:picChg>
        <pc:picChg chg="add del mod">
          <ac:chgData name="Yang, Shengming - ARS" userId="37bd5b25-7571-49cb-bfc8-588a18706c35" providerId="ADAL" clId="{1CEC4EA3-DB05-44BE-AF57-7E2779412AED}" dt="2021-12-17T19:34:10.407" v="1552" actId="478"/>
          <ac:picMkLst>
            <pc:docMk/>
            <pc:sldMk cId="3161562260" sldId="283"/>
            <ac:picMk id="12" creationId="{073F6E15-0FED-40E0-A947-98200D70C656}"/>
          </ac:picMkLst>
        </pc:picChg>
        <pc:picChg chg="add mod">
          <ac:chgData name="Yang, Shengming - ARS" userId="37bd5b25-7571-49cb-bfc8-588a18706c35" providerId="ADAL" clId="{1CEC4EA3-DB05-44BE-AF57-7E2779412AED}" dt="2021-12-17T19:39:54.284" v="1594" actId="1076"/>
          <ac:picMkLst>
            <pc:docMk/>
            <pc:sldMk cId="3161562260" sldId="283"/>
            <ac:picMk id="32" creationId="{449EC690-EC57-4819-AF95-3D64529F15F6}"/>
          </ac:picMkLst>
        </pc:picChg>
        <pc:picChg chg="add mod modCrop">
          <ac:chgData name="Yang, Shengming - ARS" userId="37bd5b25-7571-49cb-bfc8-588a18706c35" providerId="ADAL" clId="{1CEC4EA3-DB05-44BE-AF57-7E2779412AED}" dt="2021-12-17T19:43:11.745" v="1611" actId="18131"/>
          <ac:picMkLst>
            <pc:docMk/>
            <pc:sldMk cId="3161562260" sldId="283"/>
            <ac:picMk id="33" creationId="{EF9FEF66-1C62-41F5-81F1-16316F8B449C}"/>
          </ac:picMkLst>
        </pc:picChg>
        <pc:picChg chg="add mod">
          <ac:chgData name="Yang, Shengming - ARS" userId="37bd5b25-7571-49cb-bfc8-588a18706c35" providerId="ADAL" clId="{1CEC4EA3-DB05-44BE-AF57-7E2779412AED}" dt="2021-12-17T19:42:04.789" v="1605" actId="1076"/>
          <ac:picMkLst>
            <pc:docMk/>
            <pc:sldMk cId="3161562260" sldId="283"/>
            <ac:picMk id="34" creationId="{094E8038-731B-43A9-AF78-1344E140F818}"/>
          </ac:picMkLst>
        </pc:picChg>
        <pc:picChg chg="add mod">
          <ac:chgData name="Yang, Shengming - ARS" userId="37bd5b25-7571-49cb-bfc8-588a18706c35" providerId="ADAL" clId="{1CEC4EA3-DB05-44BE-AF57-7E2779412AED}" dt="2021-12-17T19:43:52.132" v="1617" actId="14100"/>
          <ac:picMkLst>
            <pc:docMk/>
            <pc:sldMk cId="3161562260" sldId="283"/>
            <ac:picMk id="35" creationId="{745C001A-D968-411D-967A-269A9A402FD0}"/>
          </ac:picMkLst>
        </pc:picChg>
        <pc:picChg chg="add mod modCrop">
          <ac:chgData name="Yang, Shengming - ARS" userId="37bd5b25-7571-49cb-bfc8-588a18706c35" providerId="ADAL" clId="{1CEC4EA3-DB05-44BE-AF57-7E2779412AED}" dt="2021-12-17T19:44:12.744" v="1618" actId="18131"/>
          <ac:picMkLst>
            <pc:docMk/>
            <pc:sldMk cId="3161562260" sldId="283"/>
            <ac:picMk id="36" creationId="{821896F8-755C-447C-B3AB-FD278D386654}"/>
          </ac:picMkLst>
        </pc:picChg>
        <pc:picChg chg="add mod">
          <ac:chgData name="Yang, Shengming - ARS" userId="37bd5b25-7571-49cb-bfc8-588a18706c35" providerId="ADAL" clId="{1CEC4EA3-DB05-44BE-AF57-7E2779412AED}" dt="2021-12-17T19:43:32.196" v="1614" actId="1076"/>
          <ac:picMkLst>
            <pc:docMk/>
            <pc:sldMk cId="3161562260" sldId="283"/>
            <ac:picMk id="37" creationId="{C2B3FB3C-31C6-4288-924D-874795D58FEB}"/>
          </ac:picMkLst>
        </pc:picChg>
        <pc:picChg chg="add mod">
          <ac:chgData name="Yang, Shengming - ARS" userId="37bd5b25-7571-49cb-bfc8-588a18706c35" providerId="ADAL" clId="{1CEC4EA3-DB05-44BE-AF57-7E2779412AED}" dt="2021-12-17T19:44:24.956" v="1621" actId="1076"/>
          <ac:picMkLst>
            <pc:docMk/>
            <pc:sldMk cId="3161562260" sldId="283"/>
            <ac:picMk id="38" creationId="{B7A19B21-874C-4169-B186-FCABA8034826}"/>
          </ac:picMkLst>
        </pc:picChg>
        <pc:cxnChg chg="add mod">
          <ac:chgData name="Yang, Shengming - ARS" userId="37bd5b25-7571-49cb-bfc8-588a18706c35" providerId="ADAL" clId="{1CEC4EA3-DB05-44BE-AF57-7E2779412AED}" dt="2021-12-17T19:31:38.552" v="1529" actId="1037"/>
          <ac:cxnSpMkLst>
            <pc:docMk/>
            <pc:sldMk cId="3161562260" sldId="283"/>
            <ac:cxnSpMk id="14" creationId="{99C7A676-A738-4063-A92D-FDBAED393C29}"/>
          </ac:cxnSpMkLst>
        </pc:cxnChg>
      </pc:sldChg>
      <pc:sldChg chg="addSp delSp modSp add mod ord">
        <pc:chgData name="Yang, Shengming - ARS" userId="37bd5b25-7571-49cb-bfc8-588a18706c35" providerId="ADAL" clId="{1CEC4EA3-DB05-44BE-AF57-7E2779412AED}" dt="2021-12-20T15:50:05.601" v="1896"/>
        <pc:sldMkLst>
          <pc:docMk/>
          <pc:sldMk cId="2625937353" sldId="284"/>
        </pc:sldMkLst>
        <pc:spChg chg="del mod">
          <ac:chgData name="Yang, Shengming - ARS" userId="37bd5b25-7571-49cb-bfc8-588a18706c35" providerId="ADAL" clId="{1CEC4EA3-DB05-44BE-AF57-7E2779412AED}" dt="2021-12-17T22:09:54.698" v="1888" actId="478"/>
          <ac:spMkLst>
            <pc:docMk/>
            <pc:sldMk cId="2625937353" sldId="284"/>
            <ac:spMk id="5" creationId="{E2BD0D26-E684-4309-A4E1-0F3D7206D0E0}"/>
          </ac:spMkLst>
        </pc:spChg>
        <pc:spChg chg="mod">
          <ac:chgData name="Yang, Shengming - ARS" userId="37bd5b25-7571-49cb-bfc8-588a18706c35" providerId="ADAL" clId="{1CEC4EA3-DB05-44BE-AF57-7E2779412AED}" dt="2021-12-17T22:07:11.421" v="1843" actId="1037"/>
          <ac:spMkLst>
            <pc:docMk/>
            <pc:sldMk cId="2625937353" sldId="284"/>
            <ac:spMk id="6" creationId="{00CB93E8-3871-4314-915D-1A6D23580C12}"/>
          </ac:spMkLst>
        </pc:spChg>
        <pc:spChg chg="del">
          <ac:chgData name="Yang, Shengming - ARS" userId="37bd5b25-7571-49cb-bfc8-588a18706c35" providerId="ADAL" clId="{1CEC4EA3-DB05-44BE-AF57-7E2779412AED}" dt="2021-12-17T22:09:54.698" v="1888" actId="478"/>
          <ac:spMkLst>
            <pc:docMk/>
            <pc:sldMk cId="2625937353" sldId="284"/>
            <ac:spMk id="7" creationId="{6B5D02AE-A96B-4B49-AC76-99C0549859AF}"/>
          </ac:spMkLst>
        </pc:spChg>
        <pc:spChg chg="del">
          <ac:chgData name="Yang, Shengming - ARS" userId="37bd5b25-7571-49cb-bfc8-588a18706c35" providerId="ADAL" clId="{1CEC4EA3-DB05-44BE-AF57-7E2779412AED}" dt="2021-12-17T22:09:54.698" v="1888" actId="478"/>
          <ac:spMkLst>
            <pc:docMk/>
            <pc:sldMk cId="2625937353" sldId="284"/>
            <ac:spMk id="8" creationId="{8F9B1C04-E6D0-4D94-BFBA-5FE59E2C2A0B}"/>
          </ac:spMkLst>
        </pc:spChg>
        <pc:spChg chg="del">
          <ac:chgData name="Yang, Shengming - ARS" userId="37bd5b25-7571-49cb-bfc8-588a18706c35" providerId="ADAL" clId="{1CEC4EA3-DB05-44BE-AF57-7E2779412AED}" dt="2021-12-17T22:09:54.698" v="1888" actId="478"/>
          <ac:spMkLst>
            <pc:docMk/>
            <pc:sldMk cId="2625937353" sldId="284"/>
            <ac:spMk id="9" creationId="{BDB59B55-CAEF-4FA2-A583-5811AAAE98BD}"/>
          </ac:spMkLst>
        </pc:spChg>
        <pc:spChg chg="del">
          <ac:chgData name="Yang, Shengming - ARS" userId="37bd5b25-7571-49cb-bfc8-588a18706c35" providerId="ADAL" clId="{1CEC4EA3-DB05-44BE-AF57-7E2779412AED}" dt="2021-12-17T22:09:54.698" v="1888" actId="478"/>
          <ac:spMkLst>
            <pc:docMk/>
            <pc:sldMk cId="2625937353" sldId="284"/>
            <ac:spMk id="10" creationId="{D66E3EA0-349D-4810-BFE8-1863FB98957A}"/>
          </ac:spMkLst>
        </pc:spChg>
        <pc:spChg chg="mod">
          <ac:chgData name="Yang, Shengming - ARS" userId="37bd5b25-7571-49cb-bfc8-588a18706c35" providerId="ADAL" clId="{1CEC4EA3-DB05-44BE-AF57-7E2779412AED}" dt="2021-12-17T19:46:50.278" v="1654" actId="14100"/>
          <ac:spMkLst>
            <pc:docMk/>
            <pc:sldMk cId="2625937353" sldId="284"/>
            <ac:spMk id="15" creationId="{D0C186DE-5306-4BCD-AFC5-6B935AAE1E14}"/>
          </ac:spMkLst>
        </pc:spChg>
        <pc:spChg chg="mod">
          <ac:chgData name="Yang, Shengming - ARS" userId="37bd5b25-7571-49cb-bfc8-588a18706c35" providerId="ADAL" clId="{1CEC4EA3-DB05-44BE-AF57-7E2779412AED}" dt="2021-12-17T19:47:28.220" v="1694" actId="1037"/>
          <ac:spMkLst>
            <pc:docMk/>
            <pc:sldMk cId="2625937353" sldId="284"/>
            <ac:spMk id="16" creationId="{73417ACE-C7C7-46D4-AB92-3B4BE10A8B80}"/>
          </ac:spMkLst>
        </pc:spChg>
        <pc:spChg chg="mod">
          <ac:chgData name="Yang, Shengming - ARS" userId="37bd5b25-7571-49cb-bfc8-588a18706c35" providerId="ADAL" clId="{1CEC4EA3-DB05-44BE-AF57-7E2779412AED}" dt="2021-12-17T19:46:50.278" v="1654" actId="14100"/>
          <ac:spMkLst>
            <pc:docMk/>
            <pc:sldMk cId="2625937353" sldId="284"/>
            <ac:spMk id="17" creationId="{EF30B42F-B2D3-4F6C-82E9-5EE0601F2E0B}"/>
          </ac:spMkLst>
        </pc:spChg>
        <pc:spChg chg="mod">
          <ac:chgData name="Yang, Shengming - ARS" userId="37bd5b25-7571-49cb-bfc8-588a18706c35" providerId="ADAL" clId="{1CEC4EA3-DB05-44BE-AF57-7E2779412AED}" dt="2021-12-17T22:10:18.827" v="1889" actId="1076"/>
          <ac:spMkLst>
            <pc:docMk/>
            <pc:sldMk cId="2625937353" sldId="284"/>
            <ac:spMk id="18" creationId="{BBB310B0-79EF-49D9-AEDB-5498AF731FED}"/>
          </ac:spMkLst>
        </pc:spChg>
        <pc:spChg chg="mod">
          <ac:chgData name="Yang, Shengming - ARS" userId="37bd5b25-7571-49cb-bfc8-588a18706c35" providerId="ADAL" clId="{1CEC4EA3-DB05-44BE-AF57-7E2779412AED}" dt="2021-12-17T19:46:59.979" v="1657" actId="1035"/>
          <ac:spMkLst>
            <pc:docMk/>
            <pc:sldMk cId="2625937353" sldId="284"/>
            <ac:spMk id="19" creationId="{0F7A8E18-9C7A-4C86-B619-6CCC77F46459}"/>
          </ac:spMkLst>
        </pc:spChg>
        <pc:spChg chg="mod">
          <ac:chgData name="Yang, Shengming - ARS" userId="37bd5b25-7571-49cb-bfc8-588a18706c35" providerId="ADAL" clId="{1CEC4EA3-DB05-44BE-AF57-7E2779412AED}" dt="2021-12-17T22:00:20.500" v="1750" actId="1076"/>
          <ac:spMkLst>
            <pc:docMk/>
            <pc:sldMk cId="2625937353" sldId="284"/>
            <ac:spMk id="23" creationId="{3FD2A3E2-01CC-4C02-AED0-6F57BD63ABCB}"/>
          </ac:spMkLst>
        </pc:spChg>
        <pc:spChg chg="mod">
          <ac:chgData name="Yang, Shengming - ARS" userId="37bd5b25-7571-49cb-bfc8-588a18706c35" providerId="ADAL" clId="{1CEC4EA3-DB05-44BE-AF57-7E2779412AED}" dt="2021-12-17T22:05:06.425" v="1792" actId="1038"/>
          <ac:spMkLst>
            <pc:docMk/>
            <pc:sldMk cId="2625937353" sldId="284"/>
            <ac:spMk id="26" creationId="{9B898974-7798-463F-9982-05850CAB45A5}"/>
          </ac:spMkLst>
        </pc:spChg>
        <pc:spChg chg="mod">
          <ac:chgData name="Yang, Shengming - ARS" userId="37bd5b25-7571-49cb-bfc8-588a18706c35" providerId="ADAL" clId="{1CEC4EA3-DB05-44BE-AF57-7E2779412AED}" dt="2021-12-17T22:07:03.239" v="1834" actId="1038"/>
          <ac:spMkLst>
            <pc:docMk/>
            <pc:sldMk cId="2625937353" sldId="284"/>
            <ac:spMk id="29" creationId="{C0EAD2EE-9202-427B-889B-A230C6AD52EE}"/>
          </ac:spMkLst>
        </pc:spChg>
        <pc:spChg chg="mod">
          <ac:chgData name="Yang, Shengming - ARS" userId="37bd5b25-7571-49cb-bfc8-588a18706c35" providerId="ADAL" clId="{1CEC4EA3-DB05-44BE-AF57-7E2779412AED}" dt="2021-12-17T22:07:26.163" v="1870" actId="1038"/>
          <ac:spMkLst>
            <pc:docMk/>
            <pc:sldMk cId="2625937353" sldId="284"/>
            <ac:spMk id="30" creationId="{DB087481-6A71-47A6-9AC7-BB8CE779FA0F}"/>
          </ac:spMkLst>
        </pc:spChg>
        <pc:spChg chg="mod">
          <ac:chgData name="Yang, Shengming - ARS" userId="37bd5b25-7571-49cb-bfc8-588a18706c35" providerId="ADAL" clId="{1CEC4EA3-DB05-44BE-AF57-7E2779412AED}" dt="2021-12-17T22:06:54.242" v="1810" actId="1038"/>
          <ac:spMkLst>
            <pc:docMk/>
            <pc:sldMk cId="2625937353" sldId="284"/>
            <ac:spMk id="31" creationId="{42E39D23-7995-444E-BD3E-C1F018FFE1B7}"/>
          </ac:spMkLst>
        </pc:spChg>
        <pc:spChg chg="add mod">
          <ac:chgData name="Yang, Shengming - ARS" userId="37bd5b25-7571-49cb-bfc8-588a18706c35" providerId="ADAL" clId="{1CEC4EA3-DB05-44BE-AF57-7E2779412AED}" dt="2021-12-17T19:47:53.117" v="1700" actId="1076"/>
          <ac:spMkLst>
            <pc:docMk/>
            <pc:sldMk cId="2625937353" sldId="284"/>
            <ac:spMk id="39" creationId="{397F490C-7EB1-4EFA-BB3D-77E42EE14657}"/>
          </ac:spMkLst>
        </pc:spChg>
        <pc:spChg chg="add mod">
          <ac:chgData name="Yang, Shengming - ARS" userId="37bd5b25-7571-49cb-bfc8-588a18706c35" providerId="ADAL" clId="{1CEC4EA3-DB05-44BE-AF57-7E2779412AED}" dt="2021-12-17T19:47:45.881" v="1699" actId="20577"/>
          <ac:spMkLst>
            <pc:docMk/>
            <pc:sldMk cId="2625937353" sldId="284"/>
            <ac:spMk id="40" creationId="{DDA24DDD-7F88-43FD-84E8-8D69317885D8}"/>
          </ac:spMkLst>
        </pc:spChg>
        <pc:spChg chg="add mod">
          <ac:chgData name="Yang, Shengming - ARS" userId="37bd5b25-7571-49cb-bfc8-588a18706c35" providerId="ADAL" clId="{1CEC4EA3-DB05-44BE-AF57-7E2779412AED}" dt="2021-12-17T19:48:04.310" v="1703" actId="20577"/>
          <ac:spMkLst>
            <pc:docMk/>
            <pc:sldMk cId="2625937353" sldId="284"/>
            <ac:spMk id="41" creationId="{B1F04B0A-EB32-4F64-A227-03FBA9B8613F}"/>
          </ac:spMkLst>
        </pc:spChg>
        <pc:spChg chg="add mod">
          <ac:chgData name="Yang, Shengming - ARS" userId="37bd5b25-7571-49cb-bfc8-588a18706c35" providerId="ADAL" clId="{1CEC4EA3-DB05-44BE-AF57-7E2779412AED}" dt="2021-12-17T19:48:24.915" v="1707" actId="20577"/>
          <ac:spMkLst>
            <pc:docMk/>
            <pc:sldMk cId="2625937353" sldId="284"/>
            <ac:spMk id="42" creationId="{B2E2514F-3C62-4A36-8AAB-8245B567DE9D}"/>
          </ac:spMkLst>
        </pc:spChg>
        <pc:spChg chg="add mod">
          <ac:chgData name="Yang, Shengming - ARS" userId="37bd5b25-7571-49cb-bfc8-588a18706c35" providerId="ADAL" clId="{1CEC4EA3-DB05-44BE-AF57-7E2779412AED}" dt="2021-12-17T19:48:36.089" v="1711" actId="20577"/>
          <ac:spMkLst>
            <pc:docMk/>
            <pc:sldMk cId="2625937353" sldId="284"/>
            <ac:spMk id="43" creationId="{124F71AF-7115-4C5C-8142-05CD1077714A}"/>
          </ac:spMkLst>
        </pc:spChg>
        <pc:spChg chg="add mod">
          <ac:chgData name="Yang, Shengming - ARS" userId="37bd5b25-7571-49cb-bfc8-588a18706c35" providerId="ADAL" clId="{1CEC4EA3-DB05-44BE-AF57-7E2779412AED}" dt="2021-12-17T22:01:09.018" v="1782" actId="1037"/>
          <ac:spMkLst>
            <pc:docMk/>
            <pc:sldMk cId="2625937353" sldId="284"/>
            <ac:spMk id="44" creationId="{5036E2C2-D0C3-4912-979E-CE0E97BFE4C7}"/>
          </ac:spMkLst>
        </pc:spChg>
        <pc:spChg chg="add mod">
          <ac:chgData name="Yang, Shengming - ARS" userId="37bd5b25-7571-49cb-bfc8-588a18706c35" providerId="ADAL" clId="{1CEC4EA3-DB05-44BE-AF57-7E2779412AED}" dt="2021-12-17T22:08:02.321" v="1879" actId="1076"/>
          <ac:spMkLst>
            <pc:docMk/>
            <pc:sldMk cId="2625937353" sldId="284"/>
            <ac:spMk id="45" creationId="{561A173B-C821-49F3-875D-7AFC1E02CE2F}"/>
          </ac:spMkLst>
        </pc:spChg>
        <pc:spChg chg="add mod">
          <ac:chgData name="Yang, Shengming - ARS" userId="37bd5b25-7571-49cb-bfc8-588a18706c35" providerId="ADAL" clId="{1CEC4EA3-DB05-44BE-AF57-7E2779412AED}" dt="2021-12-17T22:08:06.029" v="1880" actId="20577"/>
          <ac:spMkLst>
            <pc:docMk/>
            <pc:sldMk cId="2625937353" sldId="284"/>
            <ac:spMk id="46" creationId="{1C334073-8210-401F-ABDE-84BF451B23A4}"/>
          </ac:spMkLst>
        </pc:spChg>
        <pc:spChg chg="add mod">
          <ac:chgData name="Yang, Shengming - ARS" userId="37bd5b25-7571-49cb-bfc8-588a18706c35" providerId="ADAL" clId="{1CEC4EA3-DB05-44BE-AF57-7E2779412AED}" dt="2021-12-17T22:08:17.118" v="1883" actId="20577"/>
          <ac:spMkLst>
            <pc:docMk/>
            <pc:sldMk cId="2625937353" sldId="284"/>
            <ac:spMk id="47" creationId="{D320BB33-AD7F-4672-849A-58E930A112F8}"/>
          </ac:spMkLst>
        </pc:spChg>
        <pc:spChg chg="add mod">
          <ac:chgData name="Yang, Shengming - ARS" userId="37bd5b25-7571-49cb-bfc8-588a18706c35" providerId="ADAL" clId="{1CEC4EA3-DB05-44BE-AF57-7E2779412AED}" dt="2021-12-17T22:08:42.031" v="1887" actId="20577"/>
          <ac:spMkLst>
            <pc:docMk/>
            <pc:sldMk cId="2625937353" sldId="284"/>
            <ac:spMk id="48" creationId="{FAD047C0-A68E-42D3-ABA2-034D858DAD9A}"/>
          </ac:spMkLst>
        </pc:spChg>
        <pc:graphicFrameChg chg="add mod modGraphic">
          <ac:chgData name="Yang, Shengming - ARS" userId="37bd5b25-7571-49cb-bfc8-588a18706c35" providerId="ADAL" clId="{1CEC4EA3-DB05-44BE-AF57-7E2779412AED}" dt="2021-12-17T22:29:45.022" v="1894" actId="14100"/>
          <ac:graphicFrameMkLst>
            <pc:docMk/>
            <pc:sldMk cId="2625937353" sldId="284"/>
            <ac:graphicFrameMk id="3" creationId="{3184B4D2-9BCF-43C5-B7F7-49351A76A6E6}"/>
          </ac:graphicFrameMkLst>
        </pc:graphicFrameChg>
        <pc:picChg chg="add mod">
          <ac:chgData name="Yang, Shengming - ARS" userId="37bd5b25-7571-49cb-bfc8-588a18706c35" providerId="ADAL" clId="{1CEC4EA3-DB05-44BE-AF57-7E2779412AED}" dt="2021-12-17T19:52:34.202" v="1728" actId="1076"/>
          <ac:picMkLst>
            <pc:docMk/>
            <pc:sldMk cId="2625937353" sldId="284"/>
            <ac:picMk id="2" creationId="{7556588D-D216-4384-B5CD-01DA16987B6F}"/>
          </ac:picMkLst>
        </pc:picChg>
        <pc:picChg chg="add del">
          <ac:chgData name="Yang, Shengming - ARS" userId="37bd5b25-7571-49cb-bfc8-588a18706c35" providerId="ADAL" clId="{1CEC4EA3-DB05-44BE-AF57-7E2779412AED}" dt="2021-12-17T22:09:54.698" v="1888" actId="478"/>
          <ac:picMkLst>
            <pc:docMk/>
            <pc:sldMk cId="2625937353" sldId="284"/>
            <ac:picMk id="4" creationId="{B60F58E5-0C68-4CD5-B42C-7DE9F2F4B61D}"/>
          </ac:picMkLst>
        </pc:picChg>
        <pc:picChg chg="del">
          <ac:chgData name="Yang, Shengming - ARS" userId="37bd5b25-7571-49cb-bfc8-588a18706c35" providerId="ADAL" clId="{1CEC4EA3-DB05-44BE-AF57-7E2779412AED}" dt="2021-12-17T19:45:51.784" v="1623" actId="478"/>
          <ac:picMkLst>
            <pc:docMk/>
            <pc:sldMk cId="2625937353" sldId="284"/>
            <ac:picMk id="32" creationId="{449EC690-EC57-4819-AF95-3D64529F15F6}"/>
          </ac:picMkLst>
        </pc:picChg>
        <pc:picChg chg="del">
          <ac:chgData name="Yang, Shengming - ARS" userId="37bd5b25-7571-49cb-bfc8-588a18706c35" providerId="ADAL" clId="{1CEC4EA3-DB05-44BE-AF57-7E2779412AED}" dt="2021-12-17T19:45:55.832" v="1626" actId="478"/>
          <ac:picMkLst>
            <pc:docMk/>
            <pc:sldMk cId="2625937353" sldId="284"/>
            <ac:picMk id="33" creationId="{EF9FEF66-1C62-41F5-81F1-16316F8B449C}"/>
          </ac:picMkLst>
        </pc:picChg>
        <pc:picChg chg="del mod modCrop">
          <ac:chgData name="Yang, Shengming - ARS" userId="37bd5b25-7571-49cb-bfc8-588a18706c35" providerId="ADAL" clId="{1CEC4EA3-DB05-44BE-AF57-7E2779412AED}" dt="2021-12-17T22:09:54.698" v="1888" actId="478"/>
          <ac:picMkLst>
            <pc:docMk/>
            <pc:sldMk cId="2625937353" sldId="284"/>
            <ac:picMk id="34" creationId="{094E8038-731B-43A9-AF78-1344E140F818}"/>
          </ac:picMkLst>
        </pc:picChg>
        <pc:picChg chg="mod">
          <ac:chgData name="Yang, Shengming - ARS" userId="37bd5b25-7571-49cb-bfc8-588a18706c35" providerId="ADAL" clId="{1CEC4EA3-DB05-44BE-AF57-7E2779412AED}" dt="2021-12-17T19:52:28.024" v="1726" actId="1076"/>
          <ac:picMkLst>
            <pc:docMk/>
            <pc:sldMk cId="2625937353" sldId="284"/>
            <ac:picMk id="35" creationId="{745C001A-D968-411D-967A-269A9A402FD0}"/>
          </ac:picMkLst>
        </pc:picChg>
        <pc:picChg chg="del">
          <ac:chgData name="Yang, Shengming - ARS" userId="37bd5b25-7571-49cb-bfc8-588a18706c35" providerId="ADAL" clId="{1CEC4EA3-DB05-44BE-AF57-7E2779412AED}" dt="2021-12-17T19:45:56.408" v="1627" actId="478"/>
          <ac:picMkLst>
            <pc:docMk/>
            <pc:sldMk cId="2625937353" sldId="284"/>
            <ac:picMk id="36" creationId="{821896F8-755C-447C-B3AB-FD278D386654}"/>
          </ac:picMkLst>
        </pc:picChg>
        <pc:picChg chg="mod">
          <ac:chgData name="Yang, Shengming - ARS" userId="37bd5b25-7571-49cb-bfc8-588a18706c35" providerId="ADAL" clId="{1CEC4EA3-DB05-44BE-AF57-7E2779412AED}" dt="2021-12-17T19:52:30.308" v="1727" actId="1076"/>
          <ac:picMkLst>
            <pc:docMk/>
            <pc:sldMk cId="2625937353" sldId="284"/>
            <ac:picMk id="37" creationId="{C2B3FB3C-31C6-4288-924D-874795D58FEB}"/>
          </ac:picMkLst>
        </pc:picChg>
        <pc:picChg chg="mod">
          <ac:chgData name="Yang, Shengming - ARS" userId="37bd5b25-7571-49cb-bfc8-588a18706c35" providerId="ADAL" clId="{1CEC4EA3-DB05-44BE-AF57-7E2779412AED}" dt="2021-12-17T19:52:36.561" v="1729" actId="1076"/>
          <ac:picMkLst>
            <pc:docMk/>
            <pc:sldMk cId="2625937353" sldId="284"/>
            <ac:picMk id="38" creationId="{B7A19B21-874C-4169-B186-FCABA8034826}"/>
          </ac:picMkLst>
        </pc:picChg>
      </pc:sldChg>
      <pc:sldChg chg="add ord">
        <pc:chgData name="Yang, Shengming - ARS" userId="37bd5b25-7571-49cb-bfc8-588a18706c35" providerId="ADAL" clId="{1CEC4EA3-DB05-44BE-AF57-7E2779412AED}" dt="2021-12-22T20:20:36.296" v="2095"/>
        <pc:sldMkLst>
          <pc:docMk/>
          <pc:sldMk cId="2301416017" sldId="285"/>
        </pc:sldMkLst>
      </pc:sldChg>
      <pc:sldChg chg="add ord">
        <pc:chgData name="Yang, Shengming - ARS" userId="37bd5b25-7571-49cb-bfc8-588a18706c35" providerId="ADAL" clId="{1CEC4EA3-DB05-44BE-AF57-7E2779412AED}" dt="2021-12-23T19:43:43.681" v="2101"/>
        <pc:sldMkLst>
          <pc:docMk/>
          <pc:sldMk cId="2028917921" sldId="286"/>
        </pc:sldMkLst>
      </pc:sldChg>
    </pc:docChg>
  </pc:docChgLst>
  <pc:docChgLst>
    <pc:chgData name="Yang, Shengming - ARS" userId="37bd5b25-7571-49cb-bfc8-588a18706c35" providerId="ADAL" clId="{CFBAF56D-42EE-45FC-B2D3-E2B27F95FCE9}"/>
    <pc:docChg chg="undo redo custSel addSld delSld modSld sldOrd">
      <pc:chgData name="Yang, Shengming - ARS" userId="37bd5b25-7571-49cb-bfc8-588a18706c35" providerId="ADAL" clId="{CFBAF56D-42EE-45FC-B2D3-E2B27F95FCE9}" dt="2022-04-07T20:53:22.620" v="772" actId="20577"/>
      <pc:docMkLst>
        <pc:docMk/>
      </pc:docMkLst>
      <pc:sldChg chg="addSp delSp modSp mod">
        <pc:chgData name="Yang, Shengming - ARS" userId="37bd5b25-7571-49cb-bfc8-588a18706c35" providerId="ADAL" clId="{CFBAF56D-42EE-45FC-B2D3-E2B27F95FCE9}" dt="2022-03-25T14:19:59.859" v="740" actId="2"/>
        <pc:sldMkLst>
          <pc:docMk/>
          <pc:sldMk cId="1525299809" sldId="275"/>
        </pc:sldMkLst>
        <pc:spChg chg="mod topLvl">
          <ac:chgData name="Yang, Shengming - ARS" userId="37bd5b25-7571-49cb-bfc8-588a18706c35" providerId="ADAL" clId="{CFBAF56D-42EE-45FC-B2D3-E2B27F95FCE9}" dt="2022-03-15T21:53:01.558" v="289" actId="2085"/>
          <ac:spMkLst>
            <pc:docMk/>
            <pc:sldMk cId="1525299809" sldId="275"/>
            <ac:spMk id="3" creationId="{E888CEB0-32B8-4D3E-AF97-26E24DBED6A2}"/>
          </ac:spMkLst>
        </pc:spChg>
        <pc:spChg chg="mod">
          <ac:chgData name="Yang, Shengming - ARS" userId="37bd5b25-7571-49cb-bfc8-588a18706c35" providerId="ADAL" clId="{CFBAF56D-42EE-45FC-B2D3-E2B27F95FCE9}" dt="2022-03-25T14:19:59.859" v="740" actId="2"/>
          <ac:spMkLst>
            <pc:docMk/>
            <pc:sldMk cId="1525299809" sldId="275"/>
            <ac:spMk id="7" creationId="{59EC5E2F-A06C-44C2-9BC7-5083B8DB0158}"/>
          </ac:spMkLst>
        </pc:spChg>
        <pc:spChg chg="mod">
          <ac:chgData name="Yang, Shengming - ARS" userId="37bd5b25-7571-49cb-bfc8-588a18706c35" providerId="ADAL" clId="{CFBAF56D-42EE-45FC-B2D3-E2B27F95FCE9}" dt="2022-03-16T13:42:54.155" v="726" actId="1036"/>
          <ac:spMkLst>
            <pc:docMk/>
            <pc:sldMk cId="1525299809" sldId="275"/>
            <ac:spMk id="12" creationId="{521E7359-7336-437C-8A90-B14583285988}"/>
          </ac:spMkLst>
        </pc:spChg>
        <pc:spChg chg="mod">
          <ac:chgData name="Yang, Shengming - ARS" userId="37bd5b25-7571-49cb-bfc8-588a18706c35" providerId="ADAL" clId="{CFBAF56D-42EE-45FC-B2D3-E2B27F95FCE9}" dt="2022-03-16T13:42:54.155" v="726" actId="1036"/>
          <ac:spMkLst>
            <pc:docMk/>
            <pc:sldMk cId="1525299809" sldId="275"/>
            <ac:spMk id="13" creationId="{50A0EE90-3932-4530-A2F6-B29B53FA3754}"/>
          </ac:spMkLst>
        </pc:spChg>
        <pc:spChg chg="add mod">
          <ac:chgData name="Yang, Shengming - ARS" userId="37bd5b25-7571-49cb-bfc8-588a18706c35" providerId="ADAL" clId="{CFBAF56D-42EE-45FC-B2D3-E2B27F95FCE9}" dt="2022-03-23T13:48:24.537" v="738" actId="20577"/>
          <ac:spMkLst>
            <pc:docMk/>
            <pc:sldMk cId="1525299809" sldId="275"/>
            <ac:spMk id="16" creationId="{BE33CB12-E43F-460B-B174-5121A51D68C8}"/>
          </ac:spMkLst>
        </pc:spChg>
        <pc:spChg chg="mod">
          <ac:chgData name="Yang, Shengming - ARS" userId="37bd5b25-7571-49cb-bfc8-588a18706c35" providerId="ADAL" clId="{CFBAF56D-42EE-45FC-B2D3-E2B27F95FCE9}" dt="2022-03-16T13:42:54.155" v="726" actId="1036"/>
          <ac:spMkLst>
            <pc:docMk/>
            <pc:sldMk cId="1525299809" sldId="275"/>
            <ac:spMk id="17" creationId="{EF72585C-D2AF-45D3-97AC-199E08312281}"/>
          </ac:spMkLst>
        </pc:spChg>
        <pc:spChg chg="mod">
          <ac:chgData name="Yang, Shengming - ARS" userId="37bd5b25-7571-49cb-bfc8-588a18706c35" providerId="ADAL" clId="{CFBAF56D-42EE-45FC-B2D3-E2B27F95FCE9}" dt="2022-03-16T13:42:54.155" v="726" actId="1036"/>
          <ac:spMkLst>
            <pc:docMk/>
            <pc:sldMk cId="1525299809" sldId="275"/>
            <ac:spMk id="23" creationId="{EE0E463B-8D9C-4CD8-A0EC-C0A58991BB7D}"/>
          </ac:spMkLst>
        </pc:spChg>
        <pc:spChg chg="mod">
          <ac:chgData name="Yang, Shengming - ARS" userId="37bd5b25-7571-49cb-bfc8-588a18706c35" providerId="ADAL" clId="{CFBAF56D-42EE-45FC-B2D3-E2B27F95FCE9}" dt="2022-03-21T17:14:07.323" v="732" actId="20577"/>
          <ac:spMkLst>
            <pc:docMk/>
            <pc:sldMk cId="1525299809" sldId="275"/>
            <ac:spMk id="25" creationId="{A876130B-ED92-4416-90CA-563FA5FCBC5F}"/>
          </ac:spMkLst>
        </pc:spChg>
        <pc:spChg chg="del">
          <ac:chgData name="Yang, Shengming - ARS" userId="37bd5b25-7571-49cb-bfc8-588a18706c35" providerId="ADAL" clId="{CFBAF56D-42EE-45FC-B2D3-E2B27F95FCE9}" dt="2022-03-15T21:53:09.132" v="291" actId="478"/>
          <ac:spMkLst>
            <pc:docMk/>
            <pc:sldMk cId="1525299809" sldId="275"/>
            <ac:spMk id="26" creationId="{B9CCD95B-3889-4379-A2D1-2FC056F98C66}"/>
          </ac:spMkLst>
        </pc:spChg>
        <pc:spChg chg="del">
          <ac:chgData name="Yang, Shengming - ARS" userId="37bd5b25-7571-49cb-bfc8-588a18706c35" providerId="ADAL" clId="{CFBAF56D-42EE-45FC-B2D3-E2B27F95FCE9}" dt="2022-03-15T21:53:09.132" v="291" actId="478"/>
          <ac:spMkLst>
            <pc:docMk/>
            <pc:sldMk cId="1525299809" sldId="275"/>
            <ac:spMk id="27" creationId="{A025DAFC-93D1-4F78-945F-66FA9798F458}"/>
          </ac:spMkLst>
        </pc:spChg>
        <pc:spChg chg="del">
          <ac:chgData name="Yang, Shengming - ARS" userId="37bd5b25-7571-49cb-bfc8-588a18706c35" providerId="ADAL" clId="{CFBAF56D-42EE-45FC-B2D3-E2B27F95FCE9}" dt="2022-03-15T21:53:09.132" v="291" actId="478"/>
          <ac:spMkLst>
            <pc:docMk/>
            <pc:sldMk cId="1525299809" sldId="275"/>
            <ac:spMk id="29" creationId="{715CB5B5-537D-4983-A660-F90C40946944}"/>
          </ac:spMkLst>
        </pc:spChg>
        <pc:spChg chg="del">
          <ac:chgData name="Yang, Shengming - ARS" userId="37bd5b25-7571-49cb-bfc8-588a18706c35" providerId="ADAL" clId="{CFBAF56D-42EE-45FC-B2D3-E2B27F95FCE9}" dt="2022-03-15T21:53:09.132" v="291" actId="478"/>
          <ac:spMkLst>
            <pc:docMk/>
            <pc:sldMk cId="1525299809" sldId="275"/>
            <ac:spMk id="30" creationId="{C224467D-B63C-431B-940C-424E4BB0DB94}"/>
          </ac:spMkLst>
        </pc:spChg>
        <pc:spChg chg="del">
          <ac:chgData name="Yang, Shengming - ARS" userId="37bd5b25-7571-49cb-bfc8-588a18706c35" providerId="ADAL" clId="{CFBAF56D-42EE-45FC-B2D3-E2B27F95FCE9}" dt="2022-03-15T21:53:06.315" v="290" actId="478"/>
          <ac:spMkLst>
            <pc:docMk/>
            <pc:sldMk cId="1525299809" sldId="275"/>
            <ac:spMk id="31" creationId="{94E1D290-E962-4DC5-9BCF-50A122D814DD}"/>
          </ac:spMkLst>
        </pc:spChg>
        <pc:spChg chg="del">
          <ac:chgData name="Yang, Shengming - ARS" userId="37bd5b25-7571-49cb-bfc8-588a18706c35" providerId="ADAL" clId="{CFBAF56D-42EE-45FC-B2D3-E2B27F95FCE9}" dt="2022-03-15T21:53:11.581" v="292" actId="478"/>
          <ac:spMkLst>
            <pc:docMk/>
            <pc:sldMk cId="1525299809" sldId="275"/>
            <ac:spMk id="32" creationId="{1B62C987-43F5-4DE2-8AF8-592FEF0B282D}"/>
          </ac:spMkLst>
        </pc:spChg>
        <pc:grpChg chg="del">
          <ac:chgData name="Yang, Shengming - ARS" userId="37bd5b25-7571-49cb-bfc8-588a18706c35" providerId="ADAL" clId="{CFBAF56D-42EE-45FC-B2D3-E2B27F95FCE9}" dt="2022-03-15T21:52:53.862" v="288" actId="165"/>
          <ac:grpSpMkLst>
            <pc:docMk/>
            <pc:sldMk cId="1525299809" sldId="275"/>
            <ac:grpSpMk id="10" creationId="{9EB0F5CE-09DF-447B-B0F0-E641528ECE92}"/>
          </ac:grpSpMkLst>
        </pc:grpChg>
        <pc:picChg chg="mod">
          <ac:chgData name="Yang, Shengming - ARS" userId="37bd5b25-7571-49cb-bfc8-588a18706c35" providerId="ADAL" clId="{CFBAF56D-42EE-45FC-B2D3-E2B27F95FCE9}" dt="2022-03-16T13:42:54.155" v="726" actId="1036"/>
          <ac:picMkLst>
            <pc:docMk/>
            <pc:sldMk cId="1525299809" sldId="275"/>
            <ac:picMk id="5" creationId="{47886F41-8483-490F-AFEC-C9F34925FEB4}"/>
          </ac:picMkLst>
        </pc:picChg>
        <pc:picChg chg="mod">
          <ac:chgData name="Yang, Shengming - ARS" userId="37bd5b25-7571-49cb-bfc8-588a18706c35" providerId="ADAL" clId="{CFBAF56D-42EE-45FC-B2D3-E2B27F95FCE9}" dt="2022-03-16T13:42:54.155" v="726" actId="1036"/>
          <ac:picMkLst>
            <pc:docMk/>
            <pc:sldMk cId="1525299809" sldId="275"/>
            <ac:picMk id="9" creationId="{8A5CA8A6-E525-4485-ADF9-36221A12B462}"/>
          </ac:picMkLst>
        </pc:picChg>
        <pc:picChg chg="add mod modCrop">
          <ac:chgData name="Yang, Shengming - ARS" userId="37bd5b25-7571-49cb-bfc8-588a18706c35" providerId="ADAL" clId="{CFBAF56D-42EE-45FC-B2D3-E2B27F95FCE9}" dt="2022-03-23T13:48:16.513" v="737" actId="732"/>
          <ac:picMkLst>
            <pc:docMk/>
            <pc:sldMk cId="1525299809" sldId="275"/>
            <ac:picMk id="14" creationId="{648E8385-883F-477A-8035-6D3EB79651B0}"/>
          </ac:picMkLst>
        </pc:picChg>
        <pc:picChg chg="mod">
          <ac:chgData name="Yang, Shengming - ARS" userId="37bd5b25-7571-49cb-bfc8-588a18706c35" providerId="ADAL" clId="{CFBAF56D-42EE-45FC-B2D3-E2B27F95FCE9}" dt="2022-03-16T13:42:54.155" v="726" actId="1036"/>
          <ac:picMkLst>
            <pc:docMk/>
            <pc:sldMk cId="1525299809" sldId="275"/>
            <ac:picMk id="15" creationId="{59E8A476-E459-49E7-BC90-C0244CB29CE8}"/>
          </ac:picMkLst>
        </pc:picChg>
        <pc:picChg chg="del">
          <ac:chgData name="Yang, Shengming - ARS" userId="37bd5b25-7571-49cb-bfc8-588a18706c35" providerId="ADAL" clId="{CFBAF56D-42EE-45FC-B2D3-E2B27F95FCE9}" dt="2022-03-15T21:53:09.132" v="291" actId="478"/>
          <ac:picMkLst>
            <pc:docMk/>
            <pc:sldMk cId="1525299809" sldId="275"/>
            <ac:picMk id="18" creationId="{DC957572-5F76-4953-A205-6FFE95C92F40}"/>
          </ac:picMkLst>
        </pc:picChg>
        <pc:picChg chg="mod">
          <ac:chgData name="Yang, Shengming - ARS" userId="37bd5b25-7571-49cb-bfc8-588a18706c35" providerId="ADAL" clId="{CFBAF56D-42EE-45FC-B2D3-E2B27F95FCE9}" dt="2022-03-16T13:42:54.155" v="726" actId="1036"/>
          <ac:picMkLst>
            <pc:docMk/>
            <pc:sldMk cId="1525299809" sldId="275"/>
            <ac:picMk id="19" creationId="{596237EC-86BA-4274-95FA-01770DA46B69}"/>
          </ac:picMkLst>
        </pc:picChg>
        <pc:picChg chg="mod">
          <ac:chgData name="Yang, Shengming - ARS" userId="37bd5b25-7571-49cb-bfc8-588a18706c35" providerId="ADAL" clId="{CFBAF56D-42EE-45FC-B2D3-E2B27F95FCE9}" dt="2022-03-16T13:42:54.155" v="726" actId="1036"/>
          <ac:picMkLst>
            <pc:docMk/>
            <pc:sldMk cId="1525299809" sldId="275"/>
            <ac:picMk id="21" creationId="{678FCA89-43B8-45BE-8851-22EE7A6E7A89}"/>
          </ac:picMkLst>
        </pc:picChg>
        <pc:picChg chg="del">
          <ac:chgData name="Yang, Shengming - ARS" userId="37bd5b25-7571-49cb-bfc8-588a18706c35" providerId="ADAL" clId="{CFBAF56D-42EE-45FC-B2D3-E2B27F95FCE9}" dt="2022-03-15T21:53:09.132" v="291" actId="478"/>
          <ac:picMkLst>
            <pc:docMk/>
            <pc:sldMk cId="1525299809" sldId="275"/>
            <ac:picMk id="28" creationId="{5B78FAF8-81AD-4BE8-8D4D-D67EB64B4388}"/>
          </ac:picMkLst>
        </pc:picChg>
        <pc:cxnChg chg="del mod topLvl">
          <ac:chgData name="Yang, Shengming - ARS" userId="37bd5b25-7571-49cb-bfc8-588a18706c35" providerId="ADAL" clId="{CFBAF56D-42EE-45FC-B2D3-E2B27F95FCE9}" dt="2022-03-15T21:53:09.132" v="291" actId="478"/>
          <ac:cxnSpMkLst>
            <pc:docMk/>
            <pc:sldMk cId="1525299809" sldId="275"/>
            <ac:cxnSpMk id="8" creationId="{D0FAFBD5-ACC8-4431-8A0C-DF282A6B392A}"/>
          </ac:cxnSpMkLst>
        </pc:cxnChg>
      </pc:sldChg>
      <pc:sldChg chg="del">
        <pc:chgData name="Yang, Shengming - ARS" userId="37bd5b25-7571-49cb-bfc8-588a18706c35" providerId="ADAL" clId="{CFBAF56D-42EE-45FC-B2D3-E2B27F95FCE9}" dt="2022-03-15T21:36:28.910" v="10" actId="47"/>
        <pc:sldMkLst>
          <pc:docMk/>
          <pc:sldMk cId="1327558011" sldId="276"/>
        </pc:sldMkLst>
      </pc:sldChg>
      <pc:sldChg chg="del">
        <pc:chgData name="Yang, Shengming - ARS" userId="37bd5b25-7571-49cb-bfc8-588a18706c35" providerId="ADAL" clId="{CFBAF56D-42EE-45FC-B2D3-E2B27F95FCE9}" dt="2022-03-15T21:36:11.492" v="1" actId="47"/>
        <pc:sldMkLst>
          <pc:docMk/>
          <pc:sldMk cId="2338164932" sldId="277"/>
        </pc:sldMkLst>
      </pc:sldChg>
      <pc:sldChg chg="addSp delSp modSp mod">
        <pc:chgData name="Yang, Shengming - ARS" userId="37bd5b25-7571-49cb-bfc8-588a18706c35" providerId="ADAL" clId="{CFBAF56D-42EE-45FC-B2D3-E2B27F95FCE9}" dt="2022-04-07T20:53:22.620" v="772" actId="20577"/>
        <pc:sldMkLst>
          <pc:docMk/>
          <pc:sldMk cId="887383785" sldId="278"/>
        </pc:sldMkLst>
        <pc:spChg chg="mod">
          <ac:chgData name="Yang, Shengming - ARS" userId="37bd5b25-7571-49cb-bfc8-588a18706c35" providerId="ADAL" clId="{CFBAF56D-42EE-45FC-B2D3-E2B27F95FCE9}" dt="2022-03-15T22:14:13.884" v="648" actId="1076"/>
          <ac:spMkLst>
            <pc:docMk/>
            <pc:sldMk cId="887383785" sldId="278"/>
            <ac:spMk id="5" creationId="{22CABD5C-E7F8-4D30-AF77-D1DF38BD1326}"/>
          </ac:spMkLst>
        </pc:spChg>
        <pc:graphicFrameChg chg="del">
          <ac:chgData name="Yang, Shengming - ARS" userId="37bd5b25-7571-49cb-bfc8-588a18706c35" providerId="ADAL" clId="{CFBAF56D-42EE-45FC-B2D3-E2B27F95FCE9}" dt="2022-03-15T22:13:03.403" v="606" actId="478"/>
          <ac:graphicFrameMkLst>
            <pc:docMk/>
            <pc:sldMk cId="887383785" sldId="278"/>
            <ac:graphicFrameMk id="4" creationId="{12240337-9653-4844-83C7-8964481C8519}"/>
          </ac:graphicFrameMkLst>
        </pc:graphicFrameChg>
        <pc:graphicFrameChg chg="mod modGraphic">
          <ac:chgData name="Yang, Shengming - ARS" userId="37bd5b25-7571-49cb-bfc8-588a18706c35" providerId="ADAL" clId="{CFBAF56D-42EE-45FC-B2D3-E2B27F95FCE9}" dt="2022-04-07T20:53:22.620" v="772" actId="20577"/>
          <ac:graphicFrameMkLst>
            <pc:docMk/>
            <pc:sldMk cId="887383785" sldId="278"/>
            <ac:graphicFrameMk id="4" creationId="{DBB4A3FC-3A9C-4B93-8C50-F59C3749F655}"/>
          </ac:graphicFrameMkLst>
        </pc:graphicFrameChg>
        <pc:graphicFrameChg chg="add mod">
          <ac:chgData name="Yang, Shengming - ARS" userId="37bd5b25-7571-49cb-bfc8-588a18706c35" providerId="ADAL" clId="{CFBAF56D-42EE-45FC-B2D3-E2B27F95FCE9}" dt="2022-03-15T22:14:21.376" v="649" actId="1076"/>
          <ac:graphicFrameMkLst>
            <pc:docMk/>
            <pc:sldMk cId="887383785" sldId="278"/>
            <ac:graphicFrameMk id="6" creationId="{53E596D7-AB3A-4633-8D47-4B095118AE5E}"/>
          </ac:graphicFrameMkLst>
        </pc:graphicFrameChg>
      </pc:sldChg>
      <pc:sldChg chg="addSp delSp modSp del mod">
        <pc:chgData name="Yang, Shengming - ARS" userId="37bd5b25-7571-49cb-bfc8-588a18706c35" providerId="ADAL" clId="{CFBAF56D-42EE-45FC-B2D3-E2B27F95FCE9}" dt="2022-03-21T17:14:03.759" v="731" actId="47"/>
        <pc:sldMkLst>
          <pc:docMk/>
          <pc:sldMk cId="3951076637" sldId="279"/>
        </pc:sldMkLst>
        <pc:spChg chg="add mod">
          <ac:chgData name="Yang, Shengming - ARS" userId="37bd5b25-7571-49cb-bfc8-588a18706c35" providerId="ADAL" clId="{CFBAF56D-42EE-45FC-B2D3-E2B27F95FCE9}" dt="2022-03-15T22:00:27.639" v="466" actId="164"/>
          <ac:spMkLst>
            <pc:docMk/>
            <pc:sldMk cId="3951076637" sldId="279"/>
            <ac:spMk id="15" creationId="{D3EADF99-D3F4-4360-853D-D06FCEDA03CE}"/>
          </ac:spMkLst>
        </pc:spChg>
        <pc:spChg chg="add mod">
          <ac:chgData name="Yang, Shengming - ARS" userId="37bd5b25-7571-49cb-bfc8-588a18706c35" providerId="ADAL" clId="{CFBAF56D-42EE-45FC-B2D3-E2B27F95FCE9}" dt="2022-03-15T22:00:27.639" v="466" actId="164"/>
          <ac:spMkLst>
            <pc:docMk/>
            <pc:sldMk cId="3951076637" sldId="279"/>
            <ac:spMk id="16" creationId="{352EC3DD-7CEF-4206-BF5A-966861912469}"/>
          </ac:spMkLst>
        </pc:spChg>
        <pc:spChg chg="add mod">
          <ac:chgData name="Yang, Shengming - ARS" userId="37bd5b25-7571-49cb-bfc8-588a18706c35" providerId="ADAL" clId="{CFBAF56D-42EE-45FC-B2D3-E2B27F95FCE9}" dt="2022-03-15T22:00:27.639" v="466" actId="164"/>
          <ac:spMkLst>
            <pc:docMk/>
            <pc:sldMk cId="3951076637" sldId="279"/>
            <ac:spMk id="17" creationId="{D51BFC4C-8A6D-40BF-A4FB-52A4DEE21EAD}"/>
          </ac:spMkLst>
        </pc:spChg>
        <pc:spChg chg="add mod">
          <ac:chgData name="Yang, Shengming - ARS" userId="37bd5b25-7571-49cb-bfc8-588a18706c35" providerId="ADAL" clId="{CFBAF56D-42EE-45FC-B2D3-E2B27F95FCE9}" dt="2022-03-15T22:00:27.639" v="466" actId="164"/>
          <ac:spMkLst>
            <pc:docMk/>
            <pc:sldMk cId="3951076637" sldId="279"/>
            <ac:spMk id="18" creationId="{FC57FAAF-3766-4C61-98FA-519B69B19936}"/>
          </ac:spMkLst>
        </pc:spChg>
        <pc:spChg chg="add mod">
          <ac:chgData name="Yang, Shengming - ARS" userId="37bd5b25-7571-49cb-bfc8-588a18706c35" providerId="ADAL" clId="{CFBAF56D-42EE-45FC-B2D3-E2B27F95FCE9}" dt="2022-03-15T22:00:27.639" v="466" actId="164"/>
          <ac:spMkLst>
            <pc:docMk/>
            <pc:sldMk cId="3951076637" sldId="279"/>
            <ac:spMk id="19" creationId="{12B2004B-F8E0-4949-8272-DD86AEF89358}"/>
          </ac:spMkLst>
        </pc:spChg>
        <pc:spChg chg="add mod">
          <ac:chgData name="Yang, Shengming - ARS" userId="37bd5b25-7571-49cb-bfc8-588a18706c35" providerId="ADAL" clId="{CFBAF56D-42EE-45FC-B2D3-E2B27F95FCE9}" dt="2022-03-15T22:00:27.639" v="466" actId="164"/>
          <ac:spMkLst>
            <pc:docMk/>
            <pc:sldMk cId="3951076637" sldId="279"/>
            <ac:spMk id="20" creationId="{6F788AA2-2D99-40F7-A468-41E369576A23}"/>
          </ac:spMkLst>
        </pc:spChg>
        <pc:spChg chg="add mod">
          <ac:chgData name="Yang, Shengming - ARS" userId="37bd5b25-7571-49cb-bfc8-588a18706c35" providerId="ADAL" clId="{CFBAF56D-42EE-45FC-B2D3-E2B27F95FCE9}" dt="2022-03-15T22:00:27.639" v="466" actId="164"/>
          <ac:spMkLst>
            <pc:docMk/>
            <pc:sldMk cId="3951076637" sldId="279"/>
            <ac:spMk id="21" creationId="{AE68A47A-820E-4487-8E02-493EC88C0053}"/>
          </ac:spMkLst>
        </pc:spChg>
        <pc:spChg chg="add mod">
          <ac:chgData name="Yang, Shengming - ARS" userId="37bd5b25-7571-49cb-bfc8-588a18706c35" providerId="ADAL" clId="{CFBAF56D-42EE-45FC-B2D3-E2B27F95FCE9}" dt="2022-03-15T22:00:27.639" v="466" actId="164"/>
          <ac:spMkLst>
            <pc:docMk/>
            <pc:sldMk cId="3951076637" sldId="279"/>
            <ac:spMk id="22" creationId="{622500C9-023B-43D2-998A-99B6477578F9}"/>
          </ac:spMkLst>
        </pc:spChg>
        <pc:spChg chg="mod">
          <ac:chgData name="Yang, Shengming - ARS" userId="37bd5b25-7571-49cb-bfc8-588a18706c35" providerId="ADAL" clId="{CFBAF56D-42EE-45FC-B2D3-E2B27F95FCE9}" dt="2022-03-15T21:42:09.480" v="138" actId="2085"/>
          <ac:spMkLst>
            <pc:docMk/>
            <pc:sldMk cId="3951076637" sldId="279"/>
            <ac:spMk id="31" creationId="{8C88D3CF-522A-4F82-9D1E-F2BA0C73E44A}"/>
          </ac:spMkLst>
        </pc:spChg>
        <pc:spChg chg="mod">
          <ac:chgData name="Yang, Shengming - ARS" userId="37bd5b25-7571-49cb-bfc8-588a18706c35" providerId="ADAL" clId="{CFBAF56D-42EE-45FC-B2D3-E2B27F95FCE9}" dt="2022-03-15T21:59:13.744" v="451" actId="1076"/>
          <ac:spMkLst>
            <pc:docMk/>
            <pc:sldMk cId="3951076637" sldId="279"/>
            <ac:spMk id="33" creationId="{A3CCCF6D-3F3C-4533-B4BB-23BC1ECC5268}"/>
          </ac:spMkLst>
        </pc:spChg>
        <pc:grpChg chg="add mod">
          <ac:chgData name="Yang, Shengming - ARS" userId="37bd5b25-7571-49cb-bfc8-588a18706c35" providerId="ADAL" clId="{CFBAF56D-42EE-45FC-B2D3-E2B27F95FCE9}" dt="2022-03-15T22:00:31.156" v="467" actId="1076"/>
          <ac:grpSpMkLst>
            <pc:docMk/>
            <pc:sldMk cId="3951076637" sldId="279"/>
            <ac:grpSpMk id="3" creationId="{AD6E6085-5043-41B1-A474-E37EB35B2950}"/>
          </ac:grpSpMkLst>
        </pc:grpChg>
        <pc:grpChg chg="mod">
          <ac:chgData name="Yang, Shengming - ARS" userId="37bd5b25-7571-49cb-bfc8-588a18706c35" providerId="ADAL" clId="{CFBAF56D-42EE-45FC-B2D3-E2B27F95FCE9}" dt="2022-03-15T22:00:27.639" v="466" actId="164"/>
          <ac:grpSpMkLst>
            <pc:docMk/>
            <pc:sldMk cId="3951076637" sldId="279"/>
            <ac:grpSpMk id="30" creationId="{50962A51-58E8-4470-B29C-EE836E9FB46F}"/>
          </ac:grpSpMkLst>
        </pc:grpChg>
        <pc:graphicFrameChg chg="del mod">
          <ac:chgData name="Yang, Shengming - ARS" userId="37bd5b25-7571-49cb-bfc8-588a18706c35" providerId="ADAL" clId="{CFBAF56D-42EE-45FC-B2D3-E2B27F95FCE9}" dt="2022-03-15T21:48:18.504" v="239" actId="478"/>
          <ac:graphicFrameMkLst>
            <pc:docMk/>
            <pc:sldMk cId="3951076637" sldId="279"/>
            <ac:graphicFrameMk id="36" creationId="{6F1D622B-363F-4DE5-B31A-0E65AA636F7D}"/>
          </ac:graphicFrameMkLst>
        </pc:graphicFrameChg>
      </pc:sldChg>
      <pc:sldChg chg="del">
        <pc:chgData name="Yang, Shengming - ARS" userId="37bd5b25-7571-49cb-bfc8-588a18706c35" providerId="ADAL" clId="{CFBAF56D-42EE-45FC-B2D3-E2B27F95FCE9}" dt="2022-03-15T21:36:23.487" v="6" actId="47"/>
        <pc:sldMkLst>
          <pc:docMk/>
          <pc:sldMk cId="2943728638" sldId="280"/>
        </pc:sldMkLst>
      </pc:sldChg>
      <pc:sldChg chg="del">
        <pc:chgData name="Yang, Shengming - ARS" userId="37bd5b25-7571-49cb-bfc8-588a18706c35" providerId="ADAL" clId="{CFBAF56D-42EE-45FC-B2D3-E2B27F95FCE9}" dt="2022-03-15T21:36:26.488" v="8" actId="47"/>
        <pc:sldMkLst>
          <pc:docMk/>
          <pc:sldMk cId="1705255663" sldId="282"/>
        </pc:sldMkLst>
      </pc:sldChg>
      <pc:sldChg chg="del">
        <pc:chgData name="Yang, Shengming - ARS" userId="37bd5b25-7571-49cb-bfc8-588a18706c35" providerId="ADAL" clId="{CFBAF56D-42EE-45FC-B2D3-E2B27F95FCE9}" dt="2022-03-15T21:36:30.309" v="11" actId="47"/>
        <pc:sldMkLst>
          <pc:docMk/>
          <pc:sldMk cId="3161562260" sldId="283"/>
        </pc:sldMkLst>
      </pc:sldChg>
      <pc:sldChg chg="add del">
        <pc:chgData name="Yang, Shengming - ARS" userId="37bd5b25-7571-49cb-bfc8-588a18706c35" providerId="ADAL" clId="{CFBAF56D-42EE-45FC-B2D3-E2B27F95FCE9}" dt="2022-03-15T21:50:57.476" v="251" actId="47"/>
        <pc:sldMkLst>
          <pc:docMk/>
          <pc:sldMk cId="2625937353" sldId="284"/>
        </pc:sldMkLst>
      </pc:sldChg>
      <pc:sldChg chg="del">
        <pc:chgData name="Yang, Shengming - ARS" userId="37bd5b25-7571-49cb-bfc8-588a18706c35" providerId="ADAL" clId="{CFBAF56D-42EE-45FC-B2D3-E2B27F95FCE9}" dt="2022-03-15T21:36:27.993" v="9" actId="47"/>
        <pc:sldMkLst>
          <pc:docMk/>
          <pc:sldMk cId="2301416017" sldId="285"/>
        </pc:sldMkLst>
      </pc:sldChg>
      <pc:sldChg chg="del">
        <pc:chgData name="Yang, Shengming - ARS" userId="37bd5b25-7571-49cb-bfc8-588a18706c35" providerId="ADAL" clId="{CFBAF56D-42EE-45FC-B2D3-E2B27F95FCE9}" dt="2022-03-15T21:36:32.540" v="13" actId="47"/>
        <pc:sldMkLst>
          <pc:docMk/>
          <pc:sldMk cId="2028917921" sldId="286"/>
        </pc:sldMkLst>
      </pc:sldChg>
      <pc:sldChg chg="del">
        <pc:chgData name="Yang, Shengming - ARS" userId="37bd5b25-7571-49cb-bfc8-588a18706c35" providerId="ADAL" clId="{CFBAF56D-42EE-45FC-B2D3-E2B27F95FCE9}" dt="2022-03-15T21:36:10.239" v="0" actId="47"/>
        <pc:sldMkLst>
          <pc:docMk/>
          <pc:sldMk cId="1658013936" sldId="287"/>
        </pc:sldMkLst>
      </pc:sldChg>
      <pc:sldChg chg="del">
        <pc:chgData name="Yang, Shengming - ARS" userId="37bd5b25-7571-49cb-bfc8-588a18706c35" providerId="ADAL" clId="{CFBAF56D-42EE-45FC-B2D3-E2B27F95FCE9}" dt="2022-03-15T21:36:21.848" v="5" actId="47"/>
        <pc:sldMkLst>
          <pc:docMk/>
          <pc:sldMk cId="4208113970" sldId="288"/>
        </pc:sldMkLst>
      </pc:sldChg>
      <pc:sldChg chg="del">
        <pc:chgData name="Yang, Shengming - ARS" userId="37bd5b25-7571-49cb-bfc8-588a18706c35" providerId="ADAL" clId="{CFBAF56D-42EE-45FC-B2D3-E2B27F95FCE9}" dt="2022-03-15T21:36:31.222" v="12" actId="47"/>
        <pc:sldMkLst>
          <pc:docMk/>
          <pc:sldMk cId="3220999384" sldId="289"/>
        </pc:sldMkLst>
      </pc:sldChg>
      <pc:sldChg chg="addSp modSp mod ord">
        <pc:chgData name="Yang, Shengming - ARS" userId="37bd5b25-7571-49cb-bfc8-588a18706c35" providerId="ADAL" clId="{CFBAF56D-42EE-45FC-B2D3-E2B27F95FCE9}" dt="2022-03-15T22:00:08.082" v="465" actId="14100"/>
        <pc:sldMkLst>
          <pc:docMk/>
          <pc:sldMk cId="2200906561" sldId="290"/>
        </pc:sldMkLst>
        <pc:spChg chg="add mod">
          <ac:chgData name="Yang, Shengming - ARS" userId="37bd5b25-7571-49cb-bfc8-588a18706c35" providerId="ADAL" clId="{CFBAF56D-42EE-45FC-B2D3-E2B27F95FCE9}" dt="2022-03-15T22:00:08.082" v="465" actId="14100"/>
          <ac:spMkLst>
            <pc:docMk/>
            <pc:sldMk cId="2200906561" sldId="290"/>
            <ac:spMk id="31" creationId="{EDC0EEEA-8676-4C02-819C-7BEE3980EFF6}"/>
          </ac:spMkLst>
        </pc:spChg>
        <pc:spChg chg="add mod">
          <ac:chgData name="Yang, Shengming - ARS" userId="37bd5b25-7571-49cb-bfc8-588a18706c35" providerId="ADAL" clId="{CFBAF56D-42EE-45FC-B2D3-E2B27F95FCE9}" dt="2022-03-15T22:00:02.692" v="464" actId="403"/>
          <ac:spMkLst>
            <pc:docMk/>
            <pc:sldMk cId="2200906561" sldId="290"/>
            <ac:spMk id="56" creationId="{AC55C9CE-FB5E-4553-BB50-F9A580E554ED}"/>
          </ac:spMkLst>
        </pc:spChg>
        <pc:spChg chg="mod">
          <ac:chgData name="Yang, Shengming - ARS" userId="37bd5b25-7571-49cb-bfc8-588a18706c35" providerId="ADAL" clId="{CFBAF56D-42EE-45FC-B2D3-E2B27F95FCE9}" dt="2022-03-15T21:52:23.342" v="286" actId="113"/>
          <ac:spMkLst>
            <pc:docMk/>
            <pc:sldMk cId="2200906561" sldId="290"/>
            <ac:spMk id="58" creationId="{127FACC4-AEA3-45C6-A512-B76CA41EF55B}"/>
          </ac:spMkLst>
        </pc:spChg>
      </pc:sldChg>
      <pc:sldChg chg="modSp add mod">
        <pc:chgData name="Yang, Shengming - ARS" userId="37bd5b25-7571-49cb-bfc8-588a18706c35" providerId="ADAL" clId="{CFBAF56D-42EE-45FC-B2D3-E2B27F95FCE9}" dt="2022-03-15T21:40:00.422" v="16" actId="20577"/>
        <pc:sldMkLst>
          <pc:docMk/>
          <pc:sldMk cId="530921904" sldId="291"/>
        </pc:sldMkLst>
        <pc:spChg chg="mod">
          <ac:chgData name="Yang, Shengming - ARS" userId="37bd5b25-7571-49cb-bfc8-588a18706c35" providerId="ADAL" clId="{CFBAF56D-42EE-45FC-B2D3-E2B27F95FCE9}" dt="2022-03-15T21:40:00.422" v="16" actId="20577"/>
          <ac:spMkLst>
            <pc:docMk/>
            <pc:sldMk cId="530921904" sldId="291"/>
            <ac:spMk id="5" creationId="{22CABD5C-E7F8-4D30-AF77-D1DF38BD1326}"/>
          </ac:spMkLst>
        </pc:spChg>
      </pc:sldChg>
      <pc:sldChg chg="del">
        <pc:chgData name="Yang, Shengming - ARS" userId="37bd5b25-7571-49cb-bfc8-588a18706c35" providerId="ADAL" clId="{CFBAF56D-42EE-45FC-B2D3-E2B27F95FCE9}" dt="2022-03-15T21:36:24.368" v="7" actId="47"/>
        <pc:sldMkLst>
          <pc:docMk/>
          <pc:sldMk cId="2612662908" sldId="291"/>
        </pc:sldMkLst>
      </pc:sldChg>
      <pc:sldChg chg="modSp add mod">
        <pc:chgData name="Yang, Shengming - ARS" userId="37bd5b25-7571-49cb-bfc8-588a18706c35" providerId="ADAL" clId="{CFBAF56D-42EE-45FC-B2D3-E2B27F95FCE9}" dt="2022-03-15T21:54:49.161" v="340" actId="1076"/>
        <pc:sldMkLst>
          <pc:docMk/>
          <pc:sldMk cId="2282065266" sldId="292"/>
        </pc:sldMkLst>
        <pc:spChg chg="mod">
          <ac:chgData name="Yang, Shengming - ARS" userId="37bd5b25-7571-49cb-bfc8-588a18706c35" providerId="ADAL" clId="{CFBAF56D-42EE-45FC-B2D3-E2B27F95FCE9}" dt="2022-03-15T21:54:49.161" v="340" actId="1076"/>
          <ac:spMkLst>
            <pc:docMk/>
            <pc:sldMk cId="2282065266" sldId="292"/>
            <ac:spMk id="5" creationId="{22CABD5C-E7F8-4D30-AF77-D1DF38BD1326}"/>
          </ac:spMkLst>
        </pc:spChg>
      </pc:sldChg>
      <pc:sldChg chg="del">
        <pc:chgData name="Yang, Shengming - ARS" userId="37bd5b25-7571-49cb-bfc8-588a18706c35" providerId="ADAL" clId="{CFBAF56D-42EE-45FC-B2D3-E2B27F95FCE9}" dt="2022-03-15T21:36:20.897" v="4" actId="47"/>
        <pc:sldMkLst>
          <pc:docMk/>
          <pc:sldMk cId="3303732898" sldId="292"/>
        </pc:sldMkLst>
      </pc:sldChg>
    </pc:docChg>
  </pc:docChgLst>
  <pc:docChgLst>
    <pc:chgData name="Yang, Shengming - ARS" userId="37bd5b25-7571-49cb-bfc8-588a18706c35" providerId="ADAL" clId="{8181BEEC-D432-47B7-AEC6-1B03061D2BAA}"/>
    <pc:docChg chg="custSel addSld modSld">
      <pc:chgData name="Yang, Shengming - ARS" userId="37bd5b25-7571-49cb-bfc8-588a18706c35" providerId="ADAL" clId="{8181BEEC-D432-47B7-AEC6-1B03061D2BAA}" dt="2021-11-10T21:34:38.553" v="7" actId="1076"/>
      <pc:docMkLst>
        <pc:docMk/>
      </pc:docMkLst>
      <pc:sldChg chg="addSp delSp modSp new mod">
        <pc:chgData name="Yang, Shengming - ARS" userId="37bd5b25-7571-49cb-bfc8-588a18706c35" providerId="ADAL" clId="{8181BEEC-D432-47B7-AEC6-1B03061D2BAA}" dt="2021-11-10T21:34:38.553" v="7" actId="1076"/>
        <pc:sldMkLst>
          <pc:docMk/>
          <pc:sldMk cId="187198215" sldId="256"/>
        </pc:sldMkLst>
        <pc:spChg chg="del">
          <ac:chgData name="Yang, Shengming - ARS" userId="37bd5b25-7571-49cb-bfc8-588a18706c35" providerId="ADAL" clId="{8181BEEC-D432-47B7-AEC6-1B03061D2BAA}" dt="2021-11-10T21:34:14.537" v="1" actId="478"/>
          <ac:spMkLst>
            <pc:docMk/>
            <pc:sldMk cId="187198215" sldId="256"/>
            <ac:spMk id="2" creationId="{174C92CA-D17C-4B68-8E47-43F55709FDB0}"/>
          </ac:spMkLst>
        </pc:spChg>
        <pc:spChg chg="del">
          <ac:chgData name="Yang, Shengming - ARS" userId="37bd5b25-7571-49cb-bfc8-588a18706c35" providerId="ADAL" clId="{8181BEEC-D432-47B7-AEC6-1B03061D2BAA}" dt="2021-11-10T21:34:14.537" v="1" actId="478"/>
          <ac:spMkLst>
            <pc:docMk/>
            <pc:sldMk cId="187198215" sldId="256"/>
            <ac:spMk id="3" creationId="{99198A80-0D7E-4A14-B7CD-CC59C9537C7F}"/>
          </ac:spMkLst>
        </pc:spChg>
        <pc:spChg chg="mod">
          <ac:chgData name="Yang, Shengming - ARS" userId="37bd5b25-7571-49cb-bfc8-588a18706c35" providerId="ADAL" clId="{8181BEEC-D432-47B7-AEC6-1B03061D2BAA}" dt="2021-11-10T21:34:34.407" v="5" actId="255"/>
          <ac:spMkLst>
            <pc:docMk/>
            <pc:sldMk cId="187198215" sldId="256"/>
            <ac:spMk id="8" creationId="{7A85EE01-37A5-48DD-82B2-CC61EFCB05A6}"/>
          </ac:spMkLst>
        </pc:spChg>
        <pc:spChg chg="mod">
          <ac:chgData name="Yang, Shengming - ARS" userId="37bd5b25-7571-49cb-bfc8-588a18706c35" providerId="ADAL" clId="{8181BEEC-D432-47B7-AEC6-1B03061D2BAA}" dt="2021-11-10T21:34:34.407" v="5" actId="255"/>
          <ac:spMkLst>
            <pc:docMk/>
            <pc:sldMk cId="187198215" sldId="256"/>
            <ac:spMk id="24" creationId="{8E1BB1BC-4655-4667-9A9A-9388A8CD0B6A}"/>
          </ac:spMkLst>
        </pc:spChg>
        <pc:spChg chg="mod">
          <ac:chgData name="Yang, Shengming - ARS" userId="37bd5b25-7571-49cb-bfc8-588a18706c35" providerId="ADAL" clId="{8181BEEC-D432-47B7-AEC6-1B03061D2BAA}" dt="2021-11-10T21:34:34.407" v="5" actId="255"/>
          <ac:spMkLst>
            <pc:docMk/>
            <pc:sldMk cId="187198215" sldId="256"/>
            <ac:spMk id="25" creationId="{9245E1A8-7BA6-44DB-9AB5-CC7429F5BAB9}"/>
          </ac:spMkLst>
        </pc:spChg>
        <pc:spChg chg="mod">
          <ac:chgData name="Yang, Shengming - ARS" userId="37bd5b25-7571-49cb-bfc8-588a18706c35" providerId="ADAL" clId="{8181BEEC-D432-47B7-AEC6-1B03061D2BAA}" dt="2021-11-10T21:34:34.407" v="5" actId="255"/>
          <ac:spMkLst>
            <pc:docMk/>
            <pc:sldMk cId="187198215" sldId="256"/>
            <ac:spMk id="26" creationId="{14ACD6D4-6C84-4831-98FA-1D0760256699}"/>
          </ac:spMkLst>
        </pc:spChg>
        <pc:spChg chg="mod">
          <ac:chgData name="Yang, Shengming - ARS" userId="37bd5b25-7571-49cb-bfc8-588a18706c35" providerId="ADAL" clId="{8181BEEC-D432-47B7-AEC6-1B03061D2BAA}" dt="2021-11-10T21:34:34.407" v="5" actId="255"/>
          <ac:spMkLst>
            <pc:docMk/>
            <pc:sldMk cId="187198215" sldId="256"/>
            <ac:spMk id="27" creationId="{4F8D18C1-A3FB-49E5-9800-8A0CDAAC9A06}"/>
          </ac:spMkLst>
        </pc:spChg>
        <pc:spChg chg="mod">
          <ac:chgData name="Yang, Shengming - ARS" userId="37bd5b25-7571-49cb-bfc8-588a18706c35" providerId="ADAL" clId="{8181BEEC-D432-47B7-AEC6-1B03061D2BAA}" dt="2021-11-10T21:34:34.407" v="5" actId="255"/>
          <ac:spMkLst>
            <pc:docMk/>
            <pc:sldMk cId="187198215" sldId="256"/>
            <ac:spMk id="28" creationId="{55FC71C1-3FE7-4850-AC87-2D5CC70E4B67}"/>
          </ac:spMkLst>
        </pc:spChg>
        <pc:spChg chg="mod">
          <ac:chgData name="Yang, Shengming - ARS" userId="37bd5b25-7571-49cb-bfc8-588a18706c35" providerId="ADAL" clId="{8181BEEC-D432-47B7-AEC6-1B03061D2BAA}" dt="2021-11-10T21:34:34.407" v="5" actId="255"/>
          <ac:spMkLst>
            <pc:docMk/>
            <pc:sldMk cId="187198215" sldId="256"/>
            <ac:spMk id="29" creationId="{C72ED974-59CB-4AC2-A042-C083C26196DF}"/>
          </ac:spMkLst>
        </pc:spChg>
        <pc:spChg chg="mod">
          <ac:chgData name="Yang, Shengming - ARS" userId="37bd5b25-7571-49cb-bfc8-588a18706c35" providerId="ADAL" clId="{8181BEEC-D432-47B7-AEC6-1B03061D2BAA}" dt="2021-11-10T21:34:34.407" v="5" actId="255"/>
          <ac:spMkLst>
            <pc:docMk/>
            <pc:sldMk cId="187198215" sldId="256"/>
            <ac:spMk id="30" creationId="{3588F8F0-AE71-4D43-A1BE-9835CB267077}"/>
          </ac:spMkLst>
        </pc:spChg>
        <pc:spChg chg="mod">
          <ac:chgData name="Yang, Shengming - ARS" userId="37bd5b25-7571-49cb-bfc8-588a18706c35" providerId="ADAL" clId="{8181BEEC-D432-47B7-AEC6-1B03061D2BAA}" dt="2021-11-10T21:34:34.407" v="5" actId="255"/>
          <ac:spMkLst>
            <pc:docMk/>
            <pc:sldMk cId="187198215" sldId="256"/>
            <ac:spMk id="31" creationId="{F216FF89-0AA4-4565-88C4-DA0A12A877DC}"/>
          </ac:spMkLst>
        </pc:spChg>
        <pc:grpChg chg="add mod">
          <ac:chgData name="Yang, Shengming - ARS" userId="37bd5b25-7571-49cb-bfc8-588a18706c35" providerId="ADAL" clId="{8181BEEC-D432-47B7-AEC6-1B03061D2BAA}" dt="2021-11-10T21:34:38.553" v="7" actId="1076"/>
          <ac:grpSpMkLst>
            <pc:docMk/>
            <pc:sldMk cId="187198215" sldId="256"/>
            <ac:grpSpMk id="4" creationId="{4713D267-1D1C-445B-9270-5911825C9C0B}"/>
          </ac:grpSpMkLst>
        </pc:grpChg>
        <pc:grpChg chg="mod">
          <ac:chgData name="Yang, Shengming - ARS" userId="37bd5b25-7571-49cb-bfc8-588a18706c35" providerId="ADAL" clId="{8181BEEC-D432-47B7-AEC6-1B03061D2BAA}" dt="2021-11-10T21:34:16.857" v="2"/>
          <ac:grpSpMkLst>
            <pc:docMk/>
            <pc:sldMk cId="187198215" sldId="256"/>
            <ac:grpSpMk id="5" creationId="{F740D394-183F-4D4D-AA43-7211E88DC47D}"/>
          </ac:grpSpMkLst>
        </pc:grpChg>
        <pc:grpChg chg="mod">
          <ac:chgData name="Yang, Shengming - ARS" userId="37bd5b25-7571-49cb-bfc8-588a18706c35" providerId="ADAL" clId="{8181BEEC-D432-47B7-AEC6-1B03061D2BAA}" dt="2021-11-10T21:34:16.857" v="2"/>
          <ac:grpSpMkLst>
            <pc:docMk/>
            <pc:sldMk cId="187198215" sldId="256"/>
            <ac:grpSpMk id="6" creationId="{300C27BE-E024-44B7-B7B1-E5B56F1A2728}"/>
          </ac:grpSpMkLst>
        </pc:grpChg>
        <pc:grpChg chg="mod">
          <ac:chgData name="Yang, Shengming - ARS" userId="37bd5b25-7571-49cb-bfc8-588a18706c35" providerId="ADAL" clId="{8181BEEC-D432-47B7-AEC6-1B03061D2BAA}" dt="2021-11-10T21:34:16.857" v="2"/>
          <ac:grpSpMkLst>
            <pc:docMk/>
            <pc:sldMk cId="187198215" sldId="256"/>
            <ac:grpSpMk id="7" creationId="{027E727B-2E96-4A7D-B302-E1E15EE0C686}"/>
          </ac:grpSpMkLst>
        </pc:grpChg>
        <pc:cxnChg chg="mod">
          <ac:chgData name="Yang, Shengming - ARS" userId="37bd5b25-7571-49cb-bfc8-588a18706c35" providerId="ADAL" clId="{8181BEEC-D432-47B7-AEC6-1B03061D2BAA}" dt="2021-11-10T21:34:16.857" v="2"/>
          <ac:cxnSpMkLst>
            <pc:docMk/>
            <pc:sldMk cId="187198215" sldId="256"/>
            <ac:cxnSpMk id="9" creationId="{6B11905C-7860-49DB-83C0-E8C0A4A15334}"/>
          </ac:cxnSpMkLst>
        </pc:cxnChg>
        <pc:cxnChg chg="mod">
          <ac:chgData name="Yang, Shengming - ARS" userId="37bd5b25-7571-49cb-bfc8-588a18706c35" providerId="ADAL" clId="{8181BEEC-D432-47B7-AEC6-1B03061D2BAA}" dt="2021-11-10T21:34:16.857" v="2"/>
          <ac:cxnSpMkLst>
            <pc:docMk/>
            <pc:sldMk cId="187198215" sldId="256"/>
            <ac:cxnSpMk id="10" creationId="{0C107A29-8CB4-46AF-B036-5F67B9237BA9}"/>
          </ac:cxnSpMkLst>
        </pc:cxnChg>
        <pc:cxnChg chg="mod">
          <ac:chgData name="Yang, Shengming - ARS" userId="37bd5b25-7571-49cb-bfc8-588a18706c35" providerId="ADAL" clId="{8181BEEC-D432-47B7-AEC6-1B03061D2BAA}" dt="2021-11-10T21:34:16.857" v="2"/>
          <ac:cxnSpMkLst>
            <pc:docMk/>
            <pc:sldMk cId="187198215" sldId="256"/>
            <ac:cxnSpMk id="11" creationId="{FE47F660-E864-4926-86A4-2F616104C257}"/>
          </ac:cxnSpMkLst>
        </pc:cxnChg>
        <pc:cxnChg chg="mod">
          <ac:chgData name="Yang, Shengming - ARS" userId="37bd5b25-7571-49cb-bfc8-588a18706c35" providerId="ADAL" clId="{8181BEEC-D432-47B7-AEC6-1B03061D2BAA}" dt="2021-11-10T21:34:16.857" v="2"/>
          <ac:cxnSpMkLst>
            <pc:docMk/>
            <pc:sldMk cId="187198215" sldId="256"/>
            <ac:cxnSpMk id="12" creationId="{B5026062-0D1F-4D3F-BDD8-307A2A8AC7D0}"/>
          </ac:cxnSpMkLst>
        </pc:cxnChg>
        <pc:cxnChg chg="mod">
          <ac:chgData name="Yang, Shengming - ARS" userId="37bd5b25-7571-49cb-bfc8-588a18706c35" providerId="ADAL" clId="{8181BEEC-D432-47B7-AEC6-1B03061D2BAA}" dt="2021-11-10T21:34:16.857" v="2"/>
          <ac:cxnSpMkLst>
            <pc:docMk/>
            <pc:sldMk cId="187198215" sldId="256"/>
            <ac:cxnSpMk id="13" creationId="{0ABC98F5-E4B4-42A9-8A4D-75C0DF8065D5}"/>
          </ac:cxnSpMkLst>
        </pc:cxnChg>
        <pc:cxnChg chg="mod">
          <ac:chgData name="Yang, Shengming - ARS" userId="37bd5b25-7571-49cb-bfc8-588a18706c35" providerId="ADAL" clId="{8181BEEC-D432-47B7-AEC6-1B03061D2BAA}" dt="2021-11-10T21:34:16.857" v="2"/>
          <ac:cxnSpMkLst>
            <pc:docMk/>
            <pc:sldMk cId="187198215" sldId="256"/>
            <ac:cxnSpMk id="14" creationId="{817A2E5B-A163-48E2-8F8F-C01CDE89880D}"/>
          </ac:cxnSpMkLst>
        </pc:cxnChg>
        <pc:cxnChg chg="mod">
          <ac:chgData name="Yang, Shengming - ARS" userId="37bd5b25-7571-49cb-bfc8-588a18706c35" providerId="ADAL" clId="{8181BEEC-D432-47B7-AEC6-1B03061D2BAA}" dt="2021-11-10T21:34:16.857" v="2"/>
          <ac:cxnSpMkLst>
            <pc:docMk/>
            <pc:sldMk cId="187198215" sldId="256"/>
            <ac:cxnSpMk id="15" creationId="{EB9E6CC9-A9C2-4546-845B-C3E705049554}"/>
          </ac:cxnSpMkLst>
        </pc:cxnChg>
        <pc:cxnChg chg="mod">
          <ac:chgData name="Yang, Shengming - ARS" userId="37bd5b25-7571-49cb-bfc8-588a18706c35" providerId="ADAL" clId="{8181BEEC-D432-47B7-AEC6-1B03061D2BAA}" dt="2021-11-10T21:34:16.857" v="2"/>
          <ac:cxnSpMkLst>
            <pc:docMk/>
            <pc:sldMk cId="187198215" sldId="256"/>
            <ac:cxnSpMk id="16" creationId="{C681FB39-0F8F-4BEB-B08F-18348E347E74}"/>
          </ac:cxnSpMkLst>
        </pc:cxnChg>
        <pc:cxnChg chg="mod">
          <ac:chgData name="Yang, Shengming - ARS" userId="37bd5b25-7571-49cb-bfc8-588a18706c35" providerId="ADAL" clId="{8181BEEC-D432-47B7-AEC6-1B03061D2BAA}" dt="2021-11-10T21:34:16.857" v="2"/>
          <ac:cxnSpMkLst>
            <pc:docMk/>
            <pc:sldMk cId="187198215" sldId="256"/>
            <ac:cxnSpMk id="17" creationId="{BF74E94F-9465-49FC-8A6F-F44500C94FDD}"/>
          </ac:cxnSpMkLst>
        </pc:cxnChg>
        <pc:cxnChg chg="mod">
          <ac:chgData name="Yang, Shengming - ARS" userId="37bd5b25-7571-49cb-bfc8-588a18706c35" providerId="ADAL" clId="{8181BEEC-D432-47B7-AEC6-1B03061D2BAA}" dt="2021-11-10T21:34:16.857" v="2"/>
          <ac:cxnSpMkLst>
            <pc:docMk/>
            <pc:sldMk cId="187198215" sldId="256"/>
            <ac:cxnSpMk id="18" creationId="{BFF432DA-5E76-4E26-993C-DA37D1DD5254}"/>
          </ac:cxnSpMkLst>
        </pc:cxnChg>
        <pc:cxnChg chg="mod">
          <ac:chgData name="Yang, Shengming - ARS" userId="37bd5b25-7571-49cb-bfc8-588a18706c35" providerId="ADAL" clId="{8181BEEC-D432-47B7-AEC6-1B03061D2BAA}" dt="2021-11-10T21:34:16.857" v="2"/>
          <ac:cxnSpMkLst>
            <pc:docMk/>
            <pc:sldMk cId="187198215" sldId="256"/>
            <ac:cxnSpMk id="19" creationId="{BF6A49B2-E203-4E5B-B9CF-2CE2B4643E6B}"/>
          </ac:cxnSpMkLst>
        </pc:cxnChg>
        <pc:cxnChg chg="mod">
          <ac:chgData name="Yang, Shengming - ARS" userId="37bd5b25-7571-49cb-bfc8-588a18706c35" providerId="ADAL" clId="{8181BEEC-D432-47B7-AEC6-1B03061D2BAA}" dt="2021-11-10T21:34:16.857" v="2"/>
          <ac:cxnSpMkLst>
            <pc:docMk/>
            <pc:sldMk cId="187198215" sldId="256"/>
            <ac:cxnSpMk id="20" creationId="{B7B5B9D5-40CB-427A-AF7A-E528C995C57A}"/>
          </ac:cxnSpMkLst>
        </pc:cxnChg>
        <pc:cxnChg chg="mod">
          <ac:chgData name="Yang, Shengming - ARS" userId="37bd5b25-7571-49cb-bfc8-588a18706c35" providerId="ADAL" clId="{8181BEEC-D432-47B7-AEC6-1B03061D2BAA}" dt="2021-11-10T21:34:16.857" v="2"/>
          <ac:cxnSpMkLst>
            <pc:docMk/>
            <pc:sldMk cId="187198215" sldId="256"/>
            <ac:cxnSpMk id="21" creationId="{B3BBBD8E-0989-478C-B309-A80799A33A67}"/>
          </ac:cxnSpMkLst>
        </pc:cxnChg>
        <pc:cxnChg chg="mod">
          <ac:chgData name="Yang, Shengming - ARS" userId="37bd5b25-7571-49cb-bfc8-588a18706c35" providerId="ADAL" clId="{8181BEEC-D432-47B7-AEC6-1B03061D2BAA}" dt="2021-11-10T21:34:16.857" v="2"/>
          <ac:cxnSpMkLst>
            <pc:docMk/>
            <pc:sldMk cId="187198215" sldId="256"/>
            <ac:cxnSpMk id="22" creationId="{937692F3-19F4-4E0F-8FCE-C1AA41913086}"/>
          </ac:cxnSpMkLst>
        </pc:cxnChg>
        <pc:cxnChg chg="mod">
          <ac:chgData name="Yang, Shengming - ARS" userId="37bd5b25-7571-49cb-bfc8-588a18706c35" providerId="ADAL" clId="{8181BEEC-D432-47B7-AEC6-1B03061D2BAA}" dt="2021-11-10T21:34:16.857" v="2"/>
          <ac:cxnSpMkLst>
            <pc:docMk/>
            <pc:sldMk cId="187198215" sldId="256"/>
            <ac:cxnSpMk id="23" creationId="{1D4DE95D-5E32-439B-AF44-9C6A8818970C}"/>
          </ac:cxnSpMkLst>
        </pc:cxnChg>
      </pc:sldChg>
    </pc:docChg>
  </pc:docChgLst>
  <pc:docChgLst>
    <pc:chgData name="Yang, Shengming - ARS" userId="37bd5b25-7571-49cb-bfc8-588a18706c35" providerId="ADAL" clId="{7637BB5A-ED5B-4387-B28B-FAFFBA30BBF6}"/>
    <pc:docChg chg="custSel modSld">
      <pc:chgData name="Yang, Shengming - ARS" userId="37bd5b25-7571-49cb-bfc8-588a18706c35" providerId="ADAL" clId="{7637BB5A-ED5B-4387-B28B-FAFFBA30BBF6}" dt="2022-03-16T19:42:28.263" v="22"/>
      <pc:docMkLst>
        <pc:docMk/>
      </pc:docMkLst>
      <pc:sldChg chg="addSp delSp modSp mod">
        <pc:chgData name="Yang, Shengming - ARS" userId="37bd5b25-7571-49cb-bfc8-588a18706c35" providerId="ADAL" clId="{7637BB5A-ED5B-4387-B28B-FAFFBA30BBF6}" dt="2022-03-16T19:41:33.677" v="21"/>
        <pc:sldMkLst>
          <pc:docMk/>
          <pc:sldMk cId="887383785" sldId="278"/>
        </pc:sldMkLst>
        <pc:graphicFrameChg chg="add mod">
          <ac:chgData name="Yang, Shengming - ARS" userId="37bd5b25-7571-49cb-bfc8-588a18706c35" providerId="ADAL" clId="{7637BB5A-ED5B-4387-B28B-FAFFBA30BBF6}" dt="2022-03-16T19:41:33.677" v="21"/>
          <ac:graphicFrameMkLst>
            <pc:docMk/>
            <pc:sldMk cId="887383785" sldId="278"/>
            <ac:graphicFrameMk id="4" creationId="{DBB4A3FC-3A9C-4B93-8C50-F59C3749F655}"/>
          </ac:graphicFrameMkLst>
        </pc:graphicFrameChg>
        <pc:graphicFrameChg chg="del">
          <ac:chgData name="Yang, Shengming - ARS" userId="37bd5b25-7571-49cb-bfc8-588a18706c35" providerId="ADAL" clId="{7637BB5A-ED5B-4387-B28B-FAFFBA30BBF6}" dt="2022-03-16T19:41:32.301" v="20" actId="478"/>
          <ac:graphicFrameMkLst>
            <pc:docMk/>
            <pc:sldMk cId="887383785" sldId="278"/>
            <ac:graphicFrameMk id="6" creationId="{53E596D7-AB3A-4633-8D47-4B095118AE5E}"/>
          </ac:graphicFrameMkLst>
        </pc:graphicFrameChg>
      </pc:sldChg>
      <pc:sldChg chg="addSp delSp modSp mod">
        <pc:chgData name="Yang, Shengming - ARS" userId="37bd5b25-7571-49cb-bfc8-588a18706c35" providerId="ADAL" clId="{7637BB5A-ED5B-4387-B28B-FAFFBA30BBF6}" dt="2022-03-16T19:42:28.263" v="22"/>
        <pc:sldMkLst>
          <pc:docMk/>
          <pc:sldMk cId="530921904" sldId="291"/>
        </pc:sldMkLst>
        <pc:graphicFrameChg chg="add del mod">
          <ac:chgData name="Yang, Shengming - ARS" userId="37bd5b25-7571-49cb-bfc8-588a18706c35" providerId="ADAL" clId="{7637BB5A-ED5B-4387-B28B-FAFFBA30BBF6}" dt="2022-03-16T19:35:38.120" v="4" actId="478"/>
          <ac:graphicFrameMkLst>
            <pc:docMk/>
            <pc:sldMk cId="530921904" sldId="291"/>
            <ac:graphicFrameMk id="2" creationId="{181EAB28-D8BB-40DC-8AEF-2589EAE725EC}"/>
          </ac:graphicFrameMkLst>
        </pc:graphicFrameChg>
        <pc:graphicFrameChg chg="add del mod modGraphic">
          <ac:chgData name="Yang, Shengming - ARS" userId="37bd5b25-7571-49cb-bfc8-588a18706c35" providerId="ADAL" clId="{7637BB5A-ED5B-4387-B28B-FAFFBA30BBF6}" dt="2022-03-16T19:41:28.388" v="19" actId="21"/>
          <ac:graphicFrameMkLst>
            <pc:docMk/>
            <pc:sldMk cId="530921904" sldId="291"/>
            <ac:graphicFrameMk id="3" creationId="{8CF60E5A-1FA7-4B18-A554-FBDBD2EA4D03}"/>
          </ac:graphicFrameMkLst>
        </pc:graphicFrameChg>
        <pc:graphicFrameChg chg="del">
          <ac:chgData name="Yang, Shengming - ARS" userId="37bd5b25-7571-49cb-bfc8-588a18706c35" providerId="ADAL" clId="{7637BB5A-ED5B-4387-B28B-FAFFBA30BBF6}" dt="2022-03-16T19:35:17.397" v="0" actId="21"/>
          <ac:graphicFrameMkLst>
            <pc:docMk/>
            <pc:sldMk cId="530921904" sldId="291"/>
            <ac:graphicFrameMk id="4" creationId="{12240337-9653-4844-83C7-8964481C8519}"/>
          </ac:graphicFrameMkLst>
        </pc:graphicFrameChg>
        <pc:graphicFrameChg chg="add mod">
          <ac:chgData name="Yang, Shengming - ARS" userId="37bd5b25-7571-49cb-bfc8-588a18706c35" providerId="ADAL" clId="{7637BB5A-ED5B-4387-B28B-FAFFBA30BBF6}" dt="2022-03-16T19:42:28.263" v="22"/>
          <ac:graphicFrameMkLst>
            <pc:docMk/>
            <pc:sldMk cId="530921904" sldId="291"/>
            <ac:graphicFrameMk id="6" creationId="{A479B854-DC3A-4862-ACED-4ACF47A4B61F}"/>
          </ac:graphicFrameMkLst>
        </pc:graphicFrameChg>
      </pc:sldChg>
      <pc:sldChg chg="addSp delSp modSp mod">
        <pc:chgData name="Yang, Shengming - ARS" userId="37bd5b25-7571-49cb-bfc8-588a18706c35" providerId="ADAL" clId="{7637BB5A-ED5B-4387-B28B-FAFFBA30BBF6}" dt="2022-03-16T19:40:56.992" v="18" actId="1076"/>
        <pc:sldMkLst>
          <pc:docMk/>
          <pc:sldMk cId="2282065266" sldId="292"/>
        </pc:sldMkLst>
        <pc:graphicFrameChg chg="add del mod">
          <ac:chgData name="Yang, Shengming - ARS" userId="37bd5b25-7571-49cb-bfc8-588a18706c35" providerId="ADAL" clId="{7637BB5A-ED5B-4387-B28B-FAFFBA30BBF6}" dt="2022-03-16T19:40:53.168" v="17" actId="478"/>
          <ac:graphicFrameMkLst>
            <pc:docMk/>
            <pc:sldMk cId="2282065266" sldId="292"/>
            <ac:graphicFrameMk id="2" creationId="{54A3EF5E-D12C-43CB-B973-F592CA7CF4C6}"/>
          </ac:graphicFrameMkLst>
        </pc:graphicFrameChg>
        <pc:graphicFrameChg chg="add mod">
          <ac:chgData name="Yang, Shengming - ARS" userId="37bd5b25-7571-49cb-bfc8-588a18706c35" providerId="ADAL" clId="{7637BB5A-ED5B-4387-B28B-FAFFBA30BBF6}" dt="2022-03-16T19:40:56.992" v="18" actId="1076"/>
          <ac:graphicFrameMkLst>
            <pc:docMk/>
            <pc:sldMk cId="2282065266" sldId="292"/>
            <ac:graphicFrameMk id="3" creationId="{A0F8C46D-3CFE-4677-A518-154587BE828B}"/>
          </ac:graphicFrameMkLst>
        </pc:graphicFrameChg>
        <pc:graphicFrameChg chg="del">
          <ac:chgData name="Yang, Shengming - ARS" userId="37bd5b25-7571-49cb-bfc8-588a18706c35" providerId="ADAL" clId="{7637BB5A-ED5B-4387-B28B-FAFFBA30BBF6}" dt="2022-03-16T19:40:43.630" v="13" actId="478"/>
          <ac:graphicFrameMkLst>
            <pc:docMk/>
            <pc:sldMk cId="2282065266" sldId="292"/>
            <ac:graphicFrameMk id="4" creationId="{12240337-9653-4844-83C7-8964481C8519}"/>
          </ac:graphicFrameMkLst>
        </pc:graphicFrameChg>
      </pc:sldChg>
    </pc:docChg>
  </pc:docChgLst>
  <pc:docChgLst>
    <pc:chgData name="Yang, Shengming - ARS" userId="37bd5b25-7571-49cb-bfc8-588a18706c35" providerId="ADAL" clId="{0A6E7208-8512-4C97-A871-65C860D78EB1}"/>
    <pc:docChg chg="undo custSel addSld modSld">
      <pc:chgData name="Yang, Shengming - ARS" userId="37bd5b25-7571-49cb-bfc8-588a18706c35" providerId="ADAL" clId="{0A6E7208-8512-4C97-A871-65C860D78EB1}" dt="2021-12-10T22:55:18.926" v="107" actId="14100"/>
      <pc:docMkLst>
        <pc:docMk/>
      </pc:docMkLst>
      <pc:sldChg chg="modSp mod">
        <pc:chgData name="Yang, Shengming - ARS" userId="37bd5b25-7571-49cb-bfc8-588a18706c35" providerId="ADAL" clId="{0A6E7208-8512-4C97-A871-65C860D78EB1}" dt="2021-12-10T22:55:18.926" v="107" actId="14100"/>
        <pc:sldMkLst>
          <pc:docMk/>
          <pc:sldMk cId="187198215" sldId="256"/>
        </pc:sldMkLst>
        <pc:spChg chg="mod">
          <ac:chgData name="Yang, Shengming - ARS" userId="37bd5b25-7571-49cb-bfc8-588a18706c35" providerId="ADAL" clId="{0A6E7208-8512-4C97-A871-65C860D78EB1}" dt="2021-12-10T22:55:12.229" v="106" actId="404"/>
          <ac:spMkLst>
            <pc:docMk/>
            <pc:sldMk cId="187198215" sldId="256"/>
            <ac:spMk id="8" creationId="{7A85EE01-37A5-48DD-82B2-CC61EFCB05A6}"/>
          </ac:spMkLst>
        </pc:spChg>
        <pc:spChg chg="mod">
          <ac:chgData name="Yang, Shengming - ARS" userId="37bd5b25-7571-49cb-bfc8-588a18706c35" providerId="ADAL" clId="{0A6E7208-8512-4C97-A871-65C860D78EB1}" dt="2021-12-10T22:55:12.229" v="106" actId="404"/>
          <ac:spMkLst>
            <pc:docMk/>
            <pc:sldMk cId="187198215" sldId="256"/>
            <ac:spMk id="24" creationId="{8E1BB1BC-4655-4667-9A9A-9388A8CD0B6A}"/>
          </ac:spMkLst>
        </pc:spChg>
        <pc:spChg chg="mod">
          <ac:chgData name="Yang, Shengming - ARS" userId="37bd5b25-7571-49cb-bfc8-588a18706c35" providerId="ADAL" clId="{0A6E7208-8512-4C97-A871-65C860D78EB1}" dt="2021-12-10T22:55:12.229" v="106" actId="404"/>
          <ac:spMkLst>
            <pc:docMk/>
            <pc:sldMk cId="187198215" sldId="256"/>
            <ac:spMk id="25" creationId="{9245E1A8-7BA6-44DB-9AB5-CC7429F5BAB9}"/>
          </ac:spMkLst>
        </pc:spChg>
        <pc:spChg chg="mod">
          <ac:chgData name="Yang, Shengming - ARS" userId="37bd5b25-7571-49cb-bfc8-588a18706c35" providerId="ADAL" clId="{0A6E7208-8512-4C97-A871-65C860D78EB1}" dt="2021-12-10T22:55:12.229" v="106" actId="404"/>
          <ac:spMkLst>
            <pc:docMk/>
            <pc:sldMk cId="187198215" sldId="256"/>
            <ac:spMk id="26" creationId="{14ACD6D4-6C84-4831-98FA-1D0760256699}"/>
          </ac:spMkLst>
        </pc:spChg>
        <pc:spChg chg="mod">
          <ac:chgData name="Yang, Shengming - ARS" userId="37bd5b25-7571-49cb-bfc8-588a18706c35" providerId="ADAL" clId="{0A6E7208-8512-4C97-A871-65C860D78EB1}" dt="2021-12-10T22:55:12.229" v="106" actId="404"/>
          <ac:spMkLst>
            <pc:docMk/>
            <pc:sldMk cId="187198215" sldId="256"/>
            <ac:spMk id="27" creationId="{4F8D18C1-A3FB-49E5-9800-8A0CDAAC9A06}"/>
          </ac:spMkLst>
        </pc:spChg>
        <pc:spChg chg="mod">
          <ac:chgData name="Yang, Shengming - ARS" userId="37bd5b25-7571-49cb-bfc8-588a18706c35" providerId="ADAL" clId="{0A6E7208-8512-4C97-A871-65C860D78EB1}" dt="2021-12-10T22:55:12.229" v="106" actId="404"/>
          <ac:spMkLst>
            <pc:docMk/>
            <pc:sldMk cId="187198215" sldId="256"/>
            <ac:spMk id="28" creationId="{55FC71C1-3FE7-4850-AC87-2D5CC70E4B67}"/>
          </ac:spMkLst>
        </pc:spChg>
        <pc:spChg chg="mod">
          <ac:chgData name="Yang, Shengming - ARS" userId="37bd5b25-7571-49cb-bfc8-588a18706c35" providerId="ADAL" clId="{0A6E7208-8512-4C97-A871-65C860D78EB1}" dt="2021-12-10T22:55:12.229" v="106" actId="404"/>
          <ac:spMkLst>
            <pc:docMk/>
            <pc:sldMk cId="187198215" sldId="256"/>
            <ac:spMk id="29" creationId="{C72ED974-59CB-4AC2-A042-C083C26196DF}"/>
          </ac:spMkLst>
        </pc:spChg>
        <pc:spChg chg="mod">
          <ac:chgData name="Yang, Shengming - ARS" userId="37bd5b25-7571-49cb-bfc8-588a18706c35" providerId="ADAL" clId="{0A6E7208-8512-4C97-A871-65C860D78EB1}" dt="2021-12-10T22:55:12.229" v="106" actId="404"/>
          <ac:spMkLst>
            <pc:docMk/>
            <pc:sldMk cId="187198215" sldId="256"/>
            <ac:spMk id="30" creationId="{3588F8F0-AE71-4D43-A1BE-9835CB267077}"/>
          </ac:spMkLst>
        </pc:spChg>
        <pc:spChg chg="mod">
          <ac:chgData name="Yang, Shengming - ARS" userId="37bd5b25-7571-49cb-bfc8-588a18706c35" providerId="ADAL" clId="{0A6E7208-8512-4C97-A871-65C860D78EB1}" dt="2021-12-10T22:55:12.229" v="106" actId="404"/>
          <ac:spMkLst>
            <pc:docMk/>
            <pc:sldMk cId="187198215" sldId="256"/>
            <ac:spMk id="31" creationId="{F216FF89-0AA4-4565-88C4-DA0A12A877DC}"/>
          </ac:spMkLst>
        </pc:spChg>
        <pc:grpChg chg="mod">
          <ac:chgData name="Yang, Shengming - ARS" userId="37bd5b25-7571-49cb-bfc8-588a18706c35" providerId="ADAL" clId="{0A6E7208-8512-4C97-A871-65C860D78EB1}" dt="2021-12-10T22:55:18.926" v="107" actId="14100"/>
          <ac:grpSpMkLst>
            <pc:docMk/>
            <pc:sldMk cId="187198215" sldId="256"/>
            <ac:grpSpMk id="4" creationId="{4713D267-1D1C-445B-9270-5911825C9C0B}"/>
          </ac:grpSpMkLst>
        </pc:grpChg>
      </pc:sldChg>
      <pc:sldChg chg="delSp modSp mod">
        <pc:chgData name="Yang, Shengming - ARS" userId="37bd5b25-7571-49cb-bfc8-588a18706c35" providerId="ADAL" clId="{0A6E7208-8512-4C97-A871-65C860D78EB1}" dt="2021-12-04T18:48:08.858" v="17" actId="1076"/>
        <pc:sldMkLst>
          <pc:docMk/>
          <pc:sldMk cId="1525299809" sldId="275"/>
        </pc:sldMkLst>
        <pc:spChg chg="mod topLvl">
          <ac:chgData name="Yang, Shengming - ARS" userId="37bd5b25-7571-49cb-bfc8-588a18706c35" providerId="ADAL" clId="{0A6E7208-8512-4C97-A871-65C860D78EB1}" dt="2021-12-04T18:48:08.858" v="17" actId="1076"/>
          <ac:spMkLst>
            <pc:docMk/>
            <pc:sldMk cId="1525299809" sldId="275"/>
            <ac:spMk id="22" creationId="{4D948ADA-E9AF-42DA-8B05-03DACB9C498C}"/>
          </ac:spMkLst>
        </pc:spChg>
        <pc:spChg chg="mod topLvl">
          <ac:chgData name="Yang, Shengming - ARS" userId="37bd5b25-7571-49cb-bfc8-588a18706c35" providerId="ADAL" clId="{0A6E7208-8512-4C97-A871-65C860D78EB1}" dt="2021-12-04T18:48:08.858" v="17" actId="1076"/>
          <ac:spMkLst>
            <pc:docMk/>
            <pc:sldMk cId="1525299809" sldId="275"/>
            <ac:spMk id="24" creationId="{4162F7BC-929B-45B6-BA7F-921891A36F89}"/>
          </ac:spMkLst>
        </pc:spChg>
        <pc:spChg chg="mod topLvl">
          <ac:chgData name="Yang, Shengming - ARS" userId="37bd5b25-7571-49cb-bfc8-588a18706c35" providerId="ADAL" clId="{0A6E7208-8512-4C97-A871-65C860D78EB1}" dt="2021-12-04T18:48:08.858" v="17" actId="1076"/>
          <ac:spMkLst>
            <pc:docMk/>
            <pc:sldMk cId="1525299809" sldId="275"/>
            <ac:spMk id="26" creationId="{B9CCD95B-3889-4379-A2D1-2FC056F98C66}"/>
          </ac:spMkLst>
        </pc:spChg>
        <pc:spChg chg="mod topLvl">
          <ac:chgData name="Yang, Shengming - ARS" userId="37bd5b25-7571-49cb-bfc8-588a18706c35" providerId="ADAL" clId="{0A6E7208-8512-4C97-A871-65C860D78EB1}" dt="2021-12-04T18:48:08.858" v="17" actId="1076"/>
          <ac:spMkLst>
            <pc:docMk/>
            <pc:sldMk cId="1525299809" sldId="275"/>
            <ac:spMk id="27" creationId="{A025DAFC-93D1-4F78-945F-66FA9798F458}"/>
          </ac:spMkLst>
        </pc:spChg>
        <pc:grpChg chg="del mod">
          <ac:chgData name="Yang, Shengming - ARS" userId="37bd5b25-7571-49cb-bfc8-588a18706c35" providerId="ADAL" clId="{0A6E7208-8512-4C97-A871-65C860D78EB1}" dt="2021-12-04T18:45:56.093" v="3" actId="165"/>
          <ac:grpSpMkLst>
            <pc:docMk/>
            <pc:sldMk cId="1525299809" sldId="275"/>
            <ac:grpSpMk id="2" creationId="{F4EE9DA4-CB9F-486A-923F-388B16F5FCA0}"/>
          </ac:grpSpMkLst>
        </pc:grpChg>
        <pc:grpChg chg="del mod topLvl">
          <ac:chgData name="Yang, Shengming - ARS" userId="37bd5b25-7571-49cb-bfc8-588a18706c35" providerId="ADAL" clId="{0A6E7208-8512-4C97-A871-65C860D78EB1}" dt="2021-12-04T18:47:01.512" v="7" actId="165"/>
          <ac:grpSpMkLst>
            <pc:docMk/>
            <pc:sldMk cId="1525299809" sldId="275"/>
            <ac:grpSpMk id="16" creationId="{6CE4D0D7-A763-4BAE-8CC2-D0BA38EEC42E}"/>
          </ac:grpSpMkLst>
        </pc:grpChg>
        <pc:picChg chg="mod topLvl">
          <ac:chgData name="Yang, Shengming - ARS" userId="37bd5b25-7571-49cb-bfc8-588a18706c35" providerId="ADAL" clId="{0A6E7208-8512-4C97-A871-65C860D78EB1}" dt="2021-12-04T18:48:08.858" v="17" actId="1076"/>
          <ac:picMkLst>
            <pc:docMk/>
            <pc:sldMk cId="1525299809" sldId="275"/>
            <ac:picMk id="18" creationId="{DC957572-5F76-4953-A205-6FFE95C92F40}"/>
          </ac:picMkLst>
        </pc:picChg>
        <pc:picChg chg="mod topLvl">
          <ac:chgData name="Yang, Shengming - ARS" userId="37bd5b25-7571-49cb-bfc8-588a18706c35" providerId="ADAL" clId="{0A6E7208-8512-4C97-A871-65C860D78EB1}" dt="2021-12-04T18:48:08.858" v="17" actId="1076"/>
          <ac:picMkLst>
            <pc:docMk/>
            <pc:sldMk cId="1525299809" sldId="275"/>
            <ac:picMk id="20" creationId="{82B004C6-1B02-4AAE-9F53-D06DA1D4183C}"/>
          </ac:picMkLst>
        </pc:picChg>
      </pc:sldChg>
      <pc:sldChg chg="modSp mod">
        <pc:chgData name="Yang, Shengming - ARS" userId="37bd5b25-7571-49cb-bfc8-588a18706c35" providerId="ADAL" clId="{0A6E7208-8512-4C97-A871-65C860D78EB1}" dt="2021-12-04T18:52:50.378" v="73" actId="1076"/>
        <pc:sldMkLst>
          <pc:docMk/>
          <pc:sldMk cId="2338164932" sldId="277"/>
        </pc:sldMkLst>
        <pc:spChg chg="mod">
          <ac:chgData name="Yang, Shengming - ARS" userId="37bd5b25-7571-49cb-bfc8-588a18706c35" providerId="ADAL" clId="{0A6E7208-8512-4C97-A871-65C860D78EB1}" dt="2021-12-04T18:52:44.386" v="72" actId="1076"/>
          <ac:spMkLst>
            <pc:docMk/>
            <pc:sldMk cId="2338164932" sldId="277"/>
            <ac:spMk id="4" creationId="{327864F8-1AF9-48FF-8153-91701A03977B}"/>
          </ac:spMkLst>
        </pc:spChg>
        <pc:spChg chg="mod">
          <ac:chgData name="Yang, Shengming - ARS" userId="37bd5b25-7571-49cb-bfc8-588a18706c35" providerId="ADAL" clId="{0A6E7208-8512-4C97-A871-65C860D78EB1}" dt="2021-12-04T18:52:00.372" v="63" actId="404"/>
          <ac:spMkLst>
            <pc:docMk/>
            <pc:sldMk cId="2338164932" sldId="277"/>
            <ac:spMk id="9" creationId="{ACF661F1-6CE1-44C8-9915-E53CDBFA7B63}"/>
          </ac:spMkLst>
        </pc:spChg>
        <pc:spChg chg="mod">
          <ac:chgData name="Yang, Shengming - ARS" userId="37bd5b25-7571-49cb-bfc8-588a18706c35" providerId="ADAL" clId="{0A6E7208-8512-4C97-A871-65C860D78EB1}" dt="2021-12-04T18:52:44.386" v="72" actId="1076"/>
          <ac:spMkLst>
            <pc:docMk/>
            <pc:sldMk cId="2338164932" sldId="277"/>
            <ac:spMk id="12" creationId="{E6D8814D-51B2-4292-BAC4-B3F2C8897A0A}"/>
          </ac:spMkLst>
        </pc:spChg>
        <pc:spChg chg="mod">
          <ac:chgData name="Yang, Shengming - ARS" userId="37bd5b25-7571-49cb-bfc8-588a18706c35" providerId="ADAL" clId="{0A6E7208-8512-4C97-A871-65C860D78EB1}" dt="2021-12-04T18:52:44.386" v="72" actId="1076"/>
          <ac:spMkLst>
            <pc:docMk/>
            <pc:sldMk cId="2338164932" sldId="277"/>
            <ac:spMk id="25" creationId="{A0451547-3B00-4C7C-8802-76D22D0B3C4E}"/>
          </ac:spMkLst>
        </pc:spChg>
        <pc:spChg chg="mod">
          <ac:chgData name="Yang, Shengming - ARS" userId="37bd5b25-7571-49cb-bfc8-588a18706c35" providerId="ADAL" clId="{0A6E7208-8512-4C97-A871-65C860D78EB1}" dt="2021-12-04T18:52:44.386" v="72" actId="1076"/>
          <ac:spMkLst>
            <pc:docMk/>
            <pc:sldMk cId="2338164932" sldId="277"/>
            <ac:spMk id="34" creationId="{98406564-1BCE-451A-BB23-839381D5B6A9}"/>
          </ac:spMkLst>
        </pc:spChg>
        <pc:spChg chg="mod">
          <ac:chgData name="Yang, Shengming - ARS" userId="37bd5b25-7571-49cb-bfc8-588a18706c35" providerId="ADAL" clId="{0A6E7208-8512-4C97-A871-65C860D78EB1}" dt="2021-12-04T18:52:50.378" v="73" actId="1076"/>
          <ac:spMkLst>
            <pc:docMk/>
            <pc:sldMk cId="2338164932" sldId="277"/>
            <ac:spMk id="35" creationId="{AF0B610E-81AE-45AA-BE91-3A074F40C5EE}"/>
          </ac:spMkLst>
        </pc:spChg>
        <pc:cxnChg chg="mod">
          <ac:chgData name="Yang, Shengming - ARS" userId="37bd5b25-7571-49cb-bfc8-588a18706c35" providerId="ADAL" clId="{0A6E7208-8512-4C97-A871-65C860D78EB1}" dt="2021-12-04T18:26:04.990" v="0" actId="14100"/>
          <ac:cxnSpMkLst>
            <pc:docMk/>
            <pc:sldMk cId="2338164932" sldId="277"/>
            <ac:cxnSpMk id="27" creationId="{C212F65D-5149-4C30-97FA-04BD3B35D5C5}"/>
          </ac:cxnSpMkLst>
        </pc:cxnChg>
      </pc:sldChg>
      <pc:sldChg chg="addSp delSp modSp new mod">
        <pc:chgData name="Yang, Shengming - ARS" userId="37bd5b25-7571-49cb-bfc8-588a18706c35" providerId="ADAL" clId="{0A6E7208-8512-4C97-A871-65C860D78EB1}" dt="2021-12-09T01:36:59.684" v="97" actId="1076"/>
        <pc:sldMkLst>
          <pc:docMk/>
          <pc:sldMk cId="1104748975" sldId="281"/>
        </pc:sldMkLst>
        <pc:spChg chg="del">
          <ac:chgData name="Yang, Shengming - ARS" userId="37bd5b25-7571-49cb-bfc8-588a18706c35" providerId="ADAL" clId="{0A6E7208-8512-4C97-A871-65C860D78EB1}" dt="2021-12-09T01:03:48.325" v="75" actId="478"/>
          <ac:spMkLst>
            <pc:docMk/>
            <pc:sldMk cId="1104748975" sldId="281"/>
            <ac:spMk id="2" creationId="{B8064EB0-5F71-448E-A08E-7B2703279E8F}"/>
          </ac:spMkLst>
        </pc:spChg>
        <pc:spChg chg="del">
          <ac:chgData name="Yang, Shengming - ARS" userId="37bd5b25-7571-49cb-bfc8-588a18706c35" providerId="ADAL" clId="{0A6E7208-8512-4C97-A871-65C860D78EB1}" dt="2021-12-09T01:03:48.325" v="75" actId="478"/>
          <ac:spMkLst>
            <pc:docMk/>
            <pc:sldMk cId="1104748975" sldId="281"/>
            <ac:spMk id="3" creationId="{391D6937-A431-4ED8-BBA4-5C37ED9AA521}"/>
          </ac:spMkLst>
        </pc:spChg>
        <pc:picChg chg="add mod">
          <ac:chgData name="Yang, Shengming - ARS" userId="37bd5b25-7571-49cb-bfc8-588a18706c35" providerId="ADAL" clId="{0A6E7208-8512-4C97-A871-65C860D78EB1}" dt="2021-12-09T01:36:59.684" v="97" actId="1076"/>
          <ac:picMkLst>
            <pc:docMk/>
            <pc:sldMk cId="1104748975" sldId="281"/>
            <ac:picMk id="5" creationId="{268BE0B8-DA26-4BA7-BBC9-1F2701F84E01}"/>
          </ac:picMkLst>
        </pc:picChg>
        <pc:picChg chg="add del mod">
          <ac:chgData name="Yang, Shengming - ARS" userId="37bd5b25-7571-49cb-bfc8-588a18706c35" providerId="ADAL" clId="{0A6E7208-8512-4C97-A871-65C860D78EB1}" dt="2021-12-09T01:28:02.170" v="88" actId="478"/>
          <ac:picMkLst>
            <pc:docMk/>
            <pc:sldMk cId="1104748975" sldId="281"/>
            <ac:picMk id="7" creationId="{D0DD1CF9-C0F7-4686-8DE2-5AA9E9FBC220}"/>
          </ac:picMkLst>
        </pc:picChg>
        <pc:picChg chg="add mod">
          <ac:chgData name="Yang, Shengming - ARS" userId="37bd5b25-7571-49cb-bfc8-588a18706c35" providerId="ADAL" clId="{0A6E7208-8512-4C97-A871-65C860D78EB1}" dt="2021-12-09T01:36:59.684" v="97" actId="1076"/>
          <ac:picMkLst>
            <pc:docMk/>
            <pc:sldMk cId="1104748975" sldId="281"/>
            <ac:picMk id="9" creationId="{44F233FB-2819-41D0-9AF4-54786682BBC0}"/>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usdagcc-my.sharepoint.com/personal/shengming_yang_usda_gov/Documents/Manuscripts/2022FY/Lig1/Data/Lig1%20Agronomic%20Traits%204-14-2022.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usdagcc-my.sharepoint.com/personal/shengming_yang_usda_gov/Documents/Manuscripts/2022FY/Lig1/Data/Lig1%20Agronomic%20Traits%204-14-2022.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usdagcc-my.sharepoint.com/personal/shengming_yang_usda_gov/Documents/Manuscripts/2022FY/Lig1/Data/Lig1%20Agronomic%20Traits%204-14-2022.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r>
              <a:rPr lang="en-US" dirty="0"/>
              <a:t>Height</a:t>
            </a:r>
          </a:p>
        </c:rich>
      </c:tx>
      <c:overlay val="0"/>
      <c:spPr>
        <a:noFill/>
        <a:ln>
          <a:noFill/>
        </a:ln>
        <a:effectLst/>
      </c:spPr>
      <c:txPr>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tx>
            <c:strRef>
              <c:f>'Hight, tiller, seedspike'!$B$25</c:f>
              <c:strCache>
                <c:ptCount val="1"/>
                <c:pt idx="0">
                  <c:v>Height (cm)</c:v>
                </c:pt>
              </c:strCache>
            </c:strRef>
          </c:tx>
          <c:spPr>
            <a:solidFill>
              <a:schemeClr val="tx1">
                <a:lumMod val="50000"/>
                <a:lumOff val="50000"/>
              </a:schemeClr>
            </a:solidFill>
            <a:ln>
              <a:noFill/>
            </a:ln>
            <a:effectLst/>
          </c:spPr>
          <c:invertIfNegative val="0"/>
          <c:errBars>
            <c:errBarType val="both"/>
            <c:errValType val="cust"/>
            <c:noEndCap val="0"/>
            <c:plus>
              <c:numRef>
                <c:f>'Hight, tiller, seedspike'!$C$26:$C$27</c:f>
                <c:numCache>
                  <c:formatCode>General</c:formatCode>
                  <c:ptCount val="2"/>
                  <c:pt idx="0">
                    <c:v>5.4313902456001077</c:v>
                  </c:pt>
                  <c:pt idx="1">
                    <c:v>9.56382071489565</c:v>
                  </c:pt>
                </c:numCache>
              </c:numRef>
            </c:plus>
            <c:minus>
              <c:numRef>
                <c:f>'Hight, tiller, seedspike'!$C$26:$C$27</c:f>
                <c:numCache>
                  <c:formatCode>General</c:formatCode>
                  <c:ptCount val="2"/>
                  <c:pt idx="0">
                    <c:v>5.4313902456001077</c:v>
                  </c:pt>
                  <c:pt idx="1">
                    <c:v>9.56382071489565</c:v>
                  </c:pt>
                </c:numCache>
              </c:numRef>
            </c:minus>
            <c:spPr>
              <a:noFill/>
              <a:ln w="9525" cap="flat" cmpd="sng" algn="ctr">
                <a:solidFill>
                  <a:schemeClr val="tx1">
                    <a:lumMod val="65000"/>
                    <a:lumOff val="35000"/>
                  </a:schemeClr>
                </a:solidFill>
                <a:round/>
              </a:ln>
              <a:effectLst/>
            </c:spPr>
          </c:errBars>
          <c:cat>
            <c:strRef>
              <c:f>'Hight, tiller, seedspike'!$A$26:$A$27</c:f>
              <c:strCache>
                <c:ptCount val="2"/>
                <c:pt idx="0">
                  <c:v>Bowman</c:v>
                </c:pt>
                <c:pt idx="1">
                  <c:v>BW483</c:v>
                </c:pt>
              </c:strCache>
            </c:strRef>
          </c:cat>
          <c:val>
            <c:numRef>
              <c:f>'Hight, tiller, seedspike'!$B$26:$B$27</c:f>
              <c:numCache>
                <c:formatCode>General</c:formatCode>
                <c:ptCount val="2"/>
                <c:pt idx="0">
                  <c:v>78</c:v>
                </c:pt>
                <c:pt idx="1">
                  <c:v>81.666666666666671</c:v>
                </c:pt>
              </c:numCache>
            </c:numRef>
          </c:val>
          <c:extLst>
            <c:ext xmlns:c16="http://schemas.microsoft.com/office/drawing/2014/chart" uri="{C3380CC4-5D6E-409C-BE32-E72D297353CC}">
              <c16:uniqueId val="{00000000-95D4-4DF6-93A8-5FC14F340569}"/>
            </c:ext>
          </c:extLst>
        </c:ser>
        <c:dLbls>
          <c:showLegendKey val="0"/>
          <c:showVal val="0"/>
          <c:showCatName val="0"/>
          <c:showSerName val="0"/>
          <c:showPercent val="0"/>
          <c:showBubbleSize val="0"/>
        </c:dLbls>
        <c:gapWidth val="219"/>
        <c:overlap val="-27"/>
        <c:axId val="411639992"/>
        <c:axId val="411638024"/>
      </c:barChart>
      <c:catAx>
        <c:axId val="41163999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8024"/>
        <c:crosses val="autoZero"/>
        <c:auto val="1"/>
        <c:lblAlgn val="ctr"/>
        <c:lblOffset val="100"/>
        <c:noMultiLvlLbl val="0"/>
      </c:catAx>
      <c:valAx>
        <c:axId val="411638024"/>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dirty="0"/>
                  <a:t>Height (cm)</a:t>
                </a:r>
              </a:p>
            </c:rich>
          </c:tx>
          <c:layout>
            <c:manualLayout>
              <c:xMode val="edge"/>
              <c:yMode val="edge"/>
              <c:x val="3.9530013045682454E-2"/>
              <c:y val="0.1560339403326271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99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19050">
      <a:solidFill>
        <a:schemeClr val="tx1"/>
      </a:solidFill>
    </a:ln>
    <a:effectLst/>
  </c:spPr>
  <c:txPr>
    <a:bodyPr/>
    <a:lstStyle/>
    <a:p>
      <a:pPr>
        <a:defRPr sz="1200">
          <a:solidFill>
            <a:schemeClr val="tx1"/>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r>
              <a:rPr lang="en-US" dirty="0"/>
              <a:t>Tiller number/plant</a:t>
            </a:r>
          </a:p>
        </c:rich>
      </c:tx>
      <c:layout>
        <c:manualLayout>
          <c:xMode val="edge"/>
          <c:yMode val="edge"/>
          <c:x val="0.27680346930334965"/>
          <c:y val="2.3642070226256473E-2"/>
        </c:manualLayout>
      </c:layout>
      <c:overlay val="0"/>
      <c:spPr>
        <a:noFill/>
        <a:ln>
          <a:noFill/>
        </a:ln>
        <a:effectLst/>
      </c:spPr>
      <c:txPr>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tx>
            <c:strRef>
              <c:f>'Hight, tiller, seedspike'!$B$29</c:f>
              <c:strCache>
                <c:ptCount val="1"/>
                <c:pt idx="0">
                  <c:v># of tillers</c:v>
                </c:pt>
              </c:strCache>
            </c:strRef>
          </c:tx>
          <c:spPr>
            <a:solidFill>
              <a:schemeClr val="tx1">
                <a:lumMod val="50000"/>
                <a:lumOff val="50000"/>
              </a:schemeClr>
            </a:solidFill>
            <a:ln>
              <a:noFill/>
            </a:ln>
            <a:effectLst/>
          </c:spPr>
          <c:invertIfNegative val="0"/>
          <c:errBars>
            <c:errBarType val="both"/>
            <c:errValType val="cust"/>
            <c:noEndCap val="0"/>
            <c:plus>
              <c:numRef>
                <c:f>'Hight, tiller, seedspike'!$C$30:$C$31</c:f>
                <c:numCache>
                  <c:formatCode>General</c:formatCode>
                  <c:ptCount val="2"/>
                  <c:pt idx="0">
                    <c:v>1.6431676725154949</c:v>
                  </c:pt>
                  <c:pt idx="1">
                    <c:v>0.51639777949432231</c:v>
                  </c:pt>
                </c:numCache>
              </c:numRef>
            </c:plus>
            <c:minus>
              <c:numRef>
                <c:f>'Hight, tiller, seedspike'!$C$30:$C$31</c:f>
                <c:numCache>
                  <c:formatCode>General</c:formatCode>
                  <c:ptCount val="2"/>
                  <c:pt idx="0">
                    <c:v>1.6431676725154949</c:v>
                  </c:pt>
                  <c:pt idx="1">
                    <c:v>0.51639777949432231</c:v>
                  </c:pt>
                </c:numCache>
              </c:numRef>
            </c:minus>
            <c:spPr>
              <a:noFill/>
              <a:ln w="9525" cap="flat" cmpd="sng" algn="ctr">
                <a:solidFill>
                  <a:schemeClr val="tx1">
                    <a:lumMod val="65000"/>
                    <a:lumOff val="35000"/>
                  </a:schemeClr>
                </a:solidFill>
                <a:round/>
              </a:ln>
              <a:effectLst/>
            </c:spPr>
          </c:errBars>
          <c:cat>
            <c:strRef>
              <c:f>'Hight, tiller, seedspike'!$A$30:$A$31</c:f>
              <c:strCache>
                <c:ptCount val="2"/>
                <c:pt idx="0">
                  <c:v>Bowman</c:v>
                </c:pt>
                <c:pt idx="1">
                  <c:v>BW483</c:v>
                </c:pt>
              </c:strCache>
            </c:strRef>
          </c:cat>
          <c:val>
            <c:numRef>
              <c:f>'Hight, tiller, seedspike'!$B$30:$B$31</c:f>
              <c:numCache>
                <c:formatCode>General</c:formatCode>
                <c:ptCount val="2"/>
                <c:pt idx="0">
                  <c:v>13.82</c:v>
                </c:pt>
                <c:pt idx="1">
                  <c:v>14.333333333333334</c:v>
                </c:pt>
              </c:numCache>
            </c:numRef>
          </c:val>
          <c:extLst>
            <c:ext xmlns:c16="http://schemas.microsoft.com/office/drawing/2014/chart" uri="{C3380CC4-5D6E-409C-BE32-E72D297353CC}">
              <c16:uniqueId val="{00000000-F497-4373-9CA5-DDB2B6679414}"/>
            </c:ext>
          </c:extLst>
        </c:ser>
        <c:dLbls>
          <c:showLegendKey val="0"/>
          <c:showVal val="0"/>
          <c:showCatName val="0"/>
          <c:showSerName val="0"/>
          <c:showPercent val="0"/>
          <c:showBubbleSize val="0"/>
        </c:dLbls>
        <c:gapWidth val="219"/>
        <c:overlap val="-27"/>
        <c:axId val="411639992"/>
        <c:axId val="411638024"/>
      </c:barChart>
      <c:catAx>
        <c:axId val="41163999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8024"/>
        <c:crosses val="autoZero"/>
        <c:auto val="1"/>
        <c:lblAlgn val="ctr"/>
        <c:lblOffset val="100"/>
        <c:noMultiLvlLbl val="0"/>
      </c:catAx>
      <c:valAx>
        <c:axId val="411638024"/>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dirty="0"/>
                  <a:t>Tillers/plant</a:t>
                </a:r>
              </a:p>
            </c:rich>
          </c:tx>
          <c:layout>
            <c:manualLayout>
              <c:xMode val="edge"/>
              <c:yMode val="edge"/>
              <c:x val="2.9647509784261842E-2"/>
              <c:y val="0.1251022317866082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99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19050">
      <a:solidFill>
        <a:schemeClr val="tx1"/>
      </a:solidFill>
    </a:ln>
    <a:effectLst/>
  </c:spPr>
  <c:txPr>
    <a:bodyPr/>
    <a:lstStyle/>
    <a:p>
      <a:pPr>
        <a:defRPr sz="1200">
          <a:solidFill>
            <a:schemeClr val="tx1"/>
          </a:solidFill>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r>
              <a:rPr lang="en-US" dirty="0"/>
              <a:t>Seed number/spike</a:t>
            </a:r>
          </a:p>
        </c:rich>
      </c:tx>
      <c:layout>
        <c:manualLayout>
          <c:xMode val="edge"/>
          <c:yMode val="edge"/>
          <c:x val="0.28460130908151465"/>
          <c:y val="2.4767705800808424E-2"/>
        </c:manualLayout>
      </c:layout>
      <c:overlay val="0"/>
      <c:spPr>
        <a:noFill/>
        <a:ln>
          <a:noFill/>
        </a:ln>
        <a:effectLst/>
      </c:spPr>
      <c:txPr>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tx>
            <c:strRef>
              <c:f>'Hight, tiller, seedspike'!$B$33</c:f>
              <c:strCache>
                <c:ptCount val="1"/>
                <c:pt idx="0">
                  <c:v>Seeds/spike</c:v>
                </c:pt>
              </c:strCache>
            </c:strRef>
          </c:tx>
          <c:spPr>
            <a:solidFill>
              <a:schemeClr val="tx1">
                <a:lumMod val="50000"/>
                <a:lumOff val="50000"/>
              </a:schemeClr>
            </a:solidFill>
            <a:ln>
              <a:noFill/>
            </a:ln>
            <a:effectLst/>
          </c:spPr>
          <c:invertIfNegative val="0"/>
          <c:errBars>
            <c:errBarType val="both"/>
            <c:errValType val="cust"/>
            <c:noEndCap val="0"/>
            <c:plus>
              <c:numRef>
                <c:f>'Hight, tiller, seedspike'!$C$34:$C$35</c:f>
                <c:numCache>
                  <c:formatCode>General</c:formatCode>
                  <c:ptCount val="2"/>
                  <c:pt idx="0">
                    <c:v>2.0056737702645644</c:v>
                  </c:pt>
                  <c:pt idx="1">
                    <c:v>2.4349604222788757</c:v>
                  </c:pt>
                </c:numCache>
              </c:numRef>
            </c:plus>
            <c:minus>
              <c:numRef>
                <c:f>'Hight, tiller, seedspike'!$C$34:$C$35</c:f>
                <c:numCache>
                  <c:formatCode>General</c:formatCode>
                  <c:ptCount val="2"/>
                  <c:pt idx="0">
                    <c:v>2.0056737702645644</c:v>
                  </c:pt>
                  <c:pt idx="1">
                    <c:v>2.4349604222788757</c:v>
                  </c:pt>
                </c:numCache>
              </c:numRef>
            </c:minus>
            <c:spPr>
              <a:noFill/>
              <a:ln w="9525" cap="flat" cmpd="sng" algn="ctr">
                <a:solidFill>
                  <a:schemeClr val="tx1">
                    <a:lumMod val="65000"/>
                    <a:lumOff val="35000"/>
                  </a:schemeClr>
                </a:solidFill>
                <a:round/>
              </a:ln>
              <a:effectLst/>
            </c:spPr>
          </c:errBars>
          <c:cat>
            <c:strRef>
              <c:f>'Hight, tiller, seedspike'!$A$34:$A$35</c:f>
              <c:strCache>
                <c:ptCount val="2"/>
                <c:pt idx="0">
                  <c:v>Bowman</c:v>
                </c:pt>
                <c:pt idx="1">
                  <c:v>BW483</c:v>
                </c:pt>
              </c:strCache>
            </c:strRef>
          </c:cat>
          <c:val>
            <c:numRef>
              <c:f>'Hight, tiller, seedspike'!$B$34:$B$35</c:f>
              <c:numCache>
                <c:formatCode>General</c:formatCode>
                <c:ptCount val="2"/>
                <c:pt idx="0">
                  <c:v>15.175000000000001</c:v>
                </c:pt>
                <c:pt idx="1">
                  <c:v>14.935483870967699</c:v>
                </c:pt>
              </c:numCache>
            </c:numRef>
          </c:val>
          <c:extLst>
            <c:ext xmlns:c16="http://schemas.microsoft.com/office/drawing/2014/chart" uri="{C3380CC4-5D6E-409C-BE32-E72D297353CC}">
              <c16:uniqueId val="{00000000-3CEF-4822-8F9B-E63F31EA3942}"/>
            </c:ext>
          </c:extLst>
        </c:ser>
        <c:dLbls>
          <c:showLegendKey val="0"/>
          <c:showVal val="0"/>
          <c:showCatName val="0"/>
          <c:showSerName val="0"/>
          <c:showPercent val="0"/>
          <c:showBubbleSize val="0"/>
        </c:dLbls>
        <c:gapWidth val="219"/>
        <c:overlap val="-27"/>
        <c:axId val="411639992"/>
        <c:axId val="411638024"/>
      </c:barChart>
      <c:catAx>
        <c:axId val="41163999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8024"/>
        <c:crosses val="autoZero"/>
        <c:auto val="1"/>
        <c:lblAlgn val="ctr"/>
        <c:lblOffset val="100"/>
        <c:noMultiLvlLbl val="0"/>
      </c:catAx>
      <c:valAx>
        <c:axId val="411638024"/>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dirty="0"/>
                  <a:t>Sees/spike</a:t>
                </a:r>
              </a:p>
            </c:rich>
          </c:tx>
          <c:layout>
            <c:manualLayout>
              <c:xMode val="edge"/>
              <c:yMode val="edge"/>
              <c:x val="2.4706258153551534E-2"/>
              <c:y val="0.1108481111785416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1163999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19050">
      <a:solidFill>
        <a:schemeClr val="tx1"/>
      </a:solidFill>
    </a:ln>
    <a:effectLst/>
  </c:spPr>
  <c:txPr>
    <a:bodyPr/>
    <a:lstStyle/>
    <a:p>
      <a:pPr>
        <a:defRPr sz="1200">
          <a:solidFill>
            <a:schemeClr val="tx1"/>
          </a:solidFill>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r>
              <a:rPr lang="en-US" dirty="0"/>
              <a:t>100-seed weight</a:t>
            </a:r>
          </a:p>
        </c:rich>
      </c:tx>
      <c:overlay val="0"/>
      <c:spPr>
        <a:noFill/>
        <a:ln>
          <a:noFill/>
        </a:ln>
        <a:effectLst/>
      </c:spPr>
      <c:txPr>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lumMod val="50000"/>
                <a:lumOff val="50000"/>
              </a:schemeClr>
            </a:solidFill>
            <a:ln>
              <a:noFill/>
            </a:ln>
            <a:effectLst/>
          </c:spPr>
          <c:invertIfNegative val="0"/>
          <c:errBars>
            <c:errBarType val="both"/>
            <c:errValType val="cust"/>
            <c:noEndCap val="0"/>
            <c:plus>
              <c:numRef>
                <c:f>'Seed weight'!$J$3:$J$4</c:f>
                <c:numCache>
                  <c:formatCode>General</c:formatCode>
                  <c:ptCount val="2"/>
                  <c:pt idx="0">
                    <c:v>2.8674417556808867E-2</c:v>
                  </c:pt>
                  <c:pt idx="1">
                    <c:v>0.30594117081556704</c:v>
                  </c:pt>
                </c:numCache>
              </c:numRef>
            </c:plus>
            <c:minus>
              <c:numRef>
                <c:f>'Seed weight'!$J$3:$J$4</c:f>
                <c:numCache>
                  <c:formatCode>General</c:formatCode>
                  <c:ptCount val="2"/>
                  <c:pt idx="0">
                    <c:v>2.8674417556808867E-2</c:v>
                  </c:pt>
                  <c:pt idx="1">
                    <c:v>0.30594117081556704</c:v>
                  </c:pt>
                </c:numCache>
              </c:numRef>
            </c:minus>
            <c:spPr>
              <a:noFill/>
              <a:ln w="9525" cap="flat" cmpd="sng" algn="ctr">
                <a:solidFill>
                  <a:schemeClr val="tx1">
                    <a:lumMod val="65000"/>
                    <a:lumOff val="35000"/>
                  </a:schemeClr>
                </a:solidFill>
                <a:round/>
              </a:ln>
              <a:effectLst/>
            </c:spPr>
          </c:errBars>
          <c:cat>
            <c:strRef>
              <c:f>'Seed weight'!$H$3:$H$4</c:f>
              <c:strCache>
                <c:ptCount val="2"/>
                <c:pt idx="0">
                  <c:v>Bowman</c:v>
                </c:pt>
                <c:pt idx="1">
                  <c:v>BW483</c:v>
                </c:pt>
              </c:strCache>
            </c:strRef>
          </c:cat>
          <c:val>
            <c:numRef>
              <c:f>'Seed weight'!$I$3:$I$4</c:f>
              <c:numCache>
                <c:formatCode>General</c:formatCode>
                <c:ptCount val="2"/>
                <c:pt idx="0">
                  <c:v>5.4566666666666661</c:v>
                </c:pt>
                <c:pt idx="1">
                  <c:v>5.66</c:v>
                </c:pt>
              </c:numCache>
            </c:numRef>
          </c:val>
          <c:extLst>
            <c:ext xmlns:c16="http://schemas.microsoft.com/office/drawing/2014/chart" uri="{C3380CC4-5D6E-409C-BE32-E72D297353CC}">
              <c16:uniqueId val="{00000000-F9BB-4F7D-8328-CCEEDFB2B212}"/>
            </c:ext>
          </c:extLst>
        </c:ser>
        <c:dLbls>
          <c:showLegendKey val="0"/>
          <c:showVal val="0"/>
          <c:showCatName val="0"/>
          <c:showSerName val="0"/>
          <c:showPercent val="0"/>
          <c:showBubbleSize val="0"/>
        </c:dLbls>
        <c:gapWidth val="219"/>
        <c:overlap val="-27"/>
        <c:axId val="423888152"/>
        <c:axId val="423889464"/>
      </c:barChart>
      <c:catAx>
        <c:axId val="42388815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23889464"/>
        <c:crosses val="autoZero"/>
        <c:auto val="1"/>
        <c:lblAlgn val="ctr"/>
        <c:lblOffset val="100"/>
        <c:noMultiLvlLbl val="0"/>
      </c:catAx>
      <c:valAx>
        <c:axId val="423889464"/>
        <c:scaling>
          <c:orientation val="minMax"/>
          <c:max val="6"/>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dirty="0"/>
                  <a:t>100-seed weight (g)</a:t>
                </a:r>
              </a:p>
            </c:rich>
          </c:tx>
          <c:layout>
            <c:manualLayout>
              <c:xMode val="edge"/>
              <c:yMode val="edge"/>
              <c:x val="2.4713325425069196E-2"/>
              <c:y val="9.8271223533318935E-2"/>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2388815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19050">
      <a:solidFill>
        <a:schemeClr val="tx1"/>
      </a:solidFill>
    </a:ln>
    <a:effectLst/>
  </c:spPr>
  <c:txPr>
    <a:bodyPr/>
    <a:lstStyle/>
    <a:p>
      <a:pPr>
        <a:defRPr sz="1200">
          <a:solidFill>
            <a:schemeClr val="tx1"/>
          </a:solidFill>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80" b="0" i="0" u="none" strike="noStrike" kern="1200" spc="0" baseline="0">
                <a:solidFill>
                  <a:schemeClr val="tx1">
                    <a:lumMod val="95000"/>
                    <a:lumOff val="5000"/>
                  </a:schemeClr>
                </a:solidFill>
                <a:latin typeface="+mn-lt"/>
                <a:ea typeface="+mn-ea"/>
                <a:cs typeface="+mn-cs"/>
              </a:defRPr>
            </a:pPr>
            <a:r>
              <a:rPr lang="en-US"/>
              <a:t>Days to Heading</a:t>
            </a:r>
          </a:p>
        </c:rich>
      </c:tx>
      <c:layout>
        <c:manualLayout>
          <c:xMode val="edge"/>
          <c:yMode val="edge"/>
          <c:x val="0.3227539754928419"/>
          <c:y val="0.10870082072448194"/>
        </c:manualLayout>
      </c:layout>
      <c:overlay val="0"/>
      <c:spPr>
        <a:noFill/>
        <a:ln>
          <a:noFill/>
        </a:ln>
        <a:effectLst/>
      </c:spPr>
      <c:txPr>
        <a:bodyPr rot="0" spcFirstLastPara="1" vertOverflow="ellipsis" vert="horz" wrap="square" anchor="ctr" anchorCtr="1"/>
        <a:lstStyle/>
        <a:p>
          <a:pPr>
            <a:defRPr sz="1680" b="0" i="0" u="none" strike="noStrike" kern="1200" spc="0" baseline="0">
              <a:solidFill>
                <a:schemeClr val="tx1">
                  <a:lumMod val="95000"/>
                  <a:lumOff val="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tx1">
                <a:lumMod val="50000"/>
                <a:lumOff val="50000"/>
              </a:schemeClr>
            </a:solidFill>
            <a:ln>
              <a:solidFill>
                <a:schemeClr val="tx1"/>
              </a:solidFill>
            </a:ln>
            <a:effectLst/>
          </c:spPr>
          <c:invertIfNegative val="0"/>
          <c:errBars>
            <c:errBarType val="both"/>
            <c:errValType val="cust"/>
            <c:noEndCap val="0"/>
            <c:plus>
              <c:numRef>
                <c:f>'Transgenic heading'!$D$29:$D$30</c:f>
                <c:numCache>
                  <c:formatCode>General</c:formatCode>
                  <c:ptCount val="2"/>
                  <c:pt idx="0">
                    <c:v>3.7859388972001824</c:v>
                  </c:pt>
                  <c:pt idx="1">
                    <c:v>5.0199601592044534</c:v>
                  </c:pt>
                </c:numCache>
              </c:numRef>
            </c:plus>
            <c:minus>
              <c:numRef>
                <c:f>'Transgenic heading'!$D$29:$D$30</c:f>
                <c:numCache>
                  <c:formatCode>General</c:formatCode>
                  <c:ptCount val="2"/>
                  <c:pt idx="0">
                    <c:v>3.7859388972001824</c:v>
                  </c:pt>
                  <c:pt idx="1">
                    <c:v>5.0199601592044534</c:v>
                  </c:pt>
                </c:numCache>
              </c:numRef>
            </c:minus>
            <c:spPr>
              <a:noFill/>
              <a:ln w="9525" cap="flat" cmpd="sng" algn="ctr">
                <a:solidFill>
                  <a:schemeClr val="tx1">
                    <a:lumMod val="65000"/>
                    <a:lumOff val="35000"/>
                  </a:schemeClr>
                </a:solidFill>
                <a:round/>
              </a:ln>
              <a:effectLst/>
            </c:spPr>
          </c:errBars>
          <c:cat>
            <c:strRef>
              <c:f>'Transgenic heading'!$B$29:$B$30</c:f>
              <c:strCache>
                <c:ptCount val="2"/>
                <c:pt idx="0">
                  <c:v>Golden Promise</c:v>
                </c:pt>
                <c:pt idx="1">
                  <c:v> Lig1-knockout mutant</c:v>
                </c:pt>
              </c:strCache>
            </c:strRef>
          </c:cat>
          <c:val>
            <c:numRef>
              <c:f>'Transgenic heading'!$C$29:$C$30</c:f>
              <c:numCache>
                <c:formatCode>General</c:formatCode>
                <c:ptCount val="2"/>
                <c:pt idx="0">
                  <c:v>67.6666666666667</c:v>
                </c:pt>
                <c:pt idx="1">
                  <c:v>73.8</c:v>
                </c:pt>
              </c:numCache>
            </c:numRef>
          </c:val>
          <c:extLst>
            <c:ext xmlns:c16="http://schemas.microsoft.com/office/drawing/2014/chart" uri="{C3380CC4-5D6E-409C-BE32-E72D297353CC}">
              <c16:uniqueId val="{00000000-6A92-46CA-9F16-3F93E4F11FCD}"/>
            </c:ext>
          </c:extLst>
        </c:ser>
        <c:dLbls>
          <c:showLegendKey val="0"/>
          <c:showVal val="0"/>
          <c:showCatName val="0"/>
          <c:showSerName val="0"/>
          <c:showPercent val="0"/>
          <c:showBubbleSize val="0"/>
        </c:dLbls>
        <c:gapWidth val="219"/>
        <c:overlap val="-27"/>
        <c:axId val="620694344"/>
        <c:axId val="620694672"/>
      </c:barChart>
      <c:catAx>
        <c:axId val="62069434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95000"/>
                    <a:lumOff val="5000"/>
                  </a:schemeClr>
                </a:solidFill>
                <a:latin typeface="+mn-lt"/>
                <a:ea typeface="+mn-ea"/>
                <a:cs typeface="+mn-cs"/>
              </a:defRPr>
            </a:pPr>
            <a:endParaRPr lang="en-US"/>
          </a:p>
        </c:txPr>
        <c:crossAx val="620694672"/>
        <c:crosses val="autoZero"/>
        <c:auto val="1"/>
        <c:lblAlgn val="ctr"/>
        <c:lblOffset val="100"/>
        <c:noMultiLvlLbl val="0"/>
      </c:catAx>
      <c:valAx>
        <c:axId val="620694672"/>
        <c:scaling>
          <c:orientation val="minMax"/>
        </c:scaling>
        <c:delete val="0"/>
        <c:axPos val="l"/>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95000"/>
                    <a:lumOff val="5000"/>
                  </a:schemeClr>
                </a:solidFill>
                <a:latin typeface="+mn-lt"/>
                <a:ea typeface="+mn-ea"/>
                <a:cs typeface="+mn-cs"/>
              </a:defRPr>
            </a:pPr>
            <a:endParaRPr lang="en-US"/>
          </a:p>
        </c:txPr>
        <c:crossAx val="6206943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a:noFill/>
    </a:ln>
    <a:effectLst/>
  </c:spPr>
  <c:txPr>
    <a:bodyPr/>
    <a:lstStyle/>
    <a:p>
      <a:pPr>
        <a:defRPr sz="1400">
          <a:solidFill>
            <a:schemeClr val="tx1">
              <a:lumMod val="95000"/>
              <a:lumOff val="5000"/>
            </a:schemeClr>
          </a:solidFill>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r>
              <a:rPr lang="en-US" i="0" dirty="0"/>
              <a:t>Relative expression</a:t>
            </a:r>
            <a:r>
              <a:rPr lang="en-US" i="0" baseline="0" dirty="0"/>
              <a:t> levels of </a:t>
            </a:r>
            <a:r>
              <a:rPr lang="en-US" i="1" baseline="0" dirty="0"/>
              <a:t>Lig1</a:t>
            </a:r>
            <a:endParaRPr lang="en-US" i="1" dirty="0"/>
          </a:p>
        </c:rich>
      </c:tx>
      <c:layout>
        <c:manualLayout>
          <c:xMode val="edge"/>
          <c:yMode val="edge"/>
          <c:x val="0.28867080130425898"/>
          <c:y val="6.3550585238588989E-2"/>
        </c:manualLayout>
      </c:layout>
      <c:overlay val="0"/>
      <c:spPr>
        <a:noFill/>
        <a:ln>
          <a:noFill/>
        </a:ln>
        <a:effectLst/>
      </c:spPr>
      <c:txPr>
        <a:bodyPr rot="0" spcFirstLastPara="1" vertOverflow="ellipsis" vert="horz" wrap="square" anchor="ctr" anchorCtr="1"/>
        <a:lstStyle/>
        <a:p>
          <a:pPr>
            <a:defRPr sz="144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3811860266081616"/>
          <c:y val="5.8128493217176294E-2"/>
          <c:w val="0.86131654575916883"/>
          <c:h val="0.59600967095638435"/>
        </c:manualLayout>
      </c:layout>
      <c:barChart>
        <c:barDir val="col"/>
        <c:grouping val="clustered"/>
        <c:varyColors val="0"/>
        <c:ser>
          <c:idx val="0"/>
          <c:order val="0"/>
          <c:spPr>
            <a:solidFill>
              <a:schemeClr val="tx1">
                <a:lumMod val="50000"/>
                <a:lumOff val="50000"/>
              </a:schemeClr>
            </a:solidFill>
            <a:ln>
              <a:solidFill>
                <a:schemeClr val="tx1"/>
              </a:solidFill>
            </a:ln>
            <a:effectLst/>
          </c:spPr>
          <c:invertIfNegative val="0"/>
          <c:errBars>
            <c:errBarType val="both"/>
            <c:errValType val="cust"/>
            <c:noEndCap val="0"/>
            <c:plus>
              <c:numRef>
                <c:f>Sheet2!$H$2:$H$17</c:f>
                <c:numCache>
                  <c:formatCode>General</c:formatCode>
                  <c:ptCount val="16"/>
                  <c:pt idx="0">
                    <c:v>8.2397265818310736E-2</c:v>
                  </c:pt>
                  <c:pt idx="1">
                    <c:v>4.8923727787683287E-2</c:v>
                  </c:pt>
                  <c:pt idx="2">
                    <c:v>0.53300464480277587</c:v>
                  </c:pt>
                  <c:pt idx="3">
                    <c:v>1.8458234516153849E-2</c:v>
                  </c:pt>
                  <c:pt idx="4">
                    <c:v>8.2599732705378542E-2</c:v>
                  </c:pt>
                  <c:pt idx="5">
                    <c:v>0</c:v>
                  </c:pt>
                  <c:pt idx="6">
                    <c:v>2.9890231726323793E-2</c:v>
                  </c:pt>
                  <c:pt idx="7">
                    <c:v>0.26865543899202926</c:v>
                  </c:pt>
                  <c:pt idx="8">
                    <c:v>1.2390872967363238</c:v>
                  </c:pt>
                  <c:pt idx="9">
                    <c:v>0.58615934286961013</c:v>
                  </c:pt>
                  <c:pt idx="10">
                    <c:v>0</c:v>
                  </c:pt>
                  <c:pt idx="11">
                    <c:v>0</c:v>
                  </c:pt>
                  <c:pt idx="12">
                    <c:v>0.1029386032221796</c:v>
                  </c:pt>
                  <c:pt idx="13">
                    <c:v>1.5877491642888695</c:v>
                  </c:pt>
                  <c:pt idx="14">
                    <c:v>0.86505351778565365</c:v>
                  </c:pt>
                  <c:pt idx="15">
                    <c:v>2.4571450106441284E-2</c:v>
                  </c:pt>
                </c:numCache>
              </c:numRef>
            </c:plus>
            <c:minus>
              <c:numRef>
                <c:f>Sheet2!$H$2:$H$17</c:f>
                <c:numCache>
                  <c:formatCode>General</c:formatCode>
                  <c:ptCount val="16"/>
                  <c:pt idx="0">
                    <c:v>8.2397265818310736E-2</c:v>
                  </c:pt>
                  <c:pt idx="1">
                    <c:v>4.8923727787683287E-2</c:v>
                  </c:pt>
                  <c:pt idx="2">
                    <c:v>0.53300464480277587</c:v>
                  </c:pt>
                  <c:pt idx="3">
                    <c:v>1.8458234516153849E-2</c:v>
                  </c:pt>
                  <c:pt idx="4">
                    <c:v>8.2599732705378542E-2</c:v>
                  </c:pt>
                  <c:pt idx="5">
                    <c:v>0</c:v>
                  </c:pt>
                  <c:pt idx="6">
                    <c:v>2.9890231726323793E-2</c:v>
                  </c:pt>
                  <c:pt idx="7">
                    <c:v>0.26865543899202926</c:v>
                  </c:pt>
                  <c:pt idx="8">
                    <c:v>1.2390872967363238</c:v>
                  </c:pt>
                  <c:pt idx="9">
                    <c:v>0.58615934286961013</c:v>
                  </c:pt>
                  <c:pt idx="10">
                    <c:v>0</c:v>
                  </c:pt>
                  <c:pt idx="11">
                    <c:v>0</c:v>
                  </c:pt>
                  <c:pt idx="12">
                    <c:v>0.1029386032221796</c:v>
                  </c:pt>
                  <c:pt idx="13">
                    <c:v>1.5877491642888695</c:v>
                  </c:pt>
                  <c:pt idx="14">
                    <c:v>0.86505351778565365</c:v>
                  </c:pt>
                  <c:pt idx="15">
                    <c:v>2.4571450106441284E-2</c:v>
                  </c:pt>
                </c:numCache>
              </c:numRef>
            </c:minus>
            <c:spPr>
              <a:noFill/>
              <a:ln w="3175" cap="flat" cmpd="sng" algn="ctr">
                <a:solidFill>
                  <a:schemeClr val="tx1"/>
                </a:solidFill>
                <a:round/>
              </a:ln>
              <a:effectLst/>
            </c:spPr>
          </c:errBars>
          <c:cat>
            <c:strRef>
              <c:f>Sheet2!$F$2:$F$17</c:f>
              <c:strCache>
                <c:ptCount val="16"/>
                <c:pt idx="0">
                  <c:v>Germinating embryo</c:v>
                </c:pt>
                <c:pt idx="1">
                  <c:v>Etiolated </c:v>
                </c:pt>
                <c:pt idx="2">
                  <c:v>Young leaf</c:v>
                </c:pt>
                <c:pt idx="3">
                  <c:v>Epidermis </c:v>
                </c:pt>
                <c:pt idx="4">
                  <c:v>Root 1 </c:v>
                </c:pt>
                <c:pt idx="5">
                  <c:v>Root 2 </c:v>
                </c:pt>
                <c:pt idx="6">
                  <c:v>Internode</c:v>
                </c:pt>
                <c:pt idx="7">
                  <c:v>Rachis </c:v>
                </c:pt>
                <c:pt idx="8">
                  <c:v>Inflorescence 1</c:v>
                </c:pt>
                <c:pt idx="9">
                  <c:v>Inflorescence 2 </c:v>
                </c:pt>
                <c:pt idx="10">
                  <c:v>Grain 1 </c:v>
                </c:pt>
                <c:pt idx="11">
                  <c:v>Grain 2 </c:v>
                </c:pt>
                <c:pt idx="12">
                  <c:v>Lemma </c:v>
                </c:pt>
                <c:pt idx="13">
                  <c:v>Lodicule </c:v>
                </c:pt>
                <c:pt idx="14">
                  <c:v>Palea </c:v>
                </c:pt>
                <c:pt idx="15">
                  <c:v>Senescing leaf </c:v>
                </c:pt>
              </c:strCache>
            </c:strRef>
          </c:cat>
          <c:val>
            <c:numRef>
              <c:f>Sheet2!$G$2:$G$17</c:f>
              <c:numCache>
                <c:formatCode>General</c:formatCode>
                <c:ptCount val="16"/>
                <c:pt idx="0">
                  <c:v>0.19631133333333331</c:v>
                </c:pt>
                <c:pt idx="1">
                  <c:v>4.3906233333333329E-2</c:v>
                </c:pt>
                <c:pt idx="2">
                  <c:v>0.7880826666666666</c:v>
                </c:pt>
                <c:pt idx="3">
                  <c:v>1.0656866666666667E-2</c:v>
                </c:pt>
                <c:pt idx="4">
                  <c:v>0.32064399999999998</c:v>
                </c:pt>
                <c:pt idx="5">
                  <c:v>0</c:v>
                </c:pt>
                <c:pt idx="6">
                  <c:v>1.7257133333333334E-2</c:v>
                </c:pt>
                <c:pt idx="7">
                  <c:v>4.9464600000000001</c:v>
                </c:pt>
                <c:pt idx="8">
                  <c:v>4.6817033333333331</c:v>
                </c:pt>
                <c:pt idx="9">
                  <c:v>1.7133366666666667</c:v>
                </c:pt>
                <c:pt idx="10">
                  <c:v>0</c:v>
                </c:pt>
                <c:pt idx="11">
                  <c:v>0</c:v>
                </c:pt>
                <c:pt idx="12">
                  <c:v>1.2581733333333334</c:v>
                </c:pt>
                <c:pt idx="13">
                  <c:v>3.0137099999999997</c:v>
                </c:pt>
                <c:pt idx="14">
                  <c:v>2.4437533333333334</c:v>
                </c:pt>
                <c:pt idx="15">
                  <c:v>1.4186333333333334E-2</c:v>
                </c:pt>
              </c:numCache>
            </c:numRef>
          </c:val>
          <c:extLst>
            <c:ext xmlns:c16="http://schemas.microsoft.com/office/drawing/2014/chart" uri="{C3380CC4-5D6E-409C-BE32-E72D297353CC}">
              <c16:uniqueId val="{00000000-4976-4866-A67C-5E5D4958E8DF}"/>
            </c:ext>
          </c:extLst>
        </c:ser>
        <c:dLbls>
          <c:showLegendKey val="0"/>
          <c:showVal val="0"/>
          <c:showCatName val="0"/>
          <c:showSerName val="0"/>
          <c:showPercent val="0"/>
          <c:showBubbleSize val="0"/>
        </c:dLbls>
        <c:gapWidth val="219"/>
        <c:overlap val="-27"/>
        <c:axId val="483672848"/>
        <c:axId val="483666944"/>
      </c:barChart>
      <c:catAx>
        <c:axId val="483672848"/>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83666944"/>
        <c:crosses val="autoZero"/>
        <c:auto val="1"/>
        <c:lblAlgn val="ctr"/>
        <c:lblOffset val="100"/>
        <c:noMultiLvlLbl val="0"/>
      </c:catAx>
      <c:valAx>
        <c:axId val="483666944"/>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US"/>
                  <a:t>TPM </a:t>
                </a:r>
              </a:p>
            </c:rich>
          </c:tx>
          <c:layout>
            <c:manualLayout>
              <c:xMode val="edge"/>
              <c:yMode val="edge"/>
              <c:x val="4.0492523906805196E-2"/>
              <c:y val="0.30001787644128808"/>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48367284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1EDADCB-2055-4B10-8B09-177121045534}" type="datetimeFigureOut">
              <a:rPr lang="en-US" smtClean="0"/>
              <a:t>6/22/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8663C3E-7718-42B7-A92C-FE5D3647C418}" type="slidenum">
              <a:rPr lang="en-US" smtClean="0"/>
              <a:t>‹#›</a:t>
            </a:fld>
            <a:endParaRPr lang="en-US"/>
          </a:p>
        </p:txBody>
      </p:sp>
    </p:spTree>
    <p:extLst>
      <p:ext uri="{BB962C8B-B14F-4D97-AF65-F5344CB8AC3E}">
        <p14:creationId xmlns:p14="http://schemas.microsoft.com/office/powerpoint/2010/main" val="39764838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a:t>
            </a:r>
          </a:p>
        </p:txBody>
      </p:sp>
      <p:sp>
        <p:nvSpPr>
          <p:cNvPr id="4" name="Slide Number Placeholder 3"/>
          <p:cNvSpPr>
            <a:spLocks noGrp="1"/>
          </p:cNvSpPr>
          <p:nvPr>
            <p:ph type="sldNum" sz="quarter" idx="5"/>
          </p:nvPr>
        </p:nvSpPr>
        <p:spPr/>
        <p:txBody>
          <a:bodyPr/>
          <a:lstStyle/>
          <a:p>
            <a:fld id="{F8663C3E-7718-42B7-A92C-FE5D3647C418}" type="slidenum">
              <a:rPr lang="en-US" smtClean="0"/>
              <a:t>1</a:t>
            </a:fld>
            <a:endParaRPr lang="en-US"/>
          </a:p>
        </p:txBody>
      </p:sp>
    </p:spTree>
    <p:extLst>
      <p:ext uri="{BB962C8B-B14F-4D97-AF65-F5344CB8AC3E}">
        <p14:creationId xmlns:p14="http://schemas.microsoft.com/office/powerpoint/2010/main" val="13945533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9E37C09-13B2-4F2F-927D-6FC09CE67B0E}" type="slidenum">
              <a:rPr lang="en-US" smtClean="0"/>
              <a:t>4</a:t>
            </a:fld>
            <a:endParaRPr lang="en-US"/>
          </a:p>
        </p:txBody>
      </p:sp>
    </p:spTree>
    <p:extLst>
      <p:ext uri="{BB962C8B-B14F-4D97-AF65-F5344CB8AC3E}">
        <p14:creationId xmlns:p14="http://schemas.microsoft.com/office/powerpoint/2010/main" val="396127158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a:t>
            </a:r>
          </a:p>
        </p:txBody>
      </p:sp>
      <p:sp>
        <p:nvSpPr>
          <p:cNvPr id="4" name="Slide Number Placeholder 3"/>
          <p:cNvSpPr>
            <a:spLocks noGrp="1"/>
          </p:cNvSpPr>
          <p:nvPr>
            <p:ph type="sldNum" sz="quarter" idx="5"/>
          </p:nvPr>
        </p:nvSpPr>
        <p:spPr/>
        <p:txBody>
          <a:bodyPr/>
          <a:lstStyle/>
          <a:p>
            <a:fld id="{F8663C3E-7718-42B7-A92C-FE5D3647C418}" type="slidenum">
              <a:rPr lang="en-US" smtClean="0"/>
              <a:t>5</a:t>
            </a:fld>
            <a:endParaRPr lang="en-US"/>
          </a:p>
        </p:txBody>
      </p:sp>
    </p:spTree>
    <p:extLst>
      <p:ext uri="{BB962C8B-B14F-4D97-AF65-F5344CB8AC3E}">
        <p14:creationId xmlns:p14="http://schemas.microsoft.com/office/powerpoint/2010/main" val="41223404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D8AFFE-3BB4-4A63-893C-90E06021206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D4F3BF4-D4AA-44CF-BD0A-410050889DA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04F6540-9B4D-4336-8BEC-9265A9449539}"/>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88FB35D2-D9B1-4D3D-9C62-D49A9B55D1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EB7ECF-DC79-4591-BA38-D06C0220F9B0}"/>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36568919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3C7652-E38C-4CBF-B81F-849A53BF6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FD65A56-1791-4C18-93E9-1EFEA9432EE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FEBF1BB-219E-4CE5-9AF5-CD158E9BE657}"/>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3EADE685-AE43-499E-BA33-3DA8EC2BBF7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95353F-3A6F-4B13-AB0B-F5ACD6EF8E7A}"/>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41017919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7EA0FA7-5F41-4DC7-BD80-725FA15023F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72F7F3C-FB57-4313-B68D-1D6F0AAE6B1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EDD121-2162-464B-A1C0-BFCB1B6D81CF}"/>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A3D25492-1EEB-485A-B4DA-65029CF92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C1AE3D-5ADD-451B-B32F-4C0DB7F4E5F9}"/>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13608420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A44BD5-A29E-404E-BFBB-A41AF502470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4C44AD-7D61-4EAE-BE8E-DC3FF86A3FF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D410413-C98D-4F16-88DA-8BA0A2FDF601}"/>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6B6B4063-5E45-4421-8280-7146067D81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BB2AD8-195F-432C-A4E2-2C2588914CF6}"/>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36976165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3D42A-288B-4892-9C25-7955A3B3C45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268557C-CA44-46C0-AD45-1631F3AFAA3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4EBE2DE-02A7-43F6-86A4-C4BCC3A22F9D}"/>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C6FA1C66-AD1E-4935-9955-F737D727C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85966D-3006-4449-AF40-C081E8F9E68D}"/>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25119086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915D8C-5C8B-4CEF-8A43-24FC9795E2E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5AF47C8-8AFF-4493-9A9C-31719EE7CA9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D21D5F7-9959-4CF1-A6F2-6D3C49AAE79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E4DEAC0-DD7B-4A44-B626-47B01C0A5257}"/>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6" name="Footer Placeholder 5">
            <a:extLst>
              <a:ext uri="{FF2B5EF4-FFF2-40B4-BE49-F238E27FC236}">
                <a16:creationId xmlns:a16="http://schemas.microsoft.com/office/drawing/2014/main" id="{26E5B6C1-00F6-4EFB-A64C-7863787BE4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2B9009-CDD9-4460-86C3-D2CB998616BA}"/>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15859606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C0FEA7-6347-41CA-9F84-1298091AE9E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838EDFA-E22A-4D2C-9811-E2204888CC4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157A361-F96B-412D-B87B-0FE907C0F14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353661D-0E4F-4EC0-B5C9-4C42F0924C2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BAA766E-77D9-4F45-B245-2A731FEC0B7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E513FBF-C0CA-46BF-8090-4DA46CB4FC5F}"/>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8" name="Footer Placeholder 7">
            <a:extLst>
              <a:ext uri="{FF2B5EF4-FFF2-40B4-BE49-F238E27FC236}">
                <a16:creationId xmlns:a16="http://schemas.microsoft.com/office/drawing/2014/main" id="{E29643B2-7645-4DCE-A591-A9F6D4D1415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F64107D-3951-4E2D-908E-134D7ED03848}"/>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35973398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6527A0-E1AB-4272-B2FE-359B8D23BFD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300B065-02FC-4081-B4B9-9821D774CC41}"/>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4" name="Footer Placeholder 3">
            <a:extLst>
              <a:ext uri="{FF2B5EF4-FFF2-40B4-BE49-F238E27FC236}">
                <a16:creationId xmlns:a16="http://schemas.microsoft.com/office/drawing/2014/main" id="{ECE1D5D9-01DA-4E34-ACFA-C19C241AE4B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02C5452-0891-4BFD-B0D8-C493B3AEEA37}"/>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36782330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6F12F57-80C0-47EA-8B84-78C9426484A0}"/>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3" name="Footer Placeholder 2">
            <a:extLst>
              <a:ext uri="{FF2B5EF4-FFF2-40B4-BE49-F238E27FC236}">
                <a16:creationId xmlns:a16="http://schemas.microsoft.com/office/drawing/2014/main" id="{0EF2CB78-53E2-4837-B94D-50D612A3023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A9F51BE-BC9C-41E1-907A-BFC5F39B03F8}"/>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1618432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84B522-A851-4D57-B142-9FECE77280D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BCB39E6-3A83-488A-B188-CC65CDCCFEA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17FD0F6-3ABC-4C86-989A-E1198C90E3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1A90661-9297-46A4-8BDB-CA02C2EBD56B}"/>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6" name="Footer Placeholder 5">
            <a:extLst>
              <a:ext uri="{FF2B5EF4-FFF2-40B4-BE49-F238E27FC236}">
                <a16:creationId xmlns:a16="http://schemas.microsoft.com/office/drawing/2014/main" id="{858EC710-2D83-425F-BE2A-CF87C7244A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EC7B3AF-622E-4339-AE36-392A214D6E6D}"/>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1166145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6F92AF-E3C8-473D-9CA1-2568BF55B8F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2CA4258-0AAA-4DB5-BE99-3DDA3C9391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9CC700D-4D60-44A8-87E1-9CF153B9F2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A1ACC71-B9FE-427B-AC1D-B4A8FE74A8A1}"/>
              </a:ext>
            </a:extLst>
          </p:cNvPr>
          <p:cNvSpPr>
            <a:spLocks noGrp="1"/>
          </p:cNvSpPr>
          <p:nvPr>
            <p:ph type="dt" sz="half" idx="10"/>
          </p:nvPr>
        </p:nvSpPr>
        <p:spPr/>
        <p:txBody>
          <a:bodyPr/>
          <a:lstStyle/>
          <a:p>
            <a:fld id="{9AD2BDB7-3DAB-42FE-83A0-93EB32AC6B1E}" type="datetimeFigureOut">
              <a:rPr lang="en-US" smtClean="0"/>
              <a:t>6/22/2022</a:t>
            </a:fld>
            <a:endParaRPr lang="en-US"/>
          </a:p>
        </p:txBody>
      </p:sp>
      <p:sp>
        <p:nvSpPr>
          <p:cNvPr id="6" name="Footer Placeholder 5">
            <a:extLst>
              <a:ext uri="{FF2B5EF4-FFF2-40B4-BE49-F238E27FC236}">
                <a16:creationId xmlns:a16="http://schemas.microsoft.com/office/drawing/2014/main" id="{E098FBA2-F4ED-41AB-99D6-A036EC9F3E7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0C6789-B69A-45AF-A1E7-FE3A8895F527}"/>
              </a:ext>
            </a:extLst>
          </p:cNvPr>
          <p:cNvSpPr>
            <a:spLocks noGrp="1"/>
          </p:cNvSpPr>
          <p:nvPr>
            <p:ph type="sldNum" sz="quarter" idx="12"/>
          </p:nvPr>
        </p:nvSpPr>
        <p:spPr/>
        <p:txBody>
          <a:bodyPr/>
          <a:lstStyle/>
          <a:p>
            <a:fld id="{8CAC74C4-F0D1-421E-8479-1098B74C29BC}" type="slidenum">
              <a:rPr lang="en-US" smtClean="0"/>
              <a:t>‹#›</a:t>
            </a:fld>
            <a:endParaRPr lang="en-US"/>
          </a:p>
        </p:txBody>
      </p:sp>
    </p:spTree>
    <p:extLst>
      <p:ext uri="{BB962C8B-B14F-4D97-AF65-F5344CB8AC3E}">
        <p14:creationId xmlns:p14="http://schemas.microsoft.com/office/powerpoint/2010/main" val="27793046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CA8EF8C-4393-43A4-AA5B-B704B1EEB0D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7CCC278-F71A-4325-A11E-F739F33E35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5C69ADD-66BF-4C55-84DF-90C7614EEB4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D2BDB7-3DAB-42FE-83A0-93EB32AC6B1E}" type="datetimeFigureOut">
              <a:rPr lang="en-US" smtClean="0"/>
              <a:t>6/22/2022</a:t>
            </a:fld>
            <a:endParaRPr lang="en-US"/>
          </a:p>
        </p:txBody>
      </p:sp>
      <p:sp>
        <p:nvSpPr>
          <p:cNvPr id="5" name="Footer Placeholder 4">
            <a:extLst>
              <a:ext uri="{FF2B5EF4-FFF2-40B4-BE49-F238E27FC236}">
                <a16:creationId xmlns:a16="http://schemas.microsoft.com/office/drawing/2014/main" id="{156A2B51-D530-4908-9455-0A496F7E40E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4C442F3-77E0-4234-8FF8-32A551A18E2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AC74C4-F0D1-421E-8479-1098B74C29BC}" type="slidenum">
              <a:rPr lang="en-US" smtClean="0"/>
              <a:t>‹#›</a:t>
            </a:fld>
            <a:endParaRPr lang="en-US"/>
          </a:p>
        </p:txBody>
      </p:sp>
    </p:spTree>
    <p:extLst>
      <p:ext uri="{BB962C8B-B14F-4D97-AF65-F5344CB8AC3E}">
        <p14:creationId xmlns:p14="http://schemas.microsoft.com/office/powerpoint/2010/main" val="12489903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1126EB88-28CD-4B9E-99FD-9095D9E1C2DD}"/>
              </a:ext>
            </a:extLst>
          </p:cNvPr>
          <p:cNvGraphicFramePr>
            <a:graphicFrameLocks/>
          </p:cNvGraphicFramePr>
          <p:nvPr>
            <p:extLst>
              <p:ext uri="{D42A27DB-BD31-4B8C-83A1-F6EECF244321}">
                <p14:modId xmlns:p14="http://schemas.microsoft.com/office/powerpoint/2010/main" val="55755654"/>
              </p:ext>
            </p:extLst>
          </p:nvPr>
        </p:nvGraphicFramePr>
        <p:xfrm>
          <a:off x="726302" y="2317750"/>
          <a:ext cx="2570199" cy="322306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a:extLst>
              <a:ext uri="{FF2B5EF4-FFF2-40B4-BE49-F238E27FC236}">
                <a16:creationId xmlns:a16="http://schemas.microsoft.com/office/drawing/2014/main" id="{8461EFB3-125F-4A8C-9BB9-15E525D07071}"/>
              </a:ext>
            </a:extLst>
          </p:cNvPr>
          <p:cNvGraphicFramePr>
            <a:graphicFrameLocks/>
          </p:cNvGraphicFramePr>
          <p:nvPr>
            <p:extLst>
              <p:ext uri="{D42A27DB-BD31-4B8C-83A1-F6EECF244321}">
                <p14:modId xmlns:p14="http://schemas.microsoft.com/office/powerpoint/2010/main" val="2421742005"/>
              </p:ext>
            </p:extLst>
          </p:nvPr>
        </p:nvGraphicFramePr>
        <p:xfrm>
          <a:off x="3299269" y="2317750"/>
          <a:ext cx="2570199" cy="322306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a:extLst>
              <a:ext uri="{FF2B5EF4-FFF2-40B4-BE49-F238E27FC236}">
                <a16:creationId xmlns:a16="http://schemas.microsoft.com/office/drawing/2014/main" id="{B8BF5A40-FB34-4E4C-AF2E-4E34FBB6C309}"/>
              </a:ext>
            </a:extLst>
          </p:cNvPr>
          <p:cNvGraphicFramePr>
            <a:graphicFrameLocks/>
          </p:cNvGraphicFramePr>
          <p:nvPr>
            <p:extLst>
              <p:ext uri="{D42A27DB-BD31-4B8C-83A1-F6EECF244321}">
                <p14:modId xmlns:p14="http://schemas.microsoft.com/office/powerpoint/2010/main" val="1752864731"/>
              </p:ext>
            </p:extLst>
          </p:nvPr>
        </p:nvGraphicFramePr>
        <p:xfrm>
          <a:off x="5869468" y="2317750"/>
          <a:ext cx="2570199" cy="322306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a:extLst>
              <a:ext uri="{FF2B5EF4-FFF2-40B4-BE49-F238E27FC236}">
                <a16:creationId xmlns:a16="http://schemas.microsoft.com/office/drawing/2014/main" id="{8DFE45D0-B106-467B-B65C-E3F13AEB97D3}"/>
              </a:ext>
            </a:extLst>
          </p:cNvPr>
          <p:cNvGraphicFramePr>
            <a:graphicFrameLocks/>
          </p:cNvGraphicFramePr>
          <p:nvPr>
            <p:extLst>
              <p:ext uri="{D42A27DB-BD31-4B8C-83A1-F6EECF244321}">
                <p14:modId xmlns:p14="http://schemas.microsoft.com/office/powerpoint/2010/main" val="2372412519"/>
              </p:ext>
            </p:extLst>
          </p:nvPr>
        </p:nvGraphicFramePr>
        <p:xfrm>
          <a:off x="8440402" y="2317750"/>
          <a:ext cx="2504778" cy="3223068"/>
        </p:xfrm>
        <a:graphic>
          <a:graphicData uri="http://schemas.openxmlformats.org/drawingml/2006/chart">
            <c:chart xmlns:c="http://schemas.openxmlformats.org/drawingml/2006/chart" xmlns:r="http://schemas.openxmlformats.org/officeDocument/2006/relationships" r:id="rId6"/>
          </a:graphicData>
        </a:graphic>
      </p:graphicFrame>
      <p:sp>
        <p:nvSpPr>
          <p:cNvPr id="8" name="TextBox 7">
            <a:extLst>
              <a:ext uri="{FF2B5EF4-FFF2-40B4-BE49-F238E27FC236}">
                <a16:creationId xmlns:a16="http://schemas.microsoft.com/office/drawing/2014/main" id="{E1C32CE9-6DE9-43B3-83FA-0B29EACDF6C5}"/>
              </a:ext>
            </a:extLst>
          </p:cNvPr>
          <p:cNvSpPr txBox="1"/>
          <p:nvPr/>
        </p:nvSpPr>
        <p:spPr>
          <a:xfrm>
            <a:off x="268771" y="757590"/>
            <a:ext cx="11654458" cy="830997"/>
          </a:xfrm>
          <a:prstGeom prst="rect">
            <a:avLst/>
          </a:prstGeom>
          <a:noFill/>
        </p:spPr>
        <p:txBody>
          <a:bodyPr wrap="square">
            <a:spAutoFit/>
          </a:bodyPr>
          <a:lstStyle/>
          <a:p>
            <a:r>
              <a:rPr lang="en-US" sz="1600" b="1" i="0" dirty="0">
                <a:solidFill>
                  <a:srgbClr val="333333"/>
                </a:solidFill>
                <a:effectLst/>
                <a:latin typeface="Times New Roman" panose="02020603050405020304" pitchFamily="18" charset="0"/>
                <a:cs typeface="Times New Roman" panose="02020603050405020304" pitchFamily="18" charset="0"/>
              </a:rPr>
              <a:t>Figure S1. </a:t>
            </a:r>
            <a:r>
              <a:rPr lang="en-US" sz="1600" i="0" dirty="0">
                <a:solidFill>
                  <a:srgbClr val="333333"/>
                </a:solidFill>
                <a:effectLst/>
                <a:latin typeface="Times New Roman" panose="02020603050405020304" pitchFamily="18" charset="0"/>
                <a:cs typeface="Times New Roman" panose="02020603050405020304" pitchFamily="18" charset="0"/>
              </a:rPr>
              <a:t>Comparison of agronomic traits between WT Bowman and its NIL BW387 carrying the </a:t>
            </a:r>
            <a:r>
              <a:rPr lang="en-US" sz="1600" i="1" dirty="0">
                <a:solidFill>
                  <a:srgbClr val="333333"/>
                </a:solidFill>
                <a:effectLst/>
                <a:latin typeface="Times New Roman" panose="02020603050405020304" pitchFamily="18" charset="0"/>
                <a:cs typeface="Times New Roman" panose="02020603050405020304" pitchFamily="18" charset="0"/>
              </a:rPr>
              <a:t>lig1</a:t>
            </a:r>
            <a:r>
              <a:rPr lang="en-US" sz="1600" i="0" dirty="0">
                <a:solidFill>
                  <a:srgbClr val="333333"/>
                </a:solidFill>
                <a:effectLst/>
                <a:latin typeface="Times New Roman" panose="02020603050405020304" pitchFamily="18" charset="0"/>
                <a:cs typeface="Times New Roman" panose="02020603050405020304" pitchFamily="18" charset="0"/>
              </a:rPr>
              <a:t> mutation. </a:t>
            </a:r>
            <a:r>
              <a:rPr lang="en-US" sz="1600" dirty="0">
                <a:solidFill>
                  <a:srgbClr val="333333"/>
                </a:solidFill>
                <a:latin typeface="Times New Roman" panose="02020603050405020304" pitchFamily="18" charset="0"/>
                <a:cs typeface="Times New Roman" panose="02020603050405020304" pitchFamily="18" charset="0"/>
              </a:rPr>
              <a:t>No significant difference was identified in height (A, n = 10), tiller number/plant (B, n = 20), seed/number/spike (C, n = 20), and 100-seed weight (D, n = 7). </a:t>
            </a:r>
            <a:r>
              <a:rPr lang="en-US" sz="1600" i="0" dirty="0">
                <a:solidFill>
                  <a:srgbClr val="333333"/>
                </a:solidFill>
                <a:effectLst/>
                <a:latin typeface="Times New Roman" panose="02020603050405020304" pitchFamily="18" charset="0"/>
                <a:cs typeface="Times New Roman" panose="02020603050405020304" pitchFamily="18" charset="0"/>
              </a:rPr>
              <a:t>Same letters on bar graphs indicate insignificant at 0.05 level by T-test. </a:t>
            </a:r>
            <a:endParaRPr lang="en-US" sz="1600"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8FCFBE82-350D-4F58-8E39-EFDE2BA53F88}"/>
              </a:ext>
            </a:extLst>
          </p:cNvPr>
          <p:cNvSpPr txBox="1"/>
          <p:nvPr/>
        </p:nvSpPr>
        <p:spPr>
          <a:xfrm>
            <a:off x="1857802" y="3093750"/>
            <a:ext cx="312001" cy="276999"/>
          </a:xfrm>
          <a:prstGeom prst="rect">
            <a:avLst/>
          </a:prstGeom>
          <a:noFill/>
        </p:spPr>
        <p:txBody>
          <a:bodyPr wrap="square">
            <a:spAutoFit/>
          </a:bodyPr>
          <a:lstStyle/>
          <a:p>
            <a:r>
              <a:rPr lang="en-US" sz="1200" dirty="0"/>
              <a:t>a</a:t>
            </a:r>
          </a:p>
        </p:txBody>
      </p:sp>
      <p:sp>
        <p:nvSpPr>
          <p:cNvPr id="11" name="TextBox 10">
            <a:extLst>
              <a:ext uri="{FF2B5EF4-FFF2-40B4-BE49-F238E27FC236}">
                <a16:creationId xmlns:a16="http://schemas.microsoft.com/office/drawing/2014/main" id="{34C67E29-790D-4845-A2EE-C9DBF6772E22}"/>
              </a:ext>
            </a:extLst>
          </p:cNvPr>
          <p:cNvSpPr txBox="1"/>
          <p:nvPr/>
        </p:nvSpPr>
        <p:spPr>
          <a:xfrm>
            <a:off x="2696002" y="2984174"/>
            <a:ext cx="312001" cy="276999"/>
          </a:xfrm>
          <a:prstGeom prst="rect">
            <a:avLst/>
          </a:prstGeom>
          <a:noFill/>
        </p:spPr>
        <p:txBody>
          <a:bodyPr wrap="square">
            <a:spAutoFit/>
          </a:bodyPr>
          <a:lstStyle/>
          <a:p>
            <a:r>
              <a:rPr lang="en-US" sz="1200" dirty="0"/>
              <a:t>a</a:t>
            </a:r>
          </a:p>
        </p:txBody>
      </p:sp>
      <p:sp>
        <p:nvSpPr>
          <p:cNvPr id="12" name="TextBox 11">
            <a:extLst>
              <a:ext uri="{FF2B5EF4-FFF2-40B4-BE49-F238E27FC236}">
                <a16:creationId xmlns:a16="http://schemas.microsoft.com/office/drawing/2014/main" id="{E375B6E2-2A71-446E-ACF4-13C440C5CA17}"/>
              </a:ext>
            </a:extLst>
          </p:cNvPr>
          <p:cNvSpPr txBox="1"/>
          <p:nvPr/>
        </p:nvSpPr>
        <p:spPr>
          <a:xfrm>
            <a:off x="4364418" y="2945080"/>
            <a:ext cx="312001" cy="276999"/>
          </a:xfrm>
          <a:prstGeom prst="rect">
            <a:avLst/>
          </a:prstGeom>
          <a:noFill/>
        </p:spPr>
        <p:txBody>
          <a:bodyPr wrap="square">
            <a:spAutoFit/>
          </a:bodyPr>
          <a:lstStyle/>
          <a:p>
            <a:r>
              <a:rPr lang="en-US" sz="1200" dirty="0"/>
              <a:t>a</a:t>
            </a:r>
          </a:p>
        </p:txBody>
      </p:sp>
      <p:sp>
        <p:nvSpPr>
          <p:cNvPr id="13" name="TextBox 12">
            <a:extLst>
              <a:ext uri="{FF2B5EF4-FFF2-40B4-BE49-F238E27FC236}">
                <a16:creationId xmlns:a16="http://schemas.microsoft.com/office/drawing/2014/main" id="{113CDD8D-230F-4321-86DD-AF3C302A5CF7}"/>
              </a:ext>
            </a:extLst>
          </p:cNvPr>
          <p:cNvSpPr txBox="1"/>
          <p:nvPr/>
        </p:nvSpPr>
        <p:spPr>
          <a:xfrm>
            <a:off x="5221819" y="2992757"/>
            <a:ext cx="312001" cy="276999"/>
          </a:xfrm>
          <a:prstGeom prst="rect">
            <a:avLst/>
          </a:prstGeom>
          <a:noFill/>
        </p:spPr>
        <p:txBody>
          <a:bodyPr wrap="square">
            <a:spAutoFit/>
          </a:bodyPr>
          <a:lstStyle/>
          <a:p>
            <a:r>
              <a:rPr lang="en-US" sz="1200" dirty="0"/>
              <a:t>a</a:t>
            </a:r>
          </a:p>
        </p:txBody>
      </p:sp>
      <p:sp>
        <p:nvSpPr>
          <p:cNvPr id="14" name="TextBox 13">
            <a:extLst>
              <a:ext uri="{FF2B5EF4-FFF2-40B4-BE49-F238E27FC236}">
                <a16:creationId xmlns:a16="http://schemas.microsoft.com/office/drawing/2014/main" id="{25230A61-9A24-49F4-AD94-75699FAC69FE}"/>
              </a:ext>
            </a:extLst>
          </p:cNvPr>
          <p:cNvSpPr txBox="1"/>
          <p:nvPr/>
        </p:nvSpPr>
        <p:spPr>
          <a:xfrm>
            <a:off x="6944331" y="3108366"/>
            <a:ext cx="312001" cy="276999"/>
          </a:xfrm>
          <a:prstGeom prst="rect">
            <a:avLst/>
          </a:prstGeom>
          <a:noFill/>
        </p:spPr>
        <p:txBody>
          <a:bodyPr wrap="square">
            <a:spAutoFit/>
          </a:bodyPr>
          <a:lstStyle/>
          <a:p>
            <a:r>
              <a:rPr lang="en-US" sz="1200" b="1" dirty="0"/>
              <a:t>a</a:t>
            </a:r>
          </a:p>
        </p:txBody>
      </p:sp>
      <p:sp>
        <p:nvSpPr>
          <p:cNvPr id="15" name="TextBox 14">
            <a:extLst>
              <a:ext uri="{FF2B5EF4-FFF2-40B4-BE49-F238E27FC236}">
                <a16:creationId xmlns:a16="http://schemas.microsoft.com/office/drawing/2014/main" id="{E2A3D281-D9B9-4359-AD99-7A12CFFC2469}"/>
              </a:ext>
            </a:extLst>
          </p:cNvPr>
          <p:cNvSpPr txBox="1"/>
          <p:nvPr/>
        </p:nvSpPr>
        <p:spPr>
          <a:xfrm>
            <a:off x="7815189" y="3074992"/>
            <a:ext cx="312001" cy="276999"/>
          </a:xfrm>
          <a:prstGeom prst="rect">
            <a:avLst/>
          </a:prstGeom>
          <a:noFill/>
        </p:spPr>
        <p:txBody>
          <a:bodyPr wrap="square">
            <a:spAutoFit/>
          </a:bodyPr>
          <a:lstStyle/>
          <a:p>
            <a:r>
              <a:rPr lang="en-US" sz="1200" b="1" dirty="0"/>
              <a:t>a</a:t>
            </a:r>
          </a:p>
        </p:txBody>
      </p:sp>
      <p:sp>
        <p:nvSpPr>
          <p:cNvPr id="16" name="TextBox 15">
            <a:extLst>
              <a:ext uri="{FF2B5EF4-FFF2-40B4-BE49-F238E27FC236}">
                <a16:creationId xmlns:a16="http://schemas.microsoft.com/office/drawing/2014/main" id="{70EA226E-8A1D-4203-9757-3F9D004BBDDE}"/>
              </a:ext>
            </a:extLst>
          </p:cNvPr>
          <p:cNvSpPr txBox="1"/>
          <p:nvPr/>
        </p:nvSpPr>
        <p:spPr>
          <a:xfrm>
            <a:off x="9448042" y="2825334"/>
            <a:ext cx="312001" cy="276999"/>
          </a:xfrm>
          <a:prstGeom prst="rect">
            <a:avLst/>
          </a:prstGeom>
          <a:noFill/>
        </p:spPr>
        <p:txBody>
          <a:bodyPr wrap="square">
            <a:spAutoFit/>
          </a:bodyPr>
          <a:lstStyle/>
          <a:p>
            <a:r>
              <a:rPr lang="en-US" sz="1200" dirty="0"/>
              <a:t>a</a:t>
            </a:r>
          </a:p>
        </p:txBody>
      </p:sp>
      <p:sp>
        <p:nvSpPr>
          <p:cNvPr id="17" name="TextBox 16">
            <a:extLst>
              <a:ext uri="{FF2B5EF4-FFF2-40B4-BE49-F238E27FC236}">
                <a16:creationId xmlns:a16="http://schemas.microsoft.com/office/drawing/2014/main" id="{EE699132-1107-4D9A-8C5F-AAABD6A677AC}"/>
              </a:ext>
            </a:extLst>
          </p:cNvPr>
          <p:cNvSpPr txBox="1"/>
          <p:nvPr/>
        </p:nvSpPr>
        <p:spPr>
          <a:xfrm>
            <a:off x="10395102" y="2715758"/>
            <a:ext cx="312001" cy="276999"/>
          </a:xfrm>
          <a:prstGeom prst="rect">
            <a:avLst/>
          </a:prstGeom>
          <a:noFill/>
        </p:spPr>
        <p:txBody>
          <a:bodyPr wrap="square">
            <a:spAutoFit/>
          </a:bodyPr>
          <a:lstStyle/>
          <a:p>
            <a:r>
              <a:rPr lang="en-US" sz="1200" dirty="0"/>
              <a:t>a</a:t>
            </a:r>
          </a:p>
        </p:txBody>
      </p:sp>
      <p:sp>
        <p:nvSpPr>
          <p:cNvPr id="19" name="TextBox 18">
            <a:extLst>
              <a:ext uri="{FF2B5EF4-FFF2-40B4-BE49-F238E27FC236}">
                <a16:creationId xmlns:a16="http://schemas.microsoft.com/office/drawing/2014/main" id="{897F1763-2F2C-43BD-95B4-9F92881CFA6C}"/>
              </a:ext>
            </a:extLst>
          </p:cNvPr>
          <p:cNvSpPr txBox="1"/>
          <p:nvPr/>
        </p:nvSpPr>
        <p:spPr>
          <a:xfrm>
            <a:off x="687194" y="2249810"/>
            <a:ext cx="500743" cy="369332"/>
          </a:xfrm>
          <a:prstGeom prst="rect">
            <a:avLst/>
          </a:prstGeom>
          <a:noFill/>
        </p:spPr>
        <p:txBody>
          <a:bodyPr wrap="square">
            <a:spAutoFit/>
          </a:bodyPr>
          <a:lstStyle/>
          <a:p>
            <a:r>
              <a:rPr lang="en-US" b="1" dirty="0"/>
              <a:t>A</a:t>
            </a:r>
          </a:p>
        </p:txBody>
      </p:sp>
      <p:sp>
        <p:nvSpPr>
          <p:cNvPr id="20" name="TextBox 19">
            <a:extLst>
              <a:ext uri="{FF2B5EF4-FFF2-40B4-BE49-F238E27FC236}">
                <a16:creationId xmlns:a16="http://schemas.microsoft.com/office/drawing/2014/main" id="{790F631B-AFC4-4DFC-900C-1772E36890D0}"/>
              </a:ext>
            </a:extLst>
          </p:cNvPr>
          <p:cNvSpPr txBox="1"/>
          <p:nvPr/>
        </p:nvSpPr>
        <p:spPr>
          <a:xfrm>
            <a:off x="3266840" y="2249810"/>
            <a:ext cx="500743" cy="369332"/>
          </a:xfrm>
          <a:prstGeom prst="rect">
            <a:avLst/>
          </a:prstGeom>
          <a:noFill/>
        </p:spPr>
        <p:txBody>
          <a:bodyPr wrap="square">
            <a:spAutoFit/>
          </a:bodyPr>
          <a:lstStyle/>
          <a:p>
            <a:r>
              <a:rPr lang="en-US" b="1" dirty="0"/>
              <a:t>B</a:t>
            </a:r>
          </a:p>
        </p:txBody>
      </p:sp>
      <p:sp>
        <p:nvSpPr>
          <p:cNvPr id="21" name="TextBox 20">
            <a:extLst>
              <a:ext uri="{FF2B5EF4-FFF2-40B4-BE49-F238E27FC236}">
                <a16:creationId xmlns:a16="http://schemas.microsoft.com/office/drawing/2014/main" id="{CC392E81-18E2-47BF-8982-80C86BA0D11A}"/>
              </a:ext>
            </a:extLst>
          </p:cNvPr>
          <p:cNvSpPr txBox="1"/>
          <p:nvPr/>
        </p:nvSpPr>
        <p:spPr>
          <a:xfrm>
            <a:off x="5846486" y="2243859"/>
            <a:ext cx="500743" cy="369332"/>
          </a:xfrm>
          <a:prstGeom prst="rect">
            <a:avLst/>
          </a:prstGeom>
          <a:noFill/>
        </p:spPr>
        <p:txBody>
          <a:bodyPr wrap="square">
            <a:spAutoFit/>
          </a:bodyPr>
          <a:lstStyle/>
          <a:p>
            <a:r>
              <a:rPr lang="en-US" b="1" dirty="0"/>
              <a:t>C</a:t>
            </a:r>
          </a:p>
        </p:txBody>
      </p:sp>
      <p:sp>
        <p:nvSpPr>
          <p:cNvPr id="22" name="TextBox 21">
            <a:extLst>
              <a:ext uri="{FF2B5EF4-FFF2-40B4-BE49-F238E27FC236}">
                <a16:creationId xmlns:a16="http://schemas.microsoft.com/office/drawing/2014/main" id="{6E84DDA2-F23D-4E5E-B300-40E72399F14F}"/>
              </a:ext>
            </a:extLst>
          </p:cNvPr>
          <p:cNvSpPr txBox="1"/>
          <p:nvPr/>
        </p:nvSpPr>
        <p:spPr>
          <a:xfrm>
            <a:off x="8395833" y="2243859"/>
            <a:ext cx="500743" cy="369332"/>
          </a:xfrm>
          <a:prstGeom prst="rect">
            <a:avLst/>
          </a:prstGeom>
          <a:noFill/>
        </p:spPr>
        <p:txBody>
          <a:bodyPr wrap="square">
            <a:spAutoFit/>
          </a:bodyPr>
          <a:lstStyle/>
          <a:p>
            <a:r>
              <a:rPr lang="en-US" b="1" dirty="0"/>
              <a:t>D</a:t>
            </a:r>
          </a:p>
        </p:txBody>
      </p:sp>
    </p:spTree>
    <p:extLst>
      <p:ext uri="{BB962C8B-B14F-4D97-AF65-F5344CB8AC3E}">
        <p14:creationId xmlns:p14="http://schemas.microsoft.com/office/powerpoint/2010/main" val="33171376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 name="Picture 31">
            <a:extLst>
              <a:ext uri="{FF2B5EF4-FFF2-40B4-BE49-F238E27FC236}">
                <a16:creationId xmlns:a16="http://schemas.microsoft.com/office/drawing/2014/main" id="{9B5FC26D-2091-4B11-8195-3875F8DFCCEA}"/>
              </a:ext>
            </a:extLst>
          </p:cNvPr>
          <p:cNvPicPr>
            <a:picLocks noChangeAspect="1"/>
          </p:cNvPicPr>
          <p:nvPr/>
        </p:nvPicPr>
        <p:blipFill>
          <a:blip r:embed="rId2"/>
          <a:stretch>
            <a:fillRect/>
          </a:stretch>
        </p:blipFill>
        <p:spPr>
          <a:xfrm>
            <a:off x="2070184" y="5024278"/>
            <a:ext cx="8582025" cy="1009650"/>
          </a:xfrm>
          <a:prstGeom prst="rect">
            <a:avLst/>
          </a:prstGeom>
        </p:spPr>
      </p:pic>
      <p:sp>
        <p:nvSpPr>
          <p:cNvPr id="33" name="TextBox 32">
            <a:extLst>
              <a:ext uri="{FF2B5EF4-FFF2-40B4-BE49-F238E27FC236}">
                <a16:creationId xmlns:a16="http://schemas.microsoft.com/office/drawing/2014/main" id="{77A24B76-A729-4DC5-8F5A-2DB0F984B97A}"/>
              </a:ext>
            </a:extLst>
          </p:cNvPr>
          <p:cNvSpPr txBox="1"/>
          <p:nvPr/>
        </p:nvSpPr>
        <p:spPr>
          <a:xfrm>
            <a:off x="1251366" y="4961331"/>
            <a:ext cx="988938" cy="276999"/>
          </a:xfrm>
          <a:prstGeom prst="rect">
            <a:avLst/>
          </a:prstGeom>
          <a:noFill/>
        </p:spPr>
        <p:txBody>
          <a:bodyPr wrap="square">
            <a:spAutoFit/>
          </a:bodyPr>
          <a:lstStyle/>
          <a:p>
            <a:r>
              <a:rPr lang="en-US" sz="1200" dirty="0">
                <a:latin typeface="Cambria" panose="02040503050406030204" pitchFamily="18" charset="0"/>
                <a:ea typeface="Cambria" panose="02040503050406030204" pitchFamily="18" charset="0"/>
              </a:rPr>
              <a:t>HvSPL8</a:t>
            </a:r>
          </a:p>
        </p:txBody>
      </p:sp>
      <p:sp>
        <p:nvSpPr>
          <p:cNvPr id="34" name="TextBox 33">
            <a:extLst>
              <a:ext uri="{FF2B5EF4-FFF2-40B4-BE49-F238E27FC236}">
                <a16:creationId xmlns:a16="http://schemas.microsoft.com/office/drawing/2014/main" id="{89A6CE6C-E56F-4061-9F1A-069127A5E4C0}"/>
              </a:ext>
            </a:extLst>
          </p:cNvPr>
          <p:cNvSpPr txBox="1"/>
          <p:nvPr/>
        </p:nvSpPr>
        <p:spPr>
          <a:xfrm>
            <a:off x="1251366" y="5145746"/>
            <a:ext cx="988938" cy="276999"/>
          </a:xfrm>
          <a:prstGeom prst="rect">
            <a:avLst/>
          </a:prstGeom>
          <a:noFill/>
        </p:spPr>
        <p:txBody>
          <a:bodyPr wrap="square">
            <a:spAutoFit/>
          </a:bodyPr>
          <a:lstStyle/>
          <a:p>
            <a:r>
              <a:rPr lang="en-US" sz="1200" dirty="0">
                <a:latin typeface="Cambria" panose="02040503050406030204" pitchFamily="18" charset="0"/>
                <a:ea typeface="Cambria" panose="02040503050406030204" pitchFamily="18" charset="0"/>
              </a:rPr>
              <a:t>TaSPL8</a:t>
            </a:r>
          </a:p>
        </p:txBody>
      </p:sp>
      <p:sp>
        <p:nvSpPr>
          <p:cNvPr id="35" name="TextBox 34">
            <a:extLst>
              <a:ext uri="{FF2B5EF4-FFF2-40B4-BE49-F238E27FC236}">
                <a16:creationId xmlns:a16="http://schemas.microsoft.com/office/drawing/2014/main" id="{2D895EAE-B738-4D0C-82F6-46E78806A5F4}"/>
              </a:ext>
            </a:extLst>
          </p:cNvPr>
          <p:cNvSpPr txBox="1"/>
          <p:nvPr/>
        </p:nvSpPr>
        <p:spPr>
          <a:xfrm>
            <a:off x="1255126" y="5330161"/>
            <a:ext cx="988938" cy="276999"/>
          </a:xfrm>
          <a:prstGeom prst="rect">
            <a:avLst/>
          </a:prstGeom>
          <a:noFill/>
        </p:spPr>
        <p:txBody>
          <a:bodyPr wrap="square">
            <a:spAutoFit/>
          </a:bodyPr>
          <a:lstStyle/>
          <a:p>
            <a:r>
              <a:rPr lang="en-US" sz="1200" dirty="0">
                <a:latin typeface="Cambria" panose="02040503050406030204" pitchFamily="18" charset="0"/>
                <a:ea typeface="Cambria" panose="02040503050406030204" pitchFamily="18" charset="0"/>
              </a:rPr>
              <a:t>OsSPL8</a:t>
            </a:r>
          </a:p>
        </p:txBody>
      </p:sp>
      <p:sp>
        <p:nvSpPr>
          <p:cNvPr id="36" name="TextBox 35">
            <a:extLst>
              <a:ext uri="{FF2B5EF4-FFF2-40B4-BE49-F238E27FC236}">
                <a16:creationId xmlns:a16="http://schemas.microsoft.com/office/drawing/2014/main" id="{DBF3A838-897B-412E-AD15-4C8FB837AFF4}"/>
              </a:ext>
            </a:extLst>
          </p:cNvPr>
          <p:cNvSpPr txBox="1"/>
          <p:nvPr/>
        </p:nvSpPr>
        <p:spPr>
          <a:xfrm>
            <a:off x="1262106" y="5529198"/>
            <a:ext cx="988938" cy="276999"/>
          </a:xfrm>
          <a:prstGeom prst="rect">
            <a:avLst/>
          </a:prstGeom>
          <a:noFill/>
        </p:spPr>
        <p:txBody>
          <a:bodyPr wrap="square">
            <a:spAutoFit/>
          </a:bodyPr>
          <a:lstStyle/>
          <a:p>
            <a:r>
              <a:rPr lang="en-US" sz="1200" dirty="0">
                <a:latin typeface="Cambria" panose="02040503050406030204" pitchFamily="18" charset="0"/>
                <a:ea typeface="Cambria" panose="02040503050406030204" pitchFamily="18" charset="0"/>
              </a:rPr>
              <a:t>ZmLG1</a:t>
            </a:r>
          </a:p>
        </p:txBody>
      </p:sp>
      <p:sp>
        <p:nvSpPr>
          <p:cNvPr id="37" name="TextBox 36">
            <a:extLst>
              <a:ext uri="{FF2B5EF4-FFF2-40B4-BE49-F238E27FC236}">
                <a16:creationId xmlns:a16="http://schemas.microsoft.com/office/drawing/2014/main" id="{21A3EEC1-D831-4CEA-BE58-3F6F6C54B6C2}"/>
              </a:ext>
            </a:extLst>
          </p:cNvPr>
          <p:cNvSpPr txBox="1"/>
          <p:nvPr/>
        </p:nvSpPr>
        <p:spPr>
          <a:xfrm>
            <a:off x="1262938" y="5715252"/>
            <a:ext cx="988938" cy="276999"/>
          </a:xfrm>
          <a:prstGeom prst="rect">
            <a:avLst/>
          </a:prstGeom>
          <a:noFill/>
        </p:spPr>
        <p:txBody>
          <a:bodyPr wrap="square">
            <a:spAutoFit/>
          </a:bodyPr>
          <a:lstStyle/>
          <a:p>
            <a:r>
              <a:rPr lang="en-US" sz="1200" dirty="0">
                <a:latin typeface="Cambria" panose="02040503050406030204" pitchFamily="18" charset="0"/>
                <a:ea typeface="Cambria" panose="02040503050406030204" pitchFamily="18" charset="0"/>
              </a:rPr>
              <a:t>AtSPL8</a:t>
            </a:r>
          </a:p>
        </p:txBody>
      </p:sp>
      <p:sp>
        <p:nvSpPr>
          <p:cNvPr id="38" name="Rectangle 37">
            <a:extLst>
              <a:ext uri="{FF2B5EF4-FFF2-40B4-BE49-F238E27FC236}">
                <a16:creationId xmlns:a16="http://schemas.microsoft.com/office/drawing/2014/main" id="{0944D13C-54FA-43B8-BBC3-29B5FFE75A46}"/>
              </a:ext>
            </a:extLst>
          </p:cNvPr>
          <p:cNvSpPr/>
          <p:nvPr/>
        </p:nvSpPr>
        <p:spPr>
          <a:xfrm flipV="1">
            <a:off x="2070183" y="4913797"/>
            <a:ext cx="8582025" cy="45719"/>
          </a:xfrm>
          <a:prstGeom prst="rect">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a:p>
        </p:txBody>
      </p:sp>
      <p:sp>
        <p:nvSpPr>
          <p:cNvPr id="39" name="TextBox 38">
            <a:extLst>
              <a:ext uri="{FF2B5EF4-FFF2-40B4-BE49-F238E27FC236}">
                <a16:creationId xmlns:a16="http://schemas.microsoft.com/office/drawing/2014/main" id="{95CF3898-BB6B-412C-B065-75BFC472289E}"/>
              </a:ext>
            </a:extLst>
          </p:cNvPr>
          <p:cNvSpPr txBox="1"/>
          <p:nvPr/>
        </p:nvSpPr>
        <p:spPr>
          <a:xfrm>
            <a:off x="5807389" y="4633189"/>
            <a:ext cx="1384061" cy="307777"/>
          </a:xfrm>
          <a:prstGeom prst="rect">
            <a:avLst/>
          </a:prstGeom>
          <a:noFill/>
        </p:spPr>
        <p:txBody>
          <a:bodyPr wrap="square">
            <a:spAutoFit/>
          </a:bodyPr>
          <a:lstStyle/>
          <a:p>
            <a:r>
              <a:rPr lang="en-US" sz="1400" b="1" dirty="0">
                <a:latin typeface="Cambria" panose="02040503050406030204" pitchFamily="18" charset="0"/>
                <a:ea typeface="Cambria" panose="02040503050406030204" pitchFamily="18" charset="0"/>
              </a:rPr>
              <a:t>SBP domain</a:t>
            </a:r>
          </a:p>
        </p:txBody>
      </p:sp>
      <p:cxnSp>
        <p:nvCxnSpPr>
          <p:cNvPr id="40" name="Straight Connector 39">
            <a:extLst>
              <a:ext uri="{FF2B5EF4-FFF2-40B4-BE49-F238E27FC236}">
                <a16:creationId xmlns:a16="http://schemas.microsoft.com/office/drawing/2014/main" id="{AB1CABE9-60A7-4332-A43E-6D328985B38F}"/>
              </a:ext>
            </a:extLst>
          </p:cNvPr>
          <p:cNvCxnSpPr>
            <a:cxnSpLocks/>
          </p:cNvCxnSpPr>
          <p:nvPr/>
        </p:nvCxnSpPr>
        <p:spPr>
          <a:xfrm>
            <a:off x="2120907" y="6366834"/>
            <a:ext cx="2748187" cy="0"/>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AA870F86-3D05-46BA-B90E-A85661962AB5}"/>
              </a:ext>
            </a:extLst>
          </p:cNvPr>
          <p:cNvCxnSpPr>
            <a:cxnSpLocks/>
          </p:cNvCxnSpPr>
          <p:nvPr/>
        </p:nvCxnSpPr>
        <p:spPr>
          <a:xfrm>
            <a:off x="2120907" y="6032017"/>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3AB0FFAE-9AFA-4E18-86B1-FE88A43BFE6B}"/>
              </a:ext>
            </a:extLst>
          </p:cNvPr>
          <p:cNvCxnSpPr>
            <a:cxnSpLocks/>
          </p:cNvCxnSpPr>
          <p:nvPr/>
        </p:nvCxnSpPr>
        <p:spPr>
          <a:xfrm>
            <a:off x="2719874" y="6023631"/>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6512070E-123F-49F2-B5B8-951CB03E962D}"/>
              </a:ext>
            </a:extLst>
          </p:cNvPr>
          <p:cNvCxnSpPr>
            <a:cxnSpLocks/>
          </p:cNvCxnSpPr>
          <p:nvPr/>
        </p:nvCxnSpPr>
        <p:spPr>
          <a:xfrm>
            <a:off x="4658544" y="6032017"/>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4" name="Straight Connector 43">
            <a:extLst>
              <a:ext uri="{FF2B5EF4-FFF2-40B4-BE49-F238E27FC236}">
                <a16:creationId xmlns:a16="http://schemas.microsoft.com/office/drawing/2014/main" id="{62BA9983-333A-45F0-94A5-1E94EDB9ADF9}"/>
              </a:ext>
            </a:extLst>
          </p:cNvPr>
          <p:cNvCxnSpPr>
            <a:cxnSpLocks/>
          </p:cNvCxnSpPr>
          <p:nvPr/>
        </p:nvCxnSpPr>
        <p:spPr>
          <a:xfrm>
            <a:off x="4869094" y="6032016"/>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5" name="Straight Connector 44">
            <a:extLst>
              <a:ext uri="{FF2B5EF4-FFF2-40B4-BE49-F238E27FC236}">
                <a16:creationId xmlns:a16="http://schemas.microsoft.com/office/drawing/2014/main" id="{8742B4A1-04A3-44F0-B4CE-ABE220043032}"/>
              </a:ext>
            </a:extLst>
          </p:cNvPr>
          <p:cNvCxnSpPr>
            <a:cxnSpLocks/>
          </p:cNvCxnSpPr>
          <p:nvPr/>
        </p:nvCxnSpPr>
        <p:spPr>
          <a:xfrm>
            <a:off x="6931616" y="6372982"/>
            <a:ext cx="2196778" cy="2455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6" name="Straight Connector 45">
            <a:extLst>
              <a:ext uri="{FF2B5EF4-FFF2-40B4-BE49-F238E27FC236}">
                <a16:creationId xmlns:a16="http://schemas.microsoft.com/office/drawing/2014/main" id="{97C8592F-5FA8-4CCF-8703-6485971FAAF1}"/>
              </a:ext>
            </a:extLst>
          </p:cNvPr>
          <p:cNvCxnSpPr>
            <a:cxnSpLocks/>
          </p:cNvCxnSpPr>
          <p:nvPr/>
        </p:nvCxnSpPr>
        <p:spPr>
          <a:xfrm>
            <a:off x="6944544" y="6038165"/>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7" name="Straight Connector 46">
            <a:extLst>
              <a:ext uri="{FF2B5EF4-FFF2-40B4-BE49-F238E27FC236}">
                <a16:creationId xmlns:a16="http://schemas.microsoft.com/office/drawing/2014/main" id="{BF23A8AF-112E-4468-BE99-E8A45BDDB97A}"/>
              </a:ext>
            </a:extLst>
          </p:cNvPr>
          <p:cNvCxnSpPr>
            <a:cxnSpLocks/>
          </p:cNvCxnSpPr>
          <p:nvPr/>
        </p:nvCxnSpPr>
        <p:spPr>
          <a:xfrm>
            <a:off x="7741980" y="6029779"/>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8" name="Straight Connector 47">
            <a:extLst>
              <a:ext uri="{FF2B5EF4-FFF2-40B4-BE49-F238E27FC236}">
                <a16:creationId xmlns:a16="http://schemas.microsoft.com/office/drawing/2014/main" id="{FF3CFF44-B4BF-4F86-8BD5-DED17FFC3FCD}"/>
              </a:ext>
            </a:extLst>
          </p:cNvPr>
          <p:cNvCxnSpPr>
            <a:cxnSpLocks/>
          </p:cNvCxnSpPr>
          <p:nvPr/>
        </p:nvCxnSpPr>
        <p:spPr>
          <a:xfrm>
            <a:off x="7298958" y="6038165"/>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49" name="Straight Connector 48">
            <a:extLst>
              <a:ext uri="{FF2B5EF4-FFF2-40B4-BE49-F238E27FC236}">
                <a16:creationId xmlns:a16="http://schemas.microsoft.com/office/drawing/2014/main" id="{83764279-2293-4094-89A5-86D090512CB5}"/>
              </a:ext>
            </a:extLst>
          </p:cNvPr>
          <p:cNvCxnSpPr>
            <a:cxnSpLocks/>
          </p:cNvCxnSpPr>
          <p:nvPr/>
        </p:nvCxnSpPr>
        <p:spPr>
          <a:xfrm>
            <a:off x="9111491" y="6048325"/>
            <a:ext cx="0" cy="334817"/>
          </a:xfrm>
          <a:prstGeom prst="line">
            <a:avLst/>
          </a:prstGeom>
          <a:ln w="25400">
            <a:solidFill>
              <a:srgbClr val="FF0000"/>
            </a:solidFill>
          </a:ln>
        </p:spPr>
        <p:style>
          <a:lnRef idx="1">
            <a:schemeClr val="dk1"/>
          </a:lnRef>
          <a:fillRef idx="0">
            <a:schemeClr val="dk1"/>
          </a:fillRef>
          <a:effectRef idx="0">
            <a:schemeClr val="dk1"/>
          </a:effectRef>
          <a:fontRef idx="minor">
            <a:schemeClr val="tx1"/>
          </a:fontRef>
        </p:style>
      </p:cxnSp>
      <p:cxnSp>
        <p:nvCxnSpPr>
          <p:cNvPr id="50" name="Straight Connector 49">
            <a:extLst>
              <a:ext uri="{FF2B5EF4-FFF2-40B4-BE49-F238E27FC236}">
                <a16:creationId xmlns:a16="http://schemas.microsoft.com/office/drawing/2014/main" id="{27EB8523-F95C-4106-BF4D-405564A2E44A}"/>
              </a:ext>
            </a:extLst>
          </p:cNvPr>
          <p:cNvCxnSpPr>
            <a:cxnSpLocks/>
          </p:cNvCxnSpPr>
          <p:nvPr/>
        </p:nvCxnSpPr>
        <p:spPr>
          <a:xfrm>
            <a:off x="8889084" y="6593877"/>
            <a:ext cx="1733509" cy="13191"/>
          </a:xfrm>
          <a:prstGeom prst="line">
            <a:avLst/>
          </a:prstGeom>
          <a:ln w="25400">
            <a:solidFill>
              <a:srgbClr val="0000FF"/>
            </a:solidFill>
          </a:ln>
        </p:spPr>
        <p:style>
          <a:lnRef idx="1">
            <a:schemeClr val="dk1"/>
          </a:lnRef>
          <a:fillRef idx="0">
            <a:schemeClr val="dk1"/>
          </a:fillRef>
          <a:effectRef idx="0">
            <a:schemeClr val="dk1"/>
          </a:effectRef>
          <a:fontRef idx="minor">
            <a:schemeClr val="tx1"/>
          </a:fontRef>
        </p:style>
      </p:cxnSp>
      <p:cxnSp>
        <p:nvCxnSpPr>
          <p:cNvPr id="51" name="Straight Connector 50">
            <a:extLst>
              <a:ext uri="{FF2B5EF4-FFF2-40B4-BE49-F238E27FC236}">
                <a16:creationId xmlns:a16="http://schemas.microsoft.com/office/drawing/2014/main" id="{2D9853D5-9625-4B43-88CF-B313DDC91569}"/>
              </a:ext>
            </a:extLst>
          </p:cNvPr>
          <p:cNvCxnSpPr>
            <a:cxnSpLocks/>
          </p:cNvCxnSpPr>
          <p:nvPr/>
        </p:nvCxnSpPr>
        <p:spPr>
          <a:xfrm>
            <a:off x="8886573" y="6011783"/>
            <a:ext cx="0" cy="593150"/>
          </a:xfrm>
          <a:prstGeom prst="line">
            <a:avLst/>
          </a:prstGeom>
          <a:ln w="25400">
            <a:solidFill>
              <a:srgbClr val="0000FF"/>
            </a:solidFill>
          </a:ln>
        </p:spPr>
        <p:style>
          <a:lnRef idx="1">
            <a:schemeClr val="dk1"/>
          </a:lnRef>
          <a:fillRef idx="0">
            <a:schemeClr val="dk1"/>
          </a:fillRef>
          <a:effectRef idx="0">
            <a:schemeClr val="dk1"/>
          </a:effectRef>
          <a:fontRef idx="minor">
            <a:schemeClr val="tx1"/>
          </a:fontRef>
        </p:style>
      </p:cxnSp>
      <p:cxnSp>
        <p:nvCxnSpPr>
          <p:cNvPr id="52" name="Straight Connector 51">
            <a:extLst>
              <a:ext uri="{FF2B5EF4-FFF2-40B4-BE49-F238E27FC236}">
                <a16:creationId xmlns:a16="http://schemas.microsoft.com/office/drawing/2014/main" id="{4297ACDF-85C0-4987-AF58-299FE3ECD858}"/>
              </a:ext>
            </a:extLst>
          </p:cNvPr>
          <p:cNvCxnSpPr>
            <a:cxnSpLocks/>
          </p:cNvCxnSpPr>
          <p:nvPr/>
        </p:nvCxnSpPr>
        <p:spPr>
          <a:xfrm>
            <a:off x="10609680" y="6011783"/>
            <a:ext cx="0" cy="593150"/>
          </a:xfrm>
          <a:prstGeom prst="line">
            <a:avLst/>
          </a:prstGeom>
          <a:ln w="25400">
            <a:solidFill>
              <a:srgbClr val="0000FF"/>
            </a:solidFill>
          </a:ln>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472A017D-0015-4852-A108-99DB3C7D9201}"/>
              </a:ext>
            </a:extLst>
          </p:cNvPr>
          <p:cNvSpPr txBox="1"/>
          <p:nvPr/>
        </p:nvSpPr>
        <p:spPr>
          <a:xfrm>
            <a:off x="2944792" y="6304449"/>
            <a:ext cx="569159" cy="307777"/>
          </a:xfrm>
          <a:prstGeom prst="rect">
            <a:avLst/>
          </a:prstGeom>
          <a:noFill/>
        </p:spPr>
        <p:txBody>
          <a:bodyPr wrap="square">
            <a:spAutoFit/>
          </a:bodyPr>
          <a:lstStyle/>
          <a:p>
            <a:r>
              <a:rPr lang="en-US" sz="1400" b="1" dirty="0">
                <a:latin typeface="Cambria" panose="02040503050406030204" pitchFamily="18" charset="0"/>
                <a:ea typeface="Cambria" panose="02040503050406030204" pitchFamily="18" charset="0"/>
              </a:rPr>
              <a:t>Zn1</a:t>
            </a:r>
          </a:p>
        </p:txBody>
      </p:sp>
      <p:sp>
        <p:nvSpPr>
          <p:cNvPr id="54" name="TextBox 53">
            <a:extLst>
              <a:ext uri="{FF2B5EF4-FFF2-40B4-BE49-F238E27FC236}">
                <a16:creationId xmlns:a16="http://schemas.microsoft.com/office/drawing/2014/main" id="{256A1F56-CBCA-453A-916A-82BDD8E4766A}"/>
              </a:ext>
            </a:extLst>
          </p:cNvPr>
          <p:cNvSpPr txBox="1"/>
          <p:nvPr/>
        </p:nvSpPr>
        <p:spPr>
          <a:xfrm>
            <a:off x="7852900" y="6304449"/>
            <a:ext cx="569159" cy="307777"/>
          </a:xfrm>
          <a:prstGeom prst="rect">
            <a:avLst/>
          </a:prstGeom>
          <a:noFill/>
        </p:spPr>
        <p:txBody>
          <a:bodyPr wrap="square">
            <a:spAutoFit/>
          </a:bodyPr>
          <a:lstStyle/>
          <a:p>
            <a:r>
              <a:rPr lang="en-US" sz="1400" b="1" dirty="0">
                <a:latin typeface="Cambria" panose="02040503050406030204" pitchFamily="18" charset="0"/>
                <a:ea typeface="Cambria" panose="02040503050406030204" pitchFamily="18" charset="0"/>
              </a:rPr>
              <a:t>Zn1</a:t>
            </a:r>
          </a:p>
        </p:txBody>
      </p:sp>
      <p:sp>
        <p:nvSpPr>
          <p:cNvPr id="55" name="TextBox 54">
            <a:extLst>
              <a:ext uri="{FF2B5EF4-FFF2-40B4-BE49-F238E27FC236}">
                <a16:creationId xmlns:a16="http://schemas.microsoft.com/office/drawing/2014/main" id="{6AC55977-2C63-42C9-B5E1-0F8350EF00A9}"/>
              </a:ext>
            </a:extLst>
          </p:cNvPr>
          <p:cNvSpPr txBox="1"/>
          <p:nvPr/>
        </p:nvSpPr>
        <p:spPr>
          <a:xfrm>
            <a:off x="9484889" y="6551345"/>
            <a:ext cx="569159" cy="307777"/>
          </a:xfrm>
          <a:prstGeom prst="rect">
            <a:avLst/>
          </a:prstGeom>
          <a:noFill/>
        </p:spPr>
        <p:txBody>
          <a:bodyPr wrap="square">
            <a:spAutoFit/>
          </a:bodyPr>
          <a:lstStyle/>
          <a:p>
            <a:r>
              <a:rPr lang="en-US" sz="1400" b="1" dirty="0">
                <a:latin typeface="Cambria" panose="02040503050406030204" pitchFamily="18" charset="0"/>
                <a:ea typeface="Cambria" panose="02040503050406030204" pitchFamily="18" charset="0"/>
              </a:rPr>
              <a:t>NLS</a:t>
            </a:r>
          </a:p>
        </p:txBody>
      </p:sp>
      <p:sp>
        <p:nvSpPr>
          <p:cNvPr id="2" name="Rectangle 1">
            <a:extLst>
              <a:ext uri="{FF2B5EF4-FFF2-40B4-BE49-F238E27FC236}">
                <a16:creationId xmlns:a16="http://schemas.microsoft.com/office/drawing/2014/main" id="{A2F7D376-CEC0-4D66-B142-AEEB489FFC22}"/>
              </a:ext>
            </a:extLst>
          </p:cNvPr>
          <p:cNvSpPr/>
          <p:nvPr/>
        </p:nvSpPr>
        <p:spPr>
          <a:xfrm>
            <a:off x="751625" y="1619670"/>
            <a:ext cx="10306235" cy="5217064"/>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7" name="Straight Connector 56">
            <a:extLst>
              <a:ext uri="{FF2B5EF4-FFF2-40B4-BE49-F238E27FC236}">
                <a16:creationId xmlns:a16="http://schemas.microsoft.com/office/drawing/2014/main" id="{08E779B1-90CA-4359-BC50-8CBA26A4F260}"/>
              </a:ext>
            </a:extLst>
          </p:cNvPr>
          <p:cNvCxnSpPr>
            <a:cxnSpLocks/>
          </p:cNvCxnSpPr>
          <p:nvPr/>
        </p:nvCxnSpPr>
        <p:spPr>
          <a:xfrm>
            <a:off x="751625" y="4569391"/>
            <a:ext cx="1030623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127FACC4-AEA3-45C6-A512-B76CA41EF55B}"/>
              </a:ext>
            </a:extLst>
          </p:cNvPr>
          <p:cNvSpPr txBox="1"/>
          <p:nvPr/>
        </p:nvSpPr>
        <p:spPr>
          <a:xfrm>
            <a:off x="367421" y="355444"/>
            <a:ext cx="11654458" cy="1077218"/>
          </a:xfrm>
          <a:prstGeom prst="rect">
            <a:avLst/>
          </a:prstGeom>
          <a:noFill/>
        </p:spPr>
        <p:txBody>
          <a:bodyPr wrap="square">
            <a:spAutoFit/>
          </a:bodyPr>
          <a:lstStyle/>
          <a:p>
            <a:r>
              <a:rPr lang="en-US" sz="1600" b="1" i="0" dirty="0">
                <a:solidFill>
                  <a:srgbClr val="333333"/>
                </a:solidFill>
                <a:effectLst/>
                <a:latin typeface="Times New Roman" panose="02020603050405020304" pitchFamily="18" charset="0"/>
                <a:cs typeface="Times New Roman" panose="02020603050405020304" pitchFamily="18" charset="0"/>
              </a:rPr>
              <a:t>Figure S2. </a:t>
            </a:r>
            <a:r>
              <a:rPr lang="en-US" sz="1600" b="0" i="0" dirty="0">
                <a:solidFill>
                  <a:srgbClr val="333333"/>
                </a:solidFill>
                <a:effectLst/>
                <a:latin typeface="Times New Roman" panose="02020603050405020304" pitchFamily="18" charset="0"/>
                <a:cs typeface="Times New Roman" panose="02020603050405020304" pitchFamily="18" charset="0"/>
              </a:rPr>
              <a:t>Sequence alignment of HvSPL8 (HORVU.MOREX.r3.2HG0202650), TaSPL8 (TraesCS2D01G502900), OsSPL8 (Os04 g56170), ZmLG1 (U89496), and AtSPL8 </a:t>
            </a:r>
            <a:r>
              <a:rPr lang="en-US" sz="1600" b="0" i="0">
                <a:solidFill>
                  <a:srgbClr val="333333"/>
                </a:solidFill>
                <a:effectLst/>
                <a:latin typeface="Times New Roman" panose="02020603050405020304" pitchFamily="18" charset="0"/>
                <a:cs typeface="Times New Roman" panose="02020603050405020304" pitchFamily="18" charset="0"/>
              </a:rPr>
              <a:t>(At1g02065</a:t>
            </a:r>
            <a:r>
              <a:rPr lang="en-US" sz="1600" b="0" i="0" dirty="0">
                <a:solidFill>
                  <a:srgbClr val="333333"/>
                </a:solidFill>
                <a:effectLst/>
                <a:latin typeface="Times New Roman" panose="02020603050405020304" pitchFamily="18" charset="0"/>
                <a:cs typeface="Times New Roman" panose="02020603050405020304" pitchFamily="18" charset="0"/>
              </a:rPr>
              <a:t>). </a:t>
            </a:r>
            <a:r>
              <a:rPr lang="en-US" sz="1600" dirty="0">
                <a:solidFill>
                  <a:srgbClr val="333333"/>
                </a:solidFill>
                <a:latin typeface="Times New Roman" panose="02020603050405020304" pitchFamily="18" charset="0"/>
                <a:cs typeface="Times New Roman" panose="02020603050405020304" pitchFamily="18" charset="0"/>
              </a:rPr>
              <a:t>Protein sequences (A) and the SQUAMOSA promoter binding protein (SBP) domains</a:t>
            </a:r>
            <a:r>
              <a:rPr lang="en-US" sz="1600" b="0" i="0" dirty="0">
                <a:solidFill>
                  <a:srgbClr val="333333"/>
                </a:solidFill>
                <a:effectLst/>
                <a:latin typeface="Times New Roman" panose="02020603050405020304" pitchFamily="18" charset="0"/>
                <a:cs typeface="Times New Roman" panose="02020603050405020304" pitchFamily="18" charset="0"/>
              </a:rPr>
              <a:t> sequences (B) were aligned and depicted using </a:t>
            </a:r>
            <a:r>
              <a:rPr lang="en-US" sz="1600" b="0" i="0" dirty="0" err="1">
                <a:solidFill>
                  <a:srgbClr val="333333"/>
                </a:solidFill>
                <a:effectLst/>
                <a:latin typeface="Times New Roman" panose="02020603050405020304" pitchFamily="18" charset="0"/>
                <a:cs typeface="Times New Roman" panose="02020603050405020304" pitchFamily="18" charset="0"/>
              </a:rPr>
              <a:t>ClustalX</a:t>
            </a:r>
            <a:r>
              <a:rPr lang="en-US" sz="1600" b="0" i="0" dirty="0">
                <a:solidFill>
                  <a:srgbClr val="333333"/>
                </a:solidFill>
                <a:effectLst/>
                <a:latin typeface="Times New Roman" panose="02020603050405020304" pitchFamily="18" charset="0"/>
                <a:cs typeface="Times New Roman" panose="02020603050405020304" pitchFamily="18" charset="0"/>
              </a:rPr>
              <a:t>. </a:t>
            </a:r>
            <a:r>
              <a:rPr lang="en-US" sz="1600" dirty="0">
                <a:solidFill>
                  <a:srgbClr val="333333"/>
                </a:solidFill>
                <a:latin typeface="Times New Roman" panose="02020603050405020304" pitchFamily="18" charset="0"/>
                <a:cs typeface="Times New Roman" panose="02020603050405020304" pitchFamily="18" charset="0"/>
              </a:rPr>
              <a:t>T</a:t>
            </a:r>
            <a:r>
              <a:rPr lang="en-US" sz="1600" b="0" i="0" dirty="0">
                <a:solidFill>
                  <a:srgbClr val="333333"/>
                </a:solidFill>
                <a:effectLst/>
                <a:latin typeface="Times New Roman" panose="02020603050405020304" pitchFamily="18" charset="0"/>
                <a:cs typeface="Times New Roman" panose="02020603050405020304" pitchFamily="18" charset="0"/>
              </a:rPr>
              <a:t>he two zinc-finger structures (Zn1 and Zn2) and nuclear localization signal (NLS) are denoted</a:t>
            </a:r>
            <a:r>
              <a:rPr lang="en-US" sz="1600" dirty="0">
                <a:solidFill>
                  <a:srgbClr val="333333"/>
                </a:solidFill>
                <a:latin typeface="Times New Roman" panose="02020603050405020304" pitchFamily="18" charset="0"/>
                <a:cs typeface="Times New Roman" panose="02020603050405020304" pitchFamily="18" charset="0"/>
              </a:rPr>
              <a:t>. </a:t>
            </a:r>
            <a:endParaRPr lang="en-US" sz="1600" dirty="0">
              <a:latin typeface="Times New Roman" panose="02020603050405020304" pitchFamily="18" charset="0"/>
              <a:cs typeface="Times New Roman" panose="02020603050405020304" pitchFamily="18" charset="0"/>
            </a:endParaRPr>
          </a:p>
        </p:txBody>
      </p:sp>
      <p:sp>
        <p:nvSpPr>
          <p:cNvPr id="60" name="TextBox 59">
            <a:extLst>
              <a:ext uri="{FF2B5EF4-FFF2-40B4-BE49-F238E27FC236}">
                <a16:creationId xmlns:a16="http://schemas.microsoft.com/office/drawing/2014/main" id="{DD355DBD-69B4-4C1F-A384-0380D48C32B0}"/>
              </a:ext>
            </a:extLst>
          </p:cNvPr>
          <p:cNvSpPr txBox="1"/>
          <p:nvPr/>
        </p:nvSpPr>
        <p:spPr>
          <a:xfrm>
            <a:off x="956108" y="1831103"/>
            <a:ext cx="10101752" cy="2724272"/>
          </a:xfrm>
          <a:prstGeom prst="rect">
            <a:avLst/>
          </a:prstGeom>
          <a:noFill/>
        </p:spPr>
        <p:txBody>
          <a:bodyPr wrap="square">
            <a:spAutoFit/>
          </a:bodyPr>
          <a:lstStyle/>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TaSPL8          MMNLP-AAAGNSCDEFGYGAPNP----PPPSLFPIMDHQEGGGGIHREHD-HHHHHLGGYTLEPSSLALLPPSSHATIAAH-------SPHDILQFYHHPTSHHYLAAAAAGGNGSPYGQFGGGGTAGG-FQSYYHQ-QVGTGAP</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HvSPL8          MMNLP-AAAGNSCDEFGYGAPNP----PPPSLFPIMDHQEGGGGIHREHDHHHHHHLGGYSLEPSSLALLPPSSHATIAAH-------SPHDILQFYHHPTSHHYLAAAAAGGNGSPYGQFGGGGGGGGGFQSYYHQ-QPGTGAP</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OsSPL8          MMNVPSAAAASSCDDFGYNATPP----PPPSLLPIMDQDGGGGSIQRDHHHHHNHQQLGYNLEPSSLALLPPSNAAAAAAHHATIAHASPHDLLQFYPTSHYLAAAGGAGGGGNPYSHFTAAAAAG--STFQSYYQ--QPPQAAP</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ZmLG1           MMNLS--AAANGRDEFPPYVVPSNAAAPPPSLLPTMEQQ------QESSIHREHHQLLGYNLEANSLALLPPSNAAAAHHHTTFAGGHSPHDILHFYTPPPSAASHYLAAAAGNPYSHLVSAPGTTFHQTSSSYYPPAAAAQAAP</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AtSPL8          MLDYEWDNPSSIVLSGDERNPDSDPTRSSFSFFDPISHYNNDHRHITISPPLLSSFSNQQQQHHLTLYGQTNSNNQFLHHHHHHHSLYGSTTTTTPYGASDPIYHPHSSAPPASLFSYDQTGPGSGSGSSYNFLIPK-----TEV</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                *::     ...   .       .    .. *::  :.:                        .  :*   . *.      *       ..      *  .        :.  ..  .:   . .       .             </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 </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TaSPL8          EYYFPTLVSSAEENMASFAATQLGLNLGYRTYFPPRGGYTYGHHPPRCQAEGCKADLSGAKRYHRRHKVCEHHSKAPVVVTAGGLHQRFCQQCSRFHLLDEFDDAKKSCRKRLADHNRRRRKSKPSE-ADAADKRRTQASKAAS-</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HvSPL8          EYYFPTLVSSAEENMASFAATQLGLNLGYRTYFPPRGGYTYGHHPPRCQAEGCKADLSGAKRYHRRHKVCEHHSKAPVVVTAGGLHQRFCQQCSRFHLLDEFDDAKKSCRKRLADHNRRRRKSKPSD-ADAADKRRTQASKAAAS</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OsSPL8          EYYFPTLVSSAEENMASFAATQLGLNLGYRTYFPPRGGYTYGHHPPRCQAEGCKADLSSAKRYHRRHKVCEHHSKAPVVVTAGGLHQRFCQQCSRFHLLDEFDDAKKSCRKRLADHNRRRRKSKPSDGEHSGEKRRAQANKSAA-</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ZmLG1           EYYFPTLVSSAEENMASFAATQLGLNLGYRTYFPPRGGYTYGHHPPRCQAEGCKADLSSAKRYHRRHKVCEHHSKAPVVVTAGGLHQRFCQQCSRFHLLDEFDDAKKSCRKRLADHNRRRRKSKPSD-ADAGDKKRAHANKAAA-</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AtSPL8          DFTSNRIGLNLGGRTYFSAADDDFVSRLYRRSRPGESGMANSLSTPRCQAEGCNADLSHAKHYHRRHKVCEFHSKASTVVAAG-LSQRFCQQCSRFHLLSEFDNGKRSCRKRLADHNRRRRKCHQSASATQDTGTGKTTPKSPND</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                ::    :  .   .    ** :  :.  **   * ..* : .  .********:**** **:*********.****..**:** * *************.***:.*:***************.: *            : *:.  </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 </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TaSPL8          TKGKAAGSSSKSTGTGDGMDIQVQLGSGDLSKNQDETMGLGEVVKEMQVDPKGKASMQ----QQQGHHGHGLHLQS--QHGFPFPSSSAGSCFPQSQAVSSTHNTSNIGQVQQEQPGLG--FHQHSNILQLGQAMFDLDFDH</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HvSPL8          TKGKAAGSSSKSTGTGDGMDIQVQLGSGDLSKDQDETMGQGEVVKEMQVDPKGKASMQLQQQQQQGHHVHGLHLQS--QHGFPFPSTSAGSCFPQSQAVSSTDNTSNIGQVQQEQLGLG--FHQHSNILQLGQAMFDLDFDH</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OsSPL8          TKDKAG-SSSKNAGIGDGFETQL-LGGAHMSKDQDQAMDLGEVVKEA-VDPKGKASMQ----QQQQQAHHGIHQQSHQQHGFPFPSSSGSCLFPQSQGAVSSTDTSNIAQVQEPSLAFHQQHHQHSNILQLGQAMFDLDFDH</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ZmLG1           AKDKAE-SSSKNMDIGDGLGAQI-LGSALLSKEQDQTMDLGEVVKEA-VDPKGKASMQ----QH---------------YGFPFHSSSAGSCFPQTQ-AVSSDTTSNIGQVQEPSLGFHHQHHQHSNILQLGQAMFDLDFDH</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AtSPL8          SGVKASSSPSSNA-----------------------------------------------------------------------PPTISLECFRQRQFQTTASSSTSASSS--------------SNSMFFSSG--------</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800" kern="1200" dirty="0">
                <a:solidFill>
                  <a:srgbClr val="000000"/>
                </a:solidFill>
                <a:effectLst/>
                <a:latin typeface="Courier New" panose="02070309020205020404" pitchFamily="49" charset="0"/>
                <a:ea typeface="Calibri" panose="020F0502020204030204" pitchFamily="34" charset="0"/>
                <a:cs typeface="Times New Roman" panose="02020603050405020304" pitchFamily="18" charset="0"/>
              </a:rPr>
              <a:t>                :  **  *.*..                                                                         .: .   * * *   ::  ::. ..               ** : :...        </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1" name="TextBox 30">
            <a:extLst>
              <a:ext uri="{FF2B5EF4-FFF2-40B4-BE49-F238E27FC236}">
                <a16:creationId xmlns:a16="http://schemas.microsoft.com/office/drawing/2014/main" id="{EDC0EEEA-8676-4C02-819C-7BEE3980EFF6}"/>
              </a:ext>
            </a:extLst>
          </p:cNvPr>
          <p:cNvSpPr txBox="1"/>
          <p:nvPr/>
        </p:nvSpPr>
        <p:spPr>
          <a:xfrm>
            <a:off x="751625" y="1585018"/>
            <a:ext cx="632675" cy="338554"/>
          </a:xfrm>
          <a:prstGeom prst="rect">
            <a:avLst/>
          </a:prstGeom>
          <a:noFill/>
        </p:spPr>
        <p:txBody>
          <a:bodyPr wrap="square">
            <a:spAutoFit/>
          </a:bodyPr>
          <a:lstStyle/>
          <a:p>
            <a:r>
              <a:rPr lang="en-US" sz="1600" b="1" dirty="0">
                <a:solidFill>
                  <a:srgbClr val="333333"/>
                </a:solidFill>
                <a:latin typeface="Times New Roman" panose="02020603050405020304" pitchFamily="18" charset="0"/>
                <a:cs typeface="Times New Roman" panose="02020603050405020304" pitchFamily="18" charset="0"/>
              </a:rPr>
              <a:t>A</a:t>
            </a:r>
            <a:endParaRPr lang="en-US" sz="1600" b="1" dirty="0"/>
          </a:p>
        </p:txBody>
      </p:sp>
      <p:sp>
        <p:nvSpPr>
          <p:cNvPr id="56" name="TextBox 55">
            <a:extLst>
              <a:ext uri="{FF2B5EF4-FFF2-40B4-BE49-F238E27FC236}">
                <a16:creationId xmlns:a16="http://schemas.microsoft.com/office/drawing/2014/main" id="{AC55C9CE-FB5E-4553-BB50-F9A580E554ED}"/>
              </a:ext>
            </a:extLst>
          </p:cNvPr>
          <p:cNvSpPr txBox="1"/>
          <p:nvPr/>
        </p:nvSpPr>
        <p:spPr>
          <a:xfrm>
            <a:off x="751625" y="4606020"/>
            <a:ext cx="632675" cy="338554"/>
          </a:xfrm>
          <a:prstGeom prst="rect">
            <a:avLst/>
          </a:prstGeom>
          <a:noFill/>
        </p:spPr>
        <p:txBody>
          <a:bodyPr wrap="square">
            <a:spAutoFit/>
          </a:bodyPr>
          <a:lstStyle/>
          <a:p>
            <a:r>
              <a:rPr lang="en-US" sz="1600" b="1" dirty="0">
                <a:solidFill>
                  <a:srgbClr val="333333"/>
                </a:solidFill>
                <a:latin typeface="Times New Roman" panose="02020603050405020304" pitchFamily="18" charset="0"/>
                <a:cs typeface="Times New Roman" panose="02020603050405020304" pitchFamily="18" charset="0"/>
              </a:rPr>
              <a:t>B</a:t>
            </a:r>
            <a:endParaRPr lang="en-US" sz="1600" b="1" dirty="0"/>
          </a:p>
        </p:txBody>
      </p:sp>
    </p:spTree>
    <p:extLst>
      <p:ext uri="{BB962C8B-B14F-4D97-AF65-F5344CB8AC3E}">
        <p14:creationId xmlns:p14="http://schemas.microsoft.com/office/powerpoint/2010/main" val="22009065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Connector 3">
            <a:extLst>
              <a:ext uri="{FF2B5EF4-FFF2-40B4-BE49-F238E27FC236}">
                <a16:creationId xmlns:a16="http://schemas.microsoft.com/office/drawing/2014/main" id="{4D125AA6-BA27-490B-882C-B9EA0E1E05CD}"/>
              </a:ext>
            </a:extLst>
          </p:cNvPr>
          <p:cNvCxnSpPr>
            <a:cxnSpLocks/>
          </p:cNvCxnSpPr>
          <p:nvPr/>
        </p:nvCxnSpPr>
        <p:spPr>
          <a:xfrm flipH="1">
            <a:off x="984491" y="2644830"/>
            <a:ext cx="7539231" cy="0"/>
          </a:xfrm>
          <a:prstGeom prst="line">
            <a:avLst/>
          </a:prstGeom>
          <a:ln w="254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F9A1E287-8B50-4D93-9955-9708520C546D}"/>
              </a:ext>
            </a:extLst>
          </p:cNvPr>
          <p:cNvCxnSpPr>
            <a:cxnSpLocks/>
          </p:cNvCxnSpPr>
          <p:nvPr/>
        </p:nvCxnSpPr>
        <p:spPr>
          <a:xfrm flipH="1">
            <a:off x="5520712" y="2644763"/>
            <a:ext cx="2190719" cy="0"/>
          </a:xfrm>
          <a:prstGeom prst="straightConnector1">
            <a:avLst/>
          </a:prstGeom>
          <a:ln w="25400">
            <a:solidFill>
              <a:srgbClr val="0000FF"/>
            </a:solidFill>
            <a:tailEnd type="triangle"/>
          </a:ln>
        </p:spPr>
        <p:style>
          <a:lnRef idx="1">
            <a:schemeClr val="accent1"/>
          </a:lnRef>
          <a:fillRef idx="0">
            <a:schemeClr val="accent1"/>
          </a:fillRef>
          <a:effectRef idx="0">
            <a:schemeClr val="accent1"/>
          </a:effectRef>
          <a:fontRef idx="minor">
            <a:schemeClr val="tx1"/>
          </a:fontRef>
        </p:style>
      </p:cxnSp>
      <p:sp>
        <p:nvSpPr>
          <p:cNvPr id="6" name="Rectangle 5">
            <a:extLst>
              <a:ext uri="{FF2B5EF4-FFF2-40B4-BE49-F238E27FC236}">
                <a16:creationId xmlns:a16="http://schemas.microsoft.com/office/drawing/2014/main" id="{EBABDFAB-9059-4DE4-9E1E-ACE8458AAE51}"/>
              </a:ext>
            </a:extLst>
          </p:cNvPr>
          <p:cNvSpPr/>
          <p:nvPr/>
        </p:nvSpPr>
        <p:spPr>
          <a:xfrm flipH="1">
            <a:off x="6986363" y="2557371"/>
            <a:ext cx="263173" cy="174084"/>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7" name="Rectangle 6">
            <a:extLst>
              <a:ext uri="{FF2B5EF4-FFF2-40B4-BE49-F238E27FC236}">
                <a16:creationId xmlns:a16="http://schemas.microsoft.com/office/drawing/2014/main" id="{E8ACE48E-D164-4B9D-B329-565028B27A2C}"/>
              </a:ext>
            </a:extLst>
          </p:cNvPr>
          <p:cNvSpPr/>
          <p:nvPr/>
        </p:nvSpPr>
        <p:spPr>
          <a:xfrm flipH="1">
            <a:off x="6475502" y="2568932"/>
            <a:ext cx="173906" cy="14975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8" name="Rectangle 7">
            <a:extLst>
              <a:ext uri="{FF2B5EF4-FFF2-40B4-BE49-F238E27FC236}">
                <a16:creationId xmlns:a16="http://schemas.microsoft.com/office/drawing/2014/main" id="{C5C55104-D522-41DB-93F6-DF80B525D13B}"/>
              </a:ext>
            </a:extLst>
          </p:cNvPr>
          <p:cNvSpPr/>
          <p:nvPr/>
        </p:nvSpPr>
        <p:spPr>
          <a:xfrm flipH="1">
            <a:off x="6011988" y="2561444"/>
            <a:ext cx="184117" cy="16473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9" name="Arrow: Right 8">
            <a:extLst>
              <a:ext uri="{FF2B5EF4-FFF2-40B4-BE49-F238E27FC236}">
                <a16:creationId xmlns:a16="http://schemas.microsoft.com/office/drawing/2014/main" id="{4B135AEC-B398-4ACF-BBE7-8743B5D02C41}"/>
              </a:ext>
            </a:extLst>
          </p:cNvPr>
          <p:cNvSpPr/>
          <p:nvPr/>
        </p:nvSpPr>
        <p:spPr>
          <a:xfrm flipH="1">
            <a:off x="7185058" y="2806598"/>
            <a:ext cx="90948" cy="37391"/>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0" name="Arrow: Right 9">
            <a:extLst>
              <a:ext uri="{FF2B5EF4-FFF2-40B4-BE49-F238E27FC236}">
                <a16:creationId xmlns:a16="http://schemas.microsoft.com/office/drawing/2014/main" id="{173A45CE-7FAA-4927-AF0B-23A32A8CA548}"/>
              </a:ext>
            </a:extLst>
          </p:cNvPr>
          <p:cNvSpPr/>
          <p:nvPr/>
        </p:nvSpPr>
        <p:spPr>
          <a:xfrm rot="10800000" flipH="1">
            <a:off x="6986708" y="2806457"/>
            <a:ext cx="90948" cy="37391"/>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1" name="Arrow: Right 10">
            <a:extLst>
              <a:ext uri="{FF2B5EF4-FFF2-40B4-BE49-F238E27FC236}">
                <a16:creationId xmlns:a16="http://schemas.microsoft.com/office/drawing/2014/main" id="{18F8A3AF-FAE9-4577-817B-6D511413DA65}"/>
              </a:ext>
            </a:extLst>
          </p:cNvPr>
          <p:cNvSpPr/>
          <p:nvPr/>
        </p:nvSpPr>
        <p:spPr>
          <a:xfrm rot="10800000" flipH="1">
            <a:off x="5887980" y="2813578"/>
            <a:ext cx="90948" cy="33992"/>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2" name="Arrow: Right 11">
            <a:extLst>
              <a:ext uri="{FF2B5EF4-FFF2-40B4-BE49-F238E27FC236}">
                <a16:creationId xmlns:a16="http://schemas.microsoft.com/office/drawing/2014/main" id="{3F0DCC11-D4CB-4F1C-B9FB-E1394721C0E0}"/>
              </a:ext>
            </a:extLst>
          </p:cNvPr>
          <p:cNvSpPr/>
          <p:nvPr/>
        </p:nvSpPr>
        <p:spPr>
          <a:xfrm flipH="1">
            <a:off x="6605859" y="2806851"/>
            <a:ext cx="90948" cy="41130"/>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3" name="Rectangle 12">
            <a:extLst>
              <a:ext uri="{FF2B5EF4-FFF2-40B4-BE49-F238E27FC236}">
                <a16:creationId xmlns:a16="http://schemas.microsoft.com/office/drawing/2014/main" id="{DB5A4933-CF11-4AB5-932B-84BDCBFFB809}"/>
              </a:ext>
            </a:extLst>
          </p:cNvPr>
          <p:cNvSpPr/>
          <p:nvPr/>
        </p:nvSpPr>
        <p:spPr>
          <a:xfrm flipH="1">
            <a:off x="6963752" y="2505530"/>
            <a:ext cx="501875" cy="276999"/>
          </a:xfrm>
          <a:prstGeom prst="rect">
            <a:avLst/>
          </a:prstGeom>
        </p:spPr>
        <p:txBody>
          <a:bodyPr wrap="square">
            <a:spAutoFit/>
          </a:bodyPr>
          <a:lstStyle/>
          <a:p>
            <a:pPr defTabSz="896241"/>
            <a:r>
              <a:rPr lang="en-US" sz="1200" kern="0" dirty="0">
                <a:cs typeface="Times New Roman" panose="02020603050405020304" pitchFamily="18" charset="0"/>
              </a:rPr>
              <a:t>E1</a:t>
            </a:r>
          </a:p>
        </p:txBody>
      </p:sp>
      <p:sp>
        <p:nvSpPr>
          <p:cNvPr id="14" name="Rectangle 13">
            <a:extLst>
              <a:ext uri="{FF2B5EF4-FFF2-40B4-BE49-F238E27FC236}">
                <a16:creationId xmlns:a16="http://schemas.microsoft.com/office/drawing/2014/main" id="{C77BFB50-48AD-469A-94BB-E0CA2135C184}"/>
              </a:ext>
            </a:extLst>
          </p:cNvPr>
          <p:cNvSpPr/>
          <p:nvPr/>
        </p:nvSpPr>
        <p:spPr>
          <a:xfrm flipH="1">
            <a:off x="6397141" y="2499876"/>
            <a:ext cx="492191" cy="276999"/>
          </a:xfrm>
          <a:prstGeom prst="rect">
            <a:avLst/>
          </a:prstGeom>
        </p:spPr>
        <p:txBody>
          <a:bodyPr wrap="square">
            <a:spAutoFit/>
          </a:bodyPr>
          <a:lstStyle/>
          <a:p>
            <a:pPr defTabSz="896241"/>
            <a:r>
              <a:rPr lang="en-US" sz="1200" kern="0" dirty="0">
                <a:cs typeface="Times New Roman" panose="02020603050405020304" pitchFamily="18" charset="0"/>
              </a:rPr>
              <a:t>E2</a:t>
            </a:r>
          </a:p>
        </p:txBody>
      </p:sp>
      <p:sp>
        <p:nvSpPr>
          <p:cNvPr id="15" name="Rectangle 14">
            <a:extLst>
              <a:ext uri="{FF2B5EF4-FFF2-40B4-BE49-F238E27FC236}">
                <a16:creationId xmlns:a16="http://schemas.microsoft.com/office/drawing/2014/main" id="{A018B8A4-9BE6-43F5-8604-A76D00BD4949}"/>
              </a:ext>
            </a:extLst>
          </p:cNvPr>
          <p:cNvSpPr/>
          <p:nvPr/>
        </p:nvSpPr>
        <p:spPr>
          <a:xfrm flipH="1">
            <a:off x="5940732" y="2507016"/>
            <a:ext cx="361092" cy="276999"/>
          </a:xfrm>
          <a:prstGeom prst="rect">
            <a:avLst/>
          </a:prstGeom>
          <a:ln>
            <a:noFill/>
          </a:ln>
        </p:spPr>
        <p:txBody>
          <a:bodyPr wrap="square">
            <a:spAutoFit/>
          </a:bodyPr>
          <a:lstStyle/>
          <a:p>
            <a:pPr defTabSz="896241"/>
            <a:r>
              <a:rPr lang="en-US" sz="1200" kern="0" dirty="0">
                <a:cs typeface="Times New Roman" panose="02020603050405020304" pitchFamily="18" charset="0"/>
              </a:rPr>
              <a:t>E3</a:t>
            </a:r>
          </a:p>
        </p:txBody>
      </p:sp>
      <p:sp>
        <p:nvSpPr>
          <p:cNvPr id="16" name="Rectangle 15">
            <a:extLst>
              <a:ext uri="{FF2B5EF4-FFF2-40B4-BE49-F238E27FC236}">
                <a16:creationId xmlns:a16="http://schemas.microsoft.com/office/drawing/2014/main" id="{6A338B3F-3120-4AD4-AB0F-C8525465A3A2}"/>
              </a:ext>
            </a:extLst>
          </p:cNvPr>
          <p:cNvSpPr/>
          <p:nvPr/>
        </p:nvSpPr>
        <p:spPr>
          <a:xfrm flipH="1">
            <a:off x="6747363" y="2433516"/>
            <a:ext cx="501875" cy="276999"/>
          </a:xfrm>
          <a:prstGeom prst="rect">
            <a:avLst/>
          </a:prstGeom>
        </p:spPr>
        <p:txBody>
          <a:bodyPr wrap="square">
            <a:spAutoFit/>
          </a:bodyPr>
          <a:lstStyle/>
          <a:p>
            <a:pPr defTabSz="896241"/>
            <a:r>
              <a:rPr lang="en-US" sz="1200" kern="0" dirty="0">
                <a:cs typeface="Times New Roman" panose="02020603050405020304" pitchFamily="18" charset="0"/>
              </a:rPr>
              <a:t>I1</a:t>
            </a:r>
          </a:p>
        </p:txBody>
      </p:sp>
      <p:sp>
        <p:nvSpPr>
          <p:cNvPr id="17" name="Rectangle 16">
            <a:extLst>
              <a:ext uri="{FF2B5EF4-FFF2-40B4-BE49-F238E27FC236}">
                <a16:creationId xmlns:a16="http://schemas.microsoft.com/office/drawing/2014/main" id="{7BCB8FE6-3364-4258-ABBC-830200CB5BB0}"/>
              </a:ext>
            </a:extLst>
          </p:cNvPr>
          <p:cNvSpPr/>
          <p:nvPr/>
        </p:nvSpPr>
        <p:spPr>
          <a:xfrm flipH="1">
            <a:off x="6226979" y="2430370"/>
            <a:ext cx="454140" cy="276999"/>
          </a:xfrm>
          <a:prstGeom prst="rect">
            <a:avLst/>
          </a:prstGeom>
        </p:spPr>
        <p:txBody>
          <a:bodyPr wrap="square">
            <a:spAutoFit/>
          </a:bodyPr>
          <a:lstStyle/>
          <a:p>
            <a:pPr defTabSz="896241"/>
            <a:r>
              <a:rPr lang="en-US" sz="1200" kern="0" dirty="0">
                <a:cs typeface="Times New Roman" panose="02020603050405020304" pitchFamily="18" charset="0"/>
              </a:rPr>
              <a:t>I2</a:t>
            </a:r>
          </a:p>
        </p:txBody>
      </p:sp>
      <p:sp>
        <p:nvSpPr>
          <p:cNvPr id="18" name="Arrow: Right 17">
            <a:extLst>
              <a:ext uri="{FF2B5EF4-FFF2-40B4-BE49-F238E27FC236}">
                <a16:creationId xmlns:a16="http://schemas.microsoft.com/office/drawing/2014/main" id="{1A2AD85E-926D-46FD-9F1A-397E8FF2CC67}"/>
              </a:ext>
            </a:extLst>
          </p:cNvPr>
          <p:cNvSpPr/>
          <p:nvPr/>
        </p:nvSpPr>
        <p:spPr>
          <a:xfrm rot="10800000" flipH="1">
            <a:off x="6837319" y="2806458"/>
            <a:ext cx="90948" cy="37391"/>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9" name="Rectangle 18">
            <a:extLst>
              <a:ext uri="{FF2B5EF4-FFF2-40B4-BE49-F238E27FC236}">
                <a16:creationId xmlns:a16="http://schemas.microsoft.com/office/drawing/2014/main" id="{9D59066D-222A-4B6F-A461-683A2AEB6E10}"/>
              </a:ext>
            </a:extLst>
          </p:cNvPr>
          <p:cNvSpPr/>
          <p:nvPr/>
        </p:nvSpPr>
        <p:spPr>
          <a:xfrm>
            <a:off x="5767561" y="2824730"/>
            <a:ext cx="2529242" cy="276999"/>
          </a:xfrm>
          <a:prstGeom prst="rect">
            <a:avLst/>
          </a:prstGeom>
        </p:spPr>
        <p:txBody>
          <a:bodyPr wrap="square">
            <a:spAutoFit/>
          </a:bodyPr>
          <a:lstStyle/>
          <a:p>
            <a:pPr defTabSz="896241"/>
            <a:r>
              <a:rPr lang="en-US" sz="1200" kern="0" dirty="0">
                <a:cs typeface="Times New Roman" panose="02020603050405020304" pitchFamily="18" charset="0"/>
              </a:rPr>
              <a:t>R1               F2  R3  R2  F1</a:t>
            </a:r>
          </a:p>
        </p:txBody>
      </p:sp>
      <p:sp>
        <p:nvSpPr>
          <p:cNvPr id="20" name="TextBox 19">
            <a:extLst>
              <a:ext uri="{FF2B5EF4-FFF2-40B4-BE49-F238E27FC236}">
                <a16:creationId xmlns:a16="http://schemas.microsoft.com/office/drawing/2014/main" id="{B1D598EA-1B00-444B-AA63-AC9937D782A8}"/>
              </a:ext>
            </a:extLst>
          </p:cNvPr>
          <p:cNvSpPr txBox="1"/>
          <p:nvPr/>
        </p:nvSpPr>
        <p:spPr>
          <a:xfrm>
            <a:off x="7194624" y="2421273"/>
            <a:ext cx="716542" cy="277000"/>
          </a:xfrm>
          <a:prstGeom prst="rect">
            <a:avLst/>
          </a:prstGeom>
          <a:noFill/>
        </p:spPr>
        <p:txBody>
          <a:bodyPr wrap="square">
            <a:spAutoFit/>
          </a:bodyPr>
          <a:lstStyle/>
          <a:p>
            <a:r>
              <a:rPr lang="en-US" sz="1200" kern="0" dirty="0">
                <a:cs typeface="Times New Roman" panose="02020603050405020304" pitchFamily="18" charset="0"/>
              </a:rPr>
              <a:t>5’ UTR</a:t>
            </a:r>
            <a:endParaRPr lang="en-US" sz="1200" dirty="0"/>
          </a:p>
        </p:txBody>
      </p:sp>
      <p:sp>
        <p:nvSpPr>
          <p:cNvPr id="21" name="TextBox 20">
            <a:extLst>
              <a:ext uri="{FF2B5EF4-FFF2-40B4-BE49-F238E27FC236}">
                <a16:creationId xmlns:a16="http://schemas.microsoft.com/office/drawing/2014/main" id="{410C12DF-EA62-45B1-9E8A-24F8D153CF43}"/>
              </a:ext>
            </a:extLst>
          </p:cNvPr>
          <p:cNvSpPr txBox="1"/>
          <p:nvPr/>
        </p:nvSpPr>
        <p:spPr>
          <a:xfrm>
            <a:off x="5498365" y="2421274"/>
            <a:ext cx="842093" cy="276999"/>
          </a:xfrm>
          <a:prstGeom prst="rect">
            <a:avLst/>
          </a:prstGeom>
          <a:noFill/>
        </p:spPr>
        <p:txBody>
          <a:bodyPr wrap="square">
            <a:spAutoFit/>
          </a:bodyPr>
          <a:lstStyle/>
          <a:p>
            <a:r>
              <a:rPr lang="en-US" sz="1200" kern="0" dirty="0">
                <a:cs typeface="Times New Roman" panose="02020603050405020304" pitchFamily="18" charset="0"/>
              </a:rPr>
              <a:t>3’ UTR</a:t>
            </a:r>
            <a:endParaRPr lang="en-US" sz="1200" dirty="0"/>
          </a:p>
        </p:txBody>
      </p:sp>
      <p:cxnSp>
        <p:nvCxnSpPr>
          <p:cNvPr id="22" name="Straight Arrow Connector 21">
            <a:extLst>
              <a:ext uri="{FF2B5EF4-FFF2-40B4-BE49-F238E27FC236}">
                <a16:creationId xmlns:a16="http://schemas.microsoft.com/office/drawing/2014/main" id="{B9569366-2062-4C0E-9A57-9DFBDDFB9384}"/>
              </a:ext>
            </a:extLst>
          </p:cNvPr>
          <p:cNvCxnSpPr>
            <a:cxnSpLocks/>
          </p:cNvCxnSpPr>
          <p:nvPr/>
        </p:nvCxnSpPr>
        <p:spPr>
          <a:xfrm flipH="1">
            <a:off x="1594283" y="2645997"/>
            <a:ext cx="2580178" cy="0"/>
          </a:xfrm>
          <a:prstGeom prst="straightConnector1">
            <a:avLst/>
          </a:prstGeom>
          <a:ln w="25400">
            <a:solidFill>
              <a:srgbClr val="0000FF"/>
            </a:solidFill>
            <a:tailEnd type="triangle"/>
          </a:ln>
        </p:spPr>
        <p:style>
          <a:lnRef idx="1">
            <a:schemeClr val="accent1"/>
          </a:lnRef>
          <a:fillRef idx="0">
            <a:schemeClr val="accent1"/>
          </a:fillRef>
          <a:effectRef idx="0">
            <a:schemeClr val="accent1"/>
          </a:effectRef>
          <a:fontRef idx="minor">
            <a:schemeClr val="tx1"/>
          </a:fontRef>
        </p:style>
      </p:cxnSp>
      <p:sp>
        <p:nvSpPr>
          <p:cNvPr id="23" name="Rectangle 22">
            <a:extLst>
              <a:ext uri="{FF2B5EF4-FFF2-40B4-BE49-F238E27FC236}">
                <a16:creationId xmlns:a16="http://schemas.microsoft.com/office/drawing/2014/main" id="{9678172C-DAD8-4225-9157-C796BB2BC932}"/>
              </a:ext>
            </a:extLst>
          </p:cNvPr>
          <p:cNvSpPr/>
          <p:nvPr/>
        </p:nvSpPr>
        <p:spPr>
          <a:xfrm flipH="1">
            <a:off x="3463645" y="2557735"/>
            <a:ext cx="217498" cy="175825"/>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24" name="Rectangle 23">
            <a:extLst>
              <a:ext uri="{FF2B5EF4-FFF2-40B4-BE49-F238E27FC236}">
                <a16:creationId xmlns:a16="http://schemas.microsoft.com/office/drawing/2014/main" id="{30A92E5A-3B0A-45E8-A9B1-0684CA5E8505}"/>
              </a:ext>
            </a:extLst>
          </p:cNvPr>
          <p:cNvSpPr/>
          <p:nvPr/>
        </p:nvSpPr>
        <p:spPr>
          <a:xfrm flipH="1">
            <a:off x="3134001" y="2562678"/>
            <a:ext cx="158096" cy="16473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25" name="Rectangle 24">
            <a:extLst>
              <a:ext uri="{FF2B5EF4-FFF2-40B4-BE49-F238E27FC236}">
                <a16:creationId xmlns:a16="http://schemas.microsoft.com/office/drawing/2014/main" id="{33189B57-48A5-495B-811D-D7C2493F6F2B}"/>
              </a:ext>
            </a:extLst>
          </p:cNvPr>
          <p:cNvSpPr/>
          <p:nvPr/>
        </p:nvSpPr>
        <p:spPr>
          <a:xfrm flipH="1">
            <a:off x="2251852" y="2570166"/>
            <a:ext cx="245060" cy="14975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26" name="Rectangle 25">
            <a:extLst>
              <a:ext uri="{FF2B5EF4-FFF2-40B4-BE49-F238E27FC236}">
                <a16:creationId xmlns:a16="http://schemas.microsoft.com/office/drawing/2014/main" id="{1A43C643-0F66-4159-A9FF-576F7C92EB0F}"/>
              </a:ext>
            </a:extLst>
          </p:cNvPr>
          <p:cNvSpPr/>
          <p:nvPr/>
        </p:nvSpPr>
        <p:spPr>
          <a:xfrm flipH="1">
            <a:off x="3416311" y="2499876"/>
            <a:ext cx="502855" cy="335169"/>
          </a:xfrm>
          <a:prstGeom prst="rect">
            <a:avLst/>
          </a:prstGeom>
        </p:spPr>
        <p:txBody>
          <a:bodyPr wrap="square">
            <a:spAutoFit/>
          </a:bodyPr>
          <a:lstStyle/>
          <a:p>
            <a:pPr defTabSz="896241"/>
            <a:r>
              <a:rPr lang="en-US" sz="1200" kern="0" dirty="0">
                <a:cs typeface="Times New Roman" panose="02020603050405020304" pitchFamily="18" charset="0"/>
              </a:rPr>
              <a:t>E1</a:t>
            </a:r>
          </a:p>
        </p:txBody>
      </p:sp>
      <p:sp>
        <p:nvSpPr>
          <p:cNvPr id="27" name="Rectangle 26">
            <a:extLst>
              <a:ext uri="{FF2B5EF4-FFF2-40B4-BE49-F238E27FC236}">
                <a16:creationId xmlns:a16="http://schemas.microsoft.com/office/drawing/2014/main" id="{C82DD6B3-F159-4D6E-81A5-56DACAF95DBB}"/>
              </a:ext>
            </a:extLst>
          </p:cNvPr>
          <p:cNvSpPr/>
          <p:nvPr/>
        </p:nvSpPr>
        <p:spPr>
          <a:xfrm flipH="1">
            <a:off x="3044739" y="2505353"/>
            <a:ext cx="889104" cy="335169"/>
          </a:xfrm>
          <a:prstGeom prst="rect">
            <a:avLst/>
          </a:prstGeom>
        </p:spPr>
        <p:txBody>
          <a:bodyPr wrap="square">
            <a:spAutoFit/>
          </a:bodyPr>
          <a:lstStyle/>
          <a:p>
            <a:pPr defTabSz="896241"/>
            <a:r>
              <a:rPr lang="en-US" sz="1200" kern="0" dirty="0">
                <a:cs typeface="Times New Roman" panose="02020603050405020304" pitchFamily="18" charset="0"/>
              </a:rPr>
              <a:t>E2</a:t>
            </a:r>
          </a:p>
        </p:txBody>
      </p:sp>
      <p:sp>
        <p:nvSpPr>
          <p:cNvPr id="28" name="Rectangle 27">
            <a:extLst>
              <a:ext uri="{FF2B5EF4-FFF2-40B4-BE49-F238E27FC236}">
                <a16:creationId xmlns:a16="http://schemas.microsoft.com/office/drawing/2014/main" id="{B8F9A9AD-D20B-4ECE-A76A-B06BE19A842B}"/>
              </a:ext>
            </a:extLst>
          </p:cNvPr>
          <p:cNvSpPr/>
          <p:nvPr/>
        </p:nvSpPr>
        <p:spPr>
          <a:xfrm flipH="1">
            <a:off x="2196170" y="2506264"/>
            <a:ext cx="338788" cy="276998"/>
          </a:xfrm>
          <a:prstGeom prst="rect">
            <a:avLst/>
          </a:prstGeom>
          <a:ln>
            <a:noFill/>
          </a:ln>
        </p:spPr>
        <p:txBody>
          <a:bodyPr wrap="square">
            <a:spAutoFit/>
          </a:bodyPr>
          <a:lstStyle/>
          <a:p>
            <a:pPr defTabSz="896241"/>
            <a:r>
              <a:rPr lang="en-US" sz="1200" kern="0" dirty="0">
                <a:cs typeface="Times New Roman" panose="02020603050405020304" pitchFamily="18" charset="0"/>
              </a:rPr>
              <a:t>E4</a:t>
            </a:r>
          </a:p>
        </p:txBody>
      </p:sp>
      <p:sp>
        <p:nvSpPr>
          <p:cNvPr id="29" name="Rectangle 28">
            <a:extLst>
              <a:ext uri="{FF2B5EF4-FFF2-40B4-BE49-F238E27FC236}">
                <a16:creationId xmlns:a16="http://schemas.microsoft.com/office/drawing/2014/main" id="{7D89E1B4-6E06-4C13-9033-BCDF3E17E564}"/>
              </a:ext>
            </a:extLst>
          </p:cNvPr>
          <p:cNvSpPr/>
          <p:nvPr/>
        </p:nvSpPr>
        <p:spPr>
          <a:xfrm flipH="1">
            <a:off x="3240630" y="2427047"/>
            <a:ext cx="384706" cy="276999"/>
          </a:xfrm>
          <a:prstGeom prst="rect">
            <a:avLst/>
          </a:prstGeom>
        </p:spPr>
        <p:txBody>
          <a:bodyPr wrap="square">
            <a:spAutoFit/>
          </a:bodyPr>
          <a:lstStyle/>
          <a:p>
            <a:pPr defTabSz="896241"/>
            <a:r>
              <a:rPr lang="en-US" sz="1200" kern="0" dirty="0">
                <a:cs typeface="Times New Roman" panose="02020603050405020304" pitchFamily="18" charset="0"/>
              </a:rPr>
              <a:t>I1</a:t>
            </a:r>
          </a:p>
        </p:txBody>
      </p:sp>
      <p:sp>
        <p:nvSpPr>
          <p:cNvPr id="30" name="Rectangle 29">
            <a:extLst>
              <a:ext uri="{FF2B5EF4-FFF2-40B4-BE49-F238E27FC236}">
                <a16:creationId xmlns:a16="http://schemas.microsoft.com/office/drawing/2014/main" id="{D007F2F9-319D-4AF3-955D-5D3B27AAE9EF}"/>
              </a:ext>
            </a:extLst>
          </p:cNvPr>
          <p:cNvSpPr/>
          <p:nvPr/>
        </p:nvSpPr>
        <p:spPr>
          <a:xfrm flipH="1">
            <a:off x="2488078" y="2430370"/>
            <a:ext cx="496605" cy="335169"/>
          </a:xfrm>
          <a:prstGeom prst="rect">
            <a:avLst/>
          </a:prstGeom>
        </p:spPr>
        <p:txBody>
          <a:bodyPr wrap="square">
            <a:spAutoFit/>
          </a:bodyPr>
          <a:lstStyle/>
          <a:p>
            <a:pPr defTabSz="896241"/>
            <a:r>
              <a:rPr lang="en-US" sz="1200" kern="0" dirty="0">
                <a:cs typeface="Times New Roman" panose="02020603050405020304" pitchFamily="18" charset="0"/>
              </a:rPr>
              <a:t>I3</a:t>
            </a:r>
          </a:p>
        </p:txBody>
      </p:sp>
      <p:sp>
        <p:nvSpPr>
          <p:cNvPr id="31" name="TextBox 30">
            <a:extLst>
              <a:ext uri="{FF2B5EF4-FFF2-40B4-BE49-F238E27FC236}">
                <a16:creationId xmlns:a16="http://schemas.microsoft.com/office/drawing/2014/main" id="{B1FDB1A6-C213-4CDC-B31C-F8DD408350DA}"/>
              </a:ext>
            </a:extLst>
          </p:cNvPr>
          <p:cNvSpPr txBox="1"/>
          <p:nvPr/>
        </p:nvSpPr>
        <p:spPr>
          <a:xfrm>
            <a:off x="3610026" y="2412792"/>
            <a:ext cx="587121" cy="276999"/>
          </a:xfrm>
          <a:prstGeom prst="rect">
            <a:avLst/>
          </a:prstGeom>
          <a:noFill/>
        </p:spPr>
        <p:txBody>
          <a:bodyPr wrap="square">
            <a:spAutoFit/>
          </a:bodyPr>
          <a:lstStyle/>
          <a:p>
            <a:r>
              <a:rPr lang="en-US" sz="1200" kern="0" dirty="0">
                <a:cs typeface="Times New Roman" panose="02020603050405020304" pitchFamily="18" charset="0"/>
              </a:rPr>
              <a:t>5’UTR</a:t>
            </a:r>
            <a:endParaRPr lang="en-US" sz="1200" dirty="0"/>
          </a:p>
        </p:txBody>
      </p:sp>
      <p:sp>
        <p:nvSpPr>
          <p:cNvPr id="32" name="TextBox 31">
            <a:extLst>
              <a:ext uri="{FF2B5EF4-FFF2-40B4-BE49-F238E27FC236}">
                <a16:creationId xmlns:a16="http://schemas.microsoft.com/office/drawing/2014/main" id="{D14C0B03-C416-4ED3-B464-9E3EBEAB8294}"/>
              </a:ext>
            </a:extLst>
          </p:cNvPr>
          <p:cNvSpPr txBox="1"/>
          <p:nvPr/>
        </p:nvSpPr>
        <p:spPr>
          <a:xfrm>
            <a:off x="1677724" y="2430412"/>
            <a:ext cx="636505" cy="276999"/>
          </a:xfrm>
          <a:prstGeom prst="rect">
            <a:avLst/>
          </a:prstGeom>
          <a:noFill/>
        </p:spPr>
        <p:txBody>
          <a:bodyPr wrap="square">
            <a:spAutoFit/>
          </a:bodyPr>
          <a:lstStyle/>
          <a:p>
            <a:r>
              <a:rPr lang="en-US" sz="1200" kern="0" dirty="0">
                <a:cs typeface="Times New Roman" panose="02020603050405020304" pitchFamily="18" charset="0"/>
              </a:rPr>
              <a:t>3’ UTR</a:t>
            </a:r>
            <a:endParaRPr lang="en-US" sz="1200" dirty="0"/>
          </a:p>
        </p:txBody>
      </p:sp>
      <p:sp>
        <p:nvSpPr>
          <p:cNvPr id="33" name="Rectangle 32">
            <a:extLst>
              <a:ext uri="{FF2B5EF4-FFF2-40B4-BE49-F238E27FC236}">
                <a16:creationId xmlns:a16="http://schemas.microsoft.com/office/drawing/2014/main" id="{D0E52C7A-6757-4980-8B46-372CD1CD4922}"/>
              </a:ext>
            </a:extLst>
          </p:cNvPr>
          <p:cNvSpPr/>
          <p:nvPr/>
        </p:nvSpPr>
        <p:spPr>
          <a:xfrm flipH="1">
            <a:off x="2723453" y="2568912"/>
            <a:ext cx="217498" cy="145310"/>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34" name="Rectangle 33">
            <a:extLst>
              <a:ext uri="{FF2B5EF4-FFF2-40B4-BE49-F238E27FC236}">
                <a16:creationId xmlns:a16="http://schemas.microsoft.com/office/drawing/2014/main" id="{4B337127-33B7-4A08-B01E-1709799B4B4D}"/>
              </a:ext>
            </a:extLst>
          </p:cNvPr>
          <p:cNvSpPr/>
          <p:nvPr/>
        </p:nvSpPr>
        <p:spPr>
          <a:xfrm flipH="1">
            <a:off x="2660058" y="2492247"/>
            <a:ext cx="502855" cy="335169"/>
          </a:xfrm>
          <a:prstGeom prst="rect">
            <a:avLst/>
          </a:prstGeom>
        </p:spPr>
        <p:txBody>
          <a:bodyPr wrap="square">
            <a:spAutoFit/>
          </a:bodyPr>
          <a:lstStyle/>
          <a:p>
            <a:pPr defTabSz="896241"/>
            <a:r>
              <a:rPr lang="en-US" sz="1200" kern="0" dirty="0">
                <a:cs typeface="Times New Roman" panose="02020603050405020304" pitchFamily="18" charset="0"/>
              </a:rPr>
              <a:t>E3</a:t>
            </a:r>
          </a:p>
        </p:txBody>
      </p:sp>
      <p:sp>
        <p:nvSpPr>
          <p:cNvPr id="35" name="Rectangle 34">
            <a:extLst>
              <a:ext uri="{FF2B5EF4-FFF2-40B4-BE49-F238E27FC236}">
                <a16:creationId xmlns:a16="http://schemas.microsoft.com/office/drawing/2014/main" id="{9B228087-01B6-4450-99BA-7CF7156843B0}"/>
              </a:ext>
            </a:extLst>
          </p:cNvPr>
          <p:cNvSpPr/>
          <p:nvPr/>
        </p:nvSpPr>
        <p:spPr>
          <a:xfrm flipH="1">
            <a:off x="2884828" y="2433488"/>
            <a:ext cx="496605" cy="335169"/>
          </a:xfrm>
          <a:prstGeom prst="rect">
            <a:avLst/>
          </a:prstGeom>
        </p:spPr>
        <p:txBody>
          <a:bodyPr wrap="square">
            <a:spAutoFit/>
          </a:bodyPr>
          <a:lstStyle/>
          <a:p>
            <a:pPr defTabSz="896241"/>
            <a:r>
              <a:rPr lang="en-US" sz="1200" kern="0" dirty="0">
                <a:cs typeface="Times New Roman" panose="02020603050405020304" pitchFamily="18" charset="0"/>
              </a:rPr>
              <a:t>I2</a:t>
            </a:r>
          </a:p>
        </p:txBody>
      </p:sp>
      <p:sp>
        <p:nvSpPr>
          <p:cNvPr id="36" name="TextBox 35">
            <a:extLst>
              <a:ext uri="{FF2B5EF4-FFF2-40B4-BE49-F238E27FC236}">
                <a16:creationId xmlns:a16="http://schemas.microsoft.com/office/drawing/2014/main" id="{9F9DEE46-B13D-483F-8142-17B2A68B52B4}"/>
              </a:ext>
            </a:extLst>
          </p:cNvPr>
          <p:cNvSpPr txBox="1"/>
          <p:nvPr/>
        </p:nvSpPr>
        <p:spPr>
          <a:xfrm>
            <a:off x="5695119" y="3149584"/>
            <a:ext cx="2765074" cy="276999"/>
          </a:xfrm>
          <a:prstGeom prst="rect">
            <a:avLst/>
          </a:prstGeom>
          <a:noFill/>
        </p:spPr>
        <p:txBody>
          <a:bodyPr wrap="square">
            <a:spAutoFit/>
          </a:bodyPr>
          <a:lstStyle/>
          <a:p>
            <a:r>
              <a:rPr lang="en-US" sz="1200" dirty="0"/>
              <a:t>HORVU.MOREX.r3.2HG0202650</a:t>
            </a:r>
          </a:p>
        </p:txBody>
      </p:sp>
      <p:sp>
        <p:nvSpPr>
          <p:cNvPr id="37" name="TextBox 36">
            <a:extLst>
              <a:ext uri="{FF2B5EF4-FFF2-40B4-BE49-F238E27FC236}">
                <a16:creationId xmlns:a16="http://schemas.microsoft.com/office/drawing/2014/main" id="{DA0D0419-8F45-4529-9F96-8162059FE972}"/>
              </a:ext>
            </a:extLst>
          </p:cNvPr>
          <p:cNvSpPr txBox="1"/>
          <p:nvPr/>
        </p:nvSpPr>
        <p:spPr>
          <a:xfrm>
            <a:off x="1592430" y="2876297"/>
            <a:ext cx="2321628" cy="276999"/>
          </a:xfrm>
          <a:prstGeom prst="rect">
            <a:avLst/>
          </a:prstGeom>
          <a:noFill/>
        </p:spPr>
        <p:txBody>
          <a:bodyPr wrap="square">
            <a:spAutoFit/>
          </a:bodyPr>
          <a:lstStyle/>
          <a:p>
            <a:r>
              <a:rPr lang="en-US" sz="1200" dirty="0"/>
              <a:t>HORVU.MOREX.r3.2HG0202640</a:t>
            </a:r>
          </a:p>
        </p:txBody>
      </p:sp>
      <p:sp>
        <p:nvSpPr>
          <p:cNvPr id="38" name="Arrow: Down 37">
            <a:extLst>
              <a:ext uri="{FF2B5EF4-FFF2-40B4-BE49-F238E27FC236}">
                <a16:creationId xmlns:a16="http://schemas.microsoft.com/office/drawing/2014/main" id="{5E58AC31-5DBD-4880-BA0C-EA97556CF8A2}"/>
              </a:ext>
            </a:extLst>
          </p:cNvPr>
          <p:cNvSpPr/>
          <p:nvPr/>
        </p:nvSpPr>
        <p:spPr>
          <a:xfrm>
            <a:off x="6747362" y="2343852"/>
            <a:ext cx="36576" cy="277076"/>
          </a:xfrm>
          <a:prstGeom prst="downArrow">
            <a:avLst/>
          </a:prstGeom>
          <a:solidFill>
            <a:srgbClr val="FF0000"/>
          </a:solidFill>
          <a:ln>
            <a:solidFill>
              <a:srgbClr val="FF0000">
                <a:alpha val="99000"/>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39" name="Arrow: Down 38">
            <a:extLst>
              <a:ext uri="{FF2B5EF4-FFF2-40B4-BE49-F238E27FC236}">
                <a16:creationId xmlns:a16="http://schemas.microsoft.com/office/drawing/2014/main" id="{690D6783-9C68-4BF2-AF07-CB877EE3853C}"/>
              </a:ext>
            </a:extLst>
          </p:cNvPr>
          <p:cNvSpPr/>
          <p:nvPr/>
        </p:nvSpPr>
        <p:spPr>
          <a:xfrm>
            <a:off x="5177499" y="2343638"/>
            <a:ext cx="36576" cy="277076"/>
          </a:xfrm>
          <a:prstGeom prst="downArrow">
            <a:avLst/>
          </a:prstGeom>
          <a:solidFill>
            <a:srgbClr val="FF0000"/>
          </a:solidFill>
          <a:ln>
            <a:solidFill>
              <a:srgbClr val="FF0000">
                <a:alpha val="99000"/>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40" name="Rectangle 39">
            <a:extLst>
              <a:ext uri="{FF2B5EF4-FFF2-40B4-BE49-F238E27FC236}">
                <a16:creationId xmlns:a16="http://schemas.microsoft.com/office/drawing/2014/main" id="{3DC32442-42EC-49EB-AACE-5BCCB0E37654}"/>
              </a:ext>
            </a:extLst>
          </p:cNvPr>
          <p:cNvSpPr/>
          <p:nvPr/>
        </p:nvSpPr>
        <p:spPr>
          <a:xfrm>
            <a:off x="5190304" y="2336417"/>
            <a:ext cx="1581877" cy="27432"/>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41" name="TextBox 40">
            <a:extLst>
              <a:ext uri="{FF2B5EF4-FFF2-40B4-BE49-F238E27FC236}">
                <a16:creationId xmlns:a16="http://schemas.microsoft.com/office/drawing/2014/main" id="{73931615-BECF-40E4-9D21-9F7B79F4DCC0}"/>
              </a:ext>
            </a:extLst>
          </p:cNvPr>
          <p:cNvSpPr txBox="1"/>
          <p:nvPr/>
        </p:nvSpPr>
        <p:spPr>
          <a:xfrm>
            <a:off x="5069481" y="2104754"/>
            <a:ext cx="1810135" cy="276999"/>
          </a:xfrm>
          <a:prstGeom prst="rect">
            <a:avLst/>
          </a:prstGeom>
          <a:noFill/>
        </p:spPr>
        <p:txBody>
          <a:bodyPr wrap="square">
            <a:spAutoFit/>
          </a:bodyPr>
          <a:lstStyle/>
          <a:p>
            <a:r>
              <a:rPr lang="en-US" sz="1200" kern="0" dirty="0">
                <a:latin typeface="Times New Roman" panose="02020603050405020304" pitchFamily="18" charset="0"/>
                <a:cs typeface="Times New Roman" panose="02020603050405020304" pitchFamily="18" charset="0"/>
              </a:rPr>
              <a:t>⁓</a:t>
            </a:r>
            <a:r>
              <a:rPr lang="en-US" sz="1200" kern="0" dirty="0">
                <a:cs typeface="Times New Roman" panose="02020603050405020304" pitchFamily="18" charset="0"/>
              </a:rPr>
              <a:t>10 kb deletion in BW483</a:t>
            </a:r>
            <a:endParaRPr lang="en-US" sz="1200" dirty="0"/>
          </a:p>
        </p:txBody>
      </p:sp>
      <p:sp>
        <p:nvSpPr>
          <p:cNvPr id="42" name="TextBox 41">
            <a:extLst>
              <a:ext uri="{FF2B5EF4-FFF2-40B4-BE49-F238E27FC236}">
                <a16:creationId xmlns:a16="http://schemas.microsoft.com/office/drawing/2014/main" id="{957A5AE3-8874-49BC-B4F8-2D8741B36734}"/>
              </a:ext>
            </a:extLst>
          </p:cNvPr>
          <p:cNvSpPr txBox="1"/>
          <p:nvPr/>
        </p:nvSpPr>
        <p:spPr>
          <a:xfrm>
            <a:off x="4391885" y="2783262"/>
            <a:ext cx="680466" cy="276999"/>
          </a:xfrm>
          <a:prstGeom prst="rect">
            <a:avLst/>
          </a:prstGeom>
          <a:noFill/>
        </p:spPr>
        <p:txBody>
          <a:bodyPr wrap="square">
            <a:spAutoFit/>
          </a:bodyPr>
          <a:lstStyle/>
          <a:p>
            <a:r>
              <a:rPr lang="en-US" sz="1200" kern="0" dirty="0">
                <a:latin typeface="Times New Roman" panose="02020603050405020304" pitchFamily="18" charset="0"/>
                <a:cs typeface="Times New Roman" panose="02020603050405020304" pitchFamily="18" charset="0"/>
              </a:rPr>
              <a:t>⁓</a:t>
            </a:r>
            <a:r>
              <a:rPr lang="en-US" sz="1200" kern="0" dirty="0">
                <a:cs typeface="Times New Roman" panose="02020603050405020304" pitchFamily="18" charset="0"/>
              </a:rPr>
              <a:t>7.5kb</a:t>
            </a:r>
            <a:endParaRPr lang="en-US" sz="1200" dirty="0"/>
          </a:p>
        </p:txBody>
      </p:sp>
      <p:cxnSp>
        <p:nvCxnSpPr>
          <p:cNvPr id="43" name="Straight Arrow Connector 42">
            <a:extLst>
              <a:ext uri="{FF2B5EF4-FFF2-40B4-BE49-F238E27FC236}">
                <a16:creationId xmlns:a16="http://schemas.microsoft.com/office/drawing/2014/main" id="{95A2589F-2A7F-4DB5-A175-05F46218F674}"/>
              </a:ext>
            </a:extLst>
          </p:cNvPr>
          <p:cNvCxnSpPr>
            <a:cxnSpLocks/>
          </p:cNvCxnSpPr>
          <p:nvPr/>
        </p:nvCxnSpPr>
        <p:spPr>
          <a:xfrm flipH="1" flipV="1">
            <a:off x="5207594" y="2672472"/>
            <a:ext cx="223" cy="337371"/>
          </a:xfrm>
          <a:prstGeom prst="straightConnector1">
            <a:avLst/>
          </a:prstGeom>
          <a:ln w="25400">
            <a:solidFill>
              <a:srgbClr val="7030A0"/>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7DD600D4-68B3-48BF-B410-127EA5BAC6AE}"/>
              </a:ext>
            </a:extLst>
          </p:cNvPr>
          <p:cNvCxnSpPr>
            <a:cxnSpLocks/>
          </p:cNvCxnSpPr>
          <p:nvPr/>
        </p:nvCxnSpPr>
        <p:spPr>
          <a:xfrm flipH="1" flipV="1">
            <a:off x="4176271" y="2681075"/>
            <a:ext cx="396" cy="337371"/>
          </a:xfrm>
          <a:prstGeom prst="straightConnector1">
            <a:avLst/>
          </a:prstGeom>
          <a:ln w="25400">
            <a:solidFill>
              <a:srgbClr val="7030A0"/>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6967838-11B7-4882-9EBF-EA9919F60218}"/>
              </a:ext>
            </a:extLst>
          </p:cNvPr>
          <p:cNvCxnSpPr>
            <a:cxnSpLocks/>
          </p:cNvCxnSpPr>
          <p:nvPr/>
        </p:nvCxnSpPr>
        <p:spPr>
          <a:xfrm>
            <a:off x="4174204" y="3005747"/>
            <a:ext cx="1055932" cy="0"/>
          </a:xfrm>
          <a:prstGeom prst="line">
            <a:avLst/>
          </a:prstGeom>
          <a:ln w="25400">
            <a:solidFill>
              <a:srgbClr val="7030A0"/>
            </a:solidFill>
          </a:ln>
        </p:spPr>
        <p:style>
          <a:lnRef idx="1">
            <a:schemeClr val="accent1"/>
          </a:lnRef>
          <a:fillRef idx="0">
            <a:schemeClr val="accent1"/>
          </a:fillRef>
          <a:effectRef idx="0">
            <a:schemeClr val="accent1"/>
          </a:effectRef>
          <a:fontRef idx="minor">
            <a:schemeClr val="tx1"/>
          </a:fontRef>
        </p:style>
      </p:cxnSp>
      <p:sp>
        <p:nvSpPr>
          <p:cNvPr id="94" name="TextBox 93">
            <a:extLst>
              <a:ext uri="{FF2B5EF4-FFF2-40B4-BE49-F238E27FC236}">
                <a16:creationId xmlns:a16="http://schemas.microsoft.com/office/drawing/2014/main" id="{5A2AA21E-FE5D-476C-8E51-F3BFE7ABB020}"/>
              </a:ext>
            </a:extLst>
          </p:cNvPr>
          <p:cNvSpPr txBox="1"/>
          <p:nvPr/>
        </p:nvSpPr>
        <p:spPr>
          <a:xfrm>
            <a:off x="8629639" y="2491657"/>
            <a:ext cx="716542" cy="277000"/>
          </a:xfrm>
          <a:prstGeom prst="rect">
            <a:avLst/>
          </a:prstGeom>
          <a:noFill/>
        </p:spPr>
        <p:txBody>
          <a:bodyPr wrap="square">
            <a:spAutoFit/>
          </a:bodyPr>
          <a:lstStyle/>
          <a:p>
            <a:r>
              <a:rPr lang="en-US" sz="1200" kern="0" dirty="0">
                <a:cs typeface="Times New Roman" panose="02020603050405020304" pitchFamily="18" charset="0"/>
              </a:rPr>
              <a:t>2H</a:t>
            </a:r>
            <a:endParaRPr lang="en-US" sz="1200" dirty="0"/>
          </a:p>
        </p:txBody>
      </p:sp>
      <p:sp>
        <p:nvSpPr>
          <p:cNvPr id="95" name="TextBox 94">
            <a:extLst>
              <a:ext uri="{FF2B5EF4-FFF2-40B4-BE49-F238E27FC236}">
                <a16:creationId xmlns:a16="http://schemas.microsoft.com/office/drawing/2014/main" id="{E0628C6F-7A08-4A08-BFEC-6B6405268387}"/>
              </a:ext>
            </a:extLst>
          </p:cNvPr>
          <p:cNvSpPr txBox="1"/>
          <p:nvPr/>
        </p:nvSpPr>
        <p:spPr>
          <a:xfrm>
            <a:off x="105151" y="359688"/>
            <a:ext cx="11654458" cy="1569660"/>
          </a:xfrm>
          <a:prstGeom prst="rect">
            <a:avLst/>
          </a:prstGeom>
          <a:noFill/>
        </p:spPr>
        <p:txBody>
          <a:bodyPr wrap="square">
            <a:spAutoFit/>
          </a:bodyPr>
          <a:lstStyle/>
          <a:p>
            <a:r>
              <a:rPr lang="en-US" sz="1600" b="1" i="0" dirty="0">
                <a:solidFill>
                  <a:srgbClr val="333333"/>
                </a:solidFill>
                <a:effectLst/>
                <a:latin typeface="Times New Roman" panose="02020603050405020304" pitchFamily="18" charset="0"/>
                <a:cs typeface="Times New Roman" panose="02020603050405020304" pitchFamily="18" charset="0"/>
              </a:rPr>
              <a:t>Figure S3. </a:t>
            </a:r>
            <a:r>
              <a:rPr lang="en-US" sz="1600" b="0" i="0" dirty="0">
                <a:solidFill>
                  <a:srgbClr val="333333"/>
                </a:solidFill>
                <a:effectLst/>
                <a:latin typeface="Times New Roman" panose="02020603050405020304" pitchFamily="18" charset="0"/>
                <a:cs typeface="Times New Roman" panose="02020603050405020304" pitchFamily="18" charset="0"/>
              </a:rPr>
              <a:t>Genomic deletion in the BW483 mutant. An ⁓10 kb deletion (denoted by two read arrows and a red line) in </a:t>
            </a:r>
            <a:r>
              <a:rPr lang="en-US" sz="1600" b="0" i="1" dirty="0">
                <a:solidFill>
                  <a:srgbClr val="333333"/>
                </a:solidFill>
                <a:effectLst/>
                <a:latin typeface="Times New Roman" panose="02020603050405020304" pitchFamily="18" charset="0"/>
                <a:cs typeface="Times New Roman" panose="02020603050405020304" pitchFamily="18" charset="0"/>
              </a:rPr>
              <a:t>HORVU.MOREX.r3.2HG0202650 </a:t>
            </a:r>
            <a:r>
              <a:rPr lang="en-US" sz="1600" b="0" dirty="0">
                <a:solidFill>
                  <a:srgbClr val="333333"/>
                </a:solidFill>
                <a:effectLst/>
                <a:latin typeface="Times New Roman" panose="02020603050405020304" pitchFamily="18" charset="0"/>
                <a:cs typeface="Times New Roman" panose="02020603050405020304" pitchFamily="18" charset="0"/>
              </a:rPr>
              <a:t>(</a:t>
            </a:r>
            <a:r>
              <a:rPr lang="en-US" sz="1600" b="0" i="1" dirty="0">
                <a:solidFill>
                  <a:srgbClr val="333333"/>
                </a:solidFill>
                <a:effectLst/>
                <a:latin typeface="Times New Roman" panose="02020603050405020304" pitchFamily="18" charset="0"/>
                <a:cs typeface="Times New Roman" panose="02020603050405020304" pitchFamily="18" charset="0"/>
              </a:rPr>
              <a:t>HvSPL8</a:t>
            </a:r>
            <a:r>
              <a:rPr lang="en-US" sz="1600" b="0" dirty="0">
                <a:solidFill>
                  <a:srgbClr val="333333"/>
                </a:solidFill>
                <a:effectLst/>
                <a:latin typeface="Times New Roman" panose="02020603050405020304" pitchFamily="18" charset="0"/>
                <a:cs typeface="Times New Roman" panose="02020603050405020304" pitchFamily="18" charset="0"/>
              </a:rPr>
              <a:t>)</a:t>
            </a:r>
            <a:r>
              <a:rPr lang="en-US" sz="1600" b="0" i="1" dirty="0">
                <a:solidFill>
                  <a:srgbClr val="333333"/>
                </a:solidFill>
                <a:effectLst/>
                <a:latin typeface="Times New Roman" panose="02020603050405020304" pitchFamily="18" charset="0"/>
                <a:cs typeface="Times New Roman" panose="02020603050405020304" pitchFamily="18" charset="0"/>
              </a:rPr>
              <a:t> </a:t>
            </a:r>
            <a:r>
              <a:rPr lang="en-US" sz="1600" b="0" i="0" dirty="0">
                <a:solidFill>
                  <a:srgbClr val="333333"/>
                </a:solidFill>
                <a:effectLst/>
                <a:latin typeface="Times New Roman" panose="02020603050405020304" pitchFamily="18" charset="0"/>
                <a:cs typeface="Times New Roman" panose="02020603050405020304" pitchFamily="18" charset="0"/>
              </a:rPr>
              <a:t>was identified by 3’-RACE in BW483 mutant, which is ⁓7.5 kb apart from the putative 5’UTR of </a:t>
            </a:r>
            <a:r>
              <a:rPr lang="en-US" sz="1600" b="0" i="1" dirty="0">
                <a:solidFill>
                  <a:srgbClr val="333333"/>
                </a:solidFill>
                <a:effectLst/>
                <a:latin typeface="Times New Roman" panose="02020603050405020304" pitchFamily="18" charset="0"/>
                <a:cs typeface="Times New Roman" panose="02020603050405020304" pitchFamily="18" charset="0"/>
              </a:rPr>
              <a:t>HORVU.MOREX.r3.2HG0202640</a:t>
            </a:r>
            <a:r>
              <a:rPr lang="en-US" sz="1600" b="0" i="0" dirty="0">
                <a:solidFill>
                  <a:srgbClr val="333333"/>
                </a:solidFill>
                <a:effectLst/>
                <a:latin typeface="Times New Roman" panose="02020603050405020304" pitchFamily="18" charset="0"/>
                <a:cs typeface="Times New Roman" panose="02020603050405020304" pitchFamily="18" charset="0"/>
              </a:rPr>
              <a:t>. The deletion eliminat</a:t>
            </a:r>
            <a:r>
              <a:rPr lang="en-US" sz="1600" dirty="0">
                <a:solidFill>
                  <a:srgbClr val="333333"/>
                </a:solidFill>
                <a:latin typeface="Times New Roman" panose="02020603050405020304" pitchFamily="18" charset="0"/>
                <a:cs typeface="Times New Roman" panose="02020603050405020304" pitchFamily="18" charset="0"/>
              </a:rPr>
              <a:t>es the 2</a:t>
            </a:r>
            <a:r>
              <a:rPr lang="en-US" sz="1600" baseline="30000" dirty="0">
                <a:solidFill>
                  <a:srgbClr val="333333"/>
                </a:solidFill>
                <a:latin typeface="Times New Roman" panose="02020603050405020304" pitchFamily="18" charset="0"/>
                <a:cs typeface="Times New Roman" panose="02020603050405020304" pitchFamily="18" charset="0"/>
              </a:rPr>
              <a:t>nd</a:t>
            </a:r>
            <a:r>
              <a:rPr lang="en-US" sz="1600" dirty="0">
                <a:solidFill>
                  <a:srgbClr val="333333"/>
                </a:solidFill>
                <a:latin typeface="Times New Roman" panose="02020603050405020304" pitchFamily="18" charset="0"/>
                <a:cs typeface="Times New Roman" panose="02020603050405020304" pitchFamily="18" charset="0"/>
              </a:rPr>
              <a:t> and 3</a:t>
            </a:r>
            <a:r>
              <a:rPr lang="en-US" sz="1600" baseline="30000" dirty="0">
                <a:solidFill>
                  <a:srgbClr val="333333"/>
                </a:solidFill>
                <a:latin typeface="Times New Roman" panose="02020603050405020304" pitchFamily="18" charset="0"/>
                <a:cs typeface="Times New Roman" panose="02020603050405020304" pitchFamily="18" charset="0"/>
              </a:rPr>
              <a:t>rd</a:t>
            </a:r>
            <a:r>
              <a:rPr lang="en-US" sz="1600" dirty="0">
                <a:solidFill>
                  <a:srgbClr val="333333"/>
                </a:solidFill>
                <a:latin typeface="Times New Roman" panose="02020603050405020304" pitchFamily="18" charset="0"/>
                <a:cs typeface="Times New Roman" panose="02020603050405020304" pitchFamily="18" charset="0"/>
              </a:rPr>
              <a:t> coding exons, disrupting the HvSPL8 function totally in BW483. Primers used for amplification of </a:t>
            </a:r>
            <a:r>
              <a:rPr lang="en-US" sz="1600" i="1" dirty="0">
                <a:solidFill>
                  <a:srgbClr val="333333"/>
                </a:solidFill>
                <a:latin typeface="Times New Roman" panose="02020603050405020304" pitchFamily="18" charset="0"/>
                <a:cs typeface="Times New Roman" panose="02020603050405020304" pitchFamily="18" charset="0"/>
              </a:rPr>
              <a:t>HvSPL8</a:t>
            </a:r>
            <a:r>
              <a:rPr lang="en-US" sz="1600" dirty="0">
                <a:solidFill>
                  <a:srgbClr val="333333"/>
                </a:solidFill>
                <a:latin typeface="Times New Roman" panose="02020603050405020304" pitchFamily="18" charset="0"/>
                <a:cs typeface="Times New Roman" panose="02020603050405020304" pitchFamily="18" charset="0"/>
              </a:rPr>
              <a:t> sequences were indicated by black arrows. Gene models on  chromosome were denoted by blue arrows combing with small rectangles (coding exon) and blue lines (introns and UTRs). Blue arrows represent the transcriptional directions. E, coding exon; I, intron. UTR, untranslated region. </a:t>
            </a:r>
            <a:endParaRPr lang="en-US" sz="1600" b="0" i="0" dirty="0">
              <a:solidFill>
                <a:srgbClr val="333333"/>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892274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7886F41-8483-490F-AFEC-C9F34925FEB4}"/>
              </a:ext>
            </a:extLst>
          </p:cNvPr>
          <p:cNvPicPr>
            <a:picLocks noChangeAspect="1"/>
          </p:cNvPicPr>
          <p:nvPr/>
        </p:nvPicPr>
        <p:blipFill>
          <a:blip r:embed="rId3"/>
          <a:stretch>
            <a:fillRect/>
          </a:stretch>
        </p:blipFill>
        <p:spPr>
          <a:xfrm>
            <a:off x="2227978" y="3153241"/>
            <a:ext cx="3400597" cy="417346"/>
          </a:xfrm>
          <a:prstGeom prst="rect">
            <a:avLst/>
          </a:prstGeom>
        </p:spPr>
      </p:pic>
      <p:sp>
        <p:nvSpPr>
          <p:cNvPr id="7" name="TextBox 6">
            <a:extLst>
              <a:ext uri="{FF2B5EF4-FFF2-40B4-BE49-F238E27FC236}">
                <a16:creationId xmlns:a16="http://schemas.microsoft.com/office/drawing/2014/main" id="{59EC5E2F-A06C-44C2-9BC7-5083B8DB0158}"/>
              </a:ext>
            </a:extLst>
          </p:cNvPr>
          <p:cNvSpPr txBox="1"/>
          <p:nvPr/>
        </p:nvSpPr>
        <p:spPr>
          <a:xfrm>
            <a:off x="915269" y="2982457"/>
            <a:ext cx="6186081" cy="307777"/>
          </a:xfrm>
          <a:prstGeom prst="rect">
            <a:avLst/>
          </a:prstGeom>
          <a:noFill/>
        </p:spPr>
        <p:txBody>
          <a:bodyPr wrap="square">
            <a:spAutoFit/>
          </a:bodyPr>
          <a:lstStyle/>
          <a:p>
            <a:r>
              <a:rPr lang="en-US" sz="1400" dirty="0"/>
              <a:t>Mutant allele 2:  G G G A </a:t>
            </a:r>
            <a:r>
              <a:rPr lang="en-US" sz="1400" dirty="0" err="1"/>
              <a:t>A</a:t>
            </a:r>
            <a:r>
              <a:rPr lang="en-US" sz="1400" dirty="0"/>
              <a:t> C T C </a:t>
            </a:r>
            <a:r>
              <a:rPr lang="en-US" sz="1400" dirty="0" err="1"/>
              <a:t>C</a:t>
            </a:r>
            <a:r>
              <a:rPr lang="en-US" sz="1400" dirty="0"/>
              <a:t> T G C G A C G A </a:t>
            </a:r>
            <a:r>
              <a:rPr lang="en-US" sz="1400" dirty="0" err="1">
                <a:solidFill>
                  <a:srgbClr val="FF0000"/>
                </a:solidFill>
              </a:rPr>
              <a:t>A</a:t>
            </a:r>
            <a:r>
              <a:rPr lang="en-US" sz="1400" dirty="0">
                <a:solidFill>
                  <a:srgbClr val="FF0000"/>
                </a:solidFill>
              </a:rPr>
              <a:t> </a:t>
            </a:r>
            <a:r>
              <a:rPr lang="en-US" sz="1400" dirty="0"/>
              <a:t>G T </a:t>
            </a:r>
            <a:r>
              <a:rPr lang="en-US" sz="1400" dirty="0" err="1"/>
              <a:t>T</a:t>
            </a:r>
            <a:r>
              <a:rPr lang="en-US" sz="1400" dirty="0"/>
              <a:t> </a:t>
            </a:r>
            <a:r>
              <a:rPr lang="en-US" sz="1400" dirty="0">
                <a:highlight>
                  <a:srgbClr val="FFFF00"/>
                </a:highlight>
              </a:rPr>
              <a:t>C G </a:t>
            </a:r>
            <a:r>
              <a:rPr lang="en-US" sz="1400" dirty="0" err="1">
                <a:highlight>
                  <a:srgbClr val="FFFF00"/>
                </a:highlight>
              </a:rPr>
              <a:t>G</a:t>
            </a:r>
            <a:r>
              <a:rPr lang="en-US" sz="1400" dirty="0">
                <a:highlight>
                  <a:srgbClr val="FFFF00"/>
                </a:highlight>
              </a:rPr>
              <a:t> </a:t>
            </a:r>
          </a:p>
        </p:txBody>
      </p:sp>
      <p:pic>
        <p:nvPicPr>
          <p:cNvPr id="9" name="Picture 8">
            <a:extLst>
              <a:ext uri="{FF2B5EF4-FFF2-40B4-BE49-F238E27FC236}">
                <a16:creationId xmlns:a16="http://schemas.microsoft.com/office/drawing/2014/main" id="{8A5CA8A6-E525-4485-ADF9-36221A12B462}"/>
              </a:ext>
            </a:extLst>
          </p:cNvPr>
          <p:cNvPicPr>
            <a:picLocks noChangeAspect="1"/>
          </p:cNvPicPr>
          <p:nvPr/>
        </p:nvPicPr>
        <p:blipFill>
          <a:blip r:embed="rId4"/>
          <a:stretch>
            <a:fillRect/>
          </a:stretch>
        </p:blipFill>
        <p:spPr>
          <a:xfrm>
            <a:off x="2178681" y="3827162"/>
            <a:ext cx="3454697" cy="374839"/>
          </a:xfrm>
          <a:prstGeom prst="rect">
            <a:avLst/>
          </a:prstGeom>
        </p:spPr>
      </p:pic>
      <p:sp>
        <p:nvSpPr>
          <p:cNvPr id="12" name="TextBox 11">
            <a:extLst>
              <a:ext uri="{FF2B5EF4-FFF2-40B4-BE49-F238E27FC236}">
                <a16:creationId xmlns:a16="http://schemas.microsoft.com/office/drawing/2014/main" id="{521E7359-7336-437C-8A90-B14583285988}"/>
              </a:ext>
            </a:extLst>
          </p:cNvPr>
          <p:cNvSpPr txBox="1"/>
          <p:nvPr/>
        </p:nvSpPr>
        <p:spPr>
          <a:xfrm>
            <a:off x="933343" y="3615558"/>
            <a:ext cx="6171495" cy="307777"/>
          </a:xfrm>
          <a:prstGeom prst="rect">
            <a:avLst/>
          </a:prstGeom>
          <a:noFill/>
        </p:spPr>
        <p:txBody>
          <a:bodyPr wrap="square">
            <a:spAutoFit/>
          </a:bodyPr>
          <a:lstStyle/>
          <a:p>
            <a:r>
              <a:rPr lang="en-US" sz="1400" dirty="0"/>
              <a:t>Mutant allele 3: G </a:t>
            </a:r>
            <a:r>
              <a:rPr lang="en-US" sz="1400" dirty="0" err="1"/>
              <a:t>G</a:t>
            </a:r>
            <a:r>
              <a:rPr lang="en-US" sz="1400" dirty="0"/>
              <a:t> </a:t>
            </a:r>
            <a:r>
              <a:rPr lang="en-US" sz="1400" dirty="0" err="1"/>
              <a:t>G</a:t>
            </a:r>
            <a:r>
              <a:rPr lang="en-US" sz="1400" dirty="0"/>
              <a:t> A </a:t>
            </a:r>
            <a:r>
              <a:rPr lang="en-US" sz="1400" dirty="0" err="1"/>
              <a:t>A</a:t>
            </a:r>
            <a:r>
              <a:rPr lang="en-US" sz="1400" dirty="0"/>
              <a:t> C T C </a:t>
            </a:r>
            <a:r>
              <a:rPr lang="en-US" sz="1400" dirty="0" err="1"/>
              <a:t>C</a:t>
            </a:r>
            <a:r>
              <a:rPr lang="en-US" sz="1400" dirty="0"/>
              <a:t> T G C G A C G A </a:t>
            </a:r>
            <a:r>
              <a:rPr lang="en-US" sz="1400" dirty="0">
                <a:solidFill>
                  <a:srgbClr val="FF0000"/>
                </a:solidFill>
              </a:rPr>
              <a:t>C </a:t>
            </a:r>
            <a:r>
              <a:rPr lang="en-US" sz="1400" dirty="0"/>
              <a:t>G T </a:t>
            </a:r>
            <a:r>
              <a:rPr lang="en-US" sz="1400" dirty="0" err="1"/>
              <a:t>T</a:t>
            </a:r>
            <a:r>
              <a:rPr lang="en-US" sz="1400" dirty="0"/>
              <a:t> </a:t>
            </a:r>
            <a:r>
              <a:rPr lang="en-US" sz="1400" dirty="0">
                <a:highlight>
                  <a:srgbClr val="FFFF00"/>
                </a:highlight>
              </a:rPr>
              <a:t>C G </a:t>
            </a:r>
            <a:r>
              <a:rPr lang="en-US" sz="1400" dirty="0" err="1">
                <a:highlight>
                  <a:srgbClr val="FFFF00"/>
                </a:highlight>
              </a:rPr>
              <a:t>G</a:t>
            </a:r>
            <a:endParaRPr lang="en-US" sz="1400" dirty="0">
              <a:highlight>
                <a:srgbClr val="FFFF00"/>
              </a:highlight>
            </a:endParaRPr>
          </a:p>
        </p:txBody>
      </p:sp>
      <p:sp>
        <p:nvSpPr>
          <p:cNvPr id="13" name="TextBox 12">
            <a:extLst>
              <a:ext uri="{FF2B5EF4-FFF2-40B4-BE49-F238E27FC236}">
                <a16:creationId xmlns:a16="http://schemas.microsoft.com/office/drawing/2014/main" id="{50A0EE90-3932-4530-A2F6-B29B53FA3754}"/>
              </a:ext>
            </a:extLst>
          </p:cNvPr>
          <p:cNvSpPr txBox="1"/>
          <p:nvPr/>
        </p:nvSpPr>
        <p:spPr>
          <a:xfrm>
            <a:off x="1337380" y="1707165"/>
            <a:ext cx="6353455" cy="315829"/>
          </a:xfrm>
          <a:prstGeom prst="rect">
            <a:avLst/>
          </a:prstGeom>
          <a:noFill/>
        </p:spPr>
        <p:txBody>
          <a:bodyPr wrap="square">
            <a:spAutoFit/>
          </a:bodyPr>
          <a:lstStyle/>
          <a:p>
            <a:r>
              <a:rPr lang="en-US" sz="1400" dirty="0"/>
              <a:t>WT allele: G </a:t>
            </a:r>
            <a:r>
              <a:rPr lang="en-US" sz="1400" dirty="0" err="1"/>
              <a:t>G</a:t>
            </a:r>
            <a:r>
              <a:rPr lang="en-US" sz="1400" dirty="0"/>
              <a:t> </a:t>
            </a:r>
            <a:r>
              <a:rPr lang="en-US" sz="1400" dirty="0" err="1"/>
              <a:t>G</a:t>
            </a:r>
            <a:r>
              <a:rPr lang="en-US" sz="1400" dirty="0"/>
              <a:t> A </a:t>
            </a:r>
            <a:r>
              <a:rPr lang="en-US" sz="1400" dirty="0" err="1"/>
              <a:t>A</a:t>
            </a:r>
            <a:r>
              <a:rPr lang="en-US" sz="1400" dirty="0"/>
              <a:t> C T C </a:t>
            </a:r>
            <a:r>
              <a:rPr lang="en-US" sz="1400" dirty="0" err="1"/>
              <a:t>C</a:t>
            </a:r>
            <a:r>
              <a:rPr lang="en-US" sz="1400" dirty="0"/>
              <a:t> T G C G A C G A G T </a:t>
            </a:r>
            <a:r>
              <a:rPr lang="en-US" sz="1400" dirty="0" err="1"/>
              <a:t>T</a:t>
            </a:r>
            <a:r>
              <a:rPr lang="en-US" sz="1400" dirty="0"/>
              <a:t> </a:t>
            </a:r>
            <a:r>
              <a:rPr lang="en-US" sz="1400" b="1" dirty="0">
                <a:highlight>
                  <a:srgbClr val="FFFF00"/>
                </a:highlight>
              </a:rPr>
              <a:t>C G </a:t>
            </a:r>
            <a:r>
              <a:rPr lang="en-US" sz="1400" b="1" dirty="0" err="1">
                <a:highlight>
                  <a:srgbClr val="FFFF00"/>
                </a:highlight>
              </a:rPr>
              <a:t>G</a:t>
            </a:r>
            <a:r>
              <a:rPr lang="en-US" sz="1400" b="1" dirty="0">
                <a:highlight>
                  <a:srgbClr val="FFFF00"/>
                </a:highlight>
              </a:rPr>
              <a:t> </a:t>
            </a:r>
            <a:r>
              <a:rPr lang="en-US" sz="1400" dirty="0"/>
              <a:t>C T A T G </a:t>
            </a:r>
            <a:r>
              <a:rPr lang="en-US" sz="1400" dirty="0" err="1"/>
              <a:t>G</a:t>
            </a:r>
            <a:r>
              <a:rPr lang="en-US" sz="1400" dirty="0"/>
              <a:t> </a:t>
            </a:r>
            <a:r>
              <a:rPr lang="en-US" sz="1400" dirty="0" err="1"/>
              <a:t>G</a:t>
            </a:r>
            <a:r>
              <a:rPr lang="en-US" sz="1400" dirty="0"/>
              <a:t> </a:t>
            </a:r>
            <a:r>
              <a:rPr lang="en-US" sz="1400" dirty="0" err="1"/>
              <a:t>G</a:t>
            </a:r>
            <a:r>
              <a:rPr lang="en-US" sz="1400" dirty="0"/>
              <a:t> C T C </a:t>
            </a:r>
            <a:r>
              <a:rPr lang="en-US" sz="1400" dirty="0" err="1"/>
              <a:t>C</a:t>
            </a:r>
            <a:r>
              <a:rPr lang="en-US" sz="1400" dirty="0"/>
              <a:t> </a:t>
            </a:r>
            <a:r>
              <a:rPr lang="en-US" sz="1400" dirty="0" err="1"/>
              <a:t>C</a:t>
            </a:r>
            <a:r>
              <a:rPr lang="en-US" sz="1400" dirty="0"/>
              <a:t> A </a:t>
            </a:r>
            <a:r>
              <a:rPr lang="en-US" sz="1400" dirty="0" err="1"/>
              <a:t>A</a:t>
            </a:r>
            <a:endParaRPr lang="en-US" sz="1400" dirty="0"/>
          </a:p>
        </p:txBody>
      </p:sp>
      <p:pic>
        <p:nvPicPr>
          <p:cNvPr id="15" name="Picture 14">
            <a:extLst>
              <a:ext uri="{FF2B5EF4-FFF2-40B4-BE49-F238E27FC236}">
                <a16:creationId xmlns:a16="http://schemas.microsoft.com/office/drawing/2014/main" id="{59E8A476-E459-49E7-BC90-C0244CB29CE8}"/>
              </a:ext>
            </a:extLst>
          </p:cNvPr>
          <p:cNvPicPr>
            <a:picLocks noChangeAspect="1"/>
          </p:cNvPicPr>
          <p:nvPr/>
        </p:nvPicPr>
        <p:blipFill>
          <a:blip r:embed="rId5"/>
          <a:stretch>
            <a:fillRect/>
          </a:stretch>
        </p:blipFill>
        <p:spPr>
          <a:xfrm>
            <a:off x="2227978" y="4450376"/>
            <a:ext cx="2693427" cy="405753"/>
          </a:xfrm>
          <a:prstGeom prst="rect">
            <a:avLst/>
          </a:prstGeom>
        </p:spPr>
      </p:pic>
      <p:sp>
        <p:nvSpPr>
          <p:cNvPr id="17" name="TextBox 16">
            <a:extLst>
              <a:ext uri="{FF2B5EF4-FFF2-40B4-BE49-F238E27FC236}">
                <a16:creationId xmlns:a16="http://schemas.microsoft.com/office/drawing/2014/main" id="{EF72585C-D2AF-45D3-97AC-199E08312281}"/>
              </a:ext>
            </a:extLst>
          </p:cNvPr>
          <p:cNvSpPr txBox="1"/>
          <p:nvPr/>
        </p:nvSpPr>
        <p:spPr>
          <a:xfrm>
            <a:off x="954609" y="4267374"/>
            <a:ext cx="6347928" cy="307777"/>
          </a:xfrm>
          <a:prstGeom prst="rect">
            <a:avLst/>
          </a:prstGeom>
          <a:noFill/>
        </p:spPr>
        <p:txBody>
          <a:bodyPr wrap="square">
            <a:spAutoFit/>
          </a:bodyPr>
          <a:lstStyle/>
          <a:p>
            <a:r>
              <a:rPr lang="en-US" sz="1400" dirty="0"/>
              <a:t>Mutant allele 4: G </a:t>
            </a:r>
            <a:r>
              <a:rPr lang="en-US" sz="1400" dirty="0" err="1"/>
              <a:t>G</a:t>
            </a:r>
            <a:r>
              <a:rPr lang="en-US" sz="1400" dirty="0"/>
              <a:t> </a:t>
            </a:r>
            <a:r>
              <a:rPr lang="en-US" sz="1400" dirty="0" err="1"/>
              <a:t>G</a:t>
            </a:r>
            <a:r>
              <a:rPr lang="en-US" sz="1400" dirty="0"/>
              <a:t> A </a:t>
            </a:r>
            <a:r>
              <a:rPr lang="en-US" sz="1400" dirty="0" err="1"/>
              <a:t>A</a:t>
            </a:r>
            <a:r>
              <a:rPr lang="en-US" sz="1400" dirty="0"/>
              <a:t> C T C </a:t>
            </a:r>
            <a:r>
              <a:rPr lang="en-US" sz="1400" dirty="0" err="1"/>
              <a:t>C</a:t>
            </a:r>
            <a:r>
              <a:rPr lang="en-US" sz="1400" dirty="0"/>
              <a:t> T G C G A C</a:t>
            </a:r>
            <a:r>
              <a:rPr lang="en-US" sz="400" b="1" dirty="0">
                <a:solidFill>
                  <a:srgbClr val="FF0000"/>
                </a:solidFill>
              </a:rPr>
              <a:t>::::::::::::::::::::</a:t>
            </a:r>
            <a:r>
              <a:rPr lang="en-US" sz="1400" dirty="0"/>
              <a:t>C </a:t>
            </a:r>
            <a:r>
              <a:rPr lang="en-US" sz="1400" dirty="0" err="1"/>
              <a:t>C</a:t>
            </a:r>
            <a:r>
              <a:rPr lang="en-US" sz="1400" dirty="0"/>
              <a:t> A </a:t>
            </a:r>
            <a:r>
              <a:rPr lang="en-US" sz="1400" dirty="0" err="1"/>
              <a:t>A</a:t>
            </a:r>
            <a:r>
              <a:rPr lang="en-US" sz="1400" dirty="0"/>
              <a:t> </a:t>
            </a:r>
          </a:p>
        </p:txBody>
      </p:sp>
      <p:pic>
        <p:nvPicPr>
          <p:cNvPr id="19" name="Picture 18">
            <a:extLst>
              <a:ext uri="{FF2B5EF4-FFF2-40B4-BE49-F238E27FC236}">
                <a16:creationId xmlns:a16="http://schemas.microsoft.com/office/drawing/2014/main" id="{596237EC-86BA-4274-95FA-01770DA46B69}"/>
              </a:ext>
            </a:extLst>
          </p:cNvPr>
          <p:cNvPicPr>
            <a:picLocks noChangeAspect="1"/>
          </p:cNvPicPr>
          <p:nvPr/>
        </p:nvPicPr>
        <p:blipFill>
          <a:blip r:embed="rId6"/>
          <a:stretch>
            <a:fillRect/>
          </a:stretch>
        </p:blipFill>
        <p:spPr>
          <a:xfrm>
            <a:off x="2206712" y="1920567"/>
            <a:ext cx="5402312" cy="394160"/>
          </a:xfrm>
          <a:prstGeom prst="rect">
            <a:avLst/>
          </a:prstGeom>
        </p:spPr>
      </p:pic>
      <p:pic>
        <p:nvPicPr>
          <p:cNvPr id="21" name="Picture 20">
            <a:extLst>
              <a:ext uri="{FF2B5EF4-FFF2-40B4-BE49-F238E27FC236}">
                <a16:creationId xmlns:a16="http://schemas.microsoft.com/office/drawing/2014/main" id="{678FCA89-43B8-45BE-8851-22EE7A6E7A89}"/>
              </a:ext>
            </a:extLst>
          </p:cNvPr>
          <p:cNvPicPr>
            <a:picLocks noChangeAspect="1"/>
          </p:cNvPicPr>
          <p:nvPr/>
        </p:nvPicPr>
        <p:blipFill>
          <a:blip r:embed="rId7"/>
          <a:stretch>
            <a:fillRect/>
          </a:stretch>
        </p:blipFill>
        <p:spPr>
          <a:xfrm>
            <a:off x="2206712" y="2540484"/>
            <a:ext cx="3153281" cy="394160"/>
          </a:xfrm>
          <a:prstGeom prst="rect">
            <a:avLst/>
          </a:prstGeom>
        </p:spPr>
      </p:pic>
      <p:sp>
        <p:nvSpPr>
          <p:cNvPr id="23" name="TextBox 22">
            <a:extLst>
              <a:ext uri="{FF2B5EF4-FFF2-40B4-BE49-F238E27FC236}">
                <a16:creationId xmlns:a16="http://schemas.microsoft.com/office/drawing/2014/main" id="{EE0E463B-8D9C-4CD8-A0EC-C0A58991BB7D}"/>
              </a:ext>
            </a:extLst>
          </p:cNvPr>
          <p:cNvSpPr txBox="1"/>
          <p:nvPr/>
        </p:nvSpPr>
        <p:spPr>
          <a:xfrm>
            <a:off x="933826" y="2348837"/>
            <a:ext cx="5699051" cy="307777"/>
          </a:xfrm>
          <a:prstGeom prst="rect">
            <a:avLst/>
          </a:prstGeom>
          <a:noFill/>
        </p:spPr>
        <p:txBody>
          <a:bodyPr wrap="square">
            <a:spAutoFit/>
          </a:bodyPr>
          <a:lstStyle/>
          <a:p>
            <a:r>
              <a:rPr lang="en-US" sz="1400" dirty="0"/>
              <a:t>Mutant allele 1: G </a:t>
            </a:r>
            <a:r>
              <a:rPr lang="en-US" sz="1400" dirty="0" err="1"/>
              <a:t>G</a:t>
            </a:r>
            <a:r>
              <a:rPr lang="en-US" sz="1400" dirty="0"/>
              <a:t> </a:t>
            </a:r>
            <a:r>
              <a:rPr lang="en-US" sz="1400" dirty="0" err="1"/>
              <a:t>G</a:t>
            </a:r>
            <a:r>
              <a:rPr lang="en-US" sz="1400" dirty="0"/>
              <a:t> A </a:t>
            </a:r>
            <a:r>
              <a:rPr lang="en-US" sz="1400" dirty="0" err="1"/>
              <a:t>A</a:t>
            </a:r>
            <a:r>
              <a:rPr lang="en-US" sz="1400" dirty="0"/>
              <a:t> C T C </a:t>
            </a:r>
            <a:r>
              <a:rPr lang="en-US" sz="1400" dirty="0" err="1"/>
              <a:t>C</a:t>
            </a:r>
            <a:r>
              <a:rPr lang="en-US" sz="1400" dirty="0"/>
              <a:t> T G C G A C </a:t>
            </a:r>
            <a:r>
              <a:rPr lang="en-US" sz="1400" dirty="0">
                <a:solidFill>
                  <a:srgbClr val="FF0000"/>
                </a:solidFill>
              </a:rPr>
              <a:t>: </a:t>
            </a:r>
            <a:r>
              <a:rPr lang="en-US" sz="1400" dirty="0"/>
              <a:t>A G T </a:t>
            </a:r>
            <a:r>
              <a:rPr lang="en-US" sz="1400" dirty="0" err="1"/>
              <a:t>T</a:t>
            </a:r>
            <a:r>
              <a:rPr lang="en-US" sz="1400" dirty="0"/>
              <a:t> </a:t>
            </a:r>
            <a:r>
              <a:rPr lang="en-US" sz="1400" dirty="0">
                <a:highlight>
                  <a:srgbClr val="FFFF00"/>
                </a:highlight>
              </a:rPr>
              <a:t>C G </a:t>
            </a:r>
            <a:r>
              <a:rPr lang="en-US" sz="1400" dirty="0" err="1">
                <a:highlight>
                  <a:srgbClr val="FFFF00"/>
                </a:highlight>
              </a:rPr>
              <a:t>G</a:t>
            </a:r>
            <a:endParaRPr lang="en-US" sz="1400" dirty="0">
              <a:highlight>
                <a:srgbClr val="FFFF00"/>
              </a:highlight>
            </a:endParaRPr>
          </a:p>
        </p:txBody>
      </p:sp>
      <p:sp>
        <p:nvSpPr>
          <p:cNvPr id="25" name="TextBox 24">
            <a:extLst>
              <a:ext uri="{FF2B5EF4-FFF2-40B4-BE49-F238E27FC236}">
                <a16:creationId xmlns:a16="http://schemas.microsoft.com/office/drawing/2014/main" id="{A876130B-ED92-4416-90CA-563FA5FCBC5F}"/>
              </a:ext>
            </a:extLst>
          </p:cNvPr>
          <p:cNvSpPr txBox="1"/>
          <p:nvPr/>
        </p:nvSpPr>
        <p:spPr>
          <a:xfrm>
            <a:off x="300672" y="693589"/>
            <a:ext cx="11590653" cy="584775"/>
          </a:xfrm>
          <a:prstGeom prst="rect">
            <a:avLst/>
          </a:prstGeom>
          <a:noFill/>
        </p:spPr>
        <p:txBody>
          <a:bodyPr wrap="square">
            <a:spAutoFit/>
          </a:bodyPr>
          <a:lstStyle/>
          <a:p>
            <a:r>
              <a:rPr lang="en-US" sz="1600" b="1" dirty="0">
                <a:latin typeface="Times New Roman" panose="02020603050405020304" pitchFamily="18" charset="0"/>
                <a:cs typeface="Times New Roman" panose="02020603050405020304" pitchFamily="18" charset="0"/>
              </a:rPr>
              <a:t>Figure S4. </a:t>
            </a:r>
            <a:r>
              <a:rPr lang="en-US" sz="1600" dirty="0">
                <a:latin typeface="Times New Roman" panose="02020603050405020304" pitchFamily="18" charset="0"/>
                <a:cs typeface="Times New Roman" panose="02020603050405020304" pitchFamily="18" charset="0"/>
              </a:rPr>
              <a:t>Gene mutations highlighted by red colons (deletion) and letters (insertion or substitution). All mutations lead to an early stop codon, which disrupts the Lig1 function. The PAM sequence was highlighted in yellow.</a:t>
            </a:r>
          </a:p>
        </p:txBody>
      </p:sp>
      <p:sp>
        <p:nvSpPr>
          <p:cNvPr id="3" name="Rectangle 2">
            <a:extLst>
              <a:ext uri="{FF2B5EF4-FFF2-40B4-BE49-F238E27FC236}">
                <a16:creationId xmlns:a16="http://schemas.microsoft.com/office/drawing/2014/main" id="{E888CEB0-32B8-4D3E-AF97-26E24DBED6A2}"/>
              </a:ext>
            </a:extLst>
          </p:cNvPr>
          <p:cNvSpPr/>
          <p:nvPr/>
        </p:nvSpPr>
        <p:spPr>
          <a:xfrm>
            <a:off x="135898" y="1976684"/>
            <a:ext cx="11920203" cy="3793546"/>
          </a:xfrm>
          <a:prstGeom prst="rect">
            <a:avLst/>
          </a:prstGeom>
          <a:no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 name="Picture 13">
            <a:extLst>
              <a:ext uri="{FF2B5EF4-FFF2-40B4-BE49-F238E27FC236}">
                <a16:creationId xmlns:a16="http://schemas.microsoft.com/office/drawing/2014/main" id="{648E8385-883F-477A-8035-6D3EB79651B0}"/>
              </a:ext>
            </a:extLst>
          </p:cNvPr>
          <p:cNvPicPr>
            <a:picLocks noChangeAspect="1"/>
          </p:cNvPicPr>
          <p:nvPr/>
        </p:nvPicPr>
        <p:blipFill rotWithShape="1">
          <a:blip r:embed="rId8"/>
          <a:srcRect t="-1" r="32703" b="-14083"/>
          <a:stretch/>
        </p:blipFill>
        <p:spPr>
          <a:xfrm>
            <a:off x="2208070" y="5197367"/>
            <a:ext cx="3420505" cy="494596"/>
          </a:xfrm>
          <a:prstGeom prst="rect">
            <a:avLst/>
          </a:prstGeom>
        </p:spPr>
      </p:pic>
      <p:sp>
        <p:nvSpPr>
          <p:cNvPr id="16" name="TextBox 15">
            <a:extLst>
              <a:ext uri="{FF2B5EF4-FFF2-40B4-BE49-F238E27FC236}">
                <a16:creationId xmlns:a16="http://schemas.microsoft.com/office/drawing/2014/main" id="{BE33CB12-E43F-460B-B174-5121A51D68C8}"/>
              </a:ext>
            </a:extLst>
          </p:cNvPr>
          <p:cNvSpPr txBox="1"/>
          <p:nvPr/>
        </p:nvSpPr>
        <p:spPr>
          <a:xfrm>
            <a:off x="954609" y="4916389"/>
            <a:ext cx="9178829" cy="307777"/>
          </a:xfrm>
          <a:prstGeom prst="rect">
            <a:avLst/>
          </a:prstGeom>
          <a:noFill/>
        </p:spPr>
        <p:txBody>
          <a:bodyPr wrap="square">
            <a:spAutoFit/>
          </a:bodyPr>
          <a:lstStyle/>
          <a:p>
            <a:r>
              <a:rPr lang="en-US" sz="1400" dirty="0"/>
              <a:t>Mutant allele 5: G </a:t>
            </a:r>
            <a:r>
              <a:rPr lang="en-US" sz="1400" dirty="0" err="1"/>
              <a:t>G</a:t>
            </a:r>
            <a:r>
              <a:rPr lang="en-US" sz="1400" dirty="0"/>
              <a:t> </a:t>
            </a:r>
            <a:r>
              <a:rPr lang="en-US" sz="1400" dirty="0" err="1"/>
              <a:t>G</a:t>
            </a:r>
            <a:r>
              <a:rPr lang="en-US" sz="1400" dirty="0"/>
              <a:t> A </a:t>
            </a:r>
            <a:r>
              <a:rPr lang="en-US" sz="1400" dirty="0" err="1"/>
              <a:t>A</a:t>
            </a:r>
            <a:r>
              <a:rPr lang="en-US" sz="1400" dirty="0"/>
              <a:t> C T C </a:t>
            </a:r>
            <a:r>
              <a:rPr lang="en-US" sz="1400" dirty="0" err="1"/>
              <a:t>C</a:t>
            </a:r>
            <a:r>
              <a:rPr lang="en-US" sz="1400" dirty="0"/>
              <a:t> T G C G A C G A </a:t>
            </a:r>
            <a:r>
              <a:rPr lang="en-US" sz="1400" dirty="0">
                <a:solidFill>
                  <a:srgbClr val="FF0000"/>
                </a:solidFill>
              </a:rPr>
              <a:t>T</a:t>
            </a:r>
            <a:r>
              <a:rPr lang="en-US" sz="1400" dirty="0"/>
              <a:t> G T </a:t>
            </a:r>
            <a:r>
              <a:rPr lang="en-US" sz="1400" dirty="0" err="1"/>
              <a:t>T</a:t>
            </a:r>
            <a:r>
              <a:rPr lang="en-US" sz="1400" dirty="0"/>
              <a:t> </a:t>
            </a:r>
            <a:r>
              <a:rPr lang="en-US" sz="1400" b="1" dirty="0">
                <a:highlight>
                  <a:srgbClr val="FFFF00"/>
                </a:highlight>
              </a:rPr>
              <a:t>C G </a:t>
            </a:r>
            <a:r>
              <a:rPr lang="en-US" sz="1400" b="1" dirty="0" err="1">
                <a:highlight>
                  <a:srgbClr val="FFFF00"/>
                </a:highlight>
              </a:rPr>
              <a:t>G</a:t>
            </a:r>
            <a:endParaRPr lang="en-US" sz="1400" dirty="0"/>
          </a:p>
        </p:txBody>
      </p:sp>
    </p:spTree>
    <p:extLst>
      <p:ext uri="{BB962C8B-B14F-4D97-AF65-F5344CB8AC3E}">
        <p14:creationId xmlns:p14="http://schemas.microsoft.com/office/powerpoint/2010/main" val="15252998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AE2D391-4525-4372-A2DB-B7DCCFC896CD}"/>
              </a:ext>
            </a:extLst>
          </p:cNvPr>
          <p:cNvSpPr txBox="1"/>
          <p:nvPr/>
        </p:nvSpPr>
        <p:spPr>
          <a:xfrm>
            <a:off x="300673" y="464989"/>
            <a:ext cx="11590653" cy="584775"/>
          </a:xfrm>
          <a:prstGeom prst="rect">
            <a:avLst/>
          </a:prstGeom>
          <a:noFill/>
        </p:spPr>
        <p:txBody>
          <a:bodyPr wrap="square">
            <a:spAutoFit/>
          </a:bodyPr>
          <a:lstStyle/>
          <a:p>
            <a:r>
              <a:rPr lang="en-US" sz="1600" b="1" dirty="0">
                <a:latin typeface="Times New Roman" panose="02020603050405020304" pitchFamily="18" charset="0"/>
                <a:cs typeface="Times New Roman" panose="02020603050405020304" pitchFamily="18" charset="0"/>
              </a:rPr>
              <a:t>Figure S5. </a:t>
            </a:r>
            <a:r>
              <a:rPr lang="en-US" sz="1600" dirty="0">
                <a:latin typeface="Times New Roman" panose="02020603050405020304" pitchFamily="18" charset="0"/>
                <a:cs typeface="Times New Roman" panose="02020603050405020304" pitchFamily="18" charset="0"/>
              </a:rPr>
              <a:t>Delayed heading in the </a:t>
            </a:r>
            <a:r>
              <a:rPr lang="en-US" sz="1600" i="1" dirty="0">
                <a:latin typeface="Times New Roman" panose="02020603050405020304" pitchFamily="18" charset="0"/>
                <a:cs typeface="Times New Roman" panose="02020603050405020304" pitchFamily="18" charset="0"/>
              </a:rPr>
              <a:t>Lig1</a:t>
            </a:r>
            <a:r>
              <a:rPr lang="en-US" sz="1600" dirty="0">
                <a:latin typeface="Times New Roman" panose="02020603050405020304" pitchFamily="18" charset="0"/>
                <a:cs typeface="Times New Roman" panose="02020603050405020304" pitchFamily="18" charset="0"/>
              </a:rPr>
              <a:t>-knockout mutant. On the average, homozygous mutants in M1 (n=15) is 5.3 days later in heading than WT Golden Promise (n = 15). Different letters on bar graphs indicate significant at 0.05 level by T-test.  </a:t>
            </a:r>
          </a:p>
        </p:txBody>
      </p:sp>
      <p:grpSp>
        <p:nvGrpSpPr>
          <p:cNvPr id="12" name="Group 11">
            <a:extLst>
              <a:ext uri="{FF2B5EF4-FFF2-40B4-BE49-F238E27FC236}">
                <a16:creationId xmlns:a16="http://schemas.microsoft.com/office/drawing/2014/main" id="{31125B33-9867-4133-B845-71DC7469E4EC}"/>
              </a:ext>
            </a:extLst>
          </p:cNvPr>
          <p:cNvGrpSpPr/>
          <p:nvPr/>
        </p:nvGrpSpPr>
        <p:grpSpPr>
          <a:xfrm>
            <a:off x="1926751" y="1384588"/>
            <a:ext cx="3953349" cy="4088823"/>
            <a:chOff x="2472851" y="1600777"/>
            <a:chExt cx="3953349" cy="4088823"/>
          </a:xfrm>
        </p:grpSpPr>
        <p:graphicFrame>
          <p:nvGraphicFramePr>
            <p:cNvPr id="7" name="Chart 6">
              <a:extLst>
                <a:ext uri="{FF2B5EF4-FFF2-40B4-BE49-F238E27FC236}">
                  <a16:creationId xmlns:a16="http://schemas.microsoft.com/office/drawing/2014/main" id="{BB04B508-E7BB-433F-9BFE-53401031126B}"/>
                </a:ext>
              </a:extLst>
            </p:cNvPr>
            <p:cNvGraphicFramePr/>
            <p:nvPr>
              <p:extLst>
                <p:ext uri="{D42A27DB-BD31-4B8C-83A1-F6EECF244321}">
                  <p14:modId xmlns:p14="http://schemas.microsoft.com/office/powerpoint/2010/main" val="2080859628"/>
                </p:ext>
              </p:extLst>
            </p:nvPr>
          </p:nvGraphicFramePr>
          <p:xfrm>
            <a:off x="2472851" y="1600777"/>
            <a:ext cx="3953349" cy="4088823"/>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a:extLst>
                <a:ext uri="{FF2B5EF4-FFF2-40B4-BE49-F238E27FC236}">
                  <a16:creationId xmlns:a16="http://schemas.microsoft.com/office/drawing/2014/main" id="{AC6F6A05-AB6E-43CD-A419-5C94D22CF921}"/>
                </a:ext>
              </a:extLst>
            </p:cNvPr>
            <p:cNvSpPr txBox="1"/>
            <p:nvPr/>
          </p:nvSpPr>
          <p:spPr>
            <a:xfrm>
              <a:off x="3708400" y="2685534"/>
              <a:ext cx="279400" cy="307777"/>
            </a:xfrm>
            <a:prstGeom prst="rect">
              <a:avLst/>
            </a:prstGeom>
            <a:noFill/>
          </p:spPr>
          <p:txBody>
            <a:bodyPr wrap="square">
              <a:spAutoFit/>
            </a:bodyPr>
            <a:lstStyle/>
            <a:p>
              <a:r>
                <a:rPr lang="en-US" sz="1400" dirty="0"/>
                <a:t>a</a:t>
              </a:r>
            </a:p>
          </p:txBody>
        </p:sp>
        <p:sp>
          <p:nvSpPr>
            <p:cNvPr id="11" name="TextBox 10">
              <a:extLst>
                <a:ext uri="{FF2B5EF4-FFF2-40B4-BE49-F238E27FC236}">
                  <a16:creationId xmlns:a16="http://schemas.microsoft.com/office/drawing/2014/main" id="{D557658E-A638-46AF-9998-1F07470E23B1}"/>
                </a:ext>
              </a:extLst>
            </p:cNvPr>
            <p:cNvSpPr txBox="1"/>
            <p:nvPr/>
          </p:nvSpPr>
          <p:spPr>
            <a:xfrm>
              <a:off x="5372100" y="2459335"/>
              <a:ext cx="279400" cy="307777"/>
            </a:xfrm>
            <a:prstGeom prst="rect">
              <a:avLst/>
            </a:prstGeom>
            <a:noFill/>
          </p:spPr>
          <p:txBody>
            <a:bodyPr wrap="square">
              <a:spAutoFit/>
            </a:bodyPr>
            <a:lstStyle/>
            <a:p>
              <a:r>
                <a:rPr lang="en-US" sz="1400" dirty="0"/>
                <a:t>b</a:t>
              </a:r>
            </a:p>
          </p:txBody>
        </p:sp>
      </p:grpSp>
    </p:spTree>
    <p:extLst>
      <p:ext uri="{BB962C8B-B14F-4D97-AF65-F5344CB8AC3E}">
        <p14:creationId xmlns:p14="http://schemas.microsoft.com/office/powerpoint/2010/main" val="29837172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EEFB574-2781-4201-8BBC-87AB4FE082CF}"/>
              </a:ext>
            </a:extLst>
          </p:cNvPr>
          <p:cNvGraphicFramePr>
            <a:graphicFrameLocks/>
          </p:cNvGraphicFramePr>
          <p:nvPr>
            <p:extLst>
              <p:ext uri="{D42A27DB-BD31-4B8C-83A1-F6EECF244321}">
                <p14:modId xmlns:p14="http://schemas.microsoft.com/office/powerpoint/2010/main" val="3868590942"/>
              </p:ext>
            </p:extLst>
          </p:nvPr>
        </p:nvGraphicFramePr>
        <p:xfrm>
          <a:off x="1353665" y="1424539"/>
          <a:ext cx="6125164" cy="3531722"/>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C3E6BED6-1EE8-48E5-86AA-B75C468E9D4C}"/>
              </a:ext>
            </a:extLst>
          </p:cNvPr>
          <p:cNvSpPr txBox="1"/>
          <p:nvPr/>
        </p:nvSpPr>
        <p:spPr>
          <a:xfrm>
            <a:off x="386863" y="564505"/>
            <a:ext cx="9891030" cy="646331"/>
          </a:xfrm>
          <a:prstGeom prst="rect">
            <a:avLst/>
          </a:prstGeom>
          <a:noFill/>
        </p:spPr>
        <p:txBody>
          <a:bodyPr wrap="square">
            <a:spAutoFit/>
          </a:bodyPr>
          <a:lstStyle/>
          <a:p>
            <a:r>
              <a:rPr lang="en-US" sz="1800" b="1" dirty="0">
                <a:effectLst/>
                <a:latin typeface="Times New Roman" panose="02020603050405020304" pitchFamily="18" charset="0"/>
                <a:ea typeface="Calibri" panose="020F0502020204030204" pitchFamily="34" charset="0"/>
              </a:rPr>
              <a:t>Figure S6. </a:t>
            </a:r>
            <a:r>
              <a:rPr lang="en-US" sz="1800" dirty="0">
                <a:effectLst/>
                <a:latin typeface="Times New Roman" panose="02020603050405020304" pitchFamily="18" charset="0"/>
                <a:ea typeface="Calibri" panose="020F0502020204030204" pitchFamily="34" charset="0"/>
              </a:rPr>
              <a:t>Spaciotemporal analysis of the </a:t>
            </a:r>
            <a:r>
              <a:rPr lang="en-US" sz="1800" i="1" dirty="0">
                <a:effectLst/>
                <a:latin typeface="Times New Roman" panose="02020603050405020304" pitchFamily="18" charset="0"/>
                <a:ea typeface="Calibri" panose="020F0502020204030204" pitchFamily="34" charset="0"/>
              </a:rPr>
              <a:t>Lig1</a:t>
            </a:r>
            <a:r>
              <a:rPr lang="en-US" sz="1800" dirty="0">
                <a:effectLst/>
                <a:latin typeface="Times New Roman" panose="02020603050405020304" pitchFamily="18" charset="0"/>
                <a:ea typeface="Calibri" panose="020F0502020204030204" pitchFamily="34" charset="0"/>
              </a:rPr>
              <a:t> gene using the BaRTv1.0 data. TPM, transcripts per million. </a:t>
            </a:r>
            <a:endParaRPr lang="en-US" dirty="0"/>
          </a:p>
        </p:txBody>
      </p:sp>
    </p:spTree>
    <p:extLst>
      <p:ext uri="{BB962C8B-B14F-4D97-AF65-F5344CB8AC3E}">
        <p14:creationId xmlns:p14="http://schemas.microsoft.com/office/powerpoint/2010/main" val="20092766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862</TotalTime>
  <Words>826</Words>
  <Application>Microsoft Office PowerPoint</Application>
  <PresentationFormat>Widescreen</PresentationFormat>
  <Paragraphs>95</Paragraphs>
  <Slides>6</Slides>
  <Notes>3</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Arial</vt:lpstr>
      <vt:lpstr>Calibri</vt:lpstr>
      <vt:lpstr>Calibri Light</vt:lpstr>
      <vt:lpstr>Cambria</vt:lpstr>
      <vt:lpstr>Courier New</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ng, Shengming - ARS</dc:creator>
  <cp:lastModifiedBy>Yang, Shengming - ARS</cp:lastModifiedBy>
  <cp:revision>12</cp:revision>
  <dcterms:created xsi:type="dcterms:W3CDTF">2021-11-10T21:34:09Z</dcterms:created>
  <dcterms:modified xsi:type="dcterms:W3CDTF">2022-06-23T00:29:39Z</dcterms:modified>
</cp:coreProperties>
</file>